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9.jpeg" ContentType="image/jpeg"/>
  <Override PartName="/ppt/media/image18.png" ContentType="image/png"/>
  <Override PartName="/ppt/media/image58.png" ContentType="image/png"/>
  <Override PartName="/ppt/media/image46.jpeg" ContentType="image/jpeg"/>
  <Override PartName="/ppt/media/image57.jpeg" ContentType="image/jpeg"/>
  <Override PartName="/ppt/media/image63.png" ContentType="image/png"/>
  <Override PartName="/ppt/media/image56.png" ContentType="image/png"/>
  <Override PartName="/ppt/media/image55.png" ContentType="image/png"/>
  <Override PartName="/ppt/media/image53.png" ContentType="image/png"/>
  <Override PartName="/ppt/media/image52.jpeg" ContentType="image/jpeg"/>
  <Override PartName="/ppt/media/image13.png" ContentType="image/png"/>
  <Override PartName="/ppt/media/image1.png" ContentType="image/png"/>
  <Override PartName="/ppt/media/image60.png" ContentType="image/png"/>
  <Override PartName="/ppt/media/image14.jpeg" ContentType="image/jpeg"/>
  <Override PartName="/ppt/media/image54.png" ContentType="image/png"/>
  <Override PartName="/ppt/media/image33.png" ContentType="image/png"/>
  <Override PartName="/ppt/media/image17.jpeg" ContentType="image/jpeg"/>
  <Override PartName="/ppt/media/image26.png" ContentType="image/png"/>
  <Override PartName="/ppt/media/image2.jpeg" ContentType="image/jpeg"/>
  <Override PartName="/ppt/media/image49.jpeg" ContentType="image/jpeg"/>
  <Override PartName="/ppt/media/image61.png" ContentType="image/png"/>
  <Override PartName="/ppt/media/image19.png" ContentType="image/png"/>
  <Override PartName="/ppt/media/image62.jpeg" ContentType="image/jpeg"/>
  <Override PartName="/ppt/media/image50.png" ContentType="image/png"/>
  <Override PartName="/ppt/media/image3.png" ContentType="image/png"/>
  <Override PartName="/ppt/media/image15.png" ContentType="image/png"/>
  <Override PartName="/ppt/media/image24.jpeg" ContentType="image/jpeg"/>
  <Override PartName="/ppt/media/image22.png" ContentType="image/png"/>
  <Override PartName="/ppt/media/image70.jpeg" ContentType="image/jpeg"/>
  <Override PartName="/ppt/media/image5.png" ContentType="image/png"/>
  <Override PartName="/ppt/media/image43.jpeg" ContentType="image/jpeg"/>
  <Override PartName="/ppt/media/image6.jpeg" ContentType="image/jpeg"/>
  <Override PartName="/ppt/media/image71.png" ContentType="image/png"/>
  <Override PartName="/ppt/media/image29.png" ContentType="image/png"/>
  <Override PartName="/ppt/media/image34.png" ContentType="image/png"/>
  <Override PartName="/ppt/media/image25.jpeg" ContentType="image/jpeg"/>
  <Override PartName="/ppt/media/image32.png" ContentType="image/png"/>
  <Override PartName="/ppt/media/image69.png" ContentType="image/png"/>
  <Override PartName="/ppt/media/image67.jpeg" ContentType="image/jpeg"/>
  <Override PartName="/ppt/media/image64.png" ContentType="image/png"/>
  <Override PartName="/ppt/media/image41.jpeg" ContentType="image/jpeg"/>
  <Override PartName="/ppt/media/image66.png" ContentType="image/png"/>
  <Override PartName="/ppt/media/image68.jpeg" ContentType="image/jpeg"/>
  <Override PartName="/ppt/media/image21.jpeg" ContentType="image/jpeg"/>
  <Override PartName="/ppt/media/image65.png" ContentType="image/png"/>
  <Override PartName="/ppt/media/image23.png" ContentType="image/png"/>
  <Override PartName="/ppt/media/image8.png" ContentType="image/png"/>
  <Override PartName="/ppt/media/image38.png" ContentType="image/png"/>
  <Override PartName="/ppt/media/image11.jpeg" ContentType="image/jpeg"/>
  <Override PartName="/ppt/media/image28.jpeg" ContentType="image/jpeg"/>
  <Override PartName="/ppt/media/image16.png" ContentType="image/png"/>
  <Override PartName="/ppt/media/image4.png" ContentType="image/png"/>
  <Override PartName="/ppt/media/image7.jpeg" ContentType="image/jpeg"/>
  <Override PartName="/ppt/media/image9.png" ContentType="image/png"/>
  <Override PartName="/ppt/media/image39.png" ContentType="image/png"/>
  <Override PartName="/ppt/media/image27.jpeg" ContentType="image/jpeg"/>
  <Override PartName="/ppt/media/image10.jpeg" ContentType="image/jpeg"/>
  <Override PartName="/ppt/media/image12.png" ContentType="image/png"/>
  <Override PartName="/ppt/media/image30.png" ContentType="image/png"/>
  <Override PartName="/ppt/media/image20.png" ContentType="image/png"/>
  <Override PartName="/ppt/media/image37.jpeg" ContentType="image/jpeg"/>
  <Override PartName="/ppt/media/image31.jpeg" ContentType="image/jpeg"/>
  <Override PartName="/ppt/media/image35.jpeg" ContentType="image/jpeg"/>
  <Override PartName="/ppt/media/image47.png" ContentType="image/png"/>
  <Override PartName="/ppt/media/image36.png" ContentType="image/png"/>
  <Override PartName="/ppt/media/image40.png" ContentType="image/png"/>
  <Override PartName="/ppt/media/image42.png" ContentType="image/png"/>
  <Override PartName="/ppt/media/image44.png" ContentType="image/png"/>
  <Override PartName="/ppt/media/image45.png" ContentType="image/png"/>
  <Override PartName="/ppt/media/image48.png" ContentType="image/png"/>
  <Override PartName="/ppt/media/image51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19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D80F8A-286B-4955-B150-45F2F8A5CF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E101C6-DE19-4ACE-9496-BF9A4843AA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F5EFE-207E-4D9D-9385-DF2DDA2119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CC27C-841C-436D-B428-E0317F229C0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C4730-49B6-4F30-91A8-A28B18E8E4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8C5E5B-EEFA-4BB0-AB11-9CE983977E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B89D5A-13BA-48AD-9759-ECF64A1E1D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0869B8-4813-467C-BE43-5555061103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A2898C-8053-493D-B299-CBCC8210A5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6CCDC0-A681-4755-88F4-F2CE04FF43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A526F1-5355-4D50-9AC3-6706AFFA4F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E2B27-658E-4FA2-97D1-2A4E4A6FBF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CA60A7-4E74-42FD-9A4A-DA3773EF057A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2.jpeg"/><Relationship Id="rId4" Type="http://schemas.openxmlformats.org/officeDocument/2006/relationships/image" Target="../media/image3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image" Target="../media/image35.jpeg"/><Relationship Id="rId4" Type="http://schemas.openxmlformats.org/officeDocument/2006/relationships/image" Target="../media/image11.jpeg"/><Relationship Id="rId5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image" Target="../media/image37.jpeg"/><Relationship Id="rId3" Type="http://schemas.openxmlformats.org/officeDocument/2006/relationships/image" Target="../media/image11.jpeg"/><Relationship Id="rId4" Type="http://schemas.openxmlformats.org/officeDocument/2006/relationships/image" Target="../media/image38.png"/><Relationship Id="rId5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image" Target="../media/image40.png"/><Relationship Id="rId3" Type="http://schemas.openxmlformats.org/officeDocument/2006/relationships/image" Target="../media/image41.jpeg"/><Relationship Id="rId4" Type="http://schemas.openxmlformats.org/officeDocument/2006/relationships/image" Target="../media/image41.jpeg"/><Relationship Id="rId5" Type="http://schemas.openxmlformats.org/officeDocument/2006/relationships/image" Target="../media/image11.jpeg"/><Relationship Id="rId6" Type="http://schemas.openxmlformats.org/officeDocument/2006/relationships/image" Target="../media/image11.jpeg"/><Relationship Id="rId7" Type="http://schemas.openxmlformats.org/officeDocument/2006/relationships/image" Target="../media/image40.png"/><Relationship Id="rId8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image" Target="../media/image43.jpeg"/><Relationship Id="rId3" Type="http://schemas.openxmlformats.org/officeDocument/2006/relationships/image" Target="../media/image11.jpeg"/><Relationship Id="rId4" Type="http://schemas.openxmlformats.org/officeDocument/2006/relationships/image" Target="../media/image44.png"/><Relationship Id="rId5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image" Target="../media/image46.jpeg"/><Relationship Id="rId3" Type="http://schemas.openxmlformats.org/officeDocument/2006/relationships/image" Target="../media/image11.jpeg"/><Relationship Id="rId4" Type="http://schemas.openxmlformats.org/officeDocument/2006/relationships/image" Target="../media/image47.png"/><Relationship Id="rId5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48.png"/><Relationship Id="rId2" Type="http://schemas.openxmlformats.org/officeDocument/2006/relationships/image" Target="../media/image49.jpeg"/><Relationship Id="rId3" Type="http://schemas.openxmlformats.org/officeDocument/2006/relationships/image" Target="../media/image11.jpeg"/><Relationship Id="rId4" Type="http://schemas.openxmlformats.org/officeDocument/2006/relationships/image" Target="../media/image50.png"/><Relationship Id="rId5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image" Target="../media/image52.jpeg"/><Relationship Id="rId3" Type="http://schemas.openxmlformats.org/officeDocument/2006/relationships/image" Target="../media/image11.jpeg"/><Relationship Id="rId4" Type="http://schemas.openxmlformats.org/officeDocument/2006/relationships/image" Target="../media/image53.png"/><Relationship Id="rId5" Type="http://schemas.openxmlformats.org/officeDocument/2006/relationships/image" Target="../media/image54.png"/><Relationship Id="rId6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56.png"/><Relationship Id="rId3" Type="http://schemas.openxmlformats.org/officeDocument/2006/relationships/image" Target="../media/image57.jpeg"/><Relationship Id="rId4" Type="http://schemas.openxmlformats.org/officeDocument/2006/relationships/image" Target="../media/image11.jpeg"/><Relationship Id="rId5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image" Target="../media/image59.jpeg"/><Relationship Id="rId3" Type="http://schemas.openxmlformats.org/officeDocument/2006/relationships/image" Target="../media/image11.jpeg"/><Relationship Id="rId4" Type="http://schemas.openxmlformats.org/officeDocument/2006/relationships/image" Target="../media/image60.png"/><Relationship Id="rId5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61.png"/><Relationship Id="rId2" Type="http://schemas.openxmlformats.org/officeDocument/2006/relationships/image" Target="../media/image62.jpeg"/><Relationship Id="rId3" Type="http://schemas.openxmlformats.org/officeDocument/2006/relationships/image" Target="../media/image11.jpeg"/><Relationship Id="rId4" Type="http://schemas.openxmlformats.org/officeDocument/2006/relationships/image" Target="../media/image63.png"/><Relationship Id="rId5" Type="http://schemas.openxmlformats.org/officeDocument/2006/relationships/image" Target="../media/image64.png"/><Relationship Id="rId6" Type="http://schemas.openxmlformats.org/officeDocument/2006/relationships/image" Target="../media/image63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png"/><Relationship Id="rId5" Type="http://schemas.openxmlformats.org/officeDocument/2006/relationships/image" Target="../media/image8.png"/><Relationship Id="rId6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65.png"/><Relationship Id="rId2" Type="http://schemas.openxmlformats.org/officeDocument/2006/relationships/image" Target="../media/image66.png"/><Relationship Id="rId3" Type="http://schemas.openxmlformats.org/officeDocument/2006/relationships/image" Target="../media/image67.jpeg"/><Relationship Id="rId4" Type="http://schemas.openxmlformats.org/officeDocument/2006/relationships/image" Target="../media/image11.jpeg"/><Relationship Id="rId5" Type="http://schemas.openxmlformats.org/officeDocument/2006/relationships/image" Target="../media/image68.jpeg"/><Relationship Id="rId6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69.png"/><Relationship Id="rId2" Type="http://schemas.openxmlformats.org/officeDocument/2006/relationships/image" Target="../media/image70.jpeg"/><Relationship Id="rId3" Type="http://schemas.openxmlformats.org/officeDocument/2006/relationships/image" Target="../media/image11.jpeg"/><Relationship Id="rId4" Type="http://schemas.openxmlformats.org/officeDocument/2006/relationships/image" Target="../media/image71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image" Target="../media/image12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jpeg"/><Relationship Id="rId3" Type="http://schemas.openxmlformats.org/officeDocument/2006/relationships/image" Target="../media/image11.jpeg"/><Relationship Id="rId4" Type="http://schemas.openxmlformats.org/officeDocument/2006/relationships/image" Target="../media/image15.pn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jpeg"/><Relationship Id="rId3" Type="http://schemas.openxmlformats.org/officeDocument/2006/relationships/image" Target="../media/image11.jpeg"/><Relationship Id="rId4" Type="http://schemas.openxmlformats.org/officeDocument/2006/relationships/image" Target="../media/image18.pn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jpeg"/><Relationship Id="rId4" Type="http://schemas.openxmlformats.org/officeDocument/2006/relationships/image" Target="../media/image11.jpe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image" Target="../media/image24.jpeg"/><Relationship Id="rId4" Type="http://schemas.openxmlformats.org/officeDocument/2006/relationships/image" Target="../media/image25.jpeg"/><Relationship Id="rId5" Type="http://schemas.openxmlformats.org/officeDocument/2006/relationships/image" Target="../media/image25.jpeg"/><Relationship Id="rId6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jpeg"/><Relationship Id="rId3" Type="http://schemas.openxmlformats.org/officeDocument/2006/relationships/image" Target="../media/image28.jpeg"/><Relationship Id="rId4" Type="http://schemas.openxmlformats.org/officeDocument/2006/relationships/image" Target="../media/image29.png"/><Relationship Id="rId5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image" Target="../media/image31.jpeg"/><Relationship Id="rId3" Type="http://schemas.openxmlformats.org/officeDocument/2006/relationships/image" Target="../media/image11.jpeg"/><Relationship Id="rId4" Type="http://schemas.openxmlformats.org/officeDocument/2006/relationships/image" Target="../media/image3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3724200" y="2425680"/>
            <a:ext cx="2822760" cy="4853160"/>
          </a:xfrm>
          <a:prstGeom prst="rect">
            <a:avLst/>
          </a:prstGeom>
          <a:ln w="0">
            <a:noFill/>
          </a:ln>
        </p:spPr>
      </p:pic>
      <p:sp>
        <p:nvSpPr>
          <p:cNvPr id="42" name="Line 79"/>
          <p:cNvSpPr/>
          <p:nvPr/>
        </p:nvSpPr>
        <p:spPr>
          <a:xfrm flipH="1">
            <a:off x="5567400" y="2649600"/>
            <a:ext cx="1440" cy="44449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AutoShape 8"/>
          <p:cNvSpPr/>
          <p:nvPr/>
        </p:nvSpPr>
        <p:spPr>
          <a:xfrm>
            <a:off x="2651040" y="5486400"/>
            <a:ext cx="152640" cy="169560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1695600"/>
              <a:gd name="textAreaBottom" fmla="*/ 1677600 h 1695600"/>
            </a:gdLst>
            <a:ahLst/>
            <a:rect l="textAreaLeft" t="textAreaTop" r="textAreaRight" b="textAreaBottom"/>
            <a:pathLst>
              <a:path w="21600" h="239430">
                <a:moveTo>
                  <a:pt x="3600" y="0"/>
                </a:moveTo>
                <a:arcTo wR="3600" hR="3600" stAng="0" swAng="5400000"/>
                <a:lnTo>
                  <a:pt x="0" y="235830"/>
                </a:lnTo>
                <a:arcTo wR="3600" hR="3600" stAng="16200000" swAng="5400000"/>
                <a:lnTo>
                  <a:pt x="18000" y="239430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51c2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AutoShape 7"/>
          <p:cNvSpPr/>
          <p:nvPr/>
        </p:nvSpPr>
        <p:spPr>
          <a:xfrm>
            <a:off x="2651040" y="2585880"/>
            <a:ext cx="152640" cy="139716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1397160"/>
              <a:gd name="textAreaBottom" fmla="*/ 1379160 h 1397160"/>
            </a:gdLst>
            <a:ahLst/>
            <a:rect l="textAreaLeft" t="textAreaTop" r="textAreaRight" b="textAreaBottom"/>
            <a:pathLst>
              <a:path w="21600" h="197297">
                <a:moveTo>
                  <a:pt x="3600" y="0"/>
                </a:moveTo>
                <a:arcTo wR="3600" hR="3600" stAng="0" swAng="5400000"/>
                <a:lnTo>
                  <a:pt x="0" y="193697"/>
                </a:lnTo>
                <a:arcTo wR="3600" hR="3600" stAng="16200000" swAng="5400000"/>
                <a:lnTo>
                  <a:pt x="18000" y="197297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1f60a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AutoShape 13"/>
          <p:cNvSpPr/>
          <p:nvPr/>
        </p:nvSpPr>
        <p:spPr>
          <a:xfrm>
            <a:off x="2651040" y="3886200"/>
            <a:ext cx="152640" cy="638280"/>
          </a:xfrm>
          <a:custGeom>
            <a:avLst/>
            <a:gdLst>
              <a:gd name="textAreaLeft" fmla="*/ 0 w 152640"/>
              <a:gd name="textAreaRight" fmla="*/ 153000 w 152640"/>
              <a:gd name="textAreaTop" fmla="*/ 0 h 638280"/>
              <a:gd name="textAreaBottom" fmla="*/ 638640 h 638280"/>
            </a:gdLst>
            <a:ahLst/>
            <a:rect l="textAreaLeft" t="textAreaTop" r="textAreaRight" b="textAreaBottom"/>
            <a:pathLst>
              <a:path w="21600" h="90161">
                <a:moveTo>
                  <a:pt x="0" y="0"/>
                </a:moveTo>
                <a:arcTo wR="0" hR="0" stAng="10800000" swAng="-5400000"/>
                <a:lnTo>
                  <a:pt x="0" y="90161"/>
                </a:lnTo>
                <a:arcTo wR="0" hR="0" stAng="16200000" swAng="-5400000"/>
                <a:lnTo>
                  <a:pt x="21600" y="90161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AutoShape 47"/>
          <p:cNvSpPr/>
          <p:nvPr/>
        </p:nvSpPr>
        <p:spPr>
          <a:xfrm>
            <a:off x="2651040" y="4133880"/>
            <a:ext cx="152640" cy="466560"/>
          </a:xfrm>
          <a:custGeom>
            <a:avLst/>
            <a:gdLst>
              <a:gd name="textAreaLeft" fmla="*/ 0 w 152640"/>
              <a:gd name="textAreaRight" fmla="*/ 153000 w 152640"/>
              <a:gd name="textAreaTop" fmla="*/ 0 h 466560"/>
              <a:gd name="textAreaBottom" fmla="*/ 466920 h 466560"/>
            </a:gdLst>
            <a:ahLst/>
            <a:rect l="textAreaLeft" t="textAreaTop" r="textAreaRight" b="textAreaBottom"/>
            <a:pathLst>
              <a:path w="21600" h="65918">
                <a:moveTo>
                  <a:pt x="0" y="0"/>
                </a:moveTo>
                <a:arcTo wR="0" hR="0" stAng="10800000" swAng="-5400000"/>
                <a:lnTo>
                  <a:pt x="0" y="65918"/>
                </a:lnTo>
                <a:arcTo wR="0" hR="0" stAng="16200000" swAng="-5400000"/>
                <a:lnTo>
                  <a:pt x="21600" y="6591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ef252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AutoShape 11"/>
          <p:cNvSpPr/>
          <p:nvPr/>
        </p:nvSpPr>
        <p:spPr>
          <a:xfrm>
            <a:off x="2651040" y="4400640"/>
            <a:ext cx="152640" cy="1035000"/>
          </a:xfrm>
          <a:custGeom>
            <a:avLst/>
            <a:gdLst>
              <a:gd name="textAreaLeft" fmla="*/ 0 w 152640"/>
              <a:gd name="textAreaRight" fmla="*/ 153000 w 152640"/>
              <a:gd name="textAreaTop" fmla="*/ 0 h 1035000"/>
              <a:gd name="textAreaBottom" fmla="*/ 1035000 h 1035000"/>
            </a:gdLst>
            <a:ahLst/>
            <a:rect l="textAreaLeft" t="textAreaTop" r="textAreaRight" b="textAreaBottom"/>
            <a:pathLst>
              <a:path w="21600" h="146168">
                <a:moveTo>
                  <a:pt x="0" y="0"/>
                </a:moveTo>
                <a:arcTo wR="0" hR="0" stAng="10800000" swAng="-5400000"/>
                <a:lnTo>
                  <a:pt x="0" y="146168"/>
                </a:lnTo>
                <a:arcTo wR="0" hR="0" stAng="16200000" swAng="-5400000"/>
                <a:lnTo>
                  <a:pt x="21600" y="14616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eba24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5"/>
          <p:cNvSpPr/>
          <p:nvPr/>
        </p:nvSpPr>
        <p:spPr>
          <a:xfrm>
            <a:off x="2785680" y="323208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6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6"/>
          <p:cNvSpPr/>
          <p:nvPr/>
        </p:nvSpPr>
        <p:spPr>
          <a:xfrm>
            <a:off x="2871360" y="391644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AS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0"/>
          <p:cNvSpPr/>
          <p:nvPr/>
        </p:nvSpPr>
        <p:spPr>
          <a:xfrm>
            <a:off x="2897280" y="4308480"/>
            <a:ext cx="26316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1"/>
          <p:cNvSpPr/>
          <p:nvPr/>
        </p:nvSpPr>
        <p:spPr>
          <a:xfrm>
            <a:off x="2786040" y="415908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78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2"/>
          <p:cNvSpPr/>
          <p:nvPr/>
        </p:nvSpPr>
        <p:spPr>
          <a:xfrm>
            <a:off x="2785680" y="624852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61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36"/>
          <p:cNvSpPr/>
          <p:nvPr/>
        </p:nvSpPr>
        <p:spPr>
          <a:xfrm>
            <a:off x="4500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A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37"/>
          <p:cNvSpPr/>
          <p:nvPr/>
        </p:nvSpPr>
        <p:spPr>
          <a:xfrm>
            <a:off x="246060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A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38"/>
          <p:cNvSpPr/>
          <p:nvPr/>
        </p:nvSpPr>
        <p:spPr>
          <a:xfrm>
            <a:off x="394092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A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39" descr="1A Screen shot 2013-01-06 at 13"/>
          <p:cNvPicPr/>
          <p:nvPr/>
        </p:nvPicPr>
        <p:blipFill>
          <a:blip r:embed="rId2"/>
          <a:stretch/>
        </p:blipFill>
        <p:spPr>
          <a:xfrm>
            <a:off x="204840" y="2514600"/>
            <a:ext cx="376200" cy="47242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41" descr="1A Screen shot 2013-01-06 at 13"/>
          <p:cNvPicPr/>
          <p:nvPr/>
        </p:nvPicPr>
        <p:blipFill>
          <a:blip r:embed="rId3"/>
          <a:srcRect l="18895" t="21892" r="28342" b="67944"/>
          <a:stretch/>
        </p:blipFill>
        <p:spPr>
          <a:xfrm>
            <a:off x="276120" y="4168800"/>
            <a:ext cx="201600" cy="466560"/>
          </a:xfrm>
          <a:prstGeom prst="rect">
            <a:avLst/>
          </a:prstGeom>
          <a:ln w="0">
            <a:noFill/>
          </a:ln>
        </p:spPr>
      </p:pic>
      <p:grpSp>
        <p:nvGrpSpPr>
          <p:cNvPr id="58" name="Group 44"/>
          <p:cNvGrpSpPr/>
          <p:nvPr/>
        </p:nvGrpSpPr>
        <p:grpSpPr>
          <a:xfrm>
            <a:off x="230040" y="4384800"/>
            <a:ext cx="266400" cy="263520"/>
            <a:chOff x="230040" y="4384800"/>
            <a:chExt cx="266400" cy="263520"/>
          </a:xfrm>
        </p:grpSpPr>
        <p:pic>
          <p:nvPicPr>
            <p:cNvPr id="59" name="Picture 42" descr="Screen shot 2013-01-06 at 13"/>
            <p:cNvPicPr/>
            <p:nvPr/>
          </p:nvPicPr>
          <p:blipFill>
            <a:blip r:embed="rId4"/>
            <a:srcRect l="0" t="0" r="3281" b="0"/>
            <a:stretch/>
          </p:blipFill>
          <p:spPr>
            <a:xfrm>
              <a:off x="230040" y="4384800"/>
              <a:ext cx="266400" cy="114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43" descr="Screen shot 2013-01-06 at 13"/>
            <p:cNvPicPr/>
            <p:nvPr/>
          </p:nvPicPr>
          <p:blipFill>
            <a:blip r:embed="rId5"/>
            <a:srcRect l="0" t="37461" r="3281" b="0"/>
            <a:stretch/>
          </p:blipFill>
          <p:spPr>
            <a:xfrm>
              <a:off x="230040" y="4573440"/>
              <a:ext cx="266400" cy="748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1" name="Text Box 45"/>
          <p:cNvSpPr/>
          <p:nvPr/>
        </p:nvSpPr>
        <p:spPr>
          <a:xfrm>
            <a:off x="490680" y="2585880"/>
            <a:ext cx="2404800" cy="458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dupw004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cfa2153 (0.86-1.00a), </a:t>
            </a:r>
            <a:r>
              <a:rPr b="0" lang="en-GB" sz="600" spc="-1" strike="noStrike">
                <a:solidFill>
                  <a:srgbClr val="ff9900"/>
                </a:solidFill>
                <a:latin typeface="Arial"/>
              </a:rPr>
              <a:t>BG312683, </a:t>
            </a: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733361, </a:t>
            </a: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m62p64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4676-1A (0.86-1.00h)</a:t>
            </a: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	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6280-1A (0.86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73147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tPt-5413-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m51p65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psp3151 (0.86-1.00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5776-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3904-1A (0.86-1.00f), </a:t>
            </a: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m71p78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8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73161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m77p64.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barc148 (C-0.47S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66682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7074-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wmc278 (C-0.17Li), </a:t>
            </a: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9429-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psp3003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ff"/>
                </a:solidFill>
                <a:latin typeface="Arial"/>
              </a:rPr>
              <a:t>psr1327 (C-0.17L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66525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7030-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73119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ff"/>
                </a:solidFill>
                <a:latin typeface="Arial"/>
              </a:rPr>
              <a:t>psr2019.1</a:t>
            </a:r>
            <a:r>
              <a:rPr b="0" lang="en-GB" sz="600" spc="-1" strike="noStrike">
                <a:solidFill>
                  <a:srgbClr val="ff9900"/>
                </a:solidFill>
                <a:latin typeface="Arial"/>
              </a:rPr>
              <a:t>(Aba8)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ff"/>
                </a:solidFill>
                <a:latin typeface="Arial"/>
              </a:rPr>
              <a:t>psr325.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9900"/>
                </a:solidFill>
                <a:latin typeface="Arial"/>
              </a:rPr>
              <a:t>Glu-A1 (C-0.17Lj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664666 (C-0.17Lk), wPt-664968 (0.17-0.61l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	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733091 (0.61-1.00m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66569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8838-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m92p78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8016-1A (0.61-1.00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66949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1792, wPt-5660-1A (0.61-1.00f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ff"/>
                </a:solidFill>
                <a:latin typeface="Arial"/>
              </a:rPr>
              <a:t>psr967.1, bcd304.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wmc59 (0.61-1.00d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m21p76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m71p77.5, </a:t>
            </a: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5577-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8245-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tPt-1419-1A (0.61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tPt-6091-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66470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m69p78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50"/>
          <p:cNvSpPr/>
          <p:nvPr/>
        </p:nvSpPr>
        <p:spPr>
          <a:xfrm>
            <a:off x="2828880" y="401472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51"/>
          <p:cNvSpPr/>
          <p:nvPr/>
        </p:nvSpPr>
        <p:spPr>
          <a:xfrm flipV="1">
            <a:off x="2838600" y="3890520"/>
            <a:ext cx="0" cy="243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55"/>
          <p:cNvSpPr/>
          <p:nvPr/>
        </p:nvSpPr>
        <p:spPr>
          <a:xfrm>
            <a:off x="2784600" y="4754520"/>
            <a:ext cx="804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17L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x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56"/>
          <p:cNvSpPr/>
          <p:nvPr/>
        </p:nvSpPr>
        <p:spPr>
          <a:xfrm>
            <a:off x="2783880" y="5342040"/>
            <a:ext cx="108900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619ff"/>
                </a:solidFill>
                <a:latin typeface="Arial"/>
              </a:rPr>
              <a:t>Cab-1,</a:t>
            </a:r>
            <a:r>
              <a:rPr b="0" i="1" lang="en-GB" sz="800" spc="-1" strike="noStrike">
                <a:solidFill>
                  <a:srgbClr val="fc0000"/>
                </a:solidFill>
                <a:latin typeface="Arial"/>
              </a:rPr>
              <a:t> CytP, GluT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AutoShape 69"/>
          <p:cNvSpPr/>
          <p:nvPr/>
        </p:nvSpPr>
        <p:spPr>
          <a:xfrm>
            <a:off x="2655720" y="5343480"/>
            <a:ext cx="152640" cy="187200"/>
          </a:xfrm>
          <a:custGeom>
            <a:avLst/>
            <a:gdLst>
              <a:gd name="textAreaLeft" fmla="*/ 0 w 152640"/>
              <a:gd name="textAreaRight" fmla="*/ 153000 w 152640"/>
              <a:gd name="textAreaTop" fmla="*/ 0 h 187200"/>
              <a:gd name="textAreaBottom" fmla="*/ 187200 h 187200"/>
            </a:gdLst>
            <a:ahLst/>
            <a:rect l="textAreaLeft" t="textAreaTop" r="textAreaRight" b="textAreaBottom"/>
            <a:pathLst>
              <a:path w="21600" h="26479">
                <a:moveTo>
                  <a:pt x="0" y="0"/>
                </a:moveTo>
                <a:arcTo wR="0" hR="0" stAng="10800000" swAng="-5400000"/>
                <a:lnTo>
                  <a:pt x="0" y="26479"/>
                </a:lnTo>
                <a:arcTo wR="0" hR="0" stAng="16200000" swAng="-5400000"/>
                <a:lnTo>
                  <a:pt x="21600" y="26479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9c67a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60"/>
          <p:cNvSpPr/>
          <p:nvPr/>
        </p:nvSpPr>
        <p:spPr>
          <a:xfrm>
            <a:off x="299880" y="4319640"/>
            <a:ext cx="15264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62"/>
          <p:cNvSpPr/>
          <p:nvPr/>
        </p:nvSpPr>
        <p:spPr>
          <a:xfrm>
            <a:off x="2525760" y="439596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68"/>
          <p:cNvSpPr/>
          <p:nvPr/>
        </p:nvSpPr>
        <p:spPr>
          <a:xfrm>
            <a:off x="2832120" y="53402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AutoShape 6"/>
          <p:cNvSpPr/>
          <p:nvPr/>
        </p:nvSpPr>
        <p:spPr>
          <a:xfrm>
            <a:off x="2651040" y="2592360"/>
            <a:ext cx="152640" cy="459108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4591080"/>
              <a:gd name="textAreaBottom" fmla="*/ 4573080 h 4591080"/>
            </a:gdLst>
            <a:ahLst/>
            <a:rect l="textAreaLeft" t="textAreaTop" r="textAreaRight" b="textAreaBottom"/>
            <a:pathLst>
              <a:path w="21600" h="648203">
                <a:moveTo>
                  <a:pt x="3600" y="0"/>
                </a:moveTo>
                <a:arcTo wR="3600" hR="3600" stAng="0" swAng="5400000"/>
                <a:lnTo>
                  <a:pt x="0" y="644603"/>
                </a:lnTo>
                <a:arcTo wR="3600" hR="3600" stAng="16200000" swAng="5400000"/>
                <a:lnTo>
                  <a:pt x="18000" y="648203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70"/>
          <p:cNvSpPr/>
          <p:nvPr/>
        </p:nvSpPr>
        <p:spPr>
          <a:xfrm>
            <a:off x="2897280" y="523224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AL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73"/>
          <p:cNvSpPr/>
          <p:nvPr/>
        </p:nvSpPr>
        <p:spPr>
          <a:xfrm>
            <a:off x="2832120" y="55371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74"/>
          <p:cNvSpPr/>
          <p:nvPr/>
        </p:nvSpPr>
        <p:spPr>
          <a:xfrm>
            <a:off x="2897280" y="544212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AL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80"/>
          <p:cNvSpPr/>
          <p:nvPr/>
        </p:nvSpPr>
        <p:spPr>
          <a:xfrm>
            <a:off x="2784960" y="6108840"/>
            <a:ext cx="65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619ff"/>
                </a:solidFill>
                <a:latin typeface="Arial"/>
              </a:rPr>
              <a:t>Cab2,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5" name="Group 124"/>
          <p:cNvGrpSpPr/>
          <p:nvPr/>
        </p:nvGrpSpPr>
        <p:grpSpPr>
          <a:xfrm>
            <a:off x="5586480" y="6008760"/>
            <a:ext cx="1135080" cy="857160"/>
            <a:chOff x="5586480" y="6008760"/>
            <a:chExt cx="1135080" cy="857160"/>
          </a:xfrm>
        </p:grpSpPr>
        <p:sp>
          <p:nvSpPr>
            <p:cNvPr id="76" name="pole tekstowe 43"/>
            <p:cNvSpPr/>
            <p:nvPr/>
          </p:nvSpPr>
          <p:spPr>
            <a:xfrm>
              <a:off x="5870520" y="6008760"/>
              <a:ext cx="85104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TR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TR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7" name="Picture 61" descr=""/>
            <p:cNvPicPr/>
            <p:nvPr/>
          </p:nvPicPr>
          <p:blipFill>
            <a:blip r:embed="rId6"/>
            <a:srcRect l="82274" t="5622" r="10238" b="72370"/>
            <a:stretch/>
          </p:blipFill>
          <p:spPr>
            <a:xfrm>
              <a:off x="5586480" y="6059520"/>
              <a:ext cx="328680" cy="8064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0" name="Picture 3" descr=""/>
          <p:cNvPicPr/>
          <p:nvPr/>
        </p:nvPicPr>
        <p:blipFill>
          <a:blip r:embed="rId1"/>
          <a:stretch/>
        </p:blipFill>
        <p:spPr>
          <a:xfrm>
            <a:off x="4014720" y="2411280"/>
            <a:ext cx="2675160" cy="4699080"/>
          </a:xfrm>
          <a:prstGeom prst="rect">
            <a:avLst/>
          </a:prstGeom>
          <a:ln w="0">
            <a:noFill/>
          </a:ln>
        </p:spPr>
      </p:pic>
      <p:sp>
        <p:nvSpPr>
          <p:cNvPr id="401" name="Line 56"/>
          <p:cNvSpPr/>
          <p:nvPr/>
        </p:nvSpPr>
        <p:spPr>
          <a:xfrm>
            <a:off x="5762520" y="2627280"/>
            <a:ext cx="0" cy="432900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02" name="Picture 2" descr=""/>
          <p:cNvPicPr/>
          <p:nvPr/>
        </p:nvPicPr>
        <p:blipFill>
          <a:blip r:embed="rId2"/>
          <a:srcRect l="83294" t="2063" r="9291" b="74049"/>
          <a:stretch/>
        </p:blipFill>
        <p:spPr>
          <a:xfrm>
            <a:off x="5781600" y="4146480"/>
            <a:ext cx="330120" cy="863640"/>
          </a:xfrm>
          <a:prstGeom prst="rect">
            <a:avLst/>
          </a:prstGeom>
          <a:ln w="0">
            <a:noFill/>
          </a:ln>
        </p:spPr>
      </p:pic>
      <p:sp>
        <p:nvSpPr>
          <p:cNvPr id="403" name="pole tekstowe 4"/>
          <p:cNvSpPr/>
          <p:nvPr/>
        </p:nvSpPr>
        <p:spPr>
          <a:xfrm>
            <a:off x="5987880" y="4114800"/>
            <a:ext cx="8510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Ca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ET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RC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TR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TR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P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ABS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ABS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04" name="Picture 27" descr="4A Screen shot 2013-01-08 at 20"/>
          <p:cNvPicPr/>
          <p:nvPr/>
        </p:nvPicPr>
        <p:blipFill>
          <a:blip r:embed="rId3"/>
          <a:stretch/>
        </p:blipFill>
        <p:spPr>
          <a:xfrm>
            <a:off x="157320" y="2546280"/>
            <a:ext cx="303120" cy="4592880"/>
          </a:xfrm>
          <a:prstGeom prst="rect">
            <a:avLst/>
          </a:prstGeom>
          <a:ln w="0">
            <a:noFill/>
          </a:ln>
        </p:spPr>
      </p:pic>
      <p:sp>
        <p:nvSpPr>
          <p:cNvPr id="405" name="AutoShape 2"/>
          <p:cNvSpPr/>
          <p:nvPr/>
        </p:nvSpPr>
        <p:spPr>
          <a:xfrm>
            <a:off x="2441520" y="6273720"/>
            <a:ext cx="152280" cy="7495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749520"/>
              <a:gd name="textAreaBottom" fmla="*/ 731880 h 749520"/>
            </a:gdLst>
            <a:ahLst/>
            <a:rect l="textAreaLeft" t="textAreaTop" r="textAreaRight" b="textAreaBottom"/>
            <a:pathLst>
              <a:path w="21600" h="106115">
                <a:moveTo>
                  <a:pt x="3600" y="0"/>
                </a:moveTo>
                <a:arcTo wR="3600" hR="3600" stAng="0" swAng="5400000"/>
                <a:lnTo>
                  <a:pt x="0" y="102515"/>
                </a:lnTo>
                <a:arcTo wR="3600" hR="3600" stAng="16200000" swAng="5400000"/>
                <a:lnTo>
                  <a:pt x="18000" y="106115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1f60a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AutoShape 43"/>
          <p:cNvSpPr/>
          <p:nvPr/>
        </p:nvSpPr>
        <p:spPr>
          <a:xfrm>
            <a:off x="2443320" y="6083280"/>
            <a:ext cx="152280" cy="239760"/>
          </a:xfrm>
          <a:custGeom>
            <a:avLst/>
            <a:gdLst>
              <a:gd name="textAreaLeft" fmla="*/ 0 w 152280"/>
              <a:gd name="textAreaRight" fmla="*/ 152640 w 152280"/>
              <a:gd name="textAreaTop" fmla="*/ 0 h 239760"/>
              <a:gd name="textAreaBottom" fmla="*/ 240120 h 239760"/>
            </a:gdLst>
            <a:ahLst/>
            <a:rect l="textAreaLeft" t="textAreaTop" r="textAreaRight" b="textAreaBottom"/>
            <a:pathLst>
              <a:path w="21600" h="33979">
                <a:moveTo>
                  <a:pt x="0" y="0"/>
                </a:moveTo>
                <a:arcTo wR="0" hR="0" stAng="10800000" swAng="-5400000"/>
                <a:lnTo>
                  <a:pt x="0" y="33979"/>
                </a:lnTo>
                <a:arcTo wR="0" hR="0" stAng="16200000" swAng="-5400000"/>
                <a:lnTo>
                  <a:pt x="21600" y="33979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ef2c2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AutoShape 3"/>
          <p:cNvSpPr/>
          <p:nvPr/>
        </p:nvSpPr>
        <p:spPr>
          <a:xfrm>
            <a:off x="2441520" y="5442120"/>
            <a:ext cx="152280" cy="501480"/>
          </a:xfrm>
          <a:custGeom>
            <a:avLst/>
            <a:gdLst>
              <a:gd name="textAreaLeft" fmla="*/ 0 w 152280"/>
              <a:gd name="textAreaRight" fmla="*/ 152640 w 152280"/>
              <a:gd name="textAreaTop" fmla="*/ 0 h 501480"/>
              <a:gd name="textAreaBottom" fmla="*/ 501480 h 501480"/>
            </a:gdLst>
            <a:ahLst/>
            <a:rect l="textAreaLeft" t="textAreaTop" r="textAreaRight" b="textAreaBottom"/>
            <a:pathLst>
              <a:path w="21600" h="71015">
                <a:moveTo>
                  <a:pt x="0" y="0"/>
                </a:moveTo>
                <a:arcTo wR="0" hR="0" stAng="10800000" swAng="-5400000"/>
                <a:lnTo>
                  <a:pt x="0" y="71015"/>
                </a:lnTo>
                <a:arcTo wR="0" hR="0" stAng="16200000" swAng="-5400000"/>
                <a:lnTo>
                  <a:pt x="21600" y="71015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AutoShape 42"/>
          <p:cNvSpPr/>
          <p:nvPr/>
        </p:nvSpPr>
        <p:spPr>
          <a:xfrm>
            <a:off x="2443320" y="5486400"/>
            <a:ext cx="152280" cy="311040"/>
          </a:xfrm>
          <a:custGeom>
            <a:avLst/>
            <a:gdLst>
              <a:gd name="textAreaLeft" fmla="*/ 0 w 152280"/>
              <a:gd name="textAreaRight" fmla="*/ 152640 w 152280"/>
              <a:gd name="textAreaTop" fmla="*/ 0 h 311040"/>
              <a:gd name="textAreaBottom" fmla="*/ 311040 h 311040"/>
            </a:gdLst>
            <a:ahLst/>
            <a:rect l="textAreaLeft" t="textAreaTop" r="textAreaRight" b="textAreaBottom"/>
            <a:pathLst>
              <a:path w="21600" h="44066">
                <a:moveTo>
                  <a:pt x="0" y="0"/>
                </a:moveTo>
                <a:arcTo wR="0" hR="0" stAng="10800000" swAng="-5400000"/>
                <a:lnTo>
                  <a:pt x="0" y="44066"/>
                </a:lnTo>
                <a:arcTo wR="0" hR="0" stAng="16200000" swAng="-5400000"/>
                <a:lnTo>
                  <a:pt x="21600" y="44066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9e65a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AutoShape 4"/>
          <p:cNvSpPr/>
          <p:nvPr/>
        </p:nvSpPr>
        <p:spPr>
          <a:xfrm>
            <a:off x="2441520" y="2610000"/>
            <a:ext cx="152280" cy="173340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733400"/>
              <a:gd name="textAreaBottom" fmla="*/ 1715760 h 1733400"/>
            </a:gdLst>
            <a:ahLst/>
            <a:rect l="textAreaLeft" t="textAreaTop" r="textAreaRight" b="textAreaBottom"/>
            <a:pathLst>
              <a:path w="21600" h="245343">
                <a:moveTo>
                  <a:pt x="3600" y="0"/>
                </a:moveTo>
                <a:arcTo wR="3600" hR="3600" stAng="0" swAng="5400000"/>
                <a:lnTo>
                  <a:pt x="0" y="241743"/>
                </a:lnTo>
                <a:arcTo wR="3600" hR="3600" stAng="16200000" swAng="5400000"/>
                <a:lnTo>
                  <a:pt x="18000" y="245343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ceb2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AutoShape 6"/>
          <p:cNvSpPr/>
          <p:nvPr/>
        </p:nvSpPr>
        <p:spPr>
          <a:xfrm>
            <a:off x="2441520" y="4292640"/>
            <a:ext cx="152280" cy="355680"/>
          </a:xfrm>
          <a:custGeom>
            <a:avLst/>
            <a:gdLst>
              <a:gd name="textAreaLeft" fmla="*/ 0 w 152280"/>
              <a:gd name="textAreaRight" fmla="*/ 152640 w 152280"/>
              <a:gd name="textAreaTop" fmla="*/ 0 h 355680"/>
              <a:gd name="textAreaBottom" fmla="*/ 356040 h 355680"/>
            </a:gdLst>
            <a:ahLst/>
            <a:rect l="textAreaLeft" t="textAreaTop" r="textAreaRight" b="textAreaBottom"/>
            <a:pathLst>
              <a:path w="21600" h="50383">
                <a:moveTo>
                  <a:pt x="0" y="0"/>
                </a:moveTo>
                <a:arcTo wR="0" hR="0" stAng="10800000" swAng="-5400000"/>
                <a:lnTo>
                  <a:pt x="0" y="50383"/>
                </a:lnTo>
                <a:arcTo wR="0" hR="0" stAng="16200000" swAng="-5400000"/>
                <a:lnTo>
                  <a:pt x="21600" y="50383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ac6c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AutoShape 41"/>
          <p:cNvSpPr/>
          <p:nvPr/>
        </p:nvSpPr>
        <p:spPr>
          <a:xfrm>
            <a:off x="2443320" y="4533840"/>
            <a:ext cx="152280" cy="1028880"/>
          </a:xfrm>
          <a:custGeom>
            <a:avLst/>
            <a:gdLst>
              <a:gd name="textAreaLeft" fmla="*/ 0 w 152280"/>
              <a:gd name="textAreaRight" fmla="*/ 152640 w 152280"/>
              <a:gd name="textAreaTop" fmla="*/ 0 h 1028880"/>
              <a:gd name="textAreaBottom" fmla="*/ 1029240 h 1028880"/>
            </a:gdLst>
            <a:ahLst/>
            <a:rect l="textAreaLeft" t="textAreaTop" r="textAreaRight" b="textAreaBottom"/>
            <a:pathLst>
              <a:path w="21600" h="145647">
                <a:moveTo>
                  <a:pt x="0" y="0"/>
                </a:moveTo>
                <a:arcTo wR="0" hR="0" stAng="10800000" swAng="-5400000"/>
                <a:lnTo>
                  <a:pt x="0" y="145647"/>
                </a:lnTo>
                <a:arcTo wR="0" hR="0" stAng="16200000" swAng="-5400000"/>
                <a:lnTo>
                  <a:pt x="21600" y="145647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55c1a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AutoShape 7"/>
          <p:cNvSpPr/>
          <p:nvPr/>
        </p:nvSpPr>
        <p:spPr>
          <a:xfrm>
            <a:off x="2441520" y="2616120"/>
            <a:ext cx="152280" cy="44071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4407120"/>
              <a:gd name="textAreaBottom" fmla="*/ 4389480 h 4407120"/>
            </a:gdLst>
            <a:ahLst/>
            <a:rect l="textAreaLeft" t="textAreaTop" r="textAreaRight" b="textAreaBottom"/>
            <a:pathLst>
              <a:path w="21600" h="623700">
                <a:moveTo>
                  <a:pt x="3600" y="0"/>
                </a:moveTo>
                <a:arcTo wR="3600" hR="3600" stAng="0" swAng="5400000"/>
                <a:lnTo>
                  <a:pt x="0" y="620100"/>
                </a:lnTo>
                <a:arcTo wR="3600" hR="3600" stAng="16200000" swAng="5400000"/>
                <a:lnTo>
                  <a:pt x="18000" y="623700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Text Box 8"/>
          <p:cNvSpPr/>
          <p:nvPr/>
        </p:nvSpPr>
        <p:spPr>
          <a:xfrm>
            <a:off x="2559960" y="338292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0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Text Box 9"/>
          <p:cNvSpPr/>
          <p:nvPr/>
        </p:nvSpPr>
        <p:spPr>
          <a:xfrm>
            <a:off x="2671920" y="418932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4AL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Text Box 11"/>
          <p:cNvSpPr/>
          <p:nvPr/>
        </p:nvSpPr>
        <p:spPr>
          <a:xfrm>
            <a:off x="2558520" y="5632560"/>
            <a:ext cx="148392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59L </a:t>
            </a:r>
            <a:r>
              <a:rPr b="0" i="1" lang="en-GB" sz="800" spc="-1" strike="noStrike">
                <a:solidFill>
                  <a:srgbClr val="0a04fc"/>
                </a:solidFill>
                <a:latin typeface="Arial"/>
              </a:rPr>
              <a:t>Cab(CP29),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caA/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Text Box 12"/>
          <p:cNvSpPr/>
          <p:nvPr/>
        </p:nvSpPr>
        <p:spPr>
          <a:xfrm>
            <a:off x="2557440" y="6532560"/>
            <a:ext cx="964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6-1.00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UpoII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Line 13"/>
          <p:cNvSpPr/>
          <p:nvPr/>
        </p:nvSpPr>
        <p:spPr>
          <a:xfrm>
            <a:off x="2606760" y="42926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Text Box 16"/>
          <p:cNvSpPr/>
          <p:nvPr/>
        </p:nvSpPr>
        <p:spPr>
          <a:xfrm>
            <a:off x="4680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4A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Text Box 17"/>
          <p:cNvSpPr/>
          <p:nvPr/>
        </p:nvSpPr>
        <p:spPr>
          <a:xfrm>
            <a:off x="224136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4A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Text Box 18"/>
          <p:cNvSpPr/>
          <p:nvPr/>
        </p:nvSpPr>
        <p:spPr>
          <a:xfrm>
            <a:off x="409644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4A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1" name="Picture 21" descr="Chrom blank Screen shot 2013-01-07 at 10"/>
          <p:cNvPicPr/>
          <p:nvPr/>
        </p:nvPicPr>
        <p:blipFill>
          <a:blip r:embed="rId4">
            <a:lum contrast="-2000"/>
          </a:blip>
          <a:srcRect l="0" t="0" r="7663" b="0"/>
          <a:stretch/>
        </p:blipFill>
        <p:spPr>
          <a:xfrm>
            <a:off x="189000" y="5611680"/>
            <a:ext cx="180720" cy="595440"/>
          </a:xfrm>
          <a:prstGeom prst="rect">
            <a:avLst/>
          </a:prstGeom>
          <a:ln w="0">
            <a:noFill/>
          </a:ln>
        </p:spPr>
      </p:pic>
      <p:sp>
        <p:nvSpPr>
          <p:cNvPr id="422" name="Text Box 24"/>
          <p:cNvSpPr/>
          <p:nvPr/>
        </p:nvSpPr>
        <p:spPr>
          <a:xfrm>
            <a:off x="2669040" y="6227640"/>
            <a:ext cx="1146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4AS-1, 4AS-4, 4AS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Line 28"/>
          <p:cNvSpPr/>
          <p:nvPr/>
        </p:nvSpPr>
        <p:spPr>
          <a:xfrm>
            <a:off x="176040" y="6022800"/>
            <a:ext cx="22572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Line 30"/>
          <p:cNvSpPr/>
          <p:nvPr/>
        </p:nvSpPr>
        <p:spPr>
          <a:xfrm>
            <a:off x="176040" y="6129360"/>
            <a:ext cx="225720" cy="0"/>
          </a:xfrm>
          <a:prstGeom prst="line">
            <a:avLst/>
          </a:prstGeom>
          <a:ln w="176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Text Box 31"/>
          <p:cNvSpPr/>
          <p:nvPr/>
        </p:nvSpPr>
        <p:spPr>
          <a:xfrm>
            <a:off x="372960" y="2562120"/>
            <a:ext cx="2217960" cy="448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92.1 (0.85-1.00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60.1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Plc) (0.85-1.00ab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205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620-4A (0.8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828-4A (0.8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064-4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8p78.x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023-4A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3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424-4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73 (0.85-1.00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92p78.8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935-4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8p78.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60 (0.80-1.00a), barc78 (0.80-1.00a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807-4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084-4A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	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                          (0.8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687-4A (0.80-1.00f), wPt-3907 (0.8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349-4A (0.8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150-4A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490.2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Ss1) (0.80-1.00e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275-4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903-4A, wPt-2909 (0.80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71707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32 (0.80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62 (0.80-1.00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374-4A, wPt-6728 (0.66-0.80h)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466.2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Nra)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113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15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Prk) (0.66-0.80a)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59p78.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71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5000"/>
              </a:lnSpc>
              <a:spcBef>
                <a:spcPts val="71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58 (0.59-0.66y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68 (0.59-0.66y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71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747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269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dupw004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mwg634.2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638-4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97 (0.59-0.66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93.2 (C-0.59L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0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20 (C-0.63S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927.2 (0.63-0.71b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748-4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mwg5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65c (0.76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2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79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Text Box 33"/>
          <p:cNvSpPr/>
          <p:nvPr/>
        </p:nvSpPr>
        <p:spPr>
          <a:xfrm>
            <a:off x="2671560" y="545472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4AL-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Line 34"/>
          <p:cNvSpPr/>
          <p:nvPr/>
        </p:nvSpPr>
        <p:spPr>
          <a:xfrm>
            <a:off x="2606760" y="632448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8" name="Group 38"/>
          <p:cNvGrpSpPr/>
          <p:nvPr/>
        </p:nvGrpSpPr>
        <p:grpSpPr>
          <a:xfrm>
            <a:off x="2606760" y="4430880"/>
            <a:ext cx="517320" cy="215640"/>
            <a:chOff x="2606760" y="4430880"/>
            <a:chExt cx="517320" cy="215640"/>
          </a:xfrm>
        </p:grpSpPr>
        <p:sp>
          <p:nvSpPr>
            <p:cNvPr id="429" name="Text Box 36"/>
            <p:cNvSpPr/>
            <p:nvPr/>
          </p:nvSpPr>
          <p:spPr>
            <a:xfrm>
              <a:off x="2671920" y="4430880"/>
              <a:ext cx="45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4AL-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Line 37"/>
            <p:cNvSpPr/>
            <p:nvPr/>
          </p:nvSpPr>
          <p:spPr>
            <a:xfrm>
              <a:off x="2606760" y="4533840"/>
              <a:ext cx="123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31" name="Text Box 39"/>
          <p:cNvSpPr/>
          <p:nvPr/>
        </p:nvSpPr>
        <p:spPr>
          <a:xfrm>
            <a:off x="2558160" y="4322880"/>
            <a:ext cx="1230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66-0.80 </a:t>
            </a:r>
            <a:r>
              <a:rPr b="0" i="1" lang="en-GB" sz="800" spc="-1" strike="noStrike">
                <a:solidFill>
                  <a:srgbClr val="0619ff"/>
                </a:solidFill>
                <a:latin typeface="Arial"/>
              </a:rPr>
              <a:t>ACCase,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Pr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Text Box 40"/>
          <p:cNvSpPr/>
          <p:nvPr/>
        </p:nvSpPr>
        <p:spPr>
          <a:xfrm>
            <a:off x="2559240" y="4951440"/>
            <a:ext cx="1296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9-0.66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ubisco-sbp-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Text Box 44"/>
          <p:cNvSpPr/>
          <p:nvPr/>
        </p:nvSpPr>
        <p:spPr>
          <a:xfrm>
            <a:off x="2667240" y="584208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Oval 20"/>
          <p:cNvSpPr/>
          <p:nvPr/>
        </p:nvSpPr>
        <p:spPr>
          <a:xfrm>
            <a:off x="209520" y="5867280"/>
            <a:ext cx="152280" cy="152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Text Box 46"/>
          <p:cNvSpPr/>
          <p:nvPr/>
        </p:nvSpPr>
        <p:spPr>
          <a:xfrm>
            <a:off x="2559600" y="3046320"/>
            <a:ext cx="32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a04fc"/>
                </a:solidFill>
                <a:latin typeface="Arial"/>
              </a:rPr>
              <a:t>Pl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Line 48"/>
          <p:cNvSpPr/>
          <p:nvPr/>
        </p:nvSpPr>
        <p:spPr>
          <a:xfrm>
            <a:off x="2303640" y="594216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Line 51"/>
          <p:cNvSpPr/>
          <p:nvPr/>
        </p:nvSpPr>
        <p:spPr>
          <a:xfrm>
            <a:off x="2606760" y="55562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Rectangle 59"/>
          <p:cNvSpPr/>
          <p:nvPr/>
        </p:nvSpPr>
        <p:spPr>
          <a:xfrm>
            <a:off x="2559600" y="3543480"/>
            <a:ext cx="35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Text Box 61"/>
          <p:cNvSpPr/>
          <p:nvPr/>
        </p:nvSpPr>
        <p:spPr>
          <a:xfrm>
            <a:off x="3692160" y="6191280"/>
            <a:ext cx="688320" cy="30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t1,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bd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Text Box 63"/>
          <p:cNvSpPr/>
          <p:nvPr/>
        </p:nvSpPr>
        <p:spPr>
          <a:xfrm>
            <a:off x="2557080" y="6045120"/>
            <a:ext cx="144720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20S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s, </a:t>
            </a:r>
            <a:r>
              <a:rPr b="0" i="1" lang="en-GB" sz="800" spc="-1" strike="noStrike">
                <a:solidFill>
                  <a:srgbClr val="0a04fc"/>
                </a:solidFill>
                <a:latin typeface="Arial"/>
              </a:rPr>
              <a:t>O-ec 25.6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Line 100"/>
          <p:cNvSpPr/>
          <p:nvPr/>
        </p:nvSpPr>
        <p:spPr>
          <a:xfrm flipV="1">
            <a:off x="2622600" y="5846760"/>
            <a:ext cx="0" cy="192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2" name="Picture 2" descr=""/>
          <p:cNvPicPr/>
          <p:nvPr/>
        </p:nvPicPr>
        <p:blipFill>
          <a:blip r:embed="rId1"/>
          <a:stretch/>
        </p:blipFill>
        <p:spPr>
          <a:xfrm>
            <a:off x="3784680" y="2425680"/>
            <a:ext cx="2825640" cy="4643280"/>
          </a:xfrm>
          <a:prstGeom prst="rect">
            <a:avLst/>
          </a:prstGeom>
          <a:ln w="0">
            <a:noFill/>
          </a:ln>
        </p:spPr>
      </p:pic>
      <p:pic>
        <p:nvPicPr>
          <p:cNvPr id="443" name="Picture 39" descr="4B Screen shot 2013-01-09 at 00"/>
          <p:cNvPicPr/>
          <p:nvPr/>
        </p:nvPicPr>
        <p:blipFill>
          <a:blip r:embed="rId2"/>
          <a:stretch/>
        </p:blipFill>
        <p:spPr>
          <a:xfrm>
            <a:off x="268200" y="2540160"/>
            <a:ext cx="271440" cy="4572000"/>
          </a:xfrm>
          <a:prstGeom prst="rect">
            <a:avLst/>
          </a:prstGeom>
          <a:ln w="0">
            <a:noFill/>
          </a:ln>
        </p:spPr>
      </p:pic>
      <p:sp>
        <p:nvSpPr>
          <p:cNvPr id="444" name="AutoShape 3"/>
          <p:cNvSpPr/>
          <p:nvPr/>
        </p:nvSpPr>
        <p:spPr>
          <a:xfrm>
            <a:off x="2416320" y="5626080"/>
            <a:ext cx="152280" cy="139716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397160"/>
              <a:gd name="textAreaBottom" fmla="*/ 1379520 h 1397160"/>
            </a:gdLst>
            <a:ahLst/>
            <a:rect l="textAreaLeft" t="textAreaTop" r="textAreaRight" b="textAreaBottom"/>
            <a:pathLst>
              <a:path w="21600" h="197762">
                <a:moveTo>
                  <a:pt x="3600" y="0"/>
                </a:moveTo>
                <a:arcTo wR="3600" hR="3600" stAng="0" swAng="5400000"/>
                <a:lnTo>
                  <a:pt x="0" y="194162"/>
                </a:lnTo>
                <a:arcTo wR="3600" hR="3600" stAng="16200000" swAng="5400000"/>
                <a:lnTo>
                  <a:pt x="18000" y="197762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55c0a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AutoShape 7"/>
          <p:cNvSpPr/>
          <p:nvPr/>
        </p:nvSpPr>
        <p:spPr>
          <a:xfrm>
            <a:off x="2416320" y="2610000"/>
            <a:ext cx="152280" cy="13525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352520"/>
              <a:gd name="textAreaBottom" fmla="*/ 1334880 h 1352520"/>
            </a:gdLst>
            <a:ahLst/>
            <a:rect l="textAreaLeft" t="textAreaTop" r="textAreaRight" b="textAreaBottom"/>
            <a:pathLst>
              <a:path w="21600" h="191445">
                <a:moveTo>
                  <a:pt x="3600" y="0"/>
                </a:moveTo>
                <a:arcTo wR="3600" hR="3600" stAng="0" swAng="5400000"/>
                <a:lnTo>
                  <a:pt x="0" y="187845"/>
                </a:lnTo>
                <a:arcTo wR="3600" hR="3600" stAng="16200000" swAng="5400000"/>
                <a:lnTo>
                  <a:pt x="18000" y="191445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1d62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AutoShape 5"/>
          <p:cNvSpPr/>
          <p:nvPr/>
        </p:nvSpPr>
        <p:spPr>
          <a:xfrm>
            <a:off x="2416320" y="3962520"/>
            <a:ext cx="152280" cy="583920"/>
          </a:xfrm>
          <a:custGeom>
            <a:avLst/>
            <a:gdLst>
              <a:gd name="textAreaLeft" fmla="*/ 0 w 152280"/>
              <a:gd name="textAreaRight" fmla="*/ 152640 w 152280"/>
              <a:gd name="textAreaTop" fmla="*/ 0 h 583920"/>
              <a:gd name="textAreaBottom" fmla="*/ 584280 h 583920"/>
            </a:gdLst>
            <a:ahLst/>
            <a:rect l="textAreaLeft" t="textAreaTop" r="textAreaRight" b="textAreaBottom"/>
            <a:pathLst>
              <a:path w="21600" h="82681">
                <a:moveTo>
                  <a:pt x="0" y="0"/>
                </a:moveTo>
                <a:arcTo wR="0" hR="0" stAng="10800000" swAng="-5400000"/>
                <a:lnTo>
                  <a:pt x="0" y="82681"/>
                </a:lnTo>
                <a:arcTo wR="0" hR="0" stAng="16200000" swAng="-5400000"/>
                <a:lnTo>
                  <a:pt x="21600" y="82681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c176a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AutoShape 44"/>
          <p:cNvSpPr/>
          <p:nvPr/>
        </p:nvSpPr>
        <p:spPr>
          <a:xfrm>
            <a:off x="2417760" y="3892680"/>
            <a:ext cx="152280" cy="158760"/>
          </a:xfrm>
          <a:custGeom>
            <a:avLst/>
            <a:gdLst>
              <a:gd name="textAreaLeft" fmla="*/ 0 w 152280"/>
              <a:gd name="textAreaRight" fmla="*/ 152640 w 152280"/>
              <a:gd name="textAreaTop" fmla="*/ 0 h 158760"/>
              <a:gd name="textAreaBottom" fmla="*/ 159120 h 158760"/>
            </a:gdLst>
            <a:ahLst/>
            <a:rect l="textAreaLeft" t="textAreaTop" r="textAreaRight" b="textAreaBottom"/>
            <a:pathLst>
              <a:path w="21600" h="22517">
                <a:moveTo>
                  <a:pt x="0" y="0"/>
                </a:moveTo>
                <a:arcTo wR="0" hR="0" stAng="10800000" swAng="-5400000"/>
                <a:lnTo>
                  <a:pt x="0" y="22517"/>
                </a:lnTo>
                <a:arcTo wR="0" hR="0" stAng="16200000" swAng="-5400000"/>
                <a:lnTo>
                  <a:pt x="21600" y="22517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81cc7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AutoShape 43"/>
          <p:cNvSpPr/>
          <p:nvPr/>
        </p:nvSpPr>
        <p:spPr>
          <a:xfrm flipH="1">
            <a:off x="2419200" y="3365640"/>
            <a:ext cx="152640" cy="533160"/>
          </a:xfrm>
          <a:prstGeom prst="rtTriangle">
            <a:avLst/>
          </a:prstGeom>
          <a:solidFill>
            <a:srgbClr val="81cc7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AutoShape 8"/>
          <p:cNvSpPr/>
          <p:nvPr/>
        </p:nvSpPr>
        <p:spPr>
          <a:xfrm>
            <a:off x="2416320" y="5181480"/>
            <a:ext cx="152280" cy="457200"/>
          </a:xfrm>
          <a:custGeom>
            <a:avLst/>
            <a:gdLst>
              <a:gd name="textAreaLeft" fmla="*/ 0 w 152280"/>
              <a:gd name="textAreaRight" fmla="*/ 152640 w 152280"/>
              <a:gd name="textAreaTop" fmla="*/ 0 h 457200"/>
              <a:gd name="textAreaBottom" fmla="*/ 457560 h 457200"/>
            </a:gdLst>
            <a:ahLst/>
            <a:rect l="textAreaLeft" t="textAreaTop" r="textAreaRight" b="textAreaBottom"/>
            <a:pathLst>
              <a:path w="21600" h="64749">
                <a:moveTo>
                  <a:pt x="0" y="0"/>
                </a:moveTo>
                <a:arcTo wR="0" hR="0" stAng="10800000" swAng="-5400000"/>
                <a:lnTo>
                  <a:pt x="0" y="64749"/>
                </a:lnTo>
                <a:arcTo wR="0" hR="0" stAng="16200000" swAng="-5400000"/>
                <a:lnTo>
                  <a:pt x="21600" y="64749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AutoShape 9"/>
          <p:cNvSpPr/>
          <p:nvPr/>
        </p:nvSpPr>
        <p:spPr>
          <a:xfrm>
            <a:off x="2416320" y="4495680"/>
            <a:ext cx="152280" cy="533520"/>
          </a:xfrm>
          <a:custGeom>
            <a:avLst/>
            <a:gdLst>
              <a:gd name="textAreaLeft" fmla="*/ 0 w 152280"/>
              <a:gd name="textAreaRight" fmla="*/ 152640 w 152280"/>
              <a:gd name="textAreaTop" fmla="*/ 0 h 533520"/>
              <a:gd name="textAreaBottom" fmla="*/ 533880 h 533520"/>
            </a:gdLst>
            <a:ahLst/>
            <a:rect l="textAreaLeft" t="textAreaTop" r="textAreaRight" b="textAreaBottom"/>
            <a:pathLst>
              <a:path w="21600" h="75549">
                <a:moveTo>
                  <a:pt x="0" y="0"/>
                </a:moveTo>
                <a:arcTo wR="0" hR="0" stAng="10800000" swAng="-5400000"/>
                <a:lnTo>
                  <a:pt x="0" y="75549"/>
                </a:lnTo>
                <a:arcTo wR="0" hR="0" stAng="16200000" swAng="-5400000"/>
                <a:lnTo>
                  <a:pt x="21600" y="75549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ec262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AutoShape 10"/>
          <p:cNvSpPr/>
          <p:nvPr/>
        </p:nvSpPr>
        <p:spPr>
          <a:xfrm>
            <a:off x="2417760" y="4846680"/>
            <a:ext cx="152280" cy="836640"/>
          </a:xfrm>
          <a:custGeom>
            <a:avLst/>
            <a:gdLst>
              <a:gd name="textAreaLeft" fmla="*/ 0 w 152280"/>
              <a:gd name="textAreaRight" fmla="*/ 152640 w 152280"/>
              <a:gd name="textAreaTop" fmla="*/ 0 h 836640"/>
              <a:gd name="textAreaBottom" fmla="*/ 837000 h 836640"/>
            </a:gdLst>
            <a:ahLst/>
            <a:rect l="textAreaLeft" t="textAreaTop" r="textAreaRight" b="textAreaBottom"/>
            <a:pathLst>
              <a:path w="21600" h="118443">
                <a:moveTo>
                  <a:pt x="0" y="0"/>
                </a:moveTo>
                <a:arcTo wR="0" hR="0" stAng="10800000" swAng="-5400000"/>
                <a:lnTo>
                  <a:pt x="0" y="118443"/>
                </a:lnTo>
                <a:arcTo wR="0" hR="0" stAng="16200000" swAng="-5400000"/>
                <a:lnTo>
                  <a:pt x="21600" y="118443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e913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AutoShape 11"/>
          <p:cNvSpPr/>
          <p:nvPr/>
        </p:nvSpPr>
        <p:spPr>
          <a:xfrm>
            <a:off x="2416320" y="2616120"/>
            <a:ext cx="152280" cy="44071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4407120"/>
              <a:gd name="textAreaBottom" fmla="*/ 4389480 h 4407120"/>
            </a:gdLst>
            <a:ahLst/>
            <a:rect l="textAreaLeft" t="textAreaTop" r="textAreaRight" b="textAreaBottom"/>
            <a:pathLst>
              <a:path w="21600" h="623700">
                <a:moveTo>
                  <a:pt x="3600" y="0"/>
                </a:moveTo>
                <a:arcTo wR="3600" hR="3600" stAng="0" swAng="5400000"/>
                <a:lnTo>
                  <a:pt x="0" y="620100"/>
                </a:lnTo>
                <a:arcTo wR="3600" hR="3600" stAng="16200000" swAng="5400000"/>
                <a:lnTo>
                  <a:pt x="18000" y="623700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Text Box 12"/>
          <p:cNvSpPr/>
          <p:nvPr/>
        </p:nvSpPr>
        <p:spPr>
          <a:xfrm>
            <a:off x="2566440" y="321156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1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Text Box 13"/>
          <p:cNvSpPr/>
          <p:nvPr/>
        </p:nvSpPr>
        <p:spPr>
          <a:xfrm>
            <a:off x="2646000" y="394164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4BS-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Text Box 15"/>
          <p:cNvSpPr/>
          <p:nvPr/>
        </p:nvSpPr>
        <p:spPr>
          <a:xfrm>
            <a:off x="2562120" y="6208560"/>
            <a:ext cx="1198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6-1.00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ds, UpoII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Line 16"/>
          <p:cNvSpPr/>
          <p:nvPr/>
        </p:nvSpPr>
        <p:spPr>
          <a:xfrm>
            <a:off x="2581200" y="40449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Text Box 19"/>
          <p:cNvSpPr/>
          <p:nvPr/>
        </p:nvSpPr>
        <p:spPr>
          <a:xfrm>
            <a:off x="14364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4B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Text Box 20"/>
          <p:cNvSpPr/>
          <p:nvPr/>
        </p:nvSpPr>
        <p:spPr>
          <a:xfrm>
            <a:off x="220968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4B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Text Box 21"/>
          <p:cNvSpPr/>
          <p:nvPr/>
        </p:nvSpPr>
        <p:spPr>
          <a:xfrm>
            <a:off x="401724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4B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0" name="Picture 22" descr="Chrom blank Screen shot 2013-01-07 at 10"/>
          <p:cNvPicPr/>
          <p:nvPr/>
        </p:nvPicPr>
        <p:blipFill>
          <a:blip r:embed="rId3">
            <a:lum contrast="-2000"/>
          </a:blip>
          <a:srcRect l="0" t="0" r="7663" b="0"/>
          <a:stretch/>
        </p:blipFill>
        <p:spPr>
          <a:xfrm>
            <a:off x="299880" y="4836960"/>
            <a:ext cx="174960" cy="309600"/>
          </a:xfrm>
          <a:prstGeom prst="rect">
            <a:avLst/>
          </a:prstGeom>
          <a:ln w="0">
            <a:noFill/>
          </a:ln>
        </p:spPr>
      </p:pic>
      <p:sp>
        <p:nvSpPr>
          <p:cNvPr id="461" name="Text Box 23"/>
          <p:cNvSpPr/>
          <p:nvPr/>
        </p:nvSpPr>
        <p:spPr>
          <a:xfrm>
            <a:off x="2645640" y="5586480"/>
            <a:ext cx="781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4BL-1, 4BL-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Line 24"/>
          <p:cNvSpPr/>
          <p:nvPr/>
        </p:nvSpPr>
        <p:spPr>
          <a:xfrm>
            <a:off x="290520" y="4924440"/>
            <a:ext cx="19368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Line 25"/>
          <p:cNvSpPr/>
          <p:nvPr/>
        </p:nvSpPr>
        <p:spPr>
          <a:xfrm>
            <a:off x="297000" y="5095800"/>
            <a:ext cx="190440" cy="0"/>
          </a:xfrm>
          <a:prstGeom prst="line">
            <a:avLst/>
          </a:prstGeom>
          <a:ln w="176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Line 28"/>
          <p:cNvSpPr/>
          <p:nvPr/>
        </p:nvSpPr>
        <p:spPr>
          <a:xfrm>
            <a:off x="2581200" y="568332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Text Box 30"/>
          <p:cNvSpPr/>
          <p:nvPr/>
        </p:nvSpPr>
        <p:spPr>
          <a:xfrm>
            <a:off x="2646360" y="474336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Text Box 32"/>
          <p:cNvSpPr/>
          <p:nvPr/>
        </p:nvSpPr>
        <p:spPr>
          <a:xfrm>
            <a:off x="2566800" y="457056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37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Text Box 33"/>
          <p:cNvSpPr/>
          <p:nvPr/>
        </p:nvSpPr>
        <p:spPr>
          <a:xfrm>
            <a:off x="2567520" y="5160960"/>
            <a:ext cx="54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71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Oval 35"/>
          <p:cNvSpPr/>
          <p:nvPr/>
        </p:nvSpPr>
        <p:spPr>
          <a:xfrm>
            <a:off x="312840" y="4781520"/>
            <a:ext cx="15228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Line 40"/>
          <p:cNvSpPr/>
          <p:nvPr/>
        </p:nvSpPr>
        <p:spPr>
          <a:xfrm>
            <a:off x="297000" y="4965840"/>
            <a:ext cx="190440" cy="0"/>
          </a:xfrm>
          <a:prstGeom prst="line">
            <a:avLst/>
          </a:prstGeom>
          <a:ln w="176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Text Box 41"/>
          <p:cNvSpPr/>
          <p:nvPr/>
        </p:nvSpPr>
        <p:spPr>
          <a:xfrm>
            <a:off x="454680" y="2565360"/>
            <a:ext cx="1835640" cy="442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6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mwg634.1 (0.81-1.00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046-4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4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5519-4B (0.57-1.00h), wPt-9393 (0.57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a9335"/>
                </a:solidFill>
                <a:latin typeface="Arial"/>
              </a:rPr>
              <a:t>Blt801 (0.57-0.81e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163 (0.37-0.57i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Rht-B1(Gai1) (C-0.37S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2p64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30b (C-0.71Lj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374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513 (C-0.71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65a (C-0.71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49 (C-0.71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3038-4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63 (C-0.71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60 (C-0.71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6a (0.86-1.00ah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32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391-4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917-4B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75.4 (0.86-1.00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5p64.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dupw043</a:t>
            </a:r>
            <a:r>
              <a:rPr b="0" lang="en-US" sz="600" spc="-1" strike="noStrike">
                <a:solidFill>
                  <a:srgbClr val="fe9138"/>
                </a:solidFill>
                <a:latin typeface="Arial"/>
              </a:rPr>
              <a:t>(CytP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Line 45"/>
          <p:cNvSpPr/>
          <p:nvPr/>
        </p:nvSpPr>
        <p:spPr>
          <a:xfrm>
            <a:off x="2595600" y="36194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Line 46"/>
          <p:cNvSpPr/>
          <p:nvPr/>
        </p:nvSpPr>
        <p:spPr>
          <a:xfrm flipV="1">
            <a:off x="2597040" y="3378240"/>
            <a:ext cx="0" cy="4824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Text Box 47"/>
          <p:cNvSpPr/>
          <p:nvPr/>
        </p:nvSpPr>
        <p:spPr>
          <a:xfrm>
            <a:off x="2653920" y="351000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4BS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Text Box 49"/>
          <p:cNvSpPr/>
          <p:nvPr/>
        </p:nvSpPr>
        <p:spPr>
          <a:xfrm>
            <a:off x="2566440" y="3726000"/>
            <a:ext cx="1146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7-0.81 </a:t>
            </a:r>
            <a:r>
              <a:rPr b="0" i="1" lang="en-GB" sz="800" spc="-1" strike="noStrike">
                <a:solidFill>
                  <a:srgbClr val="0a04fc"/>
                </a:solidFill>
                <a:latin typeface="Arial"/>
              </a:rPr>
              <a:t>Cab(CP2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Text Box 55"/>
          <p:cNvSpPr/>
          <p:nvPr/>
        </p:nvSpPr>
        <p:spPr>
          <a:xfrm>
            <a:off x="2962800" y="5133960"/>
            <a:ext cx="81000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a04fc"/>
                </a:solidFill>
                <a:latin typeface="Arial"/>
              </a:rPr>
              <a:t>O-ec 25.6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t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Line 56"/>
          <p:cNvSpPr/>
          <p:nvPr/>
        </p:nvSpPr>
        <p:spPr>
          <a:xfrm>
            <a:off x="2278080" y="485136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Text Box 57"/>
          <p:cNvSpPr/>
          <p:nvPr/>
        </p:nvSpPr>
        <p:spPr>
          <a:xfrm>
            <a:off x="2564640" y="6811920"/>
            <a:ext cx="40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c0000"/>
                </a:solidFill>
                <a:latin typeface="Arial"/>
              </a:rPr>
              <a:t>Cy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Text Box 61"/>
          <p:cNvSpPr/>
          <p:nvPr/>
        </p:nvSpPr>
        <p:spPr>
          <a:xfrm>
            <a:off x="2640960" y="4392720"/>
            <a:ext cx="656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4BS-4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Hd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Line 62"/>
          <p:cNvSpPr/>
          <p:nvPr/>
        </p:nvSpPr>
        <p:spPr>
          <a:xfrm>
            <a:off x="2589120" y="44895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Text Box 63"/>
          <p:cNvSpPr/>
          <p:nvPr/>
        </p:nvSpPr>
        <p:spPr>
          <a:xfrm>
            <a:off x="2563560" y="4167360"/>
            <a:ext cx="986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37-0.57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caA/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Line 69"/>
          <p:cNvSpPr/>
          <p:nvPr/>
        </p:nvSpPr>
        <p:spPr>
          <a:xfrm>
            <a:off x="5241960" y="2629080"/>
            <a:ext cx="0" cy="427968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Text Box 71"/>
          <p:cNvSpPr/>
          <p:nvPr/>
        </p:nvSpPr>
        <p:spPr>
          <a:xfrm>
            <a:off x="2564280" y="4930920"/>
            <a:ext cx="35748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3" name="Group 124"/>
          <p:cNvGrpSpPr/>
          <p:nvPr/>
        </p:nvGrpSpPr>
        <p:grpSpPr>
          <a:xfrm>
            <a:off x="5651640" y="4991040"/>
            <a:ext cx="1155600" cy="1510200"/>
            <a:chOff x="5651640" y="4991040"/>
            <a:chExt cx="1155600" cy="1510200"/>
          </a:xfrm>
        </p:grpSpPr>
        <p:sp>
          <p:nvSpPr>
            <p:cNvPr id="484" name="pole tekstowe 4"/>
            <p:cNvSpPr/>
            <p:nvPr/>
          </p:nvSpPr>
          <p:spPr>
            <a:xfrm>
              <a:off x="5997600" y="4991040"/>
              <a:ext cx="809640" cy="151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Chl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+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SPA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SPA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Ca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Ca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DWP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DW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DWP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9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5" name="Picture 2" descr=""/>
            <p:cNvPicPr/>
            <p:nvPr/>
          </p:nvPicPr>
          <p:blipFill>
            <a:blip r:embed="rId4"/>
            <a:srcRect l="81422" t="1938" r="9289" b="55762"/>
            <a:stretch/>
          </p:blipFill>
          <p:spPr>
            <a:xfrm>
              <a:off x="5651640" y="5013360"/>
              <a:ext cx="441360" cy="14540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6" name="Group 105"/>
          <p:cNvGrpSpPr/>
          <p:nvPr/>
        </p:nvGrpSpPr>
        <p:grpSpPr>
          <a:xfrm>
            <a:off x="3719520" y="3138480"/>
            <a:ext cx="2825280" cy="3887640"/>
            <a:chOff x="3719520" y="3138480"/>
            <a:chExt cx="2825280" cy="3887640"/>
          </a:xfrm>
        </p:grpSpPr>
        <p:pic>
          <p:nvPicPr>
            <p:cNvPr id="487" name="Picture 3" descr=""/>
            <p:cNvPicPr/>
            <p:nvPr/>
          </p:nvPicPr>
          <p:blipFill>
            <a:blip r:embed="rId1"/>
            <a:srcRect l="-338" t="0" r="0" b="7268"/>
            <a:stretch/>
          </p:blipFill>
          <p:spPr>
            <a:xfrm rot="5400000">
              <a:off x="3623760" y="4064040"/>
              <a:ext cx="3846600" cy="1995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8" name="Picture 3" descr=""/>
            <p:cNvPicPr/>
            <p:nvPr/>
          </p:nvPicPr>
          <p:blipFill>
            <a:blip r:embed="rId2"/>
            <a:srcRect l="136" t="67512" r="17345" b="-2349"/>
            <a:stretch/>
          </p:blipFill>
          <p:spPr>
            <a:xfrm rot="5400000">
              <a:off x="2223000" y="4645800"/>
              <a:ext cx="3876480" cy="88416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489" name="Picture 42" descr="4D Screen shot 2013-01-09 at 10"/>
          <p:cNvPicPr/>
          <p:nvPr/>
        </p:nvPicPr>
        <p:blipFill>
          <a:blip r:embed="rId3"/>
          <a:srcRect l="19776" t="0" r="26368" b="0"/>
          <a:stretch/>
        </p:blipFill>
        <p:spPr>
          <a:xfrm>
            <a:off x="330120" y="2498760"/>
            <a:ext cx="138240" cy="4511520"/>
          </a:xfrm>
          <a:prstGeom prst="rect">
            <a:avLst/>
          </a:prstGeom>
          <a:ln w="0">
            <a:noFill/>
          </a:ln>
        </p:spPr>
      </p:pic>
      <p:sp>
        <p:nvSpPr>
          <p:cNvPr id="490" name="AutoShape 3"/>
          <p:cNvSpPr/>
          <p:nvPr/>
        </p:nvSpPr>
        <p:spPr>
          <a:xfrm>
            <a:off x="2443320" y="5715000"/>
            <a:ext cx="152280" cy="121608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216080"/>
              <a:gd name="textAreaBottom" fmla="*/ 1198440 h 1216080"/>
            </a:gdLst>
            <a:ahLst/>
            <a:rect l="textAreaLeft" t="textAreaTop" r="textAreaRight" b="textAreaBottom"/>
            <a:pathLst>
              <a:path w="21600" h="172138">
                <a:moveTo>
                  <a:pt x="3600" y="0"/>
                </a:moveTo>
                <a:arcTo wR="3600" hR="3600" stAng="0" swAng="5400000"/>
                <a:lnTo>
                  <a:pt x="0" y="168538"/>
                </a:lnTo>
                <a:arcTo wR="3600" hR="3600" stAng="16200000" swAng="5400000"/>
                <a:lnTo>
                  <a:pt x="18000" y="172138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ac6c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AutoShape 4"/>
          <p:cNvSpPr/>
          <p:nvPr/>
        </p:nvSpPr>
        <p:spPr>
          <a:xfrm>
            <a:off x="2446200" y="3117960"/>
            <a:ext cx="152640" cy="1434960"/>
          </a:xfrm>
          <a:custGeom>
            <a:avLst/>
            <a:gdLst>
              <a:gd name="textAreaLeft" fmla="*/ 0 w 152640"/>
              <a:gd name="textAreaRight" fmla="*/ 153000 w 152640"/>
              <a:gd name="textAreaTop" fmla="*/ 0 h 1434960"/>
              <a:gd name="textAreaBottom" fmla="*/ 1435320 h 1434960"/>
            </a:gdLst>
            <a:ahLst/>
            <a:rect l="textAreaLeft" t="textAreaTop" r="textAreaRight" b="textAreaBottom"/>
            <a:pathLst>
              <a:path w="21600" h="202633">
                <a:moveTo>
                  <a:pt x="0" y="0"/>
                </a:moveTo>
                <a:arcTo wR="0" hR="0" stAng="10800000" swAng="-5400000"/>
                <a:lnTo>
                  <a:pt x="0" y="202633"/>
                </a:lnTo>
                <a:arcTo wR="0" hR="0" stAng="16200000" swAng="-5400000"/>
                <a:lnTo>
                  <a:pt x="21600" y="202633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3233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AutoShape 5"/>
          <p:cNvSpPr/>
          <p:nvPr/>
        </p:nvSpPr>
        <p:spPr>
          <a:xfrm>
            <a:off x="2444760" y="4692600"/>
            <a:ext cx="152280" cy="1060560"/>
          </a:xfrm>
          <a:custGeom>
            <a:avLst/>
            <a:gdLst>
              <a:gd name="textAreaLeft" fmla="*/ 0 w 152280"/>
              <a:gd name="textAreaRight" fmla="*/ 152640 w 152280"/>
              <a:gd name="textAreaTop" fmla="*/ 0 h 1060560"/>
              <a:gd name="textAreaBottom" fmla="*/ 1060560 h 1060560"/>
            </a:gdLst>
            <a:ahLst/>
            <a:rect l="textAreaLeft" t="textAreaTop" r="textAreaRight" b="textAreaBottom"/>
            <a:pathLst>
              <a:path w="21600" h="150130">
                <a:moveTo>
                  <a:pt x="0" y="0"/>
                </a:moveTo>
                <a:arcTo wR="0" hR="0" stAng="10800000" swAng="-5400000"/>
                <a:lnTo>
                  <a:pt x="0" y="150130"/>
                </a:lnTo>
                <a:arcTo wR="0" hR="0" stAng="16200000" swAng="-5400000"/>
                <a:lnTo>
                  <a:pt x="21600" y="150130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9a69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AutoShape 50"/>
          <p:cNvSpPr/>
          <p:nvPr/>
        </p:nvSpPr>
        <p:spPr>
          <a:xfrm>
            <a:off x="2438280" y="5524560"/>
            <a:ext cx="152640" cy="444600"/>
          </a:xfrm>
          <a:custGeom>
            <a:avLst/>
            <a:gdLst>
              <a:gd name="textAreaLeft" fmla="*/ 0 w 152640"/>
              <a:gd name="textAreaRight" fmla="*/ 153000 w 152640"/>
              <a:gd name="textAreaTop" fmla="*/ 0 h 444600"/>
              <a:gd name="textAreaBottom" fmla="*/ 444960 h 444600"/>
            </a:gdLst>
            <a:ahLst/>
            <a:rect l="textAreaLeft" t="textAreaTop" r="textAreaRight" b="textAreaBottom"/>
            <a:pathLst>
              <a:path w="21600" h="62818">
                <a:moveTo>
                  <a:pt x="0" y="0"/>
                </a:moveTo>
                <a:arcTo wR="0" hR="0" stAng="10800000" swAng="-5400000"/>
                <a:lnTo>
                  <a:pt x="0" y="62818"/>
                </a:lnTo>
                <a:arcTo wR="0" hR="0" stAng="16200000" swAng="-5400000"/>
                <a:lnTo>
                  <a:pt x="21600" y="6281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AutoShape 7"/>
          <p:cNvSpPr/>
          <p:nvPr/>
        </p:nvSpPr>
        <p:spPr>
          <a:xfrm>
            <a:off x="2443320" y="2666880"/>
            <a:ext cx="152280" cy="444600"/>
          </a:xfrm>
          <a:custGeom>
            <a:avLst/>
            <a:gdLst>
              <a:gd name="textAreaLeft" fmla="*/ 0 w 152280"/>
              <a:gd name="textAreaRight" fmla="*/ 152640 w 152280"/>
              <a:gd name="textAreaTop" fmla="*/ 0 h 444600"/>
              <a:gd name="textAreaBottom" fmla="*/ 444600 h 444600"/>
            </a:gdLst>
            <a:ahLst/>
            <a:rect l="textAreaLeft" t="textAreaTop" r="textAreaRight" b="textAreaBottom"/>
            <a:pathLst>
              <a:path w="21600" h="62966">
                <a:moveTo>
                  <a:pt x="0" y="0"/>
                </a:moveTo>
                <a:arcTo wR="0" hR="0" stAng="10800000" swAng="-5400000"/>
                <a:lnTo>
                  <a:pt x="0" y="62966"/>
                </a:lnTo>
                <a:arcTo wR="0" hR="0" stAng="16200000" swAng="-5400000"/>
                <a:lnTo>
                  <a:pt x="21600" y="62966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AutoShape 10"/>
          <p:cNvSpPr/>
          <p:nvPr/>
        </p:nvSpPr>
        <p:spPr>
          <a:xfrm>
            <a:off x="2444760" y="4336920"/>
            <a:ext cx="152280" cy="400320"/>
          </a:xfrm>
          <a:custGeom>
            <a:avLst/>
            <a:gdLst>
              <a:gd name="textAreaLeft" fmla="*/ 0 w 152280"/>
              <a:gd name="textAreaRight" fmla="*/ 152640 w 152280"/>
              <a:gd name="textAreaTop" fmla="*/ 0 h 400320"/>
              <a:gd name="textAreaBottom" fmla="*/ 400680 h 400320"/>
            </a:gdLst>
            <a:ahLst/>
            <a:rect l="textAreaLeft" t="textAreaTop" r="textAreaRight" b="textAreaBottom"/>
            <a:pathLst>
              <a:path w="21600" h="56700">
                <a:moveTo>
                  <a:pt x="0" y="0"/>
                </a:moveTo>
                <a:arcTo wR="0" hR="0" stAng="10800000" swAng="-5400000"/>
                <a:lnTo>
                  <a:pt x="0" y="56700"/>
                </a:lnTo>
                <a:arcTo wR="0" hR="0" stAng="16200000" swAng="-5400000"/>
                <a:lnTo>
                  <a:pt x="21600" y="56700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e913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AutoShape 11"/>
          <p:cNvSpPr/>
          <p:nvPr/>
        </p:nvSpPr>
        <p:spPr>
          <a:xfrm>
            <a:off x="2443320" y="2616120"/>
            <a:ext cx="152280" cy="43117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4311720"/>
              <a:gd name="textAreaBottom" fmla="*/ 4294080 h 4311720"/>
            </a:gdLst>
            <a:ahLst/>
            <a:rect l="textAreaLeft" t="textAreaTop" r="textAreaRight" b="textAreaBottom"/>
            <a:pathLst>
              <a:path w="21600" h="610200">
                <a:moveTo>
                  <a:pt x="3600" y="0"/>
                </a:moveTo>
                <a:arcTo wR="3600" hR="3600" stAng="0" swAng="5400000"/>
                <a:lnTo>
                  <a:pt x="0" y="606600"/>
                </a:lnTo>
                <a:arcTo wR="3600" hR="3600" stAng="16200000" swAng="5400000"/>
                <a:lnTo>
                  <a:pt x="18000" y="610200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Text Box 14"/>
          <p:cNvSpPr/>
          <p:nvPr/>
        </p:nvSpPr>
        <p:spPr>
          <a:xfrm>
            <a:off x="2590560" y="6316560"/>
            <a:ext cx="964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1-1.00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UpoII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Text Box 16"/>
          <p:cNvSpPr/>
          <p:nvPr/>
        </p:nvSpPr>
        <p:spPr>
          <a:xfrm>
            <a:off x="140400" y="201132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4D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Text Box 17"/>
          <p:cNvSpPr/>
          <p:nvPr/>
        </p:nvSpPr>
        <p:spPr>
          <a:xfrm>
            <a:off x="2233440" y="2011320"/>
            <a:ext cx="12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4D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Text Box 18"/>
          <p:cNvSpPr/>
          <p:nvPr/>
        </p:nvSpPr>
        <p:spPr>
          <a:xfrm>
            <a:off x="4014000" y="2011320"/>
            <a:ext cx="216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4D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Text Box 20"/>
          <p:cNvSpPr/>
          <p:nvPr/>
        </p:nvSpPr>
        <p:spPr>
          <a:xfrm>
            <a:off x="2678400" y="5649840"/>
            <a:ext cx="1108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4DL-13, 4DL-12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Text Box 25"/>
          <p:cNvSpPr/>
          <p:nvPr/>
        </p:nvSpPr>
        <p:spPr>
          <a:xfrm>
            <a:off x="2673360" y="422928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Text Box 27"/>
          <p:cNvSpPr/>
          <p:nvPr/>
        </p:nvSpPr>
        <p:spPr>
          <a:xfrm>
            <a:off x="2593080" y="4430880"/>
            <a:ext cx="75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31L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b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Text Box 28"/>
          <p:cNvSpPr/>
          <p:nvPr/>
        </p:nvSpPr>
        <p:spPr>
          <a:xfrm>
            <a:off x="2593440" y="502128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31-0.5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Text Box 36"/>
          <p:cNvSpPr/>
          <p:nvPr/>
        </p:nvSpPr>
        <p:spPr>
          <a:xfrm>
            <a:off x="2591280" y="3630600"/>
            <a:ext cx="115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53S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caA/B,</a:t>
            </a: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Hd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Text Box 40"/>
          <p:cNvSpPr/>
          <p:nvPr/>
        </p:nvSpPr>
        <p:spPr>
          <a:xfrm>
            <a:off x="3047400" y="4991040"/>
            <a:ext cx="8679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a04fc"/>
                </a:solidFill>
                <a:latin typeface="Arial"/>
              </a:rPr>
              <a:t>O-ec 25.6kDa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SII-10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Text Box 41"/>
          <p:cNvSpPr/>
          <p:nvPr/>
        </p:nvSpPr>
        <p:spPr>
          <a:xfrm>
            <a:off x="457200" y="3260880"/>
            <a:ext cx="1447920" cy="365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103 (C-0.53Sk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809-4D, wPt-0431 (Cent l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a9335"/>
                </a:solidFill>
                <a:latin typeface="Arial"/>
              </a:rPr>
              <a:t>Blt101.t7 (0.31-0.56e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65b (C-0.31La), gwm19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9158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75.1 (0.71-1.00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609 (0.71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8" name="Picture 43" descr="4D Screen shot 2013-01-09 at 10"/>
          <p:cNvPicPr/>
          <p:nvPr/>
        </p:nvPicPr>
        <p:blipFill>
          <a:blip r:embed="rId4"/>
          <a:stretch/>
        </p:blipFill>
        <p:spPr>
          <a:xfrm>
            <a:off x="277920" y="3200400"/>
            <a:ext cx="257040" cy="3809880"/>
          </a:xfrm>
          <a:prstGeom prst="rect">
            <a:avLst/>
          </a:prstGeom>
          <a:ln w="0">
            <a:noFill/>
          </a:ln>
        </p:spPr>
      </p:pic>
      <p:pic>
        <p:nvPicPr>
          <p:cNvPr id="509" name="Picture 19" descr="Chrom blank Screen shot 2013-01-07 at 10"/>
          <p:cNvPicPr/>
          <p:nvPr/>
        </p:nvPicPr>
        <p:blipFill>
          <a:blip r:embed="rId5">
            <a:lum contrast="-2000"/>
          </a:blip>
          <a:srcRect l="0" t="0" r="7663" b="0"/>
          <a:stretch/>
        </p:blipFill>
        <p:spPr>
          <a:xfrm>
            <a:off x="318960" y="2654280"/>
            <a:ext cx="171720" cy="677880"/>
          </a:xfrm>
          <a:prstGeom prst="rect">
            <a:avLst/>
          </a:prstGeom>
          <a:ln w="0">
            <a:noFill/>
          </a:ln>
        </p:spPr>
      </p:pic>
      <p:pic>
        <p:nvPicPr>
          <p:cNvPr id="510" name="Picture 44" descr="Chrom blank Screen shot 2013-01-07 at 10"/>
          <p:cNvPicPr/>
          <p:nvPr/>
        </p:nvPicPr>
        <p:blipFill>
          <a:blip r:embed="rId6">
            <a:lum contrast="-2000"/>
          </a:blip>
          <a:srcRect l="0" t="0" r="7663" b="0"/>
          <a:stretch/>
        </p:blipFill>
        <p:spPr>
          <a:xfrm>
            <a:off x="318960" y="3360600"/>
            <a:ext cx="171720" cy="965160"/>
          </a:xfrm>
          <a:prstGeom prst="rect">
            <a:avLst/>
          </a:prstGeom>
          <a:ln w="0">
            <a:noFill/>
          </a:ln>
        </p:spPr>
      </p:pic>
      <p:sp>
        <p:nvSpPr>
          <p:cNvPr id="511" name="Line 45"/>
          <p:cNvSpPr/>
          <p:nvPr/>
        </p:nvSpPr>
        <p:spPr>
          <a:xfrm>
            <a:off x="2629080" y="2874960"/>
            <a:ext cx="123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Line 46"/>
          <p:cNvSpPr/>
          <p:nvPr/>
        </p:nvSpPr>
        <p:spPr>
          <a:xfrm flipV="1">
            <a:off x="2630520" y="2629080"/>
            <a:ext cx="0" cy="4824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Text Box 47"/>
          <p:cNvSpPr/>
          <p:nvPr/>
        </p:nvSpPr>
        <p:spPr>
          <a:xfrm>
            <a:off x="2679840" y="2773440"/>
            <a:ext cx="116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4DS-1, 4DS-3, 4DS-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Oval 29"/>
          <p:cNvSpPr/>
          <p:nvPr/>
        </p:nvSpPr>
        <p:spPr>
          <a:xfrm>
            <a:off x="330120" y="4267080"/>
            <a:ext cx="152640" cy="152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Line 51"/>
          <p:cNvSpPr/>
          <p:nvPr/>
        </p:nvSpPr>
        <p:spPr>
          <a:xfrm>
            <a:off x="2629080" y="5740560"/>
            <a:ext cx="123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Line 52"/>
          <p:cNvSpPr/>
          <p:nvPr/>
        </p:nvSpPr>
        <p:spPr>
          <a:xfrm flipV="1">
            <a:off x="2635200" y="5530680"/>
            <a:ext cx="0" cy="438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Text Box 53"/>
          <p:cNvSpPr/>
          <p:nvPr/>
        </p:nvSpPr>
        <p:spPr>
          <a:xfrm>
            <a:off x="2668680" y="4640400"/>
            <a:ext cx="45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4DL-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Line 54"/>
          <p:cNvSpPr/>
          <p:nvPr/>
        </p:nvSpPr>
        <p:spPr>
          <a:xfrm>
            <a:off x="2603520" y="47372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Line 55"/>
          <p:cNvSpPr/>
          <p:nvPr/>
        </p:nvSpPr>
        <p:spPr>
          <a:xfrm>
            <a:off x="2305080" y="433872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Line 62"/>
          <p:cNvSpPr/>
          <p:nvPr/>
        </p:nvSpPr>
        <p:spPr>
          <a:xfrm>
            <a:off x="5114880" y="3321000"/>
            <a:ext cx="0" cy="352440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Text Box 63"/>
          <p:cNvSpPr/>
          <p:nvPr/>
        </p:nvSpPr>
        <p:spPr>
          <a:xfrm>
            <a:off x="2591640" y="5878440"/>
            <a:ext cx="40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Cyt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2" name="Group 106"/>
          <p:cNvGrpSpPr/>
          <p:nvPr/>
        </p:nvGrpSpPr>
        <p:grpSpPr>
          <a:xfrm>
            <a:off x="5435640" y="5396040"/>
            <a:ext cx="1193760" cy="946440"/>
            <a:chOff x="5435640" y="5396040"/>
            <a:chExt cx="1193760" cy="946440"/>
          </a:xfrm>
        </p:grpSpPr>
        <p:sp>
          <p:nvSpPr>
            <p:cNvPr id="523" name="pole tekstowe 4"/>
            <p:cNvSpPr/>
            <p:nvPr/>
          </p:nvSpPr>
          <p:spPr>
            <a:xfrm>
              <a:off x="5759280" y="5396040"/>
              <a:ext cx="870120" cy="94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SPA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Ca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Y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GW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RC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4" name="Picture 3" descr=""/>
            <p:cNvPicPr/>
            <p:nvPr/>
          </p:nvPicPr>
          <p:blipFill>
            <a:blip r:embed="rId7"/>
            <a:srcRect l="81417" t="1803" r="9523" b="74043"/>
            <a:stretch/>
          </p:blipFill>
          <p:spPr>
            <a:xfrm>
              <a:off x="5435640" y="5419800"/>
              <a:ext cx="419040" cy="8636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25" name="Text Box 117"/>
          <p:cNvSpPr/>
          <p:nvPr/>
        </p:nvSpPr>
        <p:spPr>
          <a:xfrm>
            <a:off x="2593800" y="4862520"/>
            <a:ext cx="39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t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6" name="Picture 2" descr=""/>
          <p:cNvPicPr/>
          <p:nvPr/>
        </p:nvPicPr>
        <p:blipFill>
          <a:blip r:embed="rId1"/>
          <a:stretch/>
        </p:blipFill>
        <p:spPr>
          <a:xfrm>
            <a:off x="3905280" y="2413080"/>
            <a:ext cx="2762280" cy="4790880"/>
          </a:xfrm>
          <a:prstGeom prst="rect">
            <a:avLst/>
          </a:prstGeom>
          <a:ln w="0">
            <a:noFill/>
          </a:ln>
        </p:spPr>
      </p:pic>
      <p:sp>
        <p:nvSpPr>
          <p:cNvPr id="527" name="AutoShape 45"/>
          <p:cNvSpPr/>
          <p:nvPr/>
        </p:nvSpPr>
        <p:spPr>
          <a:xfrm>
            <a:off x="2579760" y="2616120"/>
            <a:ext cx="149040" cy="152640"/>
          </a:xfrm>
          <a:custGeom>
            <a:avLst/>
            <a:gdLst>
              <a:gd name="textAreaLeft" fmla="*/ 17280 w 149040"/>
              <a:gd name="textAreaRight" fmla="*/ 131760 w 149040"/>
              <a:gd name="textAreaTop" fmla="*/ 17280 h 152640"/>
              <a:gd name="textAreaBottom" fmla="*/ 135360 h 152640"/>
            </a:gdLst>
            <a:ahLst/>
            <a:rect l="textAreaLeft" t="textAreaTop" r="textAreaRight" b="textAreaBottom"/>
            <a:pathLst>
              <a:path w="21600" h="22120">
                <a:moveTo>
                  <a:pt x="3600" y="0"/>
                </a:moveTo>
                <a:arcTo wR="3600" hR="3600" stAng="0" swAng="5400000"/>
                <a:lnTo>
                  <a:pt x="0" y="18520"/>
                </a:lnTo>
                <a:arcTo wR="3600" hR="3600" stAng="16200000" swAng="5400000"/>
                <a:lnTo>
                  <a:pt x="18000" y="22120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436cb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AutoShape 7"/>
          <p:cNvSpPr/>
          <p:nvPr/>
        </p:nvSpPr>
        <p:spPr>
          <a:xfrm>
            <a:off x="2577960" y="2654280"/>
            <a:ext cx="152640" cy="927000"/>
          </a:xfrm>
          <a:custGeom>
            <a:avLst/>
            <a:gdLst>
              <a:gd name="textAreaLeft" fmla="*/ 3240 w 152640"/>
              <a:gd name="textAreaRight" fmla="*/ 149400 w 152640"/>
              <a:gd name="textAreaTop" fmla="*/ 3240 h 927000"/>
              <a:gd name="textAreaBottom" fmla="*/ 923760 h 927000"/>
            </a:gdLst>
            <a:ahLst/>
            <a:rect l="textAreaLeft" t="textAreaTop" r="textAreaRight" b="textAreaBottom"/>
            <a:pathLst>
              <a:path w="21600" h="130921">
                <a:moveTo>
                  <a:pt x="675" y="0"/>
                </a:moveTo>
                <a:arcTo wR="675" hR="675" stAng="0" swAng="5400000"/>
                <a:lnTo>
                  <a:pt x="0" y="130246"/>
                </a:lnTo>
                <a:arcTo wR="675" hR="675" stAng="16200000" swAng="5400000"/>
                <a:lnTo>
                  <a:pt x="20925" y="130921"/>
                </a:lnTo>
                <a:arcTo wR="675" hR="675" stAng="10800000" swAng="5400000"/>
                <a:lnTo>
                  <a:pt x="21600" y="675"/>
                </a:lnTo>
                <a:arcTo wR="675" hR="675" stAng="5400000" swAng="5400000"/>
                <a:close/>
              </a:path>
            </a:pathLst>
          </a:custGeom>
          <a:solidFill>
            <a:srgbClr val="84cc7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9" name="Picture 34" descr="5A Screen shot 2013-01-09 at 13"/>
          <p:cNvPicPr/>
          <p:nvPr/>
        </p:nvPicPr>
        <p:blipFill>
          <a:blip r:embed="rId2"/>
          <a:stretch/>
        </p:blipFill>
        <p:spPr>
          <a:xfrm>
            <a:off x="114480" y="2590920"/>
            <a:ext cx="244440" cy="4522680"/>
          </a:xfrm>
          <a:prstGeom prst="rect">
            <a:avLst/>
          </a:prstGeom>
          <a:ln w="0">
            <a:noFill/>
          </a:ln>
        </p:spPr>
      </p:pic>
      <p:sp>
        <p:nvSpPr>
          <p:cNvPr id="530" name="AutoShape 3"/>
          <p:cNvSpPr/>
          <p:nvPr/>
        </p:nvSpPr>
        <p:spPr>
          <a:xfrm>
            <a:off x="2577960" y="5884920"/>
            <a:ext cx="152640" cy="121608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1216080"/>
              <a:gd name="textAreaBottom" fmla="*/ 1198080 h 1216080"/>
            </a:gdLst>
            <a:ahLst/>
            <a:rect l="textAreaLeft" t="textAreaTop" r="textAreaRight" b="textAreaBottom"/>
            <a:pathLst>
              <a:path w="21600" h="171733">
                <a:moveTo>
                  <a:pt x="3600" y="0"/>
                </a:moveTo>
                <a:arcTo wR="3600" hR="3600" stAng="0" swAng="5400000"/>
                <a:lnTo>
                  <a:pt x="0" y="168133"/>
                </a:lnTo>
                <a:arcTo wR="3600" hR="3600" stAng="16200000" swAng="5400000"/>
                <a:lnTo>
                  <a:pt x="18000" y="171733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ac6c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AutoShape 55"/>
          <p:cNvSpPr/>
          <p:nvPr/>
        </p:nvSpPr>
        <p:spPr>
          <a:xfrm>
            <a:off x="2577960" y="5715000"/>
            <a:ext cx="152640" cy="457200"/>
          </a:xfrm>
          <a:custGeom>
            <a:avLst/>
            <a:gdLst>
              <a:gd name="textAreaLeft" fmla="*/ 0 w 152640"/>
              <a:gd name="textAreaRight" fmla="*/ 153000 w 152640"/>
              <a:gd name="textAreaTop" fmla="*/ 0 h 457200"/>
              <a:gd name="textAreaBottom" fmla="*/ 457560 h 457200"/>
            </a:gdLst>
            <a:ahLst/>
            <a:rect l="textAreaLeft" t="textAreaTop" r="textAreaRight" b="textAreaBottom"/>
            <a:pathLst>
              <a:path w="21600" h="64597">
                <a:moveTo>
                  <a:pt x="0" y="0"/>
                </a:moveTo>
                <a:arcTo wR="0" hR="0" stAng="10800000" swAng="-5400000"/>
                <a:lnTo>
                  <a:pt x="0" y="64597"/>
                </a:lnTo>
                <a:arcTo wR="0" hR="0" stAng="16200000" swAng="-5400000"/>
                <a:lnTo>
                  <a:pt x="21600" y="64597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AutoShape 4"/>
          <p:cNvSpPr/>
          <p:nvPr/>
        </p:nvSpPr>
        <p:spPr>
          <a:xfrm>
            <a:off x="2581200" y="3519360"/>
            <a:ext cx="152640" cy="112680"/>
          </a:xfrm>
          <a:custGeom>
            <a:avLst/>
            <a:gdLst>
              <a:gd name="textAreaLeft" fmla="*/ 0 w 152640"/>
              <a:gd name="textAreaRight" fmla="*/ 153000 w 152640"/>
              <a:gd name="textAreaTop" fmla="*/ 0 h 112680"/>
              <a:gd name="textAreaBottom" fmla="*/ 113040 h 112680"/>
            </a:gdLst>
            <a:ahLst/>
            <a:rect l="textAreaLeft" t="textAreaTop" r="textAreaRight" b="textAreaBottom"/>
            <a:pathLst>
              <a:path w="29236" h="21600">
                <a:moveTo>
                  <a:pt x="0" y="0"/>
                </a:moveTo>
                <a:arcTo wR="0" hR="0" stAng="10800000" swAng="-5400000"/>
                <a:lnTo>
                  <a:pt x="0" y="21600"/>
                </a:lnTo>
                <a:arcTo wR="0" hR="0" stAng="16200000" swAng="-5400000"/>
                <a:lnTo>
                  <a:pt x="29236" y="21600"/>
                </a:lnTo>
                <a:arcTo wR="0" hR="0" stAng="10800000" swAng="-5400000"/>
                <a:lnTo>
                  <a:pt x="29236" y="0"/>
                </a:lnTo>
                <a:arcTo wR="0" hR="0" stAng="16200000" swAng="-5400000"/>
                <a:close/>
              </a:path>
            </a:pathLst>
          </a:custGeom>
          <a:solidFill>
            <a:srgbClr val="ec323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AutoShape 5"/>
          <p:cNvSpPr/>
          <p:nvPr/>
        </p:nvSpPr>
        <p:spPr>
          <a:xfrm>
            <a:off x="2579760" y="3714840"/>
            <a:ext cx="152280" cy="387360"/>
          </a:xfrm>
          <a:custGeom>
            <a:avLst/>
            <a:gdLst>
              <a:gd name="textAreaLeft" fmla="*/ 0 w 152280"/>
              <a:gd name="textAreaRight" fmla="*/ 152640 w 152280"/>
              <a:gd name="textAreaTop" fmla="*/ 0 h 387360"/>
              <a:gd name="textAreaBottom" fmla="*/ 387720 h 387360"/>
            </a:gdLst>
            <a:ahLst/>
            <a:rect l="textAreaLeft" t="textAreaTop" r="textAreaRight" b="textAreaBottom"/>
            <a:pathLst>
              <a:path w="21600" h="54866">
                <a:moveTo>
                  <a:pt x="0" y="0"/>
                </a:moveTo>
                <a:arcTo wR="0" hR="0" stAng="10800000" swAng="-5400000"/>
                <a:lnTo>
                  <a:pt x="0" y="54866"/>
                </a:lnTo>
                <a:arcTo wR="0" hR="0" stAng="16200000" swAng="-5400000"/>
                <a:lnTo>
                  <a:pt x="21600" y="54866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9e66a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AutoShape 6"/>
          <p:cNvSpPr/>
          <p:nvPr/>
        </p:nvSpPr>
        <p:spPr>
          <a:xfrm>
            <a:off x="2581200" y="4305240"/>
            <a:ext cx="152640" cy="1546200"/>
          </a:xfrm>
          <a:custGeom>
            <a:avLst/>
            <a:gdLst>
              <a:gd name="textAreaLeft" fmla="*/ 0 w 152640"/>
              <a:gd name="textAreaRight" fmla="*/ 153000 w 152640"/>
              <a:gd name="textAreaTop" fmla="*/ 0 h 1546200"/>
              <a:gd name="textAreaBottom" fmla="*/ 1546560 h 1546200"/>
            </a:gdLst>
            <a:ahLst/>
            <a:rect l="textAreaLeft" t="textAreaTop" r="textAreaRight" b="textAreaBottom"/>
            <a:pathLst>
              <a:path w="21600" h="218338">
                <a:moveTo>
                  <a:pt x="0" y="0"/>
                </a:moveTo>
                <a:arcTo wR="0" hR="0" stAng="10800000" swAng="-5400000"/>
                <a:lnTo>
                  <a:pt x="0" y="218338"/>
                </a:lnTo>
                <a:arcTo wR="0" hR="0" stAng="16200000" swAng="-5400000"/>
                <a:lnTo>
                  <a:pt x="21600" y="21833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51c2a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AutoShape 8"/>
          <p:cNvSpPr/>
          <p:nvPr/>
        </p:nvSpPr>
        <p:spPr>
          <a:xfrm>
            <a:off x="2579760" y="3600360"/>
            <a:ext cx="152280" cy="146160"/>
          </a:xfrm>
          <a:custGeom>
            <a:avLst/>
            <a:gdLst>
              <a:gd name="textAreaLeft" fmla="*/ 0 w 152280"/>
              <a:gd name="textAreaRight" fmla="*/ 152280 w 152280"/>
              <a:gd name="textAreaTop" fmla="*/ 0 h 146160"/>
              <a:gd name="textAreaBottom" fmla="*/ 146520 h 146160"/>
            </a:gdLst>
            <a:ahLst/>
            <a:rect l="textAreaLeft" t="textAreaTop" r="textAreaRight" b="textAreaBottom"/>
            <a:pathLst>
              <a:path w="22502" h="21600">
                <a:moveTo>
                  <a:pt x="0" y="0"/>
                </a:moveTo>
                <a:arcTo wR="0" hR="0" stAng="10800000" swAng="-5400000"/>
                <a:lnTo>
                  <a:pt x="0" y="21600"/>
                </a:lnTo>
                <a:arcTo wR="0" hR="0" stAng="16200000" swAng="-5400000"/>
                <a:lnTo>
                  <a:pt x="22502" y="21600"/>
                </a:lnTo>
                <a:arcTo wR="0" hR="0" stAng="10800000" swAng="-5400000"/>
                <a:lnTo>
                  <a:pt x="22502" y="0"/>
                </a:lnTo>
                <a:arcTo wR="0" hR="0" stAng="16200000" swAng="-5400000"/>
                <a:close/>
              </a:path>
            </a:pathLst>
          </a:custGeom>
          <a:solidFill>
            <a:srgbClr val="ef913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AutoShape 9"/>
          <p:cNvSpPr/>
          <p:nvPr/>
        </p:nvSpPr>
        <p:spPr>
          <a:xfrm>
            <a:off x="2577960" y="2616120"/>
            <a:ext cx="152640" cy="448632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4486320"/>
              <a:gd name="textAreaBottom" fmla="*/ 4468320 h 4486320"/>
            </a:gdLst>
            <a:ahLst/>
            <a:rect l="textAreaLeft" t="textAreaTop" r="textAreaRight" b="textAreaBottom"/>
            <a:pathLst>
              <a:path w="21600" h="633414">
                <a:moveTo>
                  <a:pt x="3600" y="0"/>
                </a:moveTo>
                <a:arcTo wR="3600" hR="3600" stAng="0" swAng="5400000"/>
                <a:lnTo>
                  <a:pt x="0" y="629814"/>
                </a:lnTo>
                <a:arcTo wR="3600" hR="3600" stAng="16200000" swAng="5400000"/>
                <a:lnTo>
                  <a:pt x="18000" y="633414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Text Box 10"/>
          <p:cNvSpPr/>
          <p:nvPr/>
        </p:nvSpPr>
        <p:spPr>
          <a:xfrm>
            <a:off x="2726280" y="6507000"/>
            <a:ext cx="816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7-1.00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Text Box 11"/>
          <p:cNvSpPr/>
          <p:nvPr/>
        </p:nvSpPr>
        <p:spPr>
          <a:xfrm>
            <a:off x="14508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5A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Text Box 12"/>
          <p:cNvSpPr/>
          <p:nvPr/>
        </p:nvSpPr>
        <p:spPr>
          <a:xfrm>
            <a:off x="237312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5A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Text Box 13"/>
          <p:cNvSpPr/>
          <p:nvPr/>
        </p:nvSpPr>
        <p:spPr>
          <a:xfrm>
            <a:off x="401868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5A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Text Box 15"/>
          <p:cNvSpPr/>
          <p:nvPr/>
        </p:nvSpPr>
        <p:spPr>
          <a:xfrm>
            <a:off x="2802240" y="349236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Text Box 17"/>
          <p:cNvSpPr/>
          <p:nvPr/>
        </p:nvSpPr>
        <p:spPr>
          <a:xfrm>
            <a:off x="2726280" y="5021280"/>
            <a:ext cx="1175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7-0.78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SI-F, </a:t>
            </a:r>
            <a:r>
              <a:rPr b="0" i="1" lang="en-GB" sz="800" spc="-1" strike="noStrike">
                <a:solidFill>
                  <a:srgbClr val="fc0000"/>
                </a:solidFill>
                <a:latin typeface="Arial"/>
              </a:rPr>
              <a:t>Sgr,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Text Box 18"/>
          <p:cNvSpPr/>
          <p:nvPr/>
        </p:nvSpPr>
        <p:spPr>
          <a:xfrm>
            <a:off x="2728440" y="3825720"/>
            <a:ext cx="61056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35-0.5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4" name="Picture 22" descr="Chrom blank Screen shot 2013-01-07 at 10"/>
          <p:cNvPicPr/>
          <p:nvPr/>
        </p:nvPicPr>
        <p:blipFill>
          <a:blip r:embed="rId3">
            <a:lum contrast="-2000"/>
          </a:blip>
          <a:srcRect l="0" t="0" r="7663" b="0"/>
          <a:stretch/>
        </p:blipFill>
        <p:spPr>
          <a:xfrm>
            <a:off x="144360" y="3129120"/>
            <a:ext cx="163440" cy="377640"/>
          </a:xfrm>
          <a:prstGeom prst="rect">
            <a:avLst/>
          </a:prstGeom>
          <a:ln w="0">
            <a:noFill/>
          </a:ln>
        </p:spPr>
      </p:pic>
      <p:sp>
        <p:nvSpPr>
          <p:cNvPr id="545" name="Oval 27"/>
          <p:cNvSpPr/>
          <p:nvPr/>
        </p:nvSpPr>
        <p:spPr>
          <a:xfrm>
            <a:off x="158760" y="3511440"/>
            <a:ext cx="152280" cy="152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Line 28"/>
          <p:cNvSpPr/>
          <p:nvPr/>
        </p:nvSpPr>
        <p:spPr>
          <a:xfrm>
            <a:off x="2757600" y="420372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Line 29"/>
          <p:cNvSpPr/>
          <p:nvPr/>
        </p:nvSpPr>
        <p:spPr>
          <a:xfrm flipV="1">
            <a:off x="2762280" y="4107960"/>
            <a:ext cx="0" cy="2034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Line 32"/>
          <p:cNvSpPr/>
          <p:nvPr/>
        </p:nvSpPr>
        <p:spPr>
          <a:xfrm>
            <a:off x="2522520" y="3594240"/>
            <a:ext cx="336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Line 35"/>
          <p:cNvSpPr/>
          <p:nvPr/>
        </p:nvSpPr>
        <p:spPr>
          <a:xfrm>
            <a:off x="131760" y="3357720"/>
            <a:ext cx="187200" cy="0"/>
          </a:xfrm>
          <a:prstGeom prst="line">
            <a:avLst/>
          </a:prstGeom>
          <a:ln w="140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Line 36"/>
          <p:cNvSpPr/>
          <p:nvPr/>
        </p:nvSpPr>
        <p:spPr>
          <a:xfrm>
            <a:off x="130320" y="3319560"/>
            <a:ext cx="187200" cy="0"/>
          </a:xfrm>
          <a:prstGeom prst="line">
            <a:avLst/>
          </a:prstGeom>
          <a:ln w="140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Line 37"/>
          <p:cNvSpPr/>
          <p:nvPr/>
        </p:nvSpPr>
        <p:spPr>
          <a:xfrm>
            <a:off x="130320" y="3303720"/>
            <a:ext cx="187200" cy="0"/>
          </a:xfrm>
          <a:prstGeom prst="line">
            <a:avLst/>
          </a:prstGeom>
          <a:ln w="140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Line 38"/>
          <p:cNvSpPr/>
          <p:nvPr/>
        </p:nvSpPr>
        <p:spPr>
          <a:xfrm>
            <a:off x="131760" y="3292560"/>
            <a:ext cx="187200" cy="0"/>
          </a:xfrm>
          <a:prstGeom prst="line">
            <a:avLst/>
          </a:prstGeom>
          <a:ln w="140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Line 39"/>
          <p:cNvSpPr/>
          <p:nvPr/>
        </p:nvSpPr>
        <p:spPr>
          <a:xfrm>
            <a:off x="130320" y="3279600"/>
            <a:ext cx="187200" cy="0"/>
          </a:xfrm>
          <a:prstGeom prst="line">
            <a:avLst/>
          </a:prstGeom>
          <a:ln w="140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Line 40"/>
          <p:cNvSpPr/>
          <p:nvPr/>
        </p:nvSpPr>
        <p:spPr>
          <a:xfrm>
            <a:off x="130320" y="3263760"/>
            <a:ext cx="199800" cy="0"/>
          </a:xfrm>
          <a:prstGeom prst="line">
            <a:avLst/>
          </a:prstGeom>
          <a:ln w="140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Text Box 41"/>
          <p:cNvSpPr/>
          <p:nvPr/>
        </p:nvSpPr>
        <p:spPr>
          <a:xfrm>
            <a:off x="271440" y="2565360"/>
            <a:ext cx="2776680" cy="453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wg232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697-5A (C-0.35Lm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421-5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732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8280, wPt-797381 (C-0.40Sm), wPt-797382 (C-0.40Sm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7380 (C-0.40Sm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758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7301 (C-0.40Sm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7750, wPt-798459 (C-0.40Sm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131-5A (0.75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954-5A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26.1 (0.75-0.98n),</a:t>
            </a:r>
            <a:r>
              <a:rPr b="0" lang="en-US" sz="600" spc="-1" strike="noStrike">
                <a:solidFill>
                  <a:srgbClr val="f32331"/>
                </a:solidFill>
                <a:latin typeface="Arial"/>
              </a:rPr>
              <a:t> gwm293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(0.40-0.75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wg232.3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80 (C-0.40So)              gwm129 (C-0.40S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43p78.10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30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74, psr128 (0.35-0.57a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41 (0.35-0.57a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509-5A (0.35-0.78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50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Hsp8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748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b85 (0.35-0.57p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5p65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639a (0.68-0.78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1p77.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911 (0.57-0.78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09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202, psr806.1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Acl2) (0.57-0.78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637 (0.57-0.78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20.1 (0.57-0.78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825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262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0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967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388b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79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2021.1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Dhn2) (0.57-0.78n)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353-5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75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Vrn-A1 (0.57-0.78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426.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255-5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6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rab16, psr145</a:t>
            </a:r>
            <a:r>
              <a:rPr b="0" lang="en-GB" sz="600" spc="-1" strike="noStrike">
                <a:solidFill>
                  <a:srgbClr val="ff9900"/>
                </a:solidFill>
                <a:latin typeface="Arial"/>
              </a:rPr>
              <a:t>(Xdh)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 (0.57-0.78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a2163b (0.57-0.78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0p64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903-5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231-5A (0.87-1.00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6b (0.87-1.00p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6495-5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5p64.9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b-Amy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Text Box 43"/>
          <p:cNvSpPr/>
          <p:nvPr/>
        </p:nvSpPr>
        <p:spPr>
          <a:xfrm>
            <a:off x="2801520" y="3397320"/>
            <a:ext cx="80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AS-3, 5AS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Text Box 46"/>
          <p:cNvSpPr/>
          <p:nvPr/>
        </p:nvSpPr>
        <p:spPr>
          <a:xfrm>
            <a:off x="2804760" y="254952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AS-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Line 47"/>
          <p:cNvSpPr/>
          <p:nvPr/>
        </p:nvSpPr>
        <p:spPr>
          <a:xfrm>
            <a:off x="2739960" y="26463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Text Box 49"/>
          <p:cNvSpPr/>
          <p:nvPr/>
        </p:nvSpPr>
        <p:spPr>
          <a:xfrm>
            <a:off x="2726640" y="299232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5-0.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Line 50"/>
          <p:cNvSpPr/>
          <p:nvPr/>
        </p:nvSpPr>
        <p:spPr>
          <a:xfrm>
            <a:off x="317520" y="3559320"/>
            <a:ext cx="31680" cy="66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Line 51"/>
          <p:cNvSpPr/>
          <p:nvPr/>
        </p:nvSpPr>
        <p:spPr>
          <a:xfrm>
            <a:off x="2739960" y="350532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Text Box 52"/>
          <p:cNvSpPr/>
          <p:nvPr/>
        </p:nvSpPr>
        <p:spPr>
          <a:xfrm>
            <a:off x="2808000" y="366084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AL-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Line 53"/>
          <p:cNvSpPr/>
          <p:nvPr/>
        </p:nvSpPr>
        <p:spPr>
          <a:xfrm>
            <a:off x="2744640" y="375120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Text Box 54"/>
          <p:cNvSpPr/>
          <p:nvPr/>
        </p:nvSpPr>
        <p:spPr>
          <a:xfrm>
            <a:off x="2809800" y="410688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AL-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Line 56"/>
          <p:cNvSpPr/>
          <p:nvPr/>
        </p:nvSpPr>
        <p:spPr>
          <a:xfrm>
            <a:off x="2757600" y="60134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Line 57"/>
          <p:cNvSpPr/>
          <p:nvPr/>
        </p:nvSpPr>
        <p:spPr>
          <a:xfrm flipV="1">
            <a:off x="2762280" y="5851080"/>
            <a:ext cx="0" cy="3114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Text Box 58"/>
          <p:cNvSpPr/>
          <p:nvPr/>
        </p:nvSpPr>
        <p:spPr>
          <a:xfrm>
            <a:off x="2812320" y="5916600"/>
            <a:ext cx="1428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AL-17, 5AL-23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Mg-PpoIX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Text Box 60"/>
          <p:cNvSpPr/>
          <p:nvPr/>
        </p:nvSpPr>
        <p:spPr>
          <a:xfrm>
            <a:off x="2908080" y="348300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40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Line 61"/>
          <p:cNvSpPr/>
          <p:nvPr/>
        </p:nvSpPr>
        <p:spPr>
          <a:xfrm>
            <a:off x="324000" y="3357720"/>
            <a:ext cx="29880" cy="106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Line 62"/>
          <p:cNvSpPr/>
          <p:nvPr/>
        </p:nvSpPr>
        <p:spPr>
          <a:xfrm>
            <a:off x="324000" y="3514680"/>
            <a:ext cx="25200" cy="33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Text Box 63"/>
          <p:cNvSpPr/>
          <p:nvPr/>
        </p:nvSpPr>
        <p:spPr>
          <a:xfrm>
            <a:off x="2908800" y="3570120"/>
            <a:ext cx="54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35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Line 70"/>
          <p:cNvSpPr/>
          <p:nvPr/>
        </p:nvSpPr>
        <p:spPr>
          <a:xfrm>
            <a:off x="5708520" y="2616120"/>
            <a:ext cx="0" cy="442620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Text Box 71"/>
          <p:cNvSpPr/>
          <p:nvPr/>
        </p:nvSpPr>
        <p:spPr>
          <a:xfrm>
            <a:off x="2724840" y="4757760"/>
            <a:ext cx="89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Cab1.2,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sy3-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Text Box 73"/>
          <p:cNvSpPr/>
          <p:nvPr/>
        </p:nvSpPr>
        <p:spPr>
          <a:xfrm>
            <a:off x="2727000" y="514512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Cab1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Text Box 74"/>
          <p:cNvSpPr/>
          <p:nvPr/>
        </p:nvSpPr>
        <p:spPr>
          <a:xfrm>
            <a:off x="3187080" y="3754440"/>
            <a:ext cx="98244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ubisco-ssu,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b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Lhca4,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he-Fel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6" name="Picture 2" descr=""/>
          <p:cNvPicPr/>
          <p:nvPr/>
        </p:nvPicPr>
        <p:blipFill>
          <a:blip r:embed="rId4"/>
          <a:srcRect l="82570" t="2568" r="9676" b="73642"/>
          <a:stretch/>
        </p:blipFill>
        <p:spPr>
          <a:xfrm>
            <a:off x="5727600" y="5553000"/>
            <a:ext cx="362160" cy="863640"/>
          </a:xfrm>
          <a:prstGeom prst="rect">
            <a:avLst/>
          </a:prstGeom>
          <a:ln w="0">
            <a:noFill/>
          </a:ln>
        </p:spPr>
      </p:pic>
      <p:sp>
        <p:nvSpPr>
          <p:cNvPr id="577" name="pole tekstowe 4"/>
          <p:cNvSpPr/>
          <p:nvPr/>
        </p:nvSpPr>
        <p:spPr>
          <a:xfrm>
            <a:off x="5987880" y="5505480"/>
            <a:ext cx="8226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Chl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a+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0  Chl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a+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0  DW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GW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0  ET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RC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DI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0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P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8" name="Picture 2" descr=""/>
          <p:cNvPicPr/>
          <p:nvPr/>
        </p:nvPicPr>
        <p:blipFill>
          <a:blip r:embed="rId1"/>
          <a:stretch/>
        </p:blipFill>
        <p:spPr>
          <a:xfrm>
            <a:off x="3797280" y="2425680"/>
            <a:ext cx="2919600" cy="5019840"/>
          </a:xfrm>
          <a:prstGeom prst="rect">
            <a:avLst/>
          </a:prstGeom>
          <a:ln w="0">
            <a:noFill/>
          </a:ln>
        </p:spPr>
      </p:pic>
      <p:sp>
        <p:nvSpPr>
          <p:cNvPr id="579" name="AutoShape 5"/>
          <p:cNvSpPr/>
          <p:nvPr/>
        </p:nvSpPr>
        <p:spPr>
          <a:xfrm>
            <a:off x="2262240" y="5562720"/>
            <a:ext cx="152280" cy="17701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770120"/>
              <a:gd name="textAreaBottom" fmla="*/ 1752480 h 1770120"/>
            </a:gdLst>
            <a:ahLst/>
            <a:rect l="textAreaLeft" t="textAreaTop" r="textAreaRight" b="textAreaBottom"/>
            <a:pathLst>
              <a:path w="21600" h="250540">
                <a:moveTo>
                  <a:pt x="3600" y="0"/>
                </a:moveTo>
                <a:arcTo wR="3600" hR="3600" stAng="0" swAng="5400000"/>
                <a:lnTo>
                  <a:pt x="0" y="246940"/>
                </a:lnTo>
                <a:arcTo wR="3600" hR="3600" stAng="16200000" swAng="5400000"/>
                <a:lnTo>
                  <a:pt x="18000" y="250540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ac6c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AutoShape 54"/>
          <p:cNvSpPr/>
          <p:nvPr/>
        </p:nvSpPr>
        <p:spPr>
          <a:xfrm>
            <a:off x="2263680" y="4965840"/>
            <a:ext cx="152640" cy="691920"/>
          </a:xfrm>
          <a:custGeom>
            <a:avLst/>
            <a:gdLst>
              <a:gd name="textAreaLeft" fmla="*/ 0 w 152640"/>
              <a:gd name="textAreaRight" fmla="*/ 153000 w 152640"/>
              <a:gd name="textAreaTop" fmla="*/ 0 h 691920"/>
              <a:gd name="textAreaBottom" fmla="*/ 692280 h 691920"/>
            </a:gdLst>
            <a:ahLst/>
            <a:rect l="textAreaLeft" t="textAreaTop" r="textAreaRight" b="textAreaBottom"/>
            <a:pathLst>
              <a:path w="21600" h="97734">
                <a:moveTo>
                  <a:pt x="0" y="0"/>
                </a:moveTo>
                <a:arcTo wR="0" hR="0" stAng="10800000" swAng="-5400000"/>
                <a:lnTo>
                  <a:pt x="0" y="97734"/>
                </a:lnTo>
                <a:arcTo wR="0" hR="0" stAng="16200000" swAng="-5400000"/>
                <a:lnTo>
                  <a:pt x="21600" y="97734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d7bcd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1" name="Picture 43" descr="5B Screen shot 2013-01-09 at 18"/>
          <p:cNvPicPr/>
          <p:nvPr/>
        </p:nvPicPr>
        <p:blipFill>
          <a:blip r:embed="rId2"/>
          <a:stretch/>
        </p:blipFill>
        <p:spPr>
          <a:xfrm>
            <a:off x="252360" y="2590920"/>
            <a:ext cx="235080" cy="4800600"/>
          </a:xfrm>
          <a:prstGeom prst="rect">
            <a:avLst/>
          </a:prstGeom>
          <a:ln w="0">
            <a:noFill/>
          </a:ln>
        </p:spPr>
      </p:pic>
      <p:sp>
        <p:nvSpPr>
          <p:cNvPr id="582" name="AutoShape 2"/>
          <p:cNvSpPr/>
          <p:nvPr/>
        </p:nvSpPr>
        <p:spPr>
          <a:xfrm>
            <a:off x="2262240" y="2616120"/>
            <a:ext cx="149040" cy="704880"/>
          </a:xfrm>
          <a:custGeom>
            <a:avLst/>
            <a:gdLst>
              <a:gd name="textAreaLeft" fmla="*/ 17280 w 149040"/>
              <a:gd name="textAreaRight" fmla="*/ 131760 w 149040"/>
              <a:gd name="textAreaTop" fmla="*/ 17280 h 704880"/>
              <a:gd name="textAreaBottom" fmla="*/ 687600 h 704880"/>
            </a:gdLst>
            <a:ahLst/>
            <a:rect l="textAreaLeft" t="textAreaTop" r="textAreaRight" b="textAreaBottom"/>
            <a:pathLst>
              <a:path w="21600" h="101962">
                <a:moveTo>
                  <a:pt x="3600" y="0"/>
                </a:moveTo>
                <a:arcTo wR="3600" hR="3600" stAng="0" swAng="5400000"/>
                <a:lnTo>
                  <a:pt x="0" y="98362"/>
                </a:lnTo>
                <a:arcTo wR="3600" hR="3600" stAng="16200000" swAng="5400000"/>
                <a:lnTo>
                  <a:pt x="18000" y="101962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436cb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AutoShape 8"/>
          <p:cNvSpPr/>
          <p:nvPr/>
        </p:nvSpPr>
        <p:spPr>
          <a:xfrm>
            <a:off x="2263680" y="3505320"/>
            <a:ext cx="152640" cy="533160"/>
          </a:xfrm>
          <a:custGeom>
            <a:avLst/>
            <a:gdLst>
              <a:gd name="textAreaLeft" fmla="*/ 0 w 152640"/>
              <a:gd name="textAreaRight" fmla="*/ 153000 w 152640"/>
              <a:gd name="textAreaTop" fmla="*/ 0 h 533160"/>
              <a:gd name="textAreaBottom" fmla="*/ 533520 h 533160"/>
            </a:gdLst>
            <a:ahLst/>
            <a:rect l="textAreaLeft" t="textAreaTop" r="textAreaRight" b="textAreaBottom"/>
            <a:pathLst>
              <a:path w="21600" h="75320">
                <a:moveTo>
                  <a:pt x="0" y="0"/>
                </a:moveTo>
                <a:arcTo wR="0" hR="0" stAng="10800000" swAng="-5400000"/>
                <a:lnTo>
                  <a:pt x="0" y="75320"/>
                </a:lnTo>
                <a:arcTo wR="0" hR="0" stAng="16200000" swAng="-5400000"/>
                <a:lnTo>
                  <a:pt x="21600" y="75320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9c689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AutoShape 52"/>
          <p:cNvSpPr/>
          <p:nvPr/>
        </p:nvSpPr>
        <p:spPr>
          <a:xfrm>
            <a:off x="2263680" y="3790800"/>
            <a:ext cx="152640" cy="704880"/>
          </a:xfrm>
          <a:custGeom>
            <a:avLst/>
            <a:gdLst>
              <a:gd name="textAreaLeft" fmla="*/ 0 w 152640"/>
              <a:gd name="textAreaRight" fmla="*/ 153000 w 152640"/>
              <a:gd name="textAreaTop" fmla="*/ 0 h 704880"/>
              <a:gd name="textAreaBottom" fmla="*/ 704880 h 704880"/>
            </a:gdLst>
            <a:ahLst/>
            <a:rect l="textAreaLeft" t="textAreaTop" r="textAreaRight" b="textAreaBottom"/>
            <a:pathLst>
              <a:path w="21600" h="99563">
                <a:moveTo>
                  <a:pt x="0" y="0"/>
                </a:moveTo>
                <a:arcTo wR="0" hR="0" stAng="10800000" swAng="-5400000"/>
                <a:lnTo>
                  <a:pt x="0" y="99563"/>
                </a:lnTo>
                <a:arcTo wR="0" hR="0" stAng="16200000" swAng="-5400000"/>
                <a:lnTo>
                  <a:pt x="21600" y="99563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51c2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AutoShape 3"/>
          <p:cNvSpPr/>
          <p:nvPr/>
        </p:nvSpPr>
        <p:spPr>
          <a:xfrm>
            <a:off x="2262240" y="3238560"/>
            <a:ext cx="152280" cy="342720"/>
          </a:xfrm>
          <a:custGeom>
            <a:avLst/>
            <a:gdLst>
              <a:gd name="textAreaLeft" fmla="*/ 3240 w 152280"/>
              <a:gd name="textAreaRight" fmla="*/ 149040 w 152280"/>
              <a:gd name="textAreaTop" fmla="*/ 3240 h 342720"/>
              <a:gd name="textAreaBottom" fmla="*/ 339480 h 342720"/>
            </a:gdLst>
            <a:ahLst/>
            <a:rect l="textAreaLeft" t="textAreaTop" r="textAreaRight" b="textAreaBottom"/>
            <a:pathLst>
              <a:path w="21600" h="48549">
                <a:moveTo>
                  <a:pt x="675" y="0"/>
                </a:moveTo>
                <a:arcTo wR="675" hR="675" stAng="0" swAng="5400000"/>
                <a:lnTo>
                  <a:pt x="0" y="47874"/>
                </a:lnTo>
                <a:arcTo wR="675" hR="675" stAng="16200000" swAng="5400000"/>
                <a:lnTo>
                  <a:pt x="20925" y="48549"/>
                </a:lnTo>
                <a:arcTo wR="675" hR="675" stAng="10800000" swAng="5400000"/>
                <a:lnTo>
                  <a:pt x="21600" y="675"/>
                </a:lnTo>
                <a:arcTo wR="675" hR="675" stAng="5400000" swAng="5400000"/>
                <a:close/>
              </a:path>
            </a:pathLst>
          </a:custGeom>
          <a:solidFill>
            <a:srgbClr val="8ace9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AutoShape 9"/>
          <p:cNvSpPr/>
          <p:nvPr/>
        </p:nvSpPr>
        <p:spPr>
          <a:xfrm>
            <a:off x="2265480" y="4419720"/>
            <a:ext cx="152280" cy="361800"/>
          </a:xfrm>
          <a:custGeom>
            <a:avLst/>
            <a:gdLst>
              <a:gd name="textAreaLeft" fmla="*/ 0 w 152280"/>
              <a:gd name="textAreaRight" fmla="*/ 152640 w 152280"/>
              <a:gd name="textAreaTop" fmla="*/ 0 h 361800"/>
              <a:gd name="textAreaBottom" fmla="*/ 362160 h 361800"/>
            </a:gdLst>
            <a:ahLst/>
            <a:rect l="textAreaLeft" t="textAreaTop" r="textAreaRight" b="textAreaBottom"/>
            <a:pathLst>
              <a:path w="21600" h="51249">
                <a:moveTo>
                  <a:pt x="0" y="0"/>
                </a:moveTo>
                <a:arcTo wR="0" hR="0" stAng="10800000" swAng="-5400000"/>
                <a:lnTo>
                  <a:pt x="0" y="51249"/>
                </a:lnTo>
                <a:arcTo wR="0" hR="0" stAng="16200000" swAng="-5400000"/>
                <a:lnTo>
                  <a:pt x="21600" y="51249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c7204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AutoShape 11"/>
          <p:cNvSpPr/>
          <p:nvPr/>
        </p:nvSpPr>
        <p:spPr>
          <a:xfrm>
            <a:off x="2262240" y="2616120"/>
            <a:ext cx="152280" cy="47167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4716720"/>
              <a:gd name="textAreaBottom" fmla="*/ 4699080 h 4716720"/>
            </a:gdLst>
            <a:ahLst/>
            <a:rect l="textAreaLeft" t="textAreaTop" r="textAreaRight" b="textAreaBottom"/>
            <a:pathLst>
              <a:path w="21600" h="667511">
                <a:moveTo>
                  <a:pt x="3600" y="0"/>
                </a:moveTo>
                <a:arcTo wR="3600" hR="3600" stAng="0" swAng="5400000"/>
                <a:lnTo>
                  <a:pt x="0" y="663911"/>
                </a:lnTo>
                <a:arcTo wR="3600" hR="3600" stAng="16200000" swAng="5400000"/>
                <a:lnTo>
                  <a:pt x="18000" y="667511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Text Box 12"/>
          <p:cNvSpPr/>
          <p:nvPr/>
        </p:nvSpPr>
        <p:spPr>
          <a:xfrm>
            <a:off x="2408040" y="6342120"/>
            <a:ext cx="1340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9-1.00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Wcab, PSII-W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SI-F, RIS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Text Box 13"/>
          <p:cNvSpPr/>
          <p:nvPr/>
        </p:nvSpPr>
        <p:spPr>
          <a:xfrm>
            <a:off x="14508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5B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Text Box 14"/>
          <p:cNvSpPr/>
          <p:nvPr/>
        </p:nvSpPr>
        <p:spPr>
          <a:xfrm>
            <a:off x="205740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5B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Text Box 15"/>
          <p:cNvSpPr/>
          <p:nvPr/>
        </p:nvSpPr>
        <p:spPr>
          <a:xfrm>
            <a:off x="401868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5B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Text Box 17"/>
          <p:cNvSpPr/>
          <p:nvPr/>
        </p:nvSpPr>
        <p:spPr>
          <a:xfrm>
            <a:off x="2410560" y="5148360"/>
            <a:ext cx="1570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6-0.79 </a:t>
            </a:r>
            <a:r>
              <a:rPr b="0" i="1" lang="en-GB" sz="800" spc="-1" strike="noStrike">
                <a:solidFill>
                  <a:srgbClr val="fc0000"/>
                </a:solidFill>
                <a:latin typeface="Arial"/>
              </a:rPr>
              <a:t>Sgr,</a:t>
            </a: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ubisco-sbp-a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t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Text Box 18"/>
          <p:cNvSpPr/>
          <p:nvPr/>
        </p:nvSpPr>
        <p:spPr>
          <a:xfrm>
            <a:off x="2412360" y="4016520"/>
            <a:ext cx="61056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5-0.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4" name="Picture 19" descr="Chrom blank Screen shot 2013-01-07 at 10"/>
          <p:cNvPicPr/>
          <p:nvPr/>
        </p:nvPicPr>
        <p:blipFill>
          <a:blip r:embed="rId3">
            <a:lum contrast="-2000"/>
          </a:blip>
          <a:srcRect l="0" t="0" r="7663" b="0"/>
          <a:stretch/>
        </p:blipFill>
        <p:spPr>
          <a:xfrm>
            <a:off x="281160" y="3583080"/>
            <a:ext cx="141120" cy="236520"/>
          </a:xfrm>
          <a:prstGeom prst="rect">
            <a:avLst/>
          </a:prstGeom>
          <a:ln w="0">
            <a:noFill/>
          </a:ln>
        </p:spPr>
      </p:pic>
      <p:sp>
        <p:nvSpPr>
          <p:cNvPr id="595" name="Oval 20"/>
          <p:cNvSpPr/>
          <p:nvPr/>
        </p:nvSpPr>
        <p:spPr>
          <a:xfrm>
            <a:off x="279360" y="3511440"/>
            <a:ext cx="152280" cy="152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Line 25"/>
          <p:cNvSpPr/>
          <p:nvPr/>
        </p:nvSpPr>
        <p:spPr>
          <a:xfrm>
            <a:off x="276120" y="3605040"/>
            <a:ext cx="157320" cy="0"/>
          </a:xfrm>
          <a:prstGeom prst="line">
            <a:avLst/>
          </a:prstGeom>
          <a:ln w="140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Line 27"/>
          <p:cNvSpPr/>
          <p:nvPr/>
        </p:nvSpPr>
        <p:spPr>
          <a:xfrm>
            <a:off x="276120" y="3581280"/>
            <a:ext cx="152640" cy="0"/>
          </a:xfrm>
          <a:prstGeom prst="line">
            <a:avLst/>
          </a:prstGeom>
          <a:ln w="140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Text Box 31"/>
          <p:cNvSpPr/>
          <p:nvPr/>
        </p:nvSpPr>
        <p:spPr>
          <a:xfrm>
            <a:off x="2482920" y="3467160"/>
            <a:ext cx="1582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BS-5, 5BS8, 5BS-4, </a:t>
            </a: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, 5BL-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Text Box 32"/>
          <p:cNvSpPr/>
          <p:nvPr/>
        </p:nvSpPr>
        <p:spPr>
          <a:xfrm>
            <a:off x="2488680" y="314172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BS-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Line 33"/>
          <p:cNvSpPr/>
          <p:nvPr/>
        </p:nvSpPr>
        <p:spPr>
          <a:xfrm>
            <a:off x="2424240" y="32385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Text Box 34"/>
          <p:cNvSpPr/>
          <p:nvPr/>
        </p:nvSpPr>
        <p:spPr>
          <a:xfrm>
            <a:off x="2410920" y="2830680"/>
            <a:ext cx="876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1-1.00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Cc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Line 36"/>
          <p:cNvSpPr/>
          <p:nvPr/>
        </p:nvSpPr>
        <p:spPr>
          <a:xfrm>
            <a:off x="2424240" y="441972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Text Box 37"/>
          <p:cNvSpPr/>
          <p:nvPr/>
        </p:nvSpPr>
        <p:spPr>
          <a:xfrm>
            <a:off x="2492280" y="370044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BL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Line 38"/>
          <p:cNvSpPr/>
          <p:nvPr/>
        </p:nvSpPr>
        <p:spPr>
          <a:xfrm>
            <a:off x="2422440" y="379080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Text Box 39"/>
          <p:cNvSpPr/>
          <p:nvPr/>
        </p:nvSpPr>
        <p:spPr>
          <a:xfrm>
            <a:off x="2493720" y="432288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BL-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Line 40"/>
          <p:cNvSpPr/>
          <p:nvPr/>
        </p:nvSpPr>
        <p:spPr>
          <a:xfrm>
            <a:off x="2441520" y="487368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Line 41"/>
          <p:cNvSpPr/>
          <p:nvPr/>
        </p:nvSpPr>
        <p:spPr>
          <a:xfrm flipV="1">
            <a:off x="2452680" y="4781160"/>
            <a:ext cx="0" cy="190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Text Box 42"/>
          <p:cNvSpPr/>
          <p:nvPr/>
        </p:nvSpPr>
        <p:spPr>
          <a:xfrm>
            <a:off x="2498760" y="477684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BL-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Line 44"/>
          <p:cNvSpPr/>
          <p:nvPr/>
        </p:nvSpPr>
        <p:spPr>
          <a:xfrm>
            <a:off x="271440" y="3714840"/>
            <a:ext cx="157320" cy="0"/>
          </a:xfrm>
          <a:prstGeom prst="line">
            <a:avLst/>
          </a:prstGeom>
          <a:ln w="140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Line 45"/>
          <p:cNvSpPr/>
          <p:nvPr/>
        </p:nvSpPr>
        <p:spPr>
          <a:xfrm>
            <a:off x="276120" y="3743280"/>
            <a:ext cx="157320" cy="0"/>
          </a:xfrm>
          <a:prstGeom prst="line">
            <a:avLst/>
          </a:prstGeom>
          <a:ln w="140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Text Box 46"/>
          <p:cNvSpPr/>
          <p:nvPr/>
        </p:nvSpPr>
        <p:spPr>
          <a:xfrm>
            <a:off x="409680" y="2570040"/>
            <a:ext cx="2092320" cy="47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2p78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055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234 (0.81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dupw11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033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261-5B (0.81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wg232.2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49a, </a:t>
            </a:r>
            <a:r>
              <a:rPr b="0" lang="en-US" sz="600" spc="-1" strike="noStrike">
                <a:solidFill>
                  <a:srgbClr val="1608ff"/>
                </a:solidFill>
                <a:latin typeface="Arial"/>
              </a:rPr>
              <a:t>psr170 (0.81-1.00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1p77.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085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346-5B (0.71-1.00h), wPt-5175 (0.71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51p65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26.2 (0.71-0.81n), psr118 (C-0.43S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73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120-5B, </a:t>
            </a:r>
            <a:r>
              <a:rPr b="0" lang="en-US" sz="600" spc="-1" strike="noStrike">
                <a:solidFill>
                  <a:srgbClr val="ec3237"/>
                </a:solidFill>
                <a:latin typeface="Arial"/>
              </a:rPr>
              <a:t>barc109 (C-0.29Lr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814-5B (0.71-0.81Sf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419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737-5B (0.71-0.81S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951-5B (0.55-0.76L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289-5B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74 (0.29-0.55Lar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103-5B (0.29-0.75Ls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2203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514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18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72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499 (0.55-0.75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639b (0.55-0.75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37 (0.59-0.75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806.2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Acl2) (0.59-0.75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531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548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20.2 (0.75-0.76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5p64.8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2021.2</a:t>
            </a:r>
            <a:r>
              <a:rPr b="0" lang="en-US" sz="600" spc="-1" strike="noStrike">
                <a:solidFill>
                  <a:srgbClr val="ef913f"/>
                </a:solidFill>
                <a:latin typeface="Arial"/>
              </a:rPr>
              <a:t>(Dhn2) (0.76-0.79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271 (0.76-0.79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408 (0.76-0.79t)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426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896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304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wg908.2 (0.76-0.79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40 (0.55-0.75ar) (0.79-1.00u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103-5B, wPt-8094, wPt-9205 (0.79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239-5B (0.79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rsq805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5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0p64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3144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006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418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927-5B (0.79-1.00f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7p64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80 (0.79-1.00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00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465-5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922-5B (0.79-1.00f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17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67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3p78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Line 48"/>
          <p:cNvSpPr/>
          <p:nvPr/>
        </p:nvSpPr>
        <p:spPr>
          <a:xfrm>
            <a:off x="2124000" y="358128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Text Box 49"/>
          <p:cNvSpPr/>
          <p:nvPr/>
        </p:nvSpPr>
        <p:spPr>
          <a:xfrm>
            <a:off x="2410920" y="330660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1-0.8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Text Box 51"/>
          <p:cNvSpPr/>
          <p:nvPr/>
        </p:nvSpPr>
        <p:spPr>
          <a:xfrm>
            <a:off x="2411280" y="4494240"/>
            <a:ext cx="97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5-0.76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sy3-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Text Box 53"/>
          <p:cNvSpPr/>
          <p:nvPr/>
        </p:nvSpPr>
        <p:spPr>
          <a:xfrm>
            <a:off x="2409480" y="3602160"/>
            <a:ext cx="133128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29-0.55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Lhca4,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he-F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Line 55"/>
          <p:cNvSpPr/>
          <p:nvPr/>
        </p:nvSpPr>
        <p:spPr>
          <a:xfrm>
            <a:off x="2428920" y="56577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Text Box 56"/>
          <p:cNvSpPr/>
          <p:nvPr/>
        </p:nvSpPr>
        <p:spPr>
          <a:xfrm>
            <a:off x="2498400" y="556092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BL-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Line 61"/>
          <p:cNvSpPr/>
          <p:nvPr/>
        </p:nvSpPr>
        <p:spPr>
          <a:xfrm>
            <a:off x="5403960" y="2647800"/>
            <a:ext cx="0" cy="4635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Text Box 62"/>
          <p:cNvSpPr/>
          <p:nvPr/>
        </p:nvSpPr>
        <p:spPr>
          <a:xfrm>
            <a:off x="2411280" y="3878280"/>
            <a:ext cx="7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ubisco-ss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0" name="Group 84"/>
          <p:cNvGrpSpPr/>
          <p:nvPr/>
        </p:nvGrpSpPr>
        <p:grpSpPr>
          <a:xfrm>
            <a:off x="5442120" y="5257800"/>
            <a:ext cx="1191960" cy="1692360"/>
            <a:chOff x="5442120" y="5257800"/>
            <a:chExt cx="1191960" cy="1692360"/>
          </a:xfrm>
        </p:grpSpPr>
        <p:sp>
          <p:nvSpPr>
            <p:cNvPr id="621" name="pole tekstowe 4"/>
            <p:cNvSpPr/>
            <p:nvPr/>
          </p:nvSpPr>
          <p:spPr>
            <a:xfrm>
              <a:off x="5783400" y="5257800"/>
              <a:ext cx="850680" cy="169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SPA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TR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TR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TR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DI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DI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22" name="Picture 3" descr=""/>
            <p:cNvPicPr/>
            <p:nvPr/>
          </p:nvPicPr>
          <p:blipFill>
            <a:blip r:embed="rId4"/>
            <a:srcRect l="82329" t="1880" r="9666" b="53276"/>
            <a:stretch/>
          </p:blipFill>
          <p:spPr>
            <a:xfrm>
              <a:off x="5442120" y="5283360"/>
              <a:ext cx="428400" cy="15984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3" name="Picture 2" descr=""/>
          <p:cNvPicPr/>
          <p:nvPr/>
        </p:nvPicPr>
        <p:blipFill>
          <a:blip r:embed="rId1"/>
          <a:stretch/>
        </p:blipFill>
        <p:spPr>
          <a:xfrm>
            <a:off x="3417840" y="2408400"/>
            <a:ext cx="3254400" cy="5360760"/>
          </a:xfrm>
          <a:prstGeom prst="rect">
            <a:avLst/>
          </a:prstGeom>
          <a:ln w="0">
            <a:noFill/>
          </a:ln>
        </p:spPr>
      </p:pic>
      <p:pic>
        <p:nvPicPr>
          <p:cNvPr id="624" name="Picture 41" descr="5D Screen shot 2013-01-10 at 00"/>
          <p:cNvPicPr/>
          <p:nvPr/>
        </p:nvPicPr>
        <p:blipFill>
          <a:blip r:embed="rId2"/>
          <a:srcRect l="0" t="0" r="0" b="117"/>
          <a:stretch/>
        </p:blipFill>
        <p:spPr>
          <a:xfrm>
            <a:off x="257040" y="2610000"/>
            <a:ext cx="250920" cy="5049720"/>
          </a:xfrm>
          <a:prstGeom prst="rect">
            <a:avLst/>
          </a:prstGeom>
          <a:ln w="0">
            <a:noFill/>
          </a:ln>
        </p:spPr>
      </p:pic>
      <p:sp>
        <p:nvSpPr>
          <p:cNvPr id="625" name="Text Box 12"/>
          <p:cNvSpPr/>
          <p:nvPr/>
        </p:nvSpPr>
        <p:spPr>
          <a:xfrm>
            <a:off x="142200" y="201132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5D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Text Box 14"/>
          <p:cNvSpPr/>
          <p:nvPr/>
        </p:nvSpPr>
        <p:spPr>
          <a:xfrm>
            <a:off x="4055400" y="2011320"/>
            <a:ext cx="216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5D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7" name="Picture 17" descr="Chrom blank Screen shot 2013-01-07 at 10"/>
          <p:cNvPicPr/>
          <p:nvPr/>
        </p:nvPicPr>
        <p:blipFill>
          <a:blip r:embed="rId3">
            <a:lum contrast="-2000"/>
          </a:blip>
          <a:srcRect l="0" t="0" r="7663" b="0"/>
          <a:stretch/>
        </p:blipFill>
        <p:spPr>
          <a:xfrm>
            <a:off x="281160" y="3448080"/>
            <a:ext cx="141120" cy="976320"/>
          </a:xfrm>
          <a:prstGeom prst="rect">
            <a:avLst/>
          </a:prstGeom>
          <a:ln w="0">
            <a:noFill/>
          </a:ln>
        </p:spPr>
      </p:pic>
      <p:sp>
        <p:nvSpPr>
          <p:cNvPr id="628" name="Oval 18"/>
          <p:cNvSpPr/>
          <p:nvPr/>
        </p:nvSpPr>
        <p:spPr>
          <a:xfrm>
            <a:off x="279360" y="4464000"/>
            <a:ext cx="15228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Line 33"/>
          <p:cNvSpPr/>
          <p:nvPr/>
        </p:nvSpPr>
        <p:spPr>
          <a:xfrm>
            <a:off x="276120" y="3776760"/>
            <a:ext cx="157320" cy="0"/>
          </a:xfrm>
          <a:prstGeom prst="line">
            <a:avLst/>
          </a:prstGeom>
          <a:ln w="140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Text Box 42"/>
          <p:cNvSpPr/>
          <p:nvPr/>
        </p:nvSpPr>
        <p:spPr>
          <a:xfrm>
            <a:off x="420840" y="2590920"/>
            <a:ext cx="1865160" cy="508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3p78.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33 (0.78-1.00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18 (0.63-0.78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90 (C-0.63S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295-5D, wPt-2856 (C-0.63Sv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205 (C-0.63S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a9335"/>
                </a:solidFill>
                <a:latin typeface="Arial"/>
              </a:rPr>
              <a:t>GS2-like_46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44 (C-0.63S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8 (C-0.63Sa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256-5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583 (C-0.60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57 (C-0.60La),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 psr806.3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Acl2) (0.69-0.76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74 (0.60-0.74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7 (0.60-0.74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Ibf (0.69-0.76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3 (C-0.60Lg) (0.60-0.74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7p64.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292 (C-0.60La) (0.76-1.00w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212 (0.76-1.00a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194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97 (0.76-1.00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2p64.9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92p78.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71936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67.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7176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964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086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565 (0.76-1.00a), gwm269 (0.76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rPt-3825-5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44 (0.29-0.60r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1" name="Group 147"/>
          <p:cNvGrpSpPr/>
          <p:nvPr/>
        </p:nvGrpSpPr>
        <p:grpSpPr>
          <a:xfrm>
            <a:off x="1901880" y="2011320"/>
            <a:ext cx="1852920" cy="5640480"/>
            <a:chOff x="1901880" y="2011320"/>
            <a:chExt cx="1852920" cy="5640480"/>
          </a:xfrm>
        </p:grpSpPr>
        <p:sp>
          <p:nvSpPr>
            <p:cNvPr id="632" name="AutoShape 2"/>
            <p:cNvSpPr/>
            <p:nvPr/>
          </p:nvSpPr>
          <p:spPr>
            <a:xfrm>
              <a:off x="2109960" y="5562720"/>
              <a:ext cx="152280" cy="2089080"/>
            </a:xfrm>
            <a:custGeom>
              <a:avLst/>
              <a:gdLst>
                <a:gd name="textAreaLeft" fmla="*/ 17640 w 152280"/>
                <a:gd name="textAreaRight" fmla="*/ 134640 w 152280"/>
                <a:gd name="textAreaTop" fmla="*/ 17640 h 2089080"/>
                <a:gd name="textAreaBottom" fmla="*/ 2071440 h 2089080"/>
              </a:gdLst>
              <a:ahLst/>
              <a:rect l="textAreaLeft" t="textAreaTop" r="textAreaRight" b="textAreaBottom"/>
              <a:pathLst>
                <a:path w="21600" h="295675">
                  <a:moveTo>
                    <a:pt x="3600" y="0"/>
                  </a:moveTo>
                  <a:arcTo wR="3600" hR="3600" stAng="0" swAng="5400000"/>
                  <a:lnTo>
                    <a:pt x="0" y="292075"/>
                  </a:lnTo>
                  <a:arcTo wR="3600" hR="3600" stAng="16200000" swAng="5400000"/>
                  <a:lnTo>
                    <a:pt x="18000" y="295675"/>
                  </a:lnTo>
                  <a:arcTo wR="3600" hR="3600" stAng="10800000" swAng="5400000"/>
                  <a:lnTo>
                    <a:pt x="21600" y="3600"/>
                  </a:lnTo>
                  <a:arcTo wR="3600" hR="3600" stAng="5400000" swAng="5400000"/>
                  <a:close/>
                </a:path>
              </a:pathLst>
            </a:custGeom>
            <a:solidFill>
              <a:srgbClr val="c1153e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AutoShape 5"/>
            <p:cNvSpPr/>
            <p:nvPr/>
          </p:nvSpPr>
          <p:spPr>
            <a:xfrm>
              <a:off x="2114640" y="2616120"/>
              <a:ext cx="149040" cy="432000"/>
            </a:xfrm>
            <a:custGeom>
              <a:avLst/>
              <a:gdLst>
                <a:gd name="textAreaLeft" fmla="*/ 17280 w 149040"/>
                <a:gd name="textAreaRight" fmla="*/ 131760 w 149040"/>
                <a:gd name="textAreaTop" fmla="*/ 17280 h 432000"/>
                <a:gd name="textAreaBottom" fmla="*/ 414720 h 432000"/>
              </a:gdLst>
              <a:ahLst/>
              <a:rect l="textAreaLeft" t="textAreaTop" r="textAreaRight" b="textAreaBottom"/>
              <a:pathLst>
                <a:path w="21600" h="62510">
                  <a:moveTo>
                    <a:pt x="3600" y="0"/>
                  </a:moveTo>
                  <a:arcTo wR="3600" hR="3600" stAng="0" swAng="5400000"/>
                  <a:lnTo>
                    <a:pt x="0" y="58910"/>
                  </a:lnTo>
                  <a:arcTo wR="3600" hR="3600" stAng="16200000" swAng="5400000"/>
                  <a:lnTo>
                    <a:pt x="18000" y="62510"/>
                  </a:lnTo>
                  <a:arcTo wR="3600" hR="3600" stAng="10800000" swAng="5400000"/>
                  <a:lnTo>
                    <a:pt x="21600" y="3600"/>
                  </a:lnTo>
                  <a:arcTo wR="3600" hR="3600" stAng="5400000" swAng="5400000"/>
                  <a:close/>
                </a:path>
              </a:pathLst>
            </a:custGeom>
            <a:solidFill>
              <a:srgbClr val="416eb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AutoShape 7"/>
            <p:cNvSpPr/>
            <p:nvPr/>
          </p:nvSpPr>
          <p:spPr>
            <a:xfrm>
              <a:off x="2111400" y="5562720"/>
              <a:ext cx="152280" cy="139680"/>
            </a:xfrm>
            <a:custGeom>
              <a:avLst/>
              <a:gdLst>
                <a:gd name="textAreaLeft" fmla="*/ 0 w 152280"/>
                <a:gd name="textAreaRight" fmla="*/ 152280 w 152280"/>
                <a:gd name="textAreaTop" fmla="*/ 0 h 139680"/>
                <a:gd name="textAreaBottom" fmla="*/ 140040 h 139680"/>
              </a:gdLst>
              <a:ahLst/>
              <a:rect l="textAreaLeft" t="textAreaTop" r="textAreaRight" b="textAreaBottom"/>
              <a:pathLst>
                <a:path w="23543" h="21600">
                  <a:moveTo>
                    <a:pt x="0" y="0"/>
                  </a:moveTo>
                  <a:arcTo wR="0" hR="0" stAng="10800000" swAng="-5400000"/>
                  <a:lnTo>
                    <a:pt x="0" y="21600"/>
                  </a:lnTo>
                  <a:arcTo wR="0" hR="0" stAng="16200000" swAng="-5400000"/>
                  <a:lnTo>
                    <a:pt x="23543" y="21600"/>
                  </a:lnTo>
                  <a:arcTo wR="0" hR="0" stAng="10800000" swAng="-5400000"/>
                  <a:lnTo>
                    <a:pt x="23543" y="0"/>
                  </a:lnTo>
                  <a:arcTo wR="0" hR="0" stAng="16200000" swAng="-5400000"/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AutoShape 8"/>
            <p:cNvSpPr/>
            <p:nvPr/>
          </p:nvSpPr>
          <p:spPr>
            <a:xfrm>
              <a:off x="2109960" y="2984400"/>
              <a:ext cx="152280" cy="139680"/>
            </a:xfrm>
            <a:custGeom>
              <a:avLst/>
              <a:gdLst>
                <a:gd name="textAreaLeft" fmla="*/ 2880 w 152280"/>
                <a:gd name="textAreaRight" fmla="*/ 149400 w 152280"/>
                <a:gd name="textAreaTop" fmla="*/ 2880 h 139680"/>
                <a:gd name="textAreaBottom" fmla="*/ 136800 h 139680"/>
              </a:gdLst>
              <a:ahLst/>
              <a:rect l="textAreaLeft" t="textAreaTop" r="textAreaRight" b="textAreaBottom"/>
              <a:pathLst>
                <a:path w="23543" h="21600">
                  <a:moveTo>
                    <a:pt x="675" y="0"/>
                  </a:moveTo>
                  <a:arcTo wR="675" hR="675" stAng="0" swAng="5400000"/>
                  <a:lnTo>
                    <a:pt x="0" y="20925"/>
                  </a:lnTo>
                  <a:arcTo wR="675" hR="675" stAng="16200000" swAng="5400000"/>
                  <a:lnTo>
                    <a:pt x="22868" y="21600"/>
                  </a:lnTo>
                  <a:arcTo wR="675" hR="675" stAng="10800000" swAng="5400000"/>
                  <a:lnTo>
                    <a:pt x="23543" y="675"/>
                  </a:lnTo>
                  <a:arcTo wR="675" hR="675" stAng="5400000" swAng="5400000"/>
                  <a:close/>
                </a:path>
              </a:pathLst>
            </a:custGeom>
            <a:solidFill>
              <a:srgbClr val="91cc8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AutoShape 3"/>
            <p:cNvSpPr/>
            <p:nvPr/>
          </p:nvSpPr>
          <p:spPr>
            <a:xfrm>
              <a:off x="2111400" y="4838760"/>
              <a:ext cx="152280" cy="673200"/>
            </a:xfrm>
            <a:custGeom>
              <a:avLst/>
              <a:gdLst>
                <a:gd name="textAreaLeft" fmla="*/ 0 w 152280"/>
                <a:gd name="textAreaRight" fmla="*/ 152640 w 152280"/>
                <a:gd name="textAreaTop" fmla="*/ 0 h 673200"/>
                <a:gd name="textAreaBottom" fmla="*/ 673560 h 673200"/>
              </a:gdLst>
              <a:ahLst/>
              <a:rect l="textAreaLeft" t="textAreaTop" r="textAreaRight" b="textAreaBottom"/>
              <a:pathLst>
                <a:path w="21600" h="95315">
                  <a:moveTo>
                    <a:pt x="0" y="0"/>
                  </a:moveTo>
                  <a:arcTo wR="0" hR="0" stAng="10800000" swAng="-5400000"/>
                  <a:lnTo>
                    <a:pt x="0" y="95315"/>
                  </a:lnTo>
                  <a:arcTo wR="0" hR="0" stAng="16200000" swAng="-5400000"/>
                  <a:lnTo>
                    <a:pt x="21600" y="95315"/>
                  </a:lnTo>
                  <a:arcTo wR="0" hR="0" stAng="10800000" swAng="-5400000"/>
                  <a:lnTo>
                    <a:pt x="21600" y="0"/>
                  </a:lnTo>
                  <a:arcTo wR="0" hR="0" stAng="16200000" swAng="-5400000"/>
                  <a:close/>
                </a:path>
              </a:pathLst>
            </a:custGeom>
            <a:solidFill>
              <a:srgbClr val="996a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AutoShape 9"/>
            <p:cNvSpPr/>
            <p:nvPr/>
          </p:nvSpPr>
          <p:spPr>
            <a:xfrm>
              <a:off x="2112840" y="4476600"/>
              <a:ext cx="152640" cy="425520"/>
            </a:xfrm>
            <a:custGeom>
              <a:avLst/>
              <a:gdLst>
                <a:gd name="textAreaLeft" fmla="*/ 0 w 152640"/>
                <a:gd name="textAreaRight" fmla="*/ 153000 w 152640"/>
                <a:gd name="textAreaTop" fmla="*/ 0 h 425520"/>
                <a:gd name="textAreaBottom" fmla="*/ 425880 h 425520"/>
              </a:gdLst>
              <a:ahLst/>
              <a:rect l="textAreaLeft" t="textAreaTop" r="textAreaRight" b="textAreaBottom"/>
              <a:pathLst>
                <a:path w="21600" h="60124">
                  <a:moveTo>
                    <a:pt x="0" y="0"/>
                  </a:moveTo>
                  <a:arcTo wR="0" hR="0" stAng="10800000" swAng="-5400000"/>
                  <a:lnTo>
                    <a:pt x="0" y="60124"/>
                  </a:lnTo>
                  <a:arcTo wR="0" hR="0" stAng="16200000" swAng="-5400000"/>
                  <a:lnTo>
                    <a:pt x="21600" y="60124"/>
                  </a:lnTo>
                  <a:arcTo wR="0" hR="0" stAng="10800000" swAng="-5400000"/>
                  <a:lnTo>
                    <a:pt x="21600" y="0"/>
                  </a:lnTo>
                  <a:arcTo wR="0" hR="0" stAng="16200000" swAng="-5400000"/>
                  <a:close/>
                </a:path>
              </a:pathLst>
            </a:custGeom>
            <a:solidFill>
              <a:srgbClr val="f9964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AutoShape 45"/>
            <p:cNvSpPr/>
            <p:nvPr/>
          </p:nvSpPr>
          <p:spPr>
            <a:xfrm>
              <a:off x="2111400" y="3067200"/>
              <a:ext cx="152280" cy="1466640"/>
            </a:xfrm>
            <a:custGeom>
              <a:avLst/>
              <a:gdLst>
                <a:gd name="textAreaLeft" fmla="*/ 3240 w 152280"/>
                <a:gd name="textAreaRight" fmla="*/ 149040 w 152280"/>
                <a:gd name="textAreaTop" fmla="*/ 3240 h 1466640"/>
                <a:gd name="textAreaBottom" fmla="*/ 1463400 h 1466640"/>
              </a:gdLst>
              <a:ahLst/>
              <a:rect l="textAreaLeft" t="textAreaTop" r="textAreaRight" b="textAreaBottom"/>
              <a:pathLst>
                <a:path w="21600" h="207594">
                  <a:moveTo>
                    <a:pt x="675" y="0"/>
                  </a:moveTo>
                  <a:arcTo wR="675" hR="675" stAng="0" swAng="5400000"/>
                  <a:lnTo>
                    <a:pt x="0" y="206919"/>
                  </a:lnTo>
                  <a:arcTo wR="675" hR="675" stAng="16200000" swAng="5400000"/>
                  <a:lnTo>
                    <a:pt x="20925" y="207594"/>
                  </a:lnTo>
                  <a:arcTo wR="675" hR="675" stAng="10800000" swAng="5400000"/>
                  <a:lnTo>
                    <a:pt x="21600" y="675"/>
                  </a:lnTo>
                  <a:arcTo wR="675" hR="675" stAng="5400000" swAng="5400000"/>
                  <a:close/>
                </a:path>
              </a:pathLst>
            </a:custGeom>
            <a:solidFill>
              <a:srgbClr val="fc212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AutoShape 49"/>
            <p:cNvSpPr/>
            <p:nvPr/>
          </p:nvSpPr>
          <p:spPr>
            <a:xfrm flipH="1">
              <a:off x="2104920" y="2987640"/>
              <a:ext cx="152640" cy="88920"/>
            </a:xfrm>
            <a:prstGeom prst="rtTriangle">
              <a:avLst/>
            </a:prstGeom>
            <a:solidFill>
              <a:srgbClr val="c872b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7640" bIns="-176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AutoShape 10"/>
            <p:cNvSpPr/>
            <p:nvPr/>
          </p:nvSpPr>
          <p:spPr>
            <a:xfrm>
              <a:off x="2109960" y="2616120"/>
              <a:ext cx="152280" cy="5033880"/>
            </a:xfrm>
            <a:custGeom>
              <a:avLst/>
              <a:gdLst>
                <a:gd name="textAreaLeft" fmla="*/ 17640 w 152280"/>
                <a:gd name="textAreaRight" fmla="*/ 134640 w 152280"/>
                <a:gd name="textAreaTop" fmla="*/ 17640 h 5033880"/>
                <a:gd name="textAreaBottom" fmla="*/ 5016240 h 5033880"/>
              </a:gdLst>
              <a:ahLst/>
              <a:rect l="textAreaLeft" t="textAreaTop" r="textAreaRight" b="textAreaBottom"/>
              <a:pathLst>
                <a:path w="21600" h="712392">
                  <a:moveTo>
                    <a:pt x="3600" y="0"/>
                  </a:moveTo>
                  <a:arcTo wR="3600" hR="3600" stAng="0" swAng="5400000"/>
                  <a:lnTo>
                    <a:pt x="0" y="708792"/>
                  </a:lnTo>
                  <a:arcTo wR="3600" hR="3600" stAng="16200000" swAng="5400000"/>
                  <a:lnTo>
                    <a:pt x="18000" y="712392"/>
                  </a:lnTo>
                  <a:arcTo wR="3600" hR="3600" stAng="10800000" swAng="5400000"/>
                  <a:lnTo>
                    <a:pt x="21600" y="3600"/>
                  </a:lnTo>
                  <a:arcTo wR="3600" hR="3600" stAng="5400000" swAng="5400000"/>
                  <a:close/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Text Box 11"/>
            <p:cNvSpPr/>
            <p:nvPr/>
          </p:nvSpPr>
          <p:spPr>
            <a:xfrm>
              <a:off x="2256120" y="6504120"/>
              <a:ext cx="1022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0.76-1.00</a:t>
              </a:r>
              <a:r>
                <a:rPr b="0" lang="en-GB" sz="800" spc="-1" strike="noStrike">
                  <a:solidFill>
                    <a:srgbClr val="0808ff"/>
                  </a:solidFill>
                  <a:latin typeface="Arial"/>
                </a:rPr>
                <a:t> </a:t>
              </a:r>
              <a:r>
                <a:rPr b="0" i="1" lang="en-GB" sz="800" spc="-1" strike="noStrike">
                  <a:solidFill>
                    <a:srgbClr val="0808ff"/>
                  </a:solidFill>
                  <a:latin typeface="Arial"/>
                </a:rPr>
                <a:t>PSII-W,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800" spc="-1" strike="noStrike">
                  <a:solidFill>
                    <a:srgbClr val="0808ff"/>
                  </a:solidFill>
                  <a:latin typeface="Arial"/>
                </a:rPr>
                <a:t>PSI-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Text Box 13"/>
            <p:cNvSpPr/>
            <p:nvPr/>
          </p:nvSpPr>
          <p:spPr>
            <a:xfrm>
              <a:off x="1901880" y="2011320"/>
              <a:ext cx="120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5D bins+ge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Text Box 16"/>
            <p:cNvSpPr/>
            <p:nvPr/>
          </p:nvSpPr>
          <p:spPr>
            <a:xfrm>
              <a:off x="2257200" y="4611600"/>
              <a:ext cx="1497600" cy="28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C-0.60L </a:t>
              </a:r>
              <a:r>
                <a:rPr b="0" i="1" lang="en-GB" sz="800" spc="-1" strike="noStrike">
                  <a:solidFill>
                    <a:srgbClr val="0808ff"/>
                  </a:solidFill>
                  <a:latin typeface="Arial"/>
                </a:rPr>
                <a:t>Lhca4, </a:t>
              </a:r>
              <a:r>
                <a:rPr b="0" i="1" lang="en-GB" sz="800" spc="-1" strike="noStrike">
                  <a:solidFill>
                    <a:srgbClr val="03b800"/>
                  </a:solidFill>
                  <a:latin typeface="Arial"/>
                </a:rPr>
                <a:t>Rubisco-ssu,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800" spc="-1" strike="noStrike">
                  <a:solidFill>
                    <a:srgbClr val="0808ff"/>
                  </a:solidFill>
                  <a:latin typeface="Arial"/>
                </a:rPr>
                <a:t> </a:t>
              </a:r>
              <a:r>
                <a:rPr b="0" i="1" lang="en-GB" sz="800" spc="-1" strike="noStrike">
                  <a:solidFill>
                    <a:srgbClr val="ef2c2b"/>
                  </a:solidFill>
                  <a:latin typeface="Arial"/>
                </a:rPr>
                <a:t>Phe-Fe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Text Box 21"/>
            <p:cNvSpPr/>
            <p:nvPr/>
          </p:nvSpPr>
          <p:spPr>
            <a:xfrm>
              <a:off x="2335320" y="4432320"/>
              <a:ext cx="263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Text Box 22"/>
            <p:cNvSpPr/>
            <p:nvPr/>
          </p:nvSpPr>
          <p:spPr>
            <a:xfrm>
              <a:off x="2336400" y="2881440"/>
              <a:ext cx="46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5DS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Line 23"/>
            <p:cNvSpPr/>
            <p:nvPr/>
          </p:nvSpPr>
          <p:spPr>
            <a:xfrm>
              <a:off x="2271600" y="2978280"/>
              <a:ext cx="123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Text Box 24"/>
            <p:cNvSpPr/>
            <p:nvPr/>
          </p:nvSpPr>
          <p:spPr>
            <a:xfrm>
              <a:off x="2257200" y="2697120"/>
              <a:ext cx="1145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0.78-1.00 </a:t>
              </a:r>
              <a:r>
                <a:rPr b="0" i="1" lang="en-GB" sz="800" spc="-1" strike="noStrike">
                  <a:solidFill>
                    <a:srgbClr val="ef2c2b"/>
                  </a:solidFill>
                  <a:latin typeface="Arial"/>
                </a:rPr>
                <a:t>Ccd1, </a:t>
              </a:r>
              <a:r>
                <a:rPr b="0" i="1" lang="en-GB" sz="800" spc="-1" strike="noStrike">
                  <a:solidFill>
                    <a:srgbClr val="03b800"/>
                  </a:solidFill>
                  <a:latin typeface="Arial"/>
                </a:rPr>
                <a:t>Sut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Line 29"/>
            <p:cNvSpPr/>
            <p:nvPr/>
          </p:nvSpPr>
          <p:spPr>
            <a:xfrm>
              <a:off x="2295360" y="5602320"/>
              <a:ext cx="123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Line 30"/>
            <p:cNvSpPr/>
            <p:nvPr/>
          </p:nvSpPr>
          <p:spPr>
            <a:xfrm flipV="1">
              <a:off x="2303640" y="5511960"/>
              <a:ext cx="0" cy="188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Text Box 31"/>
            <p:cNvSpPr/>
            <p:nvPr/>
          </p:nvSpPr>
          <p:spPr>
            <a:xfrm>
              <a:off x="2346480" y="4807080"/>
              <a:ext cx="45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5DL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Line 35"/>
            <p:cNvSpPr/>
            <p:nvPr/>
          </p:nvSpPr>
          <p:spPr>
            <a:xfrm>
              <a:off x="1971720" y="4540320"/>
              <a:ext cx="4190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Text Box 36"/>
            <p:cNvSpPr/>
            <p:nvPr/>
          </p:nvSpPr>
          <p:spPr>
            <a:xfrm>
              <a:off x="2257200" y="3672000"/>
              <a:ext cx="1145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C-0.63S </a:t>
              </a:r>
              <a:r>
                <a:rPr b="0" i="1" lang="en-GB" sz="800" spc="-1" strike="noStrike">
                  <a:solidFill>
                    <a:srgbClr val="03b800"/>
                  </a:solidFill>
                  <a:latin typeface="Arial"/>
                </a:rPr>
                <a:t>Rubisco-ss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Line 39"/>
            <p:cNvSpPr/>
            <p:nvPr/>
          </p:nvSpPr>
          <p:spPr>
            <a:xfrm>
              <a:off x="2276640" y="4903920"/>
              <a:ext cx="123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Text Box 40"/>
            <p:cNvSpPr/>
            <p:nvPr/>
          </p:nvSpPr>
          <p:spPr>
            <a:xfrm>
              <a:off x="2346480" y="5504040"/>
              <a:ext cx="790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5DL-9, 5DL-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Text Box 46"/>
            <p:cNvSpPr/>
            <p:nvPr/>
          </p:nvSpPr>
          <p:spPr>
            <a:xfrm>
              <a:off x="2334960" y="2976480"/>
              <a:ext cx="46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5DS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Line 47"/>
            <p:cNvSpPr/>
            <p:nvPr/>
          </p:nvSpPr>
          <p:spPr>
            <a:xfrm>
              <a:off x="2270160" y="3073320"/>
              <a:ext cx="123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Text Box 50"/>
            <p:cNvSpPr/>
            <p:nvPr/>
          </p:nvSpPr>
          <p:spPr>
            <a:xfrm>
              <a:off x="2677680" y="2928960"/>
              <a:ext cx="46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5DS-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Text Box 52"/>
            <p:cNvSpPr/>
            <p:nvPr/>
          </p:nvSpPr>
          <p:spPr>
            <a:xfrm>
              <a:off x="2260080" y="5118120"/>
              <a:ext cx="610560" cy="191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0.60-0.7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Text Box 53"/>
            <p:cNvSpPr/>
            <p:nvPr/>
          </p:nvSpPr>
          <p:spPr>
            <a:xfrm>
              <a:off x="2256840" y="5967360"/>
              <a:ext cx="932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800" spc="-1" strike="noStrike">
                  <a:solidFill>
                    <a:srgbClr val="03b800"/>
                  </a:solidFill>
                  <a:latin typeface="Arial"/>
                </a:rPr>
                <a:t>Rubisco-sbp-a</a:t>
              </a:r>
              <a:r>
                <a:rPr b="0" i="1" lang="en-GB" sz="800" spc="-1" strike="noStrike">
                  <a:solidFill>
                    <a:srgbClr val="0808ff"/>
                  </a:solidFill>
                  <a:latin typeface="Arial"/>
                </a:rPr>
                <a:t>,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800" spc="-1" strike="noStrike">
                  <a:solidFill>
                    <a:srgbClr val="fc0000"/>
                  </a:solidFill>
                  <a:latin typeface="Arial"/>
                </a:rPr>
                <a:t>Sgr,</a:t>
              </a:r>
              <a:r>
                <a:rPr b="0" i="1" lang="en-GB" sz="800" spc="-1" strike="noStrike">
                  <a:solidFill>
                    <a:srgbClr val="ef2c2b"/>
                  </a:solidFill>
                  <a:latin typeface="Arial"/>
                </a:rPr>
                <a:t> Mg-Ppo IX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Text Box 78"/>
            <p:cNvSpPr/>
            <p:nvPr/>
          </p:nvSpPr>
          <p:spPr>
            <a:xfrm>
              <a:off x="2259720" y="5592600"/>
              <a:ext cx="515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800" spc="-1" strike="noStrike">
                  <a:solidFill>
                    <a:srgbClr val="ef2c2b"/>
                  </a:solidFill>
                  <a:latin typeface="Arial"/>
                </a:rPr>
                <a:t>Psy3-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1" name="Group 96"/>
          <p:cNvGrpSpPr/>
          <p:nvPr/>
        </p:nvGrpSpPr>
        <p:grpSpPr>
          <a:xfrm>
            <a:off x="5595840" y="3828960"/>
            <a:ext cx="1155600" cy="1517040"/>
            <a:chOff x="5595840" y="3828960"/>
            <a:chExt cx="1155600" cy="1517040"/>
          </a:xfrm>
        </p:grpSpPr>
        <p:sp>
          <p:nvSpPr>
            <p:cNvPr id="662" name="pole tekstowe 4"/>
            <p:cNvSpPr/>
            <p:nvPr/>
          </p:nvSpPr>
          <p:spPr>
            <a:xfrm>
              <a:off x="5929200" y="3866760"/>
              <a:ext cx="822240" cy="1479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SPA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Ca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DI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63" name="Picture 2" descr=""/>
            <p:cNvPicPr/>
            <p:nvPr/>
          </p:nvPicPr>
          <p:blipFill>
            <a:blip r:embed="rId4"/>
            <a:srcRect l="83442" t="0" r="10504" b="58528"/>
            <a:stretch/>
          </p:blipFill>
          <p:spPr>
            <a:xfrm>
              <a:off x="5595840" y="3828960"/>
              <a:ext cx="387360" cy="14713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64" name="Line 135"/>
          <p:cNvSpPr/>
          <p:nvPr/>
        </p:nvSpPr>
        <p:spPr>
          <a:xfrm>
            <a:off x="5538960" y="2638440"/>
            <a:ext cx="0" cy="49467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5" name="Picture 2" descr=""/>
          <p:cNvPicPr/>
          <p:nvPr/>
        </p:nvPicPr>
        <p:blipFill>
          <a:blip r:embed="rId1"/>
          <a:stretch/>
        </p:blipFill>
        <p:spPr>
          <a:xfrm>
            <a:off x="3867120" y="2444760"/>
            <a:ext cx="2762280" cy="4756320"/>
          </a:xfrm>
          <a:prstGeom prst="rect">
            <a:avLst/>
          </a:prstGeom>
          <a:ln w="0">
            <a:noFill/>
          </a:ln>
        </p:spPr>
      </p:pic>
      <p:sp>
        <p:nvSpPr>
          <p:cNvPr id="666" name="AutoShape 3"/>
          <p:cNvSpPr/>
          <p:nvPr/>
        </p:nvSpPr>
        <p:spPr>
          <a:xfrm>
            <a:off x="2606760" y="5219640"/>
            <a:ext cx="152280" cy="191124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911240"/>
              <a:gd name="textAreaBottom" fmla="*/ 1893600 h 1911240"/>
            </a:gdLst>
            <a:ahLst/>
            <a:rect l="textAreaLeft" t="textAreaTop" r="textAreaRight" b="textAreaBottom"/>
            <a:pathLst>
              <a:path w="21600" h="270509">
                <a:moveTo>
                  <a:pt x="3600" y="0"/>
                </a:moveTo>
                <a:arcTo wR="3600" hR="3600" stAng="0" swAng="5400000"/>
                <a:lnTo>
                  <a:pt x="0" y="266909"/>
                </a:lnTo>
                <a:arcTo wR="3600" hR="3600" stAng="16200000" swAng="5400000"/>
                <a:lnTo>
                  <a:pt x="18000" y="270509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55c1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7" name="Picture 40" descr="6A Screen shot 2013-01-10 at 12"/>
          <p:cNvPicPr/>
          <p:nvPr/>
        </p:nvPicPr>
        <p:blipFill>
          <a:blip r:embed="rId2"/>
          <a:stretch/>
        </p:blipFill>
        <p:spPr>
          <a:xfrm>
            <a:off x="152280" y="2590920"/>
            <a:ext cx="246240" cy="4572000"/>
          </a:xfrm>
          <a:prstGeom prst="rect">
            <a:avLst/>
          </a:prstGeom>
          <a:ln w="0">
            <a:noFill/>
          </a:ln>
        </p:spPr>
      </p:pic>
      <p:sp>
        <p:nvSpPr>
          <p:cNvPr id="668" name="AutoShape 4"/>
          <p:cNvSpPr/>
          <p:nvPr/>
        </p:nvSpPr>
        <p:spPr>
          <a:xfrm>
            <a:off x="2611440" y="2616120"/>
            <a:ext cx="149400" cy="1346400"/>
          </a:xfrm>
          <a:custGeom>
            <a:avLst/>
            <a:gdLst>
              <a:gd name="textAreaLeft" fmla="*/ 17640 w 149400"/>
              <a:gd name="textAreaRight" fmla="*/ 131760 w 149400"/>
              <a:gd name="textAreaTop" fmla="*/ 17640 h 1346400"/>
              <a:gd name="textAreaBottom" fmla="*/ 1328760 h 1346400"/>
            </a:gdLst>
            <a:ahLst/>
            <a:rect l="textAreaLeft" t="textAreaTop" r="textAreaRight" b="textAreaBottom"/>
            <a:pathLst>
              <a:path w="21600" h="194244">
                <a:moveTo>
                  <a:pt x="3600" y="0"/>
                </a:moveTo>
                <a:arcTo wR="3600" hR="3600" stAng="0" swAng="5400000"/>
                <a:lnTo>
                  <a:pt x="0" y="190644"/>
                </a:lnTo>
                <a:arcTo wR="3600" hR="3600" stAng="16200000" swAng="5400000"/>
                <a:lnTo>
                  <a:pt x="18000" y="194244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436db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AutoShape 6"/>
          <p:cNvSpPr/>
          <p:nvPr/>
        </p:nvSpPr>
        <p:spPr>
          <a:xfrm>
            <a:off x="2606760" y="3879720"/>
            <a:ext cx="152280" cy="997200"/>
          </a:xfrm>
          <a:custGeom>
            <a:avLst/>
            <a:gdLst>
              <a:gd name="textAreaLeft" fmla="*/ 3240 w 152280"/>
              <a:gd name="textAreaRight" fmla="*/ 149040 w 152280"/>
              <a:gd name="textAreaTop" fmla="*/ 3240 h 997200"/>
              <a:gd name="textAreaBottom" fmla="*/ 993960 h 997200"/>
            </a:gdLst>
            <a:ahLst/>
            <a:rect l="textAreaLeft" t="textAreaTop" r="textAreaRight" b="textAreaBottom"/>
            <a:pathLst>
              <a:path w="21600" h="141164">
                <a:moveTo>
                  <a:pt x="675" y="0"/>
                </a:moveTo>
                <a:arcTo wR="675" hR="675" stAng="0" swAng="5400000"/>
                <a:lnTo>
                  <a:pt x="0" y="140489"/>
                </a:lnTo>
                <a:arcTo wR="675" hR="675" stAng="16200000" swAng="5400000"/>
                <a:lnTo>
                  <a:pt x="20925" y="141164"/>
                </a:lnTo>
                <a:arcTo wR="675" hR="675" stAng="10800000" swAng="5400000"/>
                <a:lnTo>
                  <a:pt x="21600" y="675"/>
                </a:lnTo>
                <a:arcTo wR="675" hR="675" stAng="5400000" swAng="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AutoShape 8"/>
          <p:cNvSpPr/>
          <p:nvPr/>
        </p:nvSpPr>
        <p:spPr>
          <a:xfrm>
            <a:off x="2610000" y="4495680"/>
            <a:ext cx="152280" cy="685800"/>
          </a:xfrm>
          <a:custGeom>
            <a:avLst/>
            <a:gdLst>
              <a:gd name="textAreaLeft" fmla="*/ 0 w 152280"/>
              <a:gd name="textAreaRight" fmla="*/ 152640 w 152280"/>
              <a:gd name="textAreaTop" fmla="*/ 0 h 685800"/>
              <a:gd name="textAreaBottom" fmla="*/ 686160 h 685800"/>
            </a:gdLst>
            <a:ahLst/>
            <a:rect l="textAreaLeft" t="textAreaTop" r="textAreaRight" b="textAreaBottom"/>
            <a:pathLst>
              <a:path w="21600" h="97098">
                <a:moveTo>
                  <a:pt x="0" y="0"/>
                </a:moveTo>
                <a:arcTo wR="0" hR="0" stAng="10800000" swAng="-5400000"/>
                <a:lnTo>
                  <a:pt x="0" y="97098"/>
                </a:lnTo>
                <a:arcTo wR="0" hR="0" stAng="16200000" swAng="-5400000"/>
                <a:lnTo>
                  <a:pt x="21600" y="9709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9903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AutoShape 7"/>
          <p:cNvSpPr/>
          <p:nvPr/>
        </p:nvSpPr>
        <p:spPr>
          <a:xfrm>
            <a:off x="2608200" y="5130720"/>
            <a:ext cx="152640" cy="235080"/>
          </a:xfrm>
          <a:custGeom>
            <a:avLst/>
            <a:gdLst>
              <a:gd name="textAreaLeft" fmla="*/ 0 w 152640"/>
              <a:gd name="textAreaRight" fmla="*/ 153000 w 152640"/>
              <a:gd name="textAreaTop" fmla="*/ 0 h 235080"/>
              <a:gd name="textAreaBottom" fmla="*/ 235440 h 235080"/>
            </a:gdLst>
            <a:ahLst/>
            <a:rect l="textAreaLeft" t="textAreaTop" r="textAreaRight" b="textAreaBottom"/>
            <a:pathLst>
              <a:path w="21600" h="33239">
                <a:moveTo>
                  <a:pt x="0" y="0"/>
                </a:moveTo>
                <a:arcTo wR="0" hR="0" stAng="10800000" swAng="-5400000"/>
                <a:lnTo>
                  <a:pt x="0" y="33239"/>
                </a:lnTo>
                <a:arcTo wR="0" hR="0" stAng="16200000" swAng="-5400000"/>
                <a:lnTo>
                  <a:pt x="21600" y="33239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a065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AutoShape 11"/>
          <p:cNvSpPr/>
          <p:nvPr/>
        </p:nvSpPr>
        <p:spPr>
          <a:xfrm>
            <a:off x="2606760" y="2616120"/>
            <a:ext cx="152280" cy="45133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4513320"/>
              <a:gd name="textAreaBottom" fmla="*/ 4495680 h 4513320"/>
            </a:gdLst>
            <a:ahLst/>
            <a:rect l="textAreaLeft" t="textAreaTop" r="textAreaRight" b="textAreaBottom"/>
            <a:pathLst>
              <a:path w="21600" h="638728">
                <a:moveTo>
                  <a:pt x="3600" y="0"/>
                </a:moveTo>
                <a:arcTo wR="3600" hR="3600" stAng="0" swAng="5400000"/>
                <a:lnTo>
                  <a:pt x="0" y="635128"/>
                </a:lnTo>
                <a:arcTo wR="3600" hR="3600" stAng="16200000" swAng="5400000"/>
                <a:lnTo>
                  <a:pt x="18000" y="638728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Text Box 12"/>
          <p:cNvSpPr/>
          <p:nvPr/>
        </p:nvSpPr>
        <p:spPr>
          <a:xfrm>
            <a:off x="2755440" y="607536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90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Text Box 13"/>
          <p:cNvSpPr/>
          <p:nvPr/>
        </p:nvSpPr>
        <p:spPr>
          <a:xfrm>
            <a:off x="14688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A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Text Box 14"/>
          <p:cNvSpPr/>
          <p:nvPr/>
        </p:nvSpPr>
        <p:spPr>
          <a:xfrm>
            <a:off x="240336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A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Text Box 15"/>
          <p:cNvSpPr/>
          <p:nvPr/>
        </p:nvSpPr>
        <p:spPr>
          <a:xfrm>
            <a:off x="402048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A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Text Box 16"/>
          <p:cNvSpPr/>
          <p:nvPr/>
        </p:nvSpPr>
        <p:spPr>
          <a:xfrm>
            <a:off x="2757960" y="4726080"/>
            <a:ext cx="54180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55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8" name="Picture 17" descr="Chrom blank Screen shot 2013-01-07 at 10"/>
          <p:cNvPicPr/>
          <p:nvPr/>
        </p:nvPicPr>
        <p:blipFill>
          <a:blip r:embed="rId3">
            <a:lum contrast="-2000"/>
          </a:blip>
          <a:srcRect l="0" t="0" r="7663" b="0"/>
          <a:stretch/>
        </p:blipFill>
        <p:spPr>
          <a:xfrm>
            <a:off x="179280" y="5067360"/>
            <a:ext cx="149400" cy="417600"/>
          </a:xfrm>
          <a:prstGeom prst="rect">
            <a:avLst/>
          </a:prstGeom>
          <a:ln w="0">
            <a:noFill/>
          </a:ln>
        </p:spPr>
      </p:pic>
      <p:sp>
        <p:nvSpPr>
          <p:cNvPr id="679" name="Oval 18"/>
          <p:cNvSpPr/>
          <p:nvPr/>
        </p:nvSpPr>
        <p:spPr>
          <a:xfrm>
            <a:off x="177840" y="4413240"/>
            <a:ext cx="15228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Text Box 19"/>
          <p:cNvSpPr/>
          <p:nvPr/>
        </p:nvSpPr>
        <p:spPr>
          <a:xfrm>
            <a:off x="2832120" y="438156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Text Box 22"/>
          <p:cNvSpPr/>
          <p:nvPr/>
        </p:nvSpPr>
        <p:spPr>
          <a:xfrm>
            <a:off x="2754000" y="3129120"/>
            <a:ext cx="95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65-1.00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Wcab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Fe-NADP(H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Text Box 25"/>
          <p:cNvSpPr/>
          <p:nvPr/>
        </p:nvSpPr>
        <p:spPr>
          <a:xfrm>
            <a:off x="2843280" y="504036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AL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Line 26"/>
          <p:cNvSpPr/>
          <p:nvPr/>
        </p:nvSpPr>
        <p:spPr>
          <a:xfrm>
            <a:off x="177840" y="5219640"/>
            <a:ext cx="15696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Line 27"/>
          <p:cNvSpPr/>
          <p:nvPr/>
        </p:nvSpPr>
        <p:spPr>
          <a:xfrm>
            <a:off x="2468520" y="448956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Line 29"/>
          <p:cNvSpPr/>
          <p:nvPr/>
        </p:nvSpPr>
        <p:spPr>
          <a:xfrm>
            <a:off x="2773440" y="513720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Text Box 30"/>
          <p:cNvSpPr/>
          <p:nvPr/>
        </p:nvSpPr>
        <p:spPr>
          <a:xfrm>
            <a:off x="2843280" y="525636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AL-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Text Box 34"/>
          <p:cNvSpPr/>
          <p:nvPr/>
        </p:nvSpPr>
        <p:spPr>
          <a:xfrm>
            <a:off x="2835000" y="4081320"/>
            <a:ext cx="1073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AS-5, 6AS-1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RIS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Line 35"/>
          <p:cNvSpPr/>
          <p:nvPr/>
        </p:nvSpPr>
        <p:spPr>
          <a:xfrm>
            <a:off x="2766960" y="535320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Text Box 37"/>
          <p:cNvSpPr/>
          <p:nvPr/>
        </p:nvSpPr>
        <p:spPr>
          <a:xfrm>
            <a:off x="2756160" y="5164200"/>
            <a:ext cx="117720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5-0.90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po1(Ppx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Text Box 41"/>
          <p:cNvSpPr/>
          <p:nvPr/>
        </p:nvSpPr>
        <p:spPr>
          <a:xfrm>
            <a:off x="317520" y="2590920"/>
            <a:ext cx="2349360" cy="455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7p78.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075-6A (0.65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754-6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458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11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468-6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964-6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382-6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664-6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742-6A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899.1 (0.35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34 (0.35-1.00h) (0.65-1.00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840-6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663-6A (0.65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6208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8</a:t>
            </a:r>
            <a:r>
              <a:rPr b="0" lang="en-US" sz="600" spc="-1" strike="noStrike">
                <a:solidFill>
                  <a:srgbClr val="fa9335"/>
                </a:solidFill>
                <a:latin typeface="Arial"/>
              </a:rPr>
              <a:t>(Cxp3) (0.65-1.00ab),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 psr967.4 (0.65-1.00b),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573-6A (0.65-1.00f)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	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              wPt-2822-6A (0.65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398b (0.35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784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063-6A (C-0.55Ly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3 (C-0.55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17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902-6A (0.35-1.00Sf)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rsq805</a:t>
            </a:r>
            <a:r>
              <a:rPr b="0" lang="en-US" sz="600" spc="-1" strike="noStrike">
                <a:solidFill>
                  <a:srgbClr val="ff9a02"/>
                </a:solidFill>
                <a:latin typeface="Arial"/>
              </a:rPr>
              <a:t>(Embp) (C-0.55Lb),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	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                    psp3071 (C-0.42L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csb112</a:t>
            </a:r>
            <a:r>
              <a:rPr b="0" lang="en-US" sz="600" spc="-1" strike="noStrike">
                <a:solidFill>
                  <a:srgbClr val="ff9a02"/>
                </a:solidFill>
                <a:latin typeface="Arial"/>
              </a:rPr>
              <a:t>(Dhn5) (0.90-1.00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18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2p64.12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572-6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17 (0.83-1.00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5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mtd12h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4140, wPt-6829 (0.90-1.00h), wPt-8954 (0.90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696-6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548-6A, wPt-2216 (0.90-1.00f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6716-6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572-6A (0.90-1.00h), wPt-1642 (0.90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124-6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04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4345-6A, wPt-7204 (0.90-1.00f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7p64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268-6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Text Box 43"/>
          <p:cNvSpPr/>
          <p:nvPr/>
        </p:nvSpPr>
        <p:spPr>
          <a:xfrm>
            <a:off x="317520" y="5124600"/>
            <a:ext cx="10540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56 (0.55-0.9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Line 44"/>
          <p:cNvSpPr/>
          <p:nvPr/>
        </p:nvSpPr>
        <p:spPr>
          <a:xfrm>
            <a:off x="2787480" y="41720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Line 45"/>
          <p:cNvSpPr/>
          <p:nvPr/>
        </p:nvSpPr>
        <p:spPr>
          <a:xfrm flipV="1">
            <a:off x="2787480" y="3873600"/>
            <a:ext cx="0" cy="622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Line 51"/>
          <p:cNvSpPr/>
          <p:nvPr/>
        </p:nvSpPr>
        <p:spPr>
          <a:xfrm>
            <a:off x="5505480" y="2647800"/>
            <a:ext cx="0" cy="441324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Text Box 53"/>
          <p:cNvSpPr/>
          <p:nvPr/>
        </p:nvSpPr>
        <p:spPr>
          <a:xfrm>
            <a:off x="2757240" y="4815000"/>
            <a:ext cx="43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b-Lc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Line 51"/>
          <p:cNvSpPr/>
          <p:nvPr/>
        </p:nvSpPr>
        <p:spPr>
          <a:xfrm>
            <a:off x="4648320" y="2643120"/>
            <a:ext cx="0" cy="449748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7" name="Group 96"/>
          <p:cNvGrpSpPr/>
          <p:nvPr/>
        </p:nvGrpSpPr>
        <p:grpSpPr>
          <a:xfrm>
            <a:off x="5549760" y="5904000"/>
            <a:ext cx="1079640" cy="733320"/>
            <a:chOff x="5549760" y="5904000"/>
            <a:chExt cx="1079640" cy="733320"/>
          </a:xfrm>
        </p:grpSpPr>
        <p:pic>
          <p:nvPicPr>
            <p:cNvPr id="698" name="Picture 2" descr=""/>
            <p:cNvPicPr/>
            <p:nvPr/>
          </p:nvPicPr>
          <p:blipFill>
            <a:blip r:embed="rId4"/>
            <a:srcRect l="82022" t="2796" r="9405" b="82226"/>
            <a:stretch/>
          </p:blipFill>
          <p:spPr>
            <a:xfrm>
              <a:off x="5556240" y="6058080"/>
              <a:ext cx="358920" cy="555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9" name="Prostokąt 35"/>
            <p:cNvSpPr/>
            <p:nvPr/>
          </p:nvSpPr>
          <p:spPr>
            <a:xfrm>
              <a:off x="5826240" y="5904000"/>
              <a:ext cx="80316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DW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Y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DI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00" name="Picture 2" descr=""/>
            <p:cNvPicPr/>
            <p:nvPr/>
          </p:nvPicPr>
          <p:blipFill>
            <a:blip r:embed="rId5"/>
            <a:srcRect l="82156" t="2063" r="9719" b="93897"/>
            <a:stretch/>
          </p:blipFill>
          <p:spPr>
            <a:xfrm>
              <a:off x="5549760" y="5924520"/>
              <a:ext cx="349560" cy="1494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1" name="Picture 2" descr=""/>
          <p:cNvPicPr/>
          <p:nvPr/>
        </p:nvPicPr>
        <p:blipFill>
          <a:blip r:embed="rId1"/>
          <a:stretch/>
        </p:blipFill>
        <p:spPr>
          <a:xfrm>
            <a:off x="3825720" y="2457360"/>
            <a:ext cx="2752920" cy="4789440"/>
          </a:xfrm>
          <a:prstGeom prst="rect">
            <a:avLst/>
          </a:prstGeom>
          <a:ln w="0">
            <a:noFill/>
          </a:ln>
        </p:spPr>
      </p:pic>
      <p:sp>
        <p:nvSpPr>
          <p:cNvPr id="702" name="Text Box 12"/>
          <p:cNvSpPr/>
          <p:nvPr/>
        </p:nvSpPr>
        <p:spPr>
          <a:xfrm>
            <a:off x="402048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B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Line 59"/>
          <p:cNvSpPr/>
          <p:nvPr/>
        </p:nvSpPr>
        <p:spPr>
          <a:xfrm>
            <a:off x="5197320" y="2679840"/>
            <a:ext cx="0" cy="44067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04" name="Group 80"/>
          <p:cNvGrpSpPr/>
          <p:nvPr/>
        </p:nvGrpSpPr>
        <p:grpSpPr>
          <a:xfrm>
            <a:off x="5334120" y="5276880"/>
            <a:ext cx="1249200" cy="1372680"/>
            <a:chOff x="5334120" y="5276880"/>
            <a:chExt cx="1249200" cy="1372680"/>
          </a:xfrm>
        </p:grpSpPr>
        <p:sp>
          <p:nvSpPr>
            <p:cNvPr id="705" name="pole tekstowe 4"/>
            <p:cNvSpPr/>
            <p:nvPr/>
          </p:nvSpPr>
          <p:spPr>
            <a:xfrm>
              <a:off x="5724720" y="5276880"/>
              <a:ext cx="858600" cy="1372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PA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W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W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TR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06" name="Picture 2" descr=""/>
            <p:cNvPicPr/>
            <p:nvPr/>
          </p:nvPicPr>
          <p:blipFill>
            <a:blip r:embed="rId2"/>
            <a:srcRect l="82274" t="3206" r="10078" b="62256"/>
            <a:stretch/>
          </p:blipFill>
          <p:spPr>
            <a:xfrm>
              <a:off x="5334120" y="5361120"/>
              <a:ext cx="450720" cy="12240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07" name="AutoShape 132"/>
          <p:cNvSpPr/>
          <p:nvPr/>
        </p:nvSpPr>
        <p:spPr>
          <a:xfrm>
            <a:off x="2401920" y="2616120"/>
            <a:ext cx="149040" cy="1778040"/>
          </a:xfrm>
          <a:custGeom>
            <a:avLst/>
            <a:gdLst>
              <a:gd name="textAreaLeft" fmla="*/ 17280 w 149040"/>
              <a:gd name="textAreaRight" fmla="*/ 131760 w 149040"/>
              <a:gd name="textAreaTop" fmla="*/ 17280 h 1778040"/>
              <a:gd name="textAreaBottom" fmla="*/ 1760760 h 1778040"/>
            </a:gdLst>
            <a:ahLst/>
            <a:rect l="textAreaLeft" t="textAreaTop" r="textAreaRight" b="textAreaBottom"/>
            <a:pathLst>
              <a:path w="21600" h="257118">
                <a:moveTo>
                  <a:pt x="3600" y="0"/>
                </a:moveTo>
                <a:arcTo wR="3600" hR="3600" stAng="0" swAng="5400000"/>
                <a:lnTo>
                  <a:pt x="0" y="253518"/>
                </a:lnTo>
                <a:arcTo wR="3600" hR="3600" stAng="16200000" swAng="5400000"/>
                <a:lnTo>
                  <a:pt x="18000" y="257118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436db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AutoShape 133"/>
          <p:cNvSpPr/>
          <p:nvPr/>
        </p:nvSpPr>
        <p:spPr>
          <a:xfrm>
            <a:off x="2400480" y="4146480"/>
            <a:ext cx="152280" cy="235080"/>
          </a:xfrm>
          <a:custGeom>
            <a:avLst/>
            <a:gdLst>
              <a:gd name="textAreaLeft" fmla="*/ 0 w 152280"/>
              <a:gd name="textAreaRight" fmla="*/ 152640 w 152280"/>
              <a:gd name="textAreaTop" fmla="*/ 0 h 235080"/>
              <a:gd name="textAreaBottom" fmla="*/ 235440 h 235080"/>
            </a:gdLst>
            <a:ahLst/>
            <a:rect l="textAreaLeft" t="textAreaTop" r="textAreaRight" b="textAreaBottom"/>
            <a:pathLst>
              <a:path w="21600" h="33317">
                <a:moveTo>
                  <a:pt x="0" y="0"/>
                </a:moveTo>
                <a:arcTo wR="0" hR="0" stAng="10800000" swAng="-5400000"/>
                <a:lnTo>
                  <a:pt x="0" y="33317"/>
                </a:lnTo>
                <a:arcTo wR="0" hR="0" stAng="16200000" swAng="-5400000"/>
                <a:lnTo>
                  <a:pt x="21600" y="33317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AutoShape 134"/>
          <p:cNvSpPr/>
          <p:nvPr/>
        </p:nvSpPr>
        <p:spPr>
          <a:xfrm>
            <a:off x="2397240" y="4336920"/>
            <a:ext cx="152280" cy="736560"/>
          </a:xfrm>
          <a:custGeom>
            <a:avLst/>
            <a:gdLst>
              <a:gd name="textAreaLeft" fmla="*/ 3240 w 152280"/>
              <a:gd name="textAreaRight" fmla="*/ 149040 w 152280"/>
              <a:gd name="textAreaTop" fmla="*/ 3240 h 736560"/>
              <a:gd name="textAreaBottom" fmla="*/ 733320 h 736560"/>
            </a:gdLst>
            <a:ahLst/>
            <a:rect l="textAreaLeft" t="textAreaTop" r="textAreaRight" b="textAreaBottom"/>
            <a:pathLst>
              <a:path w="21600" h="104281">
                <a:moveTo>
                  <a:pt x="675" y="0"/>
                </a:moveTo>
                <a:arcTo wR="675" hR="675" stAng="0" swAng="5400000"/>
                <a:lnTo>
                  <a:pt x="0" y="103606"/>
                </a:lnTo>
                <a:arcTo wR="675" hR="675" stAng="16200000" swAng="5400000"/>
                <a:lnTo>
                  <a:pt x="20925" y="104281"/>
                </a:lnTo>
                <a:arcTo wR="675" hR="675" stAng="10800000" swAng="5400000"/>
                <a:lnTo>
                  <a:pt x="21600" y="675"/>
                </a:lnTo>
                <a:arcTo wR="675" hR="675" stAng="5400000" swAng="5400000"/>
                <a:close/>
              </a:path>
            </a:pathLst>
          </a:custGeom>
          <a:solidFill>
            <a:srgbClr val="8dcd8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AutoShape 135"/>
          <p:cNvSpPr/>
          <p:nvPr/>
        </p:nvSpPr>
        <p:spPr>
          <a:xfrm>
            <a:off x="2397240" y="5111640"/>
            <a:ext cx="152280" cy="206388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2063880"/>
              <a:gd name="textAreaBottom" fmla="*/ 2046240 h 2063880"/>
            </a:gdLst>
            <a:ahLst/>
            <a:rect l="textAreaLeft" t="textAreaTop" r="textAreaRight" b="textAreaBottom"/>
            <a:pathLst>
              <a:path w="21600" h="292109">
                <a:moveTo>
                  <a:pt x="3600" y="0"/>
                </a:moveTo>
                <a:arcTo wR="3600" hR="3600" stAng="0" swAng="5400000"/>
                <a:lnTo>
                  <a:pt x="0" y="288509"/>
                </a:lnTo>
                <a:arcTo wR="3600" hR="3600" stAng="16200000" swAng="5400000"/>
                <a:lnTo>
                  <a:pt x="18000" y="292109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55c1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AutoShape 136"/>
          <p:cNvSpPr/>
          <p:nvPr/>
        </p:nvSpPr>
        <p:spPr>
          <a:xfrm>
            <a:off x="2400480" y="4495680"/>
            <a:ext cx="152280" cy="577800"/>
          </a:xfrm>
          <a:custGeom>
            <a:avLst/>
            <a:gdLst>
              <a:gd name="textAreaLeft" fmla="*/ 0 w 152280"/>
              <a:gd name="textAreaRight" fmla="*/ 152640 w 152280"/>
              <a:gd name="textAreaTop" fmla="*/ 0 h 577800"/>
              <a:gd name="textAreaBottom" fmla="*/ 577800 h 577800"/>
            </a:gdLst>
            <a:ahLst/>
            <a:rect l="textAreaLeft" t="textAreaTop" r="textAreaRight" b="textAreaBottom"/>
            <a:pathLst>
              <a:path w="21600" h="81815">
                <a:moveTo>
                  <a:pt x="0" y="0"/>
                </a:moveTo>
                <a:arcTo wR="0" hR="0" stAng="10800000" swAng="-5400000"/>
                <a:lnTo>
                  <a:pt x="0" y="81815"/>
                </a:lnTo>
                <a:arcTo wR="0" hR="0" stAng="16200000" swAng="-5400000"/>
                <a:lnTo>
                  <a:pt x="21600" y="81815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9903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AutoShape 137"/>
          <p:cNvSpPr/>
          <p:nvPr/>
        </p:nvSpPr>
        <p:spPr>
          <a:xfrm>
            <a:off x="2400480" y="4476600"/>
            <a:ext cx="152280" cy="457200"/>
          </a:xfrm>
          <a:custGeom>
            <a:avLst/>
            <a:gdLst>
              <a:gd name="textAreaLeft" fmla="*/ 0 w 152280"/>
              <a:gd name="textAreaRight" fmla="*/ 152640 w 152280"/>
              <a:gd name="textAreaTop" fmla="*/ 0 h 457200"/>
              <a:gd name="textAreaBottom" fmla="*/ 457560 h 457200"/>
            </a:gdLst>
            <a:ahLst/>
            <a:rect l="textAreaLeft" t="textAreaTop" r="textAreaRight" b="textAreaBottom"/>
            <a:pathLst>
              <a:path w="21600" h="64749">
                <a:moveTo>
                  <a:pt x="0" y="0"/>
                </a:moveTo>
                <a:arcTo wR="0" hR="0" stAng="10800000" swAng="-5400000"/>
                <a:lnTo>
                  <a:pt x="0" y="64749"/>
                </a:lnTo>
                <a:arcTo wR="0" hR="0" stAng="16200000" swAng="-5400000"/>
                <a:lnTo>
                  <a:pt x="21600" y="64749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5282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AutoShape 138"/>
          <p:cNvSpPr/>
          <p:nvPr/>
        </p:nvSpPr>
        <p:spPr>
          <a:xfrm>
            <a:off x="2398680" y="5073480"/>
            <a:ext cx="152280" cy="108000"/>
          </a:xfrm>
          <a:custGeom>
            <a:avLst/>
            <a:gdLst>
              <a:gd name="textAreaLeft" fmla="*/ 0 w 152280"/>
              <a:gd name="textAreaRight" fmla="*/ 152280 w 15228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30427" h="21600">
                <a:moveTo>
                  <a:pt x="0" y="0"/>
                </a:moveTo>
                <a:arcTo wR="0" hR="0" stAng="10800000" swAng="-5400000"/>
                <a:lnTo>
                  <a:pt x="0" y="21600"/>
                </a:lnTo>
                <a:arcTo wR="0" hR="0" stAng="16200000" swAng="-5400000"/>
                <a:lnTo>
                  <a:pt x="30427" y="21600"/>
                </a:lnTo>
                <a:arcTo wR="0" hR="0" stAng="10800000" swAng="-5400000"/>
                <a:lnTo>
                  <a:pt x="30427" y="0"/>
                </a:lnTo>
                <a:arcTo wR="0" hR="0" stAng="16200000" swAng="-5400000"/>
                <a:close/>
              </a:path>
            </a:pathLst>
          </a:custGeom>
          <a:solidFill>
            <a:srgbClr val="a065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AutoShape 139"/>
          <p:cNvSpPr/>
          <p:nvPr/>
        </p:nvSpPr>
        <p:spPr>
          <a:xfrm>
            <a:off x="2397240" y="2616120"/>
            <a:ext cx="152280" cy="455796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4557960"/>
              <a:gd name="textAreaBottom" fmla="*/ 4540320 h 4557960"/>
            </a:gdLst>
            <a:ahLst/>
            <a:rect l="textAreaLeft" t="textAreaTop" r="textAreaRight" b="textAreaBottom"/>
            <a:pathLst>
              <a:path w="21600" h="645045">
                <a:moveTo>
                  <a:pt x="3600" y="0"/>
                </a:moveTo>
                <a:arcTo wR="3600" hR="3600" stAng="0" swAng="5400000"/>
                <a:lnTo>
                  <a:pt x="0" y="641445"/>
                </a:lnTo>
                <a:arcTo wR="3600" hR="3600" stAng="16200000" swAng="5400000"/>
                <a:lnTo>
                  <a:pt x="18000" y="645045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Text Box 140"/>
          <p:cNvSpPr/>
          <p:nvPr/>
        </p:nvSpPr>
        <p:spPr>
          <a:xfrm>
            <a:off x="2543400" y="6035760"/>
            <a:ext cx="1401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40-1.00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SII-10kDa,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b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Text Box 141"/>
          <p:cNvSpPr/>
          <p:nvPr/>
        </p:nvSpPr>
        <p:spPr>
          <a:xfrm>
            <a:off x="213372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B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Text Box 142"/>
          <p:cNvSpPr/>
          <p:nvPr/>
        </p:nvSpPr>
        <p:spPr>
          <a:xfrm>
            <a:off x="2547720" y="4630680"/>
            <a:ext cx="55404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76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Text Box 143"/>
          <p:cNvSpPr/>
          <p:nvPr/>
        </p:nvSpPr>
        <p:spPr>
          <a:xfrm>
            <a:off x="2622600" y="482616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Text Box 144"/>
          <p:cNvSpPr/>
          <p:nvPr/>
        </p:nvSpPr>
        <p:spPr>
          <a:xfrm>
            <a:off x="2544480" y="3303720"/>
            <a:ext cx="1381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sat 0.00-1.00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Fe-NADP(H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Text Box 145"/>
          <p:cNvSpPr/>
          <p:nvPr/>
        </p:nvSpPr>
        <p:spPr>
          <a:xfrm>
            <a:off x="2633760" y="497052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BL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Line 146"/>
          <p:cNvSpPr/>
          <p:nvPr/>
        </p:nvSpPr>
        <p:spPr>
          <a:xfrm>
            <a:off x="2259000" y="493380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Line 147"/>
          <p:cNvSpPr/>
          <p:nvPr/>
        </p:nvSpPr>
        <p:spPr>
          <a:xfrm>
            <a:off x="2563920" y="507348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Text Box 148"/>
          <p:cNvSpPr/>
          <p:nvPr/>
        </p:nvSpPr>
        <p:spPr>
          <a:xfrm>
            <a:off x="2633760" y="507852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BL-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Text Box 149"/>
          <p:cNvSpPr/>
          <p:nvPr/>
        </p:nvSpPr>
        <p:spPr>
          <a:xfrm>
            <a:off x="2626920" y="4138560"/>
            <a:ext cx="80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BS-2, 6BS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Line 150"/>
          <p:cNvSpPr/>
          <p:nvPr/>
        </p:nvSpPr>
        <p:spPr>
          <a:xfrm>
            <a:off x="2557440" y="516888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Line 151"/>
          <p:cNvSpPr/>
          <p:nvPr/>
        </p:nvSpPr>
        <p:spPr>
          <a:xfrm>
            <a:off x="2571840" y="424188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Line 152"/>
          <p:cNvSpPr/>
          <p:nvPr/>
        </p:nvSpPr>
        <p:spPr>
          <a:xfrm flipV="1">
            <a:off x="2581200" y="4146120"/>
            <a:ext cx="0" cy="190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Line 153"/>
          <p:cNvSpPr/>
          <p:nvPr/>
        </p:nvSpPr>
        <p:spPr>
          <a:xfrm>
            <a:off x="2558880" y="448308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Text Box 154"/>
          <p:cNvSpPr/>
          <p:nvPr/>
        </p:nvSpPr>
        <p:spPr>
          <a:xfrm>
            <a:off x="2623680" y="438624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BS-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Text Box 155"/>
          <p:cNvSpPr/>
          <p:nvPr/>
        </p:nvSpPr>
        <p:spPr>
          <a:xfrm>
            <a:off x="2547000" y="4294080"/>
            <a:ext cx="90000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6-1.05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Wca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Text Box 156"/>
          <p:cNvSpPr/>
          <p:nvPr/>
        </p:nvSpPr>
        <p:spPr>
          <a:xfrm>
            <a:off x="2934360" y="4905360"/>
            <a:ext cx="82080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36L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b-Lc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Text Box 157"/>
          <p:cNvSpPr/>
          <p:nvPr/>
        </p:nvSpPr>
        <p:spPr>
          <a:xfrm>
            <a:off x="2959200" y="5027760"/>
            <a:ext cx="70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SII-10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3" name="Picture 32" descr="6B Screen shot 2013-01-10 at 14"/>
          <p:cNvPicPr/>
          <p:nvPr/>
        </p:nvPicPr>
        <p:blipFill>
          <a:blip r:embed="rId3"/>
          <a:stretch/>
        </p:blipFill>
        <p:spPr>
          <a:xfrm>
            <a:off x="185760" y="2575080"/>
            <a:ext cx="266760" cy="4647960"/>
          </a:xfrm>
          <a:prstGeom prst="rect">
            <a:avLst/>
          </a:prstGeom>
          <a:ln w="0">
            <a:noFill/>
          </a:ln>
        </p:spPr>
      </p:pic>
      <p:sp>
        <p:nvSpPr>
          <p:cNvPr id="734" name="Text Box 10"/>
          <p:cNvSpPr/>
          <p:nvPr/>
        </p:nvSpPr>
        <p:spPr>
          <a:xfrm>
            <a:off x="14688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B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5" name="Picture 14" descr="Chrom blank Screen shot 2013-01-07 at 10"/>
          <p:cNvPicPr/>
          <p:nvPr/>
        </p:nvPicPr>
        <p:blipFill>
          <a:blip r:embed="rId4">
            <a:lum contrast="-2000"/>
          </a:blip>
          <a:srcRect l="0" t="0" r="7663" b="0"/>
          <a:stretch/>
        </p:blipFill>
        <p:spPr>
          <a:xfrm>
            <a:off x="217440" y="4738680"/>
            <a:ext cx="169920" cy="285840"/>
          </a:xfrm>
          <a:prstGeom prst="rect">
            <a:avLst/>
          </a:prstGeom>
          <a:ln w="0">
            <a:noFill/>
          </a:ln>
        </p:spPr>
      </p:pic>
      <p:sp>
        <p:nvSpPr>
          <p:cNvPr id="736" name="Oval 15"/>
          <p:cNvSpPr/>
          <p:nvPr/>
        </p:nvSpPr>
        <p:spPr>
          <a:xfrm>
            <a:off x="231840" y="4857840"/>
            <a:ext cx="15228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Line 20"/>
          <p:cNvSpPr/>
          <p:nvPr/>
        </p:nvSpPr>
        <p:spPr>
          <a:xfrm>
            <a:off x="209520" y="4862520"/>
            <a:ext cx="18252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Line 33"/>
          <p:cNvSpPr/>
          <p:nvPr/>
        </p:nvSpPr>
        <p:spPr>
          <a:xfrm>
            <a:off x="209520" y="4896000"/>
            <a:ext cx="18252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Line 34"/>
          <p:cNvSpPr/>
          <p:nvPr/>
        </p:nvSpPr>
        <p:spPr>
          <a:xfrm>
            <a:off x="209520" y="4929120"/>
            <a:ext cx="18252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Line 35"/>
          <p:cNvSpPr/>
          <p:nvPr/>
        </p:nvSpPr>
        <p:spPr>
          <a:xfrm>
            <a:off x="209520" y="4957920"/>
            <a:ext cx="18252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Line 36"/>
          <p:cNvSpPr/>
          <p:nvPr/>
        </p:nvSpPr>
        <p:spPr>
          <a:xfrm>
            <a:off x="217440" y="5014800"/>
            <a:ext cx="18252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Text Box 37"/>
          <p:cNvSpPr/>
          <p:nvPr/>
        </p:nvSpPr>
        <p:spPr>
          <a:xfrm>
            <a:off x="369720" y="2606760"/>
            <a:ext cx="2198880" cy="458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67</a:t>
            </a:r>
            <a:r>
              <a:rPr b="0" lang="en-US" sz="600" spc="-1" strike="noStrike">
                <a:solidFill>
                  <a:srgbClr val="f9903b"/>
                </a:solidFill>
                <a:latin typeface="Arial"/>
              </a:rPr>
              <a:t>(Hpr) (sat0.00-1.00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585-6B, wPt-7065 (sat0.0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08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466.1</a:t>
            </a:r>
            <a:r>
              <a:rPr b="0" lang="en-US" sz="600" spc="-1" strike="noStrike">
                <a:solidFill>
                  <a:srgbClr val="f9903b"/>
                </a:solidFill>
                <a:latin typeface="Arial"/>
              </a:rPr>
              <a:t>(Nra) (0.76-sat1.00b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706-6B, wPt-49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073-6B (sat0.00-1.00f)                  (sat0.0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67-6B (sat0.0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5052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3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51p65.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814-6B (sat0.0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679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576-6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94 (0.46-0.76h) (sat0.00-1.00i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09 (0.36L-0.76j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wg908.1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570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247-6B (ca. 0.76Sk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784-6B (0.76-1.05h)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398a (0.76-1.05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2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424-6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000-6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118, gwm191 (C-0.76Sa) (C-0.25S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wg232.4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791-6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397 (C-0.13Ld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461-6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060-6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rPt-1040-6B (C-0.36L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35-6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564-6B (C-0.36Lh)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1p78.3, m87p78.5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GS1 (0.40-1.00e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881-6B (0.40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211-6B (0.36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498-6B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5p64.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112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43p78.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219 (0.40-1.00a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78 (0.40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532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3p78.3a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dupw12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608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662-6B (0.36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059-6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406-6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3" name="Picture 3" descr=""/>
          <p:cNvPicPr/>
          <p:nvPr/>
        </p:nvPicPr>
        <p:blipFill>
          <a:blip r:embed="rId1"/>
          <a:stretch/>
        </p:blipFill>
        <p:spPr>
          <a:xfrm>
            <a:off x="3657600" y="2459160"/>
            <a:ext cx="2971800" cy="4790880"/>
          </a:xfrm>
          <a:prstGeom prst="rect">
            <a:avLst/>
          </a:prstGeom>
          <a:ln w="0">
            <a:noFill/>
          </a:ln>
        </p:spPr>
      </p:pic>
      <p:pic>
        <p:nvPicPr>
          <p:cNvPr id="744" name="Picture 40" descr="6D Screen shot 2013-01-10 at 18"/>
          <p:cNvPicPr/>
          <p:nvPr/>
        </p:nvPicPr>
        <p:blipFill>
          <a:blip r:embed="rId2"/>
          <a:stretch/>
        </p:blipFill>
        <p:spPr>
          <a:xfrm>
            <a:off x="209520" y="2583000"/>
            <a:ext cx="273240" cy="4663800"/>
          </a:xfrm>
          <a:prstGeom prst="rect">
            <a:avLst/>
          </a:prstGeom>
          <a:ln w="0">
            <a:noFill/>
          </a:ln>
        </p:spPr>
      </p:pic>
      <p:sp>
        <p:nvSpPr>
          <p:cNvPr id="745" name="AutoShape 2"/>
          <p:cNvSpPr/>
          <p:nvPr/>
        </p:nvSpPr>
        <p:spPr>
          <a:xfrm>
            <a:off x="2268360" y="2622600"/>
            <a:ext cx="149400" cy="1314360"/>
          </a:xfrm>
          <a:custGeom>
            <a:avLst/>
            <a:gdLst>
              <a:gd name="textAreaLeft" fmla="*/ 17640 w 149400"/>
              <a:gd name="textAreaRight" fmla="*/ 131760 w 149400"/>
              <a:gd name="textAreaTop" fmla="*/ 17640 h 1314360"/>
              <a:gd name="textAreaBottom" fmla="*/ 1296720 h 1314360"/>
            </a:gdLst>
            <a:ahLst/>
            <a:rect l="textAreaLeft" t="textAreaTop" r="textAreaRight" b="textAreaBottom"/>
            <a:pathLst>
              <a:path w="21600" h="189623">
                <a:moveTo>
                  <a:pt x="3600" y="0"/>
                </a:moveTo>
                <a:arcTo wR="3600" hR="3600" stAng="0" swAng="5400000"/>
                <a:lnTo>
                  <a:pt x="0" y="186023"/>
                </a:lnTo>
                <a:arcTo wR="3600" hR="3600" stAng="16200000" swAng="5400000"/>
                <a:lnTo>
                  <a:pt x="18000" y="189623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436db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AutoShape 5"/>
          <p:cNvSpPr/>
          <p:nvPr/>
        </p:nvSpPr>
        <p:spPr>
          <a:xfrm>
            <a:off x="2263680" y="3924360"/>
            <a:ext cx="152640" cy="171360"/>
          </a:xfrm>
          <a:custGeom>
            <a:avLst/>
            <a:gdLst>
              <a:gd name="textAreaLeft" fmla="*/ 3240 w 152640"/>
              <a:gd name="textAreaRight" fmla="*/ 149400 w 152640"/>
              <a:gd name="textAreaTop" fmla="*/ 3240 h 171360"/>
              <a:gd name="textAreaBottom" fmla="*/ 168120 h 171360"/>
            </a:gdLst>
            <a:ahLst/>
            <a:rect l="textAreaLeft" t="textAreaTop" r="textAreaRight" b="textAreaBottom"/>
            <a:pathLst>
              <a:path w="21600" h="24243">
                <a:moveTo>
                  <a:pt x="675" y="0"/>
                </a:moveTo>
                <a:arcTo wR="675" hR="675" stAng="0" swAng="5400000"/>
                <a:lnTo>
                  <a:pt x="0" y="23568"/>
                </a:lnTo>
                <a:arcTo wR="675" hR="675" stAng="16200000" swAng="5400000"/>
                <a:lnTo>
                  <a:pt x="20925" y="24243"/>
                </a:lnTo>
                <a:arcTo wR="675" hR="675" stAng="10800000" swAng="5400000"/>
                <a:lnTo>
                  <a:pt x="21600" y="675"/>
                </a:lnTo>
                <a:arcTo wR="675" hR="675" stAng="5400000" swAng="5400000"/>
                <a:close/>
              </a:path>
            </a:pathLst>
          </a:custGeom>
          <a:solidFill>
            <a:srgbClr val="85d08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AutoShape 6"/>
          <p:cNvSpPr/>
          <p:nvPr/>
        </p:nvSpPr>
        <p:spPr>
          <a:xfrm>
            <a:off x="2263680" y="6172200"/>
            <a:ext cx="152640" cy="100332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1003320"/>
              <a:gd name="textAreaBottom" fmla="*/ 985320 h 1003320"/>
            </a:gdLst>
            <a:ahLst/>
            <a:rect l="textAreaLeft" t="textAreaTop" r="textAreaRight" b="textAreaBottom"/>
            <a:pathLst>
              <a:path w="21600" h="141696">
                <a:moveTo>
                  <a:pt x="3600" y="0"/>
                </a:moveTo>
                <a:arcTo wR="3600" hR="3600" stAng="0" swAng="5400000"/>
                <a:lnTo>
                  <a:pt x="0" y="138096"/>
                </a:lnTo>
                <a:arcTo wR="3600" hR="3600" stAng="16200000" swAng="5400000"/>
                <a:lnTo>
                  <a:pt x="18000" y="141696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96d7f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AutoShape 7"/>
          <p:cNvSpPr/>
          <p:nvPr/>
        </p:nvSpPr>
        <p:spPr>
          <a:xfrm>
            <a:off x="2266920" y="4476600"/>
            <a:ext cx="152280" cy="400320"/>
          </a:xfrm>
          <a:custGeom>
            <a:avLst/>
            <a:gdLst>
              <a:gd name="textAreaLeft" fmla="*/ 0 w 152280"/>
              <a:gd name="textAreaRight" fmla="*/ 152640 w 152280"/>
              <a:gd name="textAreaTop" fmla="*/ 0 h 400320"/>
              <a:gd name="textAreaBottom" fmla="*/ 400680 h 400320"/>
            </a:gdLst>
            <a:ahLst/>
            <a:rect l="textAreaLeft" t="textAreaTop" r="textAreaRight" b="textAreaBottom"/>
            <a:pathLst>
              <a:path w="21600" h="56700">
                <a:moveTo>
                  <a:pt x="0" y="0"/>
                </a:moveTo>
                <a:arcTo wR="0" hR="0" stAng="10800000" swAng="-5400000"/>
                <a:lnTo>
                  <a:pt x="0" y="56700"/>
                </a:lnTo>
                <a:arcTo wR="0" hR="0" stAng="16200000" swAng="-5400000"/>
                <a:lnTo>
                  <a:pt x="21600" y="56700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7994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AutoShape 4"/>
          <p:cNvSpPr/>
          <p:nvPr/>
        </p:nvSpPr>
        <p:spPr>
          <a:xfrm>
            <a:off x="2270160" y="6089760"/>
            <a:ext cx="152280" cy="234720"/>
          </a:xfrm>
          <a:custGeom>
            <a:avLst/>
            <a:gdLst>
              <a:gd name="textAreaLeft" fmla="*/ 0 w 152280"/>
              <a:gd name="textAreaRight" fmla="*/ 152640 w 152280"/>
              <a:gd name="textAreaTop" fmla="*/ 0 h 234720"/>
              <a:gd name="textAreaBottom" fmla="*/ 234720 h 234720"/>
            </a:gdLst>
            <a:ahLst/>
            <a:rect l="textAreaLeft" t="textAreaTop" r="textAreaRight" b="textAreaBottom"/>
            <a:pathLst>
              <a:path w="21600" h="33266">
                <a:moveTo>
                  <a:pt x="0" y="0"/>
                </a:moveTo>
                <a:arcTo wR="0" hR="0" stAng="10800000" swAng="-5400000"/>
                <a:lnTo>
                  <a:pt x="0" y="33266"/>
                </a:lnTo>
                <a:arcTo wR="0" hR="0" stAng="16200000" swAng="-5400000"/>
                <a:lnTo>
                  <a:pt x="21600" y="33266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AutoShape 8"/>
          <p:cNvSpPr/>
          <p:nvPr/>
        </p:nvSpPr>
        <p:spPr>
          <a:xfrm>
            <a:off x="2266920" y="5054760"/>
            <a:ext cx="152280" cy="482400"/>
          </a:xfrm>
          <a:custGeom>
            <a:avLst/>
            <a:gdLst>
              <a:gd name="textAreaLeft" fmla="*/ 0 w 152280"/>
              <a:gd name="textAreaRight" fmla="*/ 152640 w 152280"/>
              <a:gd name="textAreaTop" fmla="*/ 0 h 482400"/>
              <a:gd name="textAreaBottom" fmla="*/ 482400 h 482400"/>
            </a:gdLst>
            <a:ahLst/>
            <a:rect l="textAreaLeft" t="textAreaTop" r="textAreaRight" b="textAreaBottom"/>
            <a:pathLst>
              <a:path w="21600" h="68315">
                <a:moveTo>
                  <a:pt x="0" y="0"/>
                </a:moveTo>
                <a:arcTo wR="0" hR="0" stAng="10800000" swAng="-5400000"/>
                <a:lnTo>
                  <a:pt x="0" y="68315"/>
                </a:lnTo>
                <a:arcTo wR="0" hR="0" stAng="16200000" swAng="-5400000"/>
                <a:lnTo>
                  <a:pt x="21600" y="68315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4dc5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AutoShape 9"/>
          <p:cNvSpPr/>
          <p:nvPr/>
        </p:nvSpPr>
        <p:spPr>
          <a:xfrm>
            <a:off x="2265480" y="4768920"/>
            <a:ext cx="152280" cy="361800"/>
          </a:xfrm>
          <a:custGeom>
            <a:avLst/>
            <a:gdLst>
              <a:gd name="textAreaLeft" fmla="*/ 0 w 152280"/>
              <a:gd name="textAreaRight" fmla="*/ 152640 w 152280"/>
              <a:gd name="textAreaTop" fmla="*/ 0 h 361800"/>
              <a:gd name="textAreaBottom" fmla="*/ 362160 h 361800"/>
            </a:gdLst>
            <a:ahLst/>
            <a:rect l="textAreaLeft" t="textAreaTop" r="textAreaRight" b="textAreaBottom"/>
            <a:pathLst>
              <a:path w="21600" h="51249">
                <a:moveTo>
                  <a:pt x="0" y="0"/>
                </a:moveTo>
                <a:arcTo wR="0" hR="0" stAng="10800000" swAng="-5400000"/>
                <a:lnTo>
                  <a:pt x="0" y="51249"/>
                </a:lnTo>
                <a:arcTo wR="0" hR="0" stAng="16200000" swAng="-5400000"/>
                <a:lnTo>
                  <a:pt x="21600" y="51249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9a65a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AutoShape 43"/>
          <p:cNvSpPr/>
          <p:nvPr/>
        </p:nvSpPr>
        <p:spPr>
          <a:xfrm flipH="1">
            <a:off x="2263680" y="3384720"/>
            <a:ext cx="152640" cy="545760"/>
          </a:xfrm>
          <a:prstGeom prst="rtTriangle">
            <a:avLst/>
          </a:prstGeom>
          <a:solidFill>
            <a:srgbClr val="85d08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AutoShape 10"/>
          <p:cNvSpPr/>
          <p:nvPr/>
        </p:nvSpPr>
        <p:spPr>
          <a:xfrm>
            <a:off x="2263680" y="2622600"/>
            <a:ext cx="152640" cy="455148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4551480"/>
              <a:gd name="textAreaBottom" fmla="*/ 4533480 h 4551480"/>
            </a:gdLst>
            <a:ahLst/>
            <a:rect l="textAreaLeft" t="textAreaTop" r="textAreaRight" b="textAreaBottom"/>
            <a:pathLst>
              <a:path w="21600" h="642613">
                <a:moveTo>
                  <a:pt x="3600" y="0"/>
                </a:moveTo>
                <a:arcTo wR="3600" hR="3600" stAng="0" swAng="5400000"/>
                <a:lnTo>
                  <a:pt x="0" y="639013"/>
                </a:lnTo>
                <a:arcTo wR="3600" hR="3600" stAng="16200000" swAng="5400000"/>
                <a:lnTo>
                  <a:pt x="18000" y="642613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Text Box 11"/>
          <p:cNvSpPr/>
          <p:nvPr/>
        </p:nvSpPr>
        <p:spPr>
          <a:xfrm>
            <a:off x="2410560" y="6595920"/>
            <a:ext cx="1162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0-1.00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SII-10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Text Box 12"/>
          <p:cNvSpPr/>
          <p:nvPr/>
        </p:nvSpPr>
        <p:spPr>
          <a:xfrm>
            <a:off x="143640" y="201132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D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Text Box 13"/>
          <p:cNvSpPr/>
          <p:nvPr/>
        </p:nvSpPr>
        <p:spPr>
          <a:xfrm>
            <a:off x="2057400" y="2011320"/>
            <a:ext cx="12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D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Text Box 14"/>
          <p:cNvSpPr/>
          <p:nvPr/>
        </p:nvSpPr>
        <p:spPr>
          <a:xfrm>
            <a:off x="4017240" y="2011320"/>
            <a:ext cx="216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D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Text Box 15"/>
          <p:cNvSpPr/>
          <p:nvPr/>
        </p:nvSpPr>
        <p:spPr>
          <a:xfrm>
            <a:off x="2415240" y="4567320"/>
            <a:ext cx="54180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29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9" name="Picture 16" descr="Chrom blank Screen shot 2013-01-07 at 10"/>
          <p:cNvPicPr/>
          <p:nvPr/>
        </p:nvPicPr>
        <p:blipFill>
          <a:blip r:embed="rId3">
            <a:lum contrast="-2000"/>
          </a:blip>
          <a:srcRect l="0" t="0" r="7663" b="0"/>
          <a:stretch/>
        </p:blipFill>
        <p:spPr>
          <a:xfrm>
            <a:off x="233280" y="4253040"/>
            <a:ext cx="169920" cy="633240"/>
          </a:xfrm>
          <a:prstGeom prst="rect">
            <a:avLst/>
          </a:prstGeom>
          <a:ln w="0">
            <a:noFill/>
          </a:ln>
        </p:spPr>
      </p:pic>
      <p:sp>
        <p:nvSpPr>
          <p:cNvPr id="760" name="Oval 17"/>
          <p:cNvSpPr/>
          <p:nvPr/>
        </p:nvSpPr>
        <p:spPr>
          <a:xfrm>
            <a:off x="247680" y="4400640"/>
            <a:ext cx="15228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Text Box 18"/>
          <p:cNvSpPr/>
          <p:nvPr/>
        </p:nvSpPr>
        <p:spPr>
          <a:xfrm>
            <a:off x="2489400" y="436896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Text Box 19"/>
          <p:cNvSpPr/>
          <p:nvPr/>
        </p:nvSpPr>
        <p:spPr>
          <a:xfrm>
            <a:off x="2412360" y="2913120"/>
            <a:ext cx="1215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99-1.00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Fe-NADP(H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Text Box 20"/>
          <p:cNvSpPr/>
          <p:nvPr/>
        </p:nvSpPr>
        <p:spPr>
          <a:xfrm>
            <a:off x="2500560" y="4665600"/>
            <a:ext cx="45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DL-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Line 21"/>
          <p:cNvSpPr/>
          <p:nvPr/>
        </p:nvSpPr>
        <p:spPr>
          <a:xfrm>
            <a:off x="228600" y="4649760"/>
            <a:ext cx="18252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Line 22"/>
          <p:cNvSpPr/>
          <p:nvPr/>
        </p:nvSpPr>
        <p:spPr>
          <a:xfrm>
            <a:off x="2125800" y="447660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Line 23"/>
          <p:cNvSpPr/>
          <p:nvPr/>
        </p:nvSpPr>
        <p:spPr>
          <a:xfrm>
            <a:off x="2430360" y="476892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Text Box 24"/>
          <p:cNvSpPr/>
          <p:nvPr/>
        </p:nvSpPr>
        <p:spPr>
          <a:xfrm>
            <a:off x="2500560" y="5027760"/>
            <a:ext cx="45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DL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Line 26"/>
          <p:cNvSpPr/>
          <p:nvPr/>
        </p:nvSpPr>
        <p:spPr>
          <a:xfrm>
            <a:off x="2430360" y="512460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Line 27"/>
          <p:cNvSpPr/>
          <p:nvPr/>
        </p:nvSpPr>
        <p:spPr>
          <a:xfrm>
            <a:off x="2438280" y="365760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Line 28"/>
          <p:cNvSpPr/>
          <p:nvPr/>
        </p:nvSpPr>
        <p:spPr>
          <a:xfrm flipV="1">
            <a:off x="2444760" y="3390480"/>
            <a:ext cx="0" cy="5526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Text Box 36"/>
          <p:cNvSpPr/>
          <p:nvPr/>
        </p:nvSpPr>
        <p:spPr>
          <a:xfrm>
            <a:off x="2496960" y="3560760"/>
            <a:ext cx="46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DS-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Text Box 37"/>
          <p:cNvSpPr/>
          <p:nvPr/>
        </p:nvSpPr>
        <p:spPr>
          <a:xfrm>
            <a:off x="2414160" y="3844800"/>
            <a:ext cx="61056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9-0.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Text Box 38"/>
          <p:cNvSpPr/>
          <p:nvPr/>
        </p:nvSpPr>
        <p:spPr>
          <a:xfrm>
            <a:off x="2413800" y="4854600"/>
            <a:ext cx="88920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29-0.47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b-Lc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4" name="Text Box 41"/>
          <p:cNvSpPr/>
          <p:nvPr/>
        </p:nvSpPr>
        <p:spPr>
          <a:xfrm>
            <a:off x="403200" y="2606760"/>
            <a:ext cx="1577880" cy="456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49 (0.99-1.00a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899.2 (0.99-1.00b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700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73 (0.99-1.00a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469 (0.99-1.00a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5166 (0.79-1.00l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6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71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6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80 (C-0.29La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76 (0.29-0.47a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6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3p78.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75 (C-0.29La) (0.47-0.80m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9p78.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spcBef>
                <a:spcPts val="71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5675 (0.80-1.00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127-6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421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21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055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61-6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863-6D (0.8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626, wPt-667006 (0.80-1.00n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183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Line 44"/>
          <p:cNvSpPr/>
          <p:nvPr/>
        </p:nvSpPr>
        <p:spPr>
          <a:xfrm>
            <a:off x="2441520" y="42735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Line 45"/>
          <p:cNvSpPr/>
          <p:nvPr/>
        </p:nvSpPr>
        <p:spPr>
          <a:xfrm flipV="1">
            <a:off x="2444760" y="4088880"/>
            <a:ext cx="0" cy="381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Text Box 46"/>
          <p:cNvSpPr/>
          <p:nvPr/>
        </p:nvSpPr>
        <p:spPr>
          <a:xfrm>
            <a:off x="2493000" y="4176720"/>
            <a:ext cx="81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DS-4, 6DS-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Line 47"/>
          <p:cNvSpPr/>
          <p:nvPr/>
        </p:nvSpPr>
        <p:spPr>
          <a:xfrm>
            <a:off x="2441520" y="59180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9" name="Line 48"/>
          <p:cNvSpPr/>
          <p:nvPr/>
        </p:nvSpPr>
        <p:spPr>
          <a:xfrm flipV="1">
            <a:off x="2444760" y="5536800"/>
            <a:ext cx="0" cy="7873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0" name="Text Box 49"/>
          <p:cNvSpPr/>
          <p:nvPr/>
        </p:nvSpPr>
        <p:spPr>
          <a:xfrm>
            <a:off x="2500560" y="5821200"/>
            <a:ext cx="1293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6DL-12, 6DL-11, 6DL-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Text Box 50"/>
          <p:cNvSpPr/>
          <p:nvPr/>
        </p:nvSpPr>
        <p:spPr>
          <a:xfrm>
            <a:off x="2412360" y="5241960"/>
            <a:ext cx="116208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47-0.68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SII-10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Line 56"/>
          <p:cNvSpPr/>
          <p:nvPr/>
        </p:nvSpPr>
        <p:spPr>
          <a:xfrm>
            <a:off x="5413320" y="2673360"/>
            <a:ext cx="0" cy="44067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Text Box 58"/>
          <p:cNvSpPr/>
          <p:nvPr/>
        </p:nvSpPr>
        <p:spPr>
          <a:xfrm>
            <a:off x="2414520" y="4062240"/>
            <a:ext cx="441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Wca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84" name="Group 70"/>
          <p:cNvGrpSpPr/>
          <p:nvPr/>
        </p:nvGrpSpPr>
        <p:grpSpPr>
          <a:xfrm>
            <a:off x="5429160" y="5091120"/>
            <a:ext cx="1204920" cy="931320"/>
            <a:chOff x="5429160" y="5091120"/>
            <a:chExt cx="1204920" cy="931320"/>
          </a:xfrm>
        </p:grpSpPr>
        <p:sp>
          <p:nvSpPr>
            <p:cNvPr id="785" name="pole tekstowe 4"/>
            <p:cNvSpPr/>
            <p:nvPr/>
          </p:nvSpPr>
          <p:spPr>
            <a:xfrm>
              <a:off x="5779800" y="5091120"/>
              <a:ext cx="854280" cy="93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Ca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Ca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TR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86" name="Picture 2" descr=""/>
            <p:cNvPicPr/>
            <p:nvPr/>
          </p:nvPicPr>
          <p:blipFill>
            <a:blip r:embed="rId4"/>
            <a:srcRect l="82027" t="2928" r="9794" b="76234"/>
            <a:stretch/>
          </p:blipFill>
          <p:spPr>
            <a:xfrm>
              <a:off x="5429160" y="5145120"/>
              <a:ext cx="438120" cy="7459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7" name="Picture 3" descr=""/>
          <p:cNvPicPr/>
          <p:nvPr/>
        </p:nvPicPr>
        <p:blipFill>
          <a:blip r:embed="rId1"/>
          <a:stretch/>
        </p:blipFill>
        <p:spPr>
          <a:xfrm>
            <a:off x="3886200" y="2400480"/>
            <a:ext cx="2832120" cy="5499000"/>
          </a:xfrm>
          <a:prstGeom prst="rect">
            <a:avLst/>
          </a:prstGeom>
          <a:ln w="0">
            <a:noFill/>
          </a:ln>
        </p:spPr>
      </p:pic>
      <p:pic>
        <p:nvPicPr>
          <p:cNvPr id="788" name="Picture 42" descr="7A Screen shot 2013-01-11 at 08"/>
          <p:cNvPicPr/>
          <p:nvPr/>
        </p:nvPicPr>
        <p:blipFill>
          <a:blip r:embed="rId2"/>
          <a:stretch/>
        </p:blipFill>
        <p:spPr>
          <a:xfrm>
            <a:off x="152280" y="2575080"/>
            <a:ext cx="282600" cy="5257800"/>
          </a:xfrm>
          <a:prstGeom prst="rect">
            <a:avLst/>
          </a:prstGeom>
          <a:ln w="0">
            <a:noFill/>
          </a:ln>
        </p:spPr>
      </p:pic>
      <p:sp>
        <p:nvSpPr>
          <p:cNvPr id="789" name="AutoShape 3"/>
          <p:cNvSpPr/>
          <p:nvPr/>
        </p:nvSpPr>
        <p:spPr>
          <a:xfrm>
            <a:off x="2529000" y="2622600"/>
            <a:ext cx="149040" cy="882720"/>
          </a:xfrm>
          <a:custGeom>
            <a:avLst/>
            <a:gdLst>
              <a:gd name="textAreaLeft" fmla="*/ 17280 w 149040"/>
              <a:gd name="textAreaRight" fmla="*/ 131760 w 149040"/>
              <a:gd name="textAreaTop" fmla="*/ 17280 h 882720"/>
              <a:gd name="textAreaBottom" fmla="*/ 865440 h 882720"/>
            </a:gdLst>
            <a:ahLst/>
            <a:rect l="textAreaLeft" t="textAreaTop" r="textAreaRight" b="textAreaBottom"/>
            <a:pathLst>
              <a:path w="21600" h="127674">
                <a:moveTo>
                  <a:pt x="3600" y="0"/>
                </a:moveTo>
                <a:arcTo wR="3600" hR="3600" stAng="0" swAng="5400000"/>
                <a:lnTo>
                  <a:pt x="0" y="124074"/>
                </a:lnTo>
                <a:arcTo wR="3600" hR="3600" stAng="16200000" swAng="5400000"/>
                <a:lnTo>
                  <a:pt x="18000" y="127674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446cb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0" name="AutoShape 9"/>
          <p:cNvSpPr/>
          <p:nvPr/>
        </p:nvSpPr>
        <p:spPr>
          <a:xfrm>
            <a:off x="2525760" y="4927680"/>
            <a:ext cx="152280" cy="749160"/>
          </a:xfrm>
          <a:custGeom>
            <a:avLst/>
            <a:gdLst>
              <a:gd name="textAreaLeft" fmla="*/ 0 w 152280"/>
              <a:gd name="textAreaRight" fmla="*/ 152640 w 152280"/>
              <a:gd name="textAreaTop" fmla="*/ 0 h 749160"/>
              <a:gd name="textAreaBottom" fmla="*/ 749520 h 749160"/>
            </a:gdLst>
            <a:ahLst/>
            <a:rect l="textAreaLeft" t="textAreaTop" r="textAreaRight" b="textAreaBottom"/>
            <a:pathLst>
              <a:path w="21600" h="106064">
                <a:moveTo>
                  <a:pt x="0" y="0"/>
                </a:moveTo>
                <a:arcTo wR="0" hR="0" stAng="10800000" swAng="-5400000"/>
                <a:lnTo>
                  <a:pt x="0" y="106064"/>
                </a:lnTo>
                <a:arcTo wR="0" hR="0" stAng="16200000" swAng="-5400000"/>
                <a:lnTo>
                  <a:pt x="21600" y="106064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62e3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1" name="AutoShape 4"/>
          <p:cNvSpPr/>
          <p:nvPr/>
        </p:nvSpPr>
        <p:spPr>
          <a:xfrm>
            <a:off x="2523960" y="3409920"/>
            <a:ext cx="152640" cy="1555920"/>
          </a:xfrm>
          <a:custGeom>
            <a:avLst/>
            <a:gdLst>
              <a:gd name="textAreaLeft" fmla="*/ 3240 w 152640"/>
              <a:gd name="textAreaRight" fmla="*/ 149400 w 152640"/>
              <a:gd name="textAreaTop" fmla="*/ 3240 h 1555920"/>
              <a:gd name="textAreaBottom" fmla="*/ 1552680 h 1555920"/>
            </a:gdLst>
            <a:ahLst/>
            <a:rect l="textAreaLeft" t="textAreaTop" r="textAreaRight" b="textAreaBottom"/>
            <a:pathLst>
              <a:path w="21600" h="219710">
                <a:moveTo>
                  <a:pt x="675" y="0"/>
                </a:moveTo>
                <a:arcTo wR="675" hR="675" stAng="0" swAng="5400000"/>
                <a:lnTo>
                  <a:pt x="0" y="219035"/>
                </a:lnTo>
                <a:arcTo wR="675" hR="675" stAng="16200000" swAng="5400000"/>
                <a:lnTo>
                  <a:pt x="20925" y="219710"/>
                </a:lnTo>
                <a:arcTo wR="675" hR="675" stAng="10800000" swAng="5400000"/>
                <a:lnTo>
                  <a:pt x="21600" y="675"/>
                </a:lnTo>
                <a:arcTo wR="675" hR="675" stAng="5400000" swAng="5400000"/>
                <a:close/>
              </a:path>
            </a:pathLst>
          </a:custGeom>
          <a:solidFill>
            <a:srgbClr val="8dcc9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AutoShape 5"/>
          <p:cNvSpPr/>
          <p:nvPr/>
        </p:nvSpPr>
        <p:spPr>
          <a:xfrm>
            <a:off x="2523960" y="7391520"/>
            <a:ext cx="152640" cy="39348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393480"/>
              <a:gd name="textAreaBottom" fmla="*/ 375480 h 393480"/>
            </a:gdLst>
            <a:ahLst/>
            <a:rect l="textAreaLeft" t="textAreaTop" r="textAreaRight" b="textAreaBottom"/>
            <a:pathLst>
              <a:path w="21600" h="55601">
                <a:moveTo>
                  <a:pt x="3600" y="0"/>
                </a:moveTo>
                <a:arcTo wR="3600" hR="3600" stAng="0" swAng="5400000"/>
                <a:lnTo>
                  <a:pt x="0" y="52001"/>
                </a:lnTo>
                <a:arcTo wR="3600" hR="3600" stAng="16200000" swAng="5400000"/>
                <a:lnTo>
                  <a:pt x="18000" y="55601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92d9f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AutoShape 6"/>
          <p:cNvSpPr/>
          <p:nvPr/>
        </p:nvSpPr>
        <p:spPr>
          <a:xfrm>
            <a:off x="2527200" y="5835600"/>
            <a:ext cx="152640" cy="641520"/>
          </a:xfrm>
          <a:custGeom>
            <a:avLst/>
            <a:gdLst>
              <a:gd name="textAreaLeft" fmla="*/ 0 w 152640"/>
              <a:gd name="textAreaRight" fmla="*/ 153000 w 152640"/>
              <a:gd name="textAreaTop" fmla="*/ 0 h 641520"/>
              <a:gd name="textAreaBottom" fmla="*/ 641880 h 641520"/>
            </a:gdLst>
            <a:ahLst/>
            <a:rect l="textAreaLeft" t="textAreaTop" r="textAreaRight" b="textAreaBottom"/>
            <a:pathLst>
              <a:path w="21600" h="90618">
                <a:moveTo>
                  <a:pt x="0" y="0"/>
                </a:moveTo>
                <a:arcTo wR="0" hR="0" stAng="10800000" swAng="-5400000"/>
                <a:lnTo>
                  <a:pt x="0" y="90618"/>
                </a:lnTo>
                <a:arcTo wR="0" hR="0" stAng="16200000" swAng="-5400000"/>
                <a:lnTo>
                  <a:pt x="21600" y="9061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4943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AutoShape 7"/>
          <p:cNvSpPr/>
          <p:nvPr/>
        </p:nvSpPr>
        <p:spPr>
          <a:xfrm>
            <a:off x="2530440" y="6438960"/>
            <a:ext cx="152280" cy="234720"/>
          </a:xfrm>
          <a:custGeom>
            <a:avLst/>
            <a:gdLst>
              <a:gd name="textAreaLeft" fmla="*/ 0 w 152280"/>
              <a:gd name="textAreaRight" fmla="*/ 152640 w 152280"/>
              <a:gd name="textAreaTop" fmla="*/ 0 h 234720"/>
              <a:gd name="textAreaBottom" fmla="*/ 234720 h 234720"/>
            </a:gdLst>
            <a:ahLst/>
            <a:rect l="textAreaLeft" t="textAreaTop" r="textAreaRight" b="textAreaBottom"/>
            <a:pathLst>
              <a:path w="21600" h="33266">
                <a:moveTo>
                  <a:pt x="0" y="0"/>
                </a:moveTo>
                <a:arcTo wR="0" hR="0" stAng="10800000" swAng="-5400000"/>
                <a:lnTo>
                  <a:pt x="0" y="33266"/>
                </a:lnTo>
                <a:arcTo wR="0" hR="0" stAng="16200000" swAng="-5400000"/>
                <a:lnTo>
                  <a:pt x="21600" y="33266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9e65a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5" name="AutoShape 49"/>
          <p:cNvSpPr/>
          <p:nvPr/>
        </p:nvSpPr>
        <p:spPr>
          <a:xfrm>
            <a:off x="2525760" y="7327800"/>
            <a:ext cx="152280" cy="190440"/>
          </a:xfrm>
          <a:custGeom>
            <a:avLst/>
            <a:gdLst>
              <a:gd name="textAreaLeft" fmla="*/ 0 w 152280"/>
              <a:gd name="textAreaRight" fmla="*/ 152640 w 152280"/>
              <a:gd name="textAreaTop" fmla="*/ 0 h 190440"/>
              <a:gd name="textAreaBottom" fmla="*/ 190800 h 190440"/>
            </a:gdLst>
            <a:ahLst/>
            <a:rect l="textAreaLeft" t="textAreaTop" r="textAreaRight" b="textAreaBottom"/>
            <a:pathLst>
              <a:path w="21600" h="27000">
                <a:moveTo>
                  <a:pt x="0" y="0"/>
                </a:moveTo>
                <a:arcTo wR="0" hR="0" stAng="10800000" swAng="-5400000"/>
                <a:lnTo>
                  <a:pt x="0" y="27000"/>
                </a:lnTo>
                <a:arcTo wR="0" hR="0" stAng="16200000" swAng="-5400000"/>
                <a:lnTo>
                  <a:pt x="21600" y="27000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c99ec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6" name="AutoShape 8"/>
          <p:cNvSpPr/>
          <p:nvPr/>
        </p:nvSpPr>
        <p:spPr>
          <a:xfrm>
            <a:off x="2527200" y="6527880"/>
            <a:ext cx="152640" cy="304560"/>
          </a:xfrm>
          <a:custGeom>
            <a:avLst/>
            <a:gdLst>
              <a:gd name="textAreaLeft" fmla="*/ 0 w 152640"/>
              <a:gd name="textAreaRight" fmla="*/ 153000 w 152640"/>
              <a:gd name="textAreaTop" fmla="*/ 0 h 304560"/>
              <a:gd name="textAreaBottom" fmla="*/ 304920 h 304560"/>
            </a:gdLst>
            <a:ahLst/>
            <a:rect l="textAreaLeft" t="textAreaTop" r="textAreaRight" b="textAreaBottom"/>
            <a:pathLst>
              <a:path w="21600" h="43048">
                <a:moveTo>
                  <a:pt x="0" y="0"/>
                </a:moveTo>
                <a:arcTo wR="0" hR="0" stAng="10800000" swAng="-5400000"/>
                <a:lnTo>
                  <a:pt x="0" y="43048"/>
                </a:lnTo>
                <a:arcTo wR="0" hR="0" stAng="16200000" swAng="-5400000"/>
                <a:lnTo>
                  <a:pt x="21600" y="4304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7" name="Text Box 12"/>
          <p:cNvSpPr/>
          <p:nvPr/>
        </p:nvSpPr>
        <p:spPr>
          <a:xfrm>
            <a:off x="2671560" y="6426360"/>
            <a:ext cx="1370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39-0.71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Xantha-h, Alad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8" name="Text Box 13"/>
          <p:cNvSpPr/>
          <p:nvPr/>
        </p:nvSpPr>
        <p:spPr>
          <a:xfrm>
            <a:off x="14832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7A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Text Box 14"/>
          <p:cNvSpPr/>
          <p:nvPr/>
        </p:nvSpPr>
        <p:spPr>
          <a:xfrm>
            <a:off x="220356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7A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Text Box 15"/>
          <p:cNvSpPr/>
          <p:nvPr/>
        </p:nvSpPr>
        <p:spPr>
          <a:xfrm>
            <a:off x="402192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7A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1" name="Picture 17" descr="Chrom blank Screen shot 2013-01-07 at 10"/>
          <p:cNvPicPr/>
          <p:nvPr/>
        </p:nvPicPr>
        <p:blipFill>
          <a:blip r:embed="rId3">
            <a:lum contrast="-2000"/>
          </a:blip>
          <a:srcRect l="0" t="0" r="7663" b="0"/>
          <a:stretch/>
        </p:blipFill>
        <p:spPr>
          <a:xfrm>
            <a:off x="193680" y="5359320"/>
            <a:ext cx="169920" cy="417600"/>
          </a:xfrm>
          <a:prstGeom prst="rect">
            <a:avLst/>
          </a:prstGeom>
          <a:ln w="0">
            <a:noFill/>
          </a:ln>
        </p:spPr>
      </p:pic>
      <p:sp>
        <p:nvSpPr>
          <p:cNvPr id="802" name="Oval 18"/>
          <p:cNvSpPr/>
          <p:nvPr/>
        </p:nvSpPr>
        <p:spPr>
          <a:xfrm>
            <a:off x="203040" y="5676840"/>
            <a:ext cx="152640" cy="152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Text Box 19"/>
          <p:cNvSpPr/>
          <p:nvPr/>
        </p:nvSpPr>
        <p:spPr>
          <a:xfrm>
            <a:off x="2749680" y="564516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Text Box 20"/>
          <p:cNvSpPr/>
          <p:nvPr/>
        </p:nvSpPr>
        <p:spPr>
          <a:xfrm>
            <a:off x="2671920" y="2913120"/>
            <a:ext cx="782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9-1.00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l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Text Box 21"/>
          <p:cNvSpPr/>
          <p:nvPr/>
        </p:nvSpPr>
        <p:spPr>
          <a:xfrm>
            <a:off x="2754000" y="331488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AS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Line 22"/>
          <p:cNvSpPr/>
          <p:nvPr/>
        </p:nvSpPr>
        <p:spPr>
          <a:xfrm>
            <a:off x="190440" y="5459400"/>
            <a:ext cx="18252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Line 23"/>
          <p:cNvSpPr/>
          <p:nvPr/>
        </p:nvSpPr>
        <p:spPr>
          <a:xfrm>
            <a:off x="2386080" y="575316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Line 24"/>
          <p:cNvSpPr/>
          <p:nvPr/>
        </p:nvSpPr>
        <p:spPr>
          <a:xfrm>
            <a:off x="2690640" y="34178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Text Box 25"/>
          <p:cNvSpPr/>
          <p:nvPr/>
        </p:nvSpPr>
        <p:spPr>
          <a:xfrm>
            <a:off x="2752200" y="4863960"/>
            <a:ext cx="80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AS-5, 7AS-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Line 26"/>
          <p:cNvSpPr/>
          <p:nvPr/>
        </p:nvSpPr>
        <p:spPr>
          <a:xfrm>
            <a:off x="2684520" y="496080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Text Box 30"/>
          <p:cNvSpPr/>
          <p:nvPr/>
        </p:nvSpPr>
        <p:spPr>
          <a:xfrm>
            <a:off x="2672640" y="4083120"/>
            <a:ext cx="116820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9-0.89 </a:t>
            </a:r>
            <a:r>
              <a:rPr b="0" i="1" lang="en-GB" sz="800" spc="-1" strike="noStrike">
                <a:solidFill>
                  <a:srgbClr val="f62e30"/>
                </a:solidFill>
                <a:latin typeface="Arial"/>
              </a:rPr>
              <a:t>GluTR,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Line 34"/>
          <p:cNvSpPr/>
          <p:nvPr/>
        </p:nvSpPr>
        <p:spPr>
          <a:xfrm>
            <a:off x="2701800" y="69213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3" name="Line 35"/>
          <p:cNvSpPr/>
          <p:nvPr/>
        </p:nvSpPr>
        <p:spPr>
          <a:xfrm flipV="1">
            <a:off x="2703600" y="6534000"/>
            <a:ext cx="0" cy="787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4" name="Line 38"/>
          <p:cNvSpPr/>
          <p:nvPr/>
        </p:nvSpPr>
        <p:spPr>
          <a:xfrm flipV="1">
            <a:off x="2711520" y="5670720"/>
            <a:ext cx="0" cy="164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5" name="Text Box 40"/>
          <p:cNvSpPr/>
          <p:nvPr/>
        </p:nvSpPr>
        <p:spPr>
          <a:xfrm>
            <a:off x="2674800" y="5267160"/>
            <a:ext cx="55404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45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6" name="Line 43"/>
          <p:cNvSpPr/>
          <p:nvPr/>
        </p:nvSpPr>
        <p:spPr>
          <a:xfrm>
            <a:off x="189000" y="5603760"/>
            <a:ext cx="18252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Text Box 44"/>
          <p:cNvSpPr/>
          <p:nvPr/>
        </p:nvSpPr>
        <p:spPr>
          <a:xfrm>
            <a:off x="339840" y="2600280"/>
            <a:ext cx="2251080" cy="518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641-7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645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39p78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092 (0.89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21p76.14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151-7A, wPt-8043 (0.59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388c, wmc158 (0.89-1.00d)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63.2 (0.89-1.00b),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780-7A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490.3</a:t>
            </a:r>
            <a:r>
              <a:rPr b="0" lang="en-US" sz="600" spc="-1" strike="noStrike">
                <a:solidFill>
                  <a:srgbClr val="f9903b"/>
                </a:solidFill>
                <a:latin typeface="Arial"/>
              </a:rPr>
              <a:t>(Ss1)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                         wPt-8192-7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635b (0.59-0.89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86.2 (0.89-1.00b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207-7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79 (0.59-0.89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58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835-7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9111-7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188-7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407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796-7A, wPt-1163 (0.59-0.89h), wPt-3883 (0.59-0.89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83a (0.59-0.89o) (0.59-0.73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49p78.4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a2028 (C-0.45S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49p78.7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321-7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83 (C-0.45S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5p65.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74 (C-0.45S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7p77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515-7A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08a (C-0.39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50 (C-0.39L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22 (C-0.39L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21p76.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49p78.2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88b (C-0.39L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810-7A, wPt-0205 (0.39-0.71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637-7A (0.39-0.71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wg232.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51p65.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8p78.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0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94a (C-0.18Ld), gwm332 (0.86-0.90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872-7A,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 cfa2019 (0.86-0.90a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836 (0.71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48</a:t>
            </a:r>
            <a:r>
              <a:rPr b="0" lang="en-US" sz="600" spc="-1" strike="noStrike">
                <a:solidFill>
                  <a:srgbClr val="f9903b"/>
                </a:solidFill>
                <a:latin typeface="Arial"/>
              </a:rPr>
              <a:t>(CatO) (0.90-1.00b),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763-7A, wPt-0551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147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	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                     (0.90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8" name="Text Box 46"/>
          <p:cNvSpPr/>
          <p:nvPr/>
        </p:nvSpPr>
        <p:spPr>
          <a:xfrm>
            <a:off x="2754360" y="633240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AL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9" name="Line 47"/>
          <p:cNvSpPr/>
          <p:nvPr/>
        </p:nvSpPr>
        <p:spPr>
          <a:xfrm>
            <a:off x="2684520" y="64292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0" name="Text Box 48"/>
          <p:cNvSpPr/>
          <p:nvPr/>
        </p:nvSpPr>
        <p:spPr>
          <a:xfrm>
            <a:off x="2675520" y="6051600"/>
            <a:ext cx="54180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39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1" name="Text Box 50"/>
          <p:cNvSpPr/>
          <p:nvPr/>
        </p:nvSpPr>
        <p:spPr>
          <a:xfrm>
            <a:off x="2754360" y="6815160"/>
            <a:ext cx="1279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AL-17, 7AL-21, 7AL-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2" name="Text Box 51"/>
          <p:cNvSpPr/>
          <p:nvPr/>
        </p:nvSpPr>
        <p:spPr>
          <a:xfrm>
            <a:off x="2754000" y="741060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AL-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3" name="Line 52"/>
          <p:cNvSpPr/>
          <p:nvPr/>
        </p:nvSpPr>
        <p:spPr>
          <a:xfrm>
            <a:off x="2684520" y="75074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4" name="Text Box 53"/>
          <p:cNvSpPr/>
          <p:nvPr/>
        </p:nvSpPr>
        <p:spPr>
          <a:xfrm>
            <a:off x="2673000" y="730404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6-0.9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5" name="Text Box 54"/>
          <p:cNvSpPr/>
          <p:nvPr/>
        </p:nvSpPr>
        <p:spPr>
          <a:xfrm>
            <a:off x="2673000" y="753912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90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6" name="AutoShape 11"/>
          <p:cNvSpPr/>
          <p:nvPr/>
        </p:nvSpPr>
        <p:spPr>
          <a:xfrm>
            <a:off x="2523960" y="2622600"/>
            <a:ext cx="152640" cy="516096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5160960"/>
              <a:gd name="textAreaBottom" fmla="*/ 5142960 h 5160960"/>
            </a:gdLst>
            <a:ahLst/>
            <a:rect l="textAreaLeft" t="textAreaTop" r="textAreaRight" b="textAreaBottom"/>
            <a:pathLst>
              <a:path w="21600" h="728657">
                <a:moveTo>
                  <a:pt x="3600" y="0"/>
                </a:moveTo>
                <a:arcTo wR="3600" hR="3600" stAng="0" swAng="5400000"/>
                <a:lnTo>
                  <a:pt x="0" y="725057"/>
                </a:lnTo>
                <a:arcTo wR="3600" hR="3600" stAng="16200000" swAng="5400000"/>
                <a:lnTo>
                  <a:pt x="18000" y="728657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7" name="Line 61"/>
          <p:cNvSpPr/>
          <p:nvPr/>
        </p:nvSpPr>
        <p:spPr>
          <a:xfrm>
            <a:off x="5556240" y="2647800"/>
            <a:ext cx="0" cy="5067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8" name="Text Box 63"/>
          <p:cNvSpPr/>
          <p:nvPr/>
        </p:nvSpPr>
        <p:spPr>
          <a:xfrm>
            <a:off x="2672280" y="3198960"/>
            <a:ext cx="35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9" name="Text Box 65"/>
          <p:cNvSpPr/>
          <p:nvPr/>
        </p:nvSpPr>
        <p:spPr>
          <a:xfrm>
            <a:off x="3143520" y="7467480"/>
            <a:ext cx="56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sy1-A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0" name="Group 118"/>
          <p:cNvGrpSpPr/>
          <p:nvPr/>
        </p:nvGrpSpPr>
        <p:grpSpPr>
          <a:xfrm>
            <a:off x="5668920" y="3198960"/>
            <a:ext cx="1062000" cy="1464120"/>
            <a:chOff x="5668920" y="3198960"/>
            <a:chExt cx="1062000" cy="1464120"/>
          </a:xfrm>
        </p:grpSpPr>
        <p:grpSp>
          <p:nvGrpSpPr>
            <p:cNvPr id="831" name="Group 111"/>
            <p:cNvGrpSpPr/>
            <p:nvPr/>
          </p:nvGrpSpPr>
          <p:grpSpPr>
            <a:xfrm>
              <a:off x="5668920" y="3198960"/>
              <a:ext cx="1062000" cy="1464120"/>
              <a:chOff x="5668920" y="3198960"/>
              <a:chExt cx="1062000" cy="1464120"/>
            </a:xfrm>
          </p:grpSpPr>
          <p:sp>
            <p:nvSpPr>
              <p:cNvPr id="832" name="pole tekstowe 4"/>
              <p:cNvSpPr/>
              <p:nvPr/>
            </p:nvSpPr>
            <p:spPr>
              <a:xfrm>
                <a:off x="5932440" y="3198960"/>
                <a:ext cx="798480" cy="1464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08  Chl</a:t>
                </a:r>
                <a:r>
                  <a:rPr b="0" lang="pl-PL" sz="6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a+b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08  DW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10  DW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07  Y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10  Y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08  GW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10  GW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07  </a:t>
                </a: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GWE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07  ET</a:t>
                </a:r>
                <a:r>
                  <a:rPr b="0" lang="pl-PL" sz="5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0</a:t>
                </a:r>
                <a:r>
                  <a:rPr b="0" lang="pl-PL" sz="6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/</a:t>
                </a: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CS</a:t>
                </a:r>
                <a:r>
                  <a:rPr b="0" lang="pl-PL" sz="6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m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07  PI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10  F</a:t>
                </a:r>
                <a:r>
                  <a:rPr b="0" lang="pl-PL" sz="6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v</a:t>
                </a: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/F</a:t>
                </a:r>
                <a:r>
                  <a:rPr b="0" lang="pl-PL" sz="6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m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11  DI</a:t>
                </a:r>
                <a:r>
                  <a:rPr b="0" lang="pl-PL" sz="5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0</a:t>
                </a:r>
                <a:r>
                  <a:rPr b="0" lang="pl-PL" sz="7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/CS</a:t>
                </a:r>
                <a:r>
                  <a:rPr b="0" lang="pl-PL" sz="6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m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33" name="Picture 2" descr=""/>
              <p:cNvPicPr/>
              <p:nvPr/>
            </p:nvPicPr>
            <p:blipFill>
              <a:blip r:embed="rId4"/>
              <a:srcRect l="82185" t="4529" r="10415" b="65907"/>
              <a:stretch/>
            </p:blipFill>
            <p:spPr>
              <a:xfrm>
                <a:off x="5668920" y="3429000"/>
                <a:ext cx="330480" cy="1052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34" name="Picture 2" descr=""/>
              <p:cNvPicPr/>
              <p:nvPr/>
            </p:nvPicPr>
            <p:blipFill>
              <a:blip r:embed="rId5"/>
              <a:srcRect l="82955" t="2290" r="10593" b="94483"/>
              <a:stretch/>
            </p:blipFill>
            <p:spPr>
              <a:xfrm>
                <a:off x="5689800" y="3346560"/>
                <a:ext cx="306360" cy="115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35" name="Picture 2" descr=""/>
              <p:cNvPicPr/>
              <p:nvPr/>
            </p:nvPicPr>
            <p:blipFill>
              <a:blip r:embed="rId6"/>
              <a:srcRect l="82629" t="1985" r="10415" b="94151"/>
              <a:stretch/>
            </p:blipFill>
            <p:spPr>
              <a:xfrm>
                <a:off x="5688000" y="3225960"/>
                <a:ext cx="311400" cy="1378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836" name="Line 116"/>
            <p:cNvSpPr/>
            <p:nvPr/>
          </p:nvSpPr>
          <p:spPr>
            <a:xfrm>
              <a:off x="5692680" y="3724200"/>
              <a:ext cx="304920" cy="0"/>
            </a:xfrm>
            <a:prstGeom prst="line">
              <a:avLst/>
            </a:prstGeom>
            <a:ln w="15840">
              <a:solidFill>
                <a:srgbClr val="ffffff">
                  <a:alpha val="99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Line 115"/>
            <p:cNvSpPr/>
            <p:nvPr/>
          </p:nvSpPr>
          <p:spPr>
            <a:xfrm>
              <a:off x="5699160" y="3733920"/>
              <a:ext cx="304920" cy="0"/>
            </a:xfrm>
            <a:prstGeom prst="line">
              <a:avLst/>
            </a:prstGeom>
            <a:ln w="9360">
              <a:solidFill>
                <a:srgbClr val="ff0000">
                  <a:alpha val="99000"/>
                </a:srgbClr>
              </a:solidFill>
              <a:prstDash val="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2" descr=""/>
          <p:cNvPicPr/>
          <p:nvPr/>
        </p:nvPicPr>
        <p:blipFill>
          <a:blip r:embed="rId1"/>
          <a:stretch/>
        </p:blipFill>
        <p:spPr>
          <a:xfrm>
            <a:off x="3441600" y="2374920"/>
            <a:ext cx="3257640" cy="5651640"/>
          </a:xfrm>
          <a:prstGeom prst="rect">
            <a:avLst/>
          </a:prstGeom>
          <a:ln w="0">
            <a:noFill/>
          </a:ln>
        </p:spPr>
      </p:pic>
      <p:sp>
        <p:nvSpPr>
          <p:cNvPr id="79" name="AutoShape 3"/>
          <p:cNvSpPr/>
          <p:nvPr/>
        </p:nvSpPr>
        <p:spPr>
          <a:xfrm>
            <a:off x="2257560" y="2585880"/>
            <a:ext cx="152280" cy="8431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843120"/>
              <a:gd name="textAreaBottom" fmla="*/ 825480 h 843120"/>
            </a:gdLst>
            <a:ahLst/>
            <a:rect l="textAreaLeft" t="textAreaTop" r="textAreaRight" b="textAreaBottom"/>
            <a:pathLst>
              <a:path w="21600" h="119360">
                <a:moveTo>
                  <a:pt x="3600" y="0"/>
                </a:moveTo>
                <a:arcTo wR="3600" hR="3600" stAng="0" swAng="5400000"/>
                <a:lnTo>
                  <a:pt x="0" y="115760"/>
                </a:lnTo>
                <a:arcTo wR="3600" hR="3600" stAng="16200000" swAng="5400000"/>
                <a:lnTo>
                  <a:pt x="18000" y="119360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1f60a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AutoShape 4"/>
          <p:cNvSpPr/>
          <p:nvPr/>
        </p:nvSpPr>
        <p:spPr>
          <a:xfrm>
            <a:off x="2257560" y="3232080"/>
            <a:ext cx="152280" cy="273240"/>
          </a:xfrm>
          <a:custGeom>
            <a:avLst/>
            <a:gdLst>
              <a:gd name="textAreaLeft" fmla="*/ 0 w 152280"/>
              <a:gd name="textAreaRight" fmla="*/ 152640 w 152280"/>
              <a:gd name="textAreaTop" fmla="*/ 0 h 273240"/>
              <a:gd name="textAreaBottom" fmla="*/ 273600 h 273240"/>
            </a:gdLst>
            <a:ahLst/>
            <a:rect l="textAreaLeft" t="textAreaTop" r="textAreaRight" b="textAreaBottom"/>
            <a:pathLst>
              <a:path w="21600" h="38717">
                <a:moveTo>
                  <a:pt x="0" y="0"/>
                </a:moveTo>
                <a:arcTo wR="0" hR="0" stAng="10800000" swAng="-5400000"/>
                <a:lnTo>
                  <a:pt x="0" y="38717"/>
                </a:lnTo>
                <a:arcTo wR="0" hR="0" stAng="16200000" swAng="-5400000"/>
                <a:lnTo>
                  <a:pt x="21600" y="38717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8ecf9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AutoShape 49"/>
          <p:cNvSpPr/>
          <p:nvPr/>
        </p:nvSpPr>
        <p:spPr>
          <a:xfrm>
            <a:off x="2260440" y="3484440"/>
            <a:ext cx="152640" cy="93960"/>
          </a:xfrm>
          <a:custGeom>
            <a:avLst/>
            <a:gdLst>
              <a:gd name="textAreaLeft" fmla="*/ 0 w 152640"/>
              <a:gd name="textAreaRight" fmla="*/ 153000 w 152640"/>
              <a:gd name="textAreaTop" fmla="*/ 0 h 93960"/>
              <a:gd name="textAreaBottom" fmla="*/ 94320 h 93960"/>
            </a:gdLst>
            <a:ahLst/>
            <a:rect l="textAreaLeft" t="textAreaTop" r="textAreaRight" b="textAreaBottom"/>
            <a:pathLst>
              <a:path w="35038" h="21600">
                <a:moveTo>
                  <a:pt x="0" y="0"/>
                </a:moveTo>
                <a:arcTo wR="0" hR="0" stAng="10800000" swAng="-5400000"/>
                <a:lnTo>
                  <a:pt x="0" y="21600"/>
                </a:lnTo>
                <a:arcTo wR="0" hR="0" stAng="16200000" swAng="-5400000"/>
                <a:lnTo>
                  <a:pt x="35038" y="21600"/>
                </a:lnTo>
                <a:arcTo wR="0" hR="0" stAng="10800000" swAng="-5400000"/>
                <a:lnTo>
                  <a:pt x="35038" y="0"/>
                </a:lnTo>
                <a:arcTo wR="0" hR="0" stAng="16200000" swAng="-5400000"/>
                <a:close/>
              </a:path>
            </a:pathLst>
          </a:custGeom>
          <a:solidFill>
            <a:srgbClr val="bb78b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82"/>
          <p:cNvSpPr/>
          <p:nvPr/>
        </p:nvSpPr>
        <p:spPr>
          <a:xfrm>
            <a:off x="5362560" y="2631960"/>
            <a:ext cx="0" cy="52261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AutoShape 47"/>
          <p:cNvSpPr/>
          <p:nvPr/>
        </p:nvSpPr>
        <p:spPr>
          <a:xfrm>
            <a:off x="2260440" y="3498840"/>
            <a:ext cx="152640" cy="187200"/>
          </a:xfrm>
          <a:custGeom>
            <a:avLst/>
            <a:gdLst>
              <a:gd name="textAreaLeft" fmla="*/ 0 w 152640"/>
              <a:gd name="textAreaRight" fmla="*/ 153000 w 152640"/>
              <a:gd name="textAreaTop" fmla="*/ 0 h 187200"/>
              <a:gd name="textAreaBottom" fmla="*/ 187200 h 187200"/>
            </a:gdLst>
            <a:ahLst/>
            <a:rect l="textAreaLeft" t="textAreaTop" r="textAreaRight" b="textAreaBottom"/>
            <a:pathLst>
              <a:path w="21600" h="26479">
                <a:moveTo>
                  <a:pt x="0" y="0"/>
                </a:moveTo>
                <a:arcTo wR="0" hR="0" stAng="10800000" swAng="-5400000"/>
                <a:lnTo>
                  <a:pt x="0" y="26479"/>
                </a:lnTo>
                <a:arcTo wR="0" hR="0" stAng="16200000" swAng="-5400000"/>
                <a:lnTo>
                  <a:pt x="21600" y="26479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ccc63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AutoShape 2"/>
          <p:cNvSpPr/>
          <p:nvPr/>
        </p:nvSpPr>
        <p:spPr>
          <a:xfrm>
            <a:off x="2257560" y="6848640"/>
            <a:ext cx="152280" cy="105696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056960"/>
              <a:gd name="textAreaBottom" fmla="*/ 1039320 h 1056960"/>
            </a:gdLst>
            <a:ahLst/>
            <a:rect l="textAreaLeft" t="textAreaTop" r="textAreaRight" b="textAreaBottom"/>
            <a:pathLst>
              <a:path w="21600" h="149621">
                <a:moveTo>
                  <a:pt x="3600" y="0"/>
                </a:moveTo>
                <a:arcTo wR="3600" hR="3600" stAng="0" swAng="5400000"/>
                <a:lnTo>
                  <a:pt x="0" y="146021"/>
                </a:lnTo>
                <a:arcTo wR="3600" hR="3600" stAng="16200000" swAng="5400000"/>
                <a:lnTo>
                  <a:pt x="18000" y="149621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ceb2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AutoShape 108"/>
          <p:cNvSpPr/>
          <p:nvPr/>
        </p:nvSpPr>
        <p:spPr>
          <a:xfrm flipH="1">
            <a:off x="2256840" y="3235320"/>
            <a:ext cx="152280" cy="257040"/>
          </a:xfrm>
          <a:prstGeom prst="rtTriangle">
            <a:avLst/>
          </a:prstGeom>
          <a:solidFill>
            <a:srgbClr val="bb78b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720" bIns="36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AutoShape 5"/>
          <p:cNvSpPr/>
          <p:nvPr/>
        </p:nvSpPr>
        <p:spPr>
          <a:xfrm>
            <a:off x="2257560" y="4016520"/>
            <a:ext cx="152280" cy="500040"/>
          </a:xfrm>
          <a:custGeom>
            <a:avLst/>
            <a:gdLst>
              <a:gd name="textAreaLeft" fmla="*/ 0 w 152280"/>
              <a:gd name="textAreaRight" fmla="*/ 152640 w 152280"/>
              <a:gd name="textAreaTop" fmla="*/ 0 h 500040"/>
              <a:gd name="textAreaBottom" fmla="*/ 500400 h 500040"/>
            </a:gdLst>
            <a:ahLst/>
            <a:rect l="textAreaLeft" t="textAreaTop" r="textAreaRight" b="textAreaBottom"/>
            <a:pathLst>
              <a:path w="21600" h="70811">
                <a:moveTo>
                  <a:pt x="0" y="0"/>
                </a:moveTo>
                <a:arcTo wR="0" hR="0" stAng="10800000" swAng="-5400000"/>
                <a:lnTo>
                  <a:pt x="0" y="70811"/>
                </a:lnTo>
                <a:arcTo wR="0" hR="0" stAng="16200000" swAng="-5400000"/>
                <a:lnTo>
                  <a:pt x="21600" y="70811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ef252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AutoShape 6"/>
          <p:cNvSpPr/>
          <p:nvPr/>
        </p:nvSpPr>
        <p:spPr>
          <a:xfrm>
            <a:off x="2257560" y="5072040"/>
            <a:ext cx="152280" cy="679320"/>
          </a:xfrm>
          <a:custGeom>
            <a:avLst/>
            <a:gdLst>
              <a:gd name="textAreaLeft" fmla="*/ 0 w 152280"/>
              <a:gd name="textAreaRight" fmla="*/ 152640 w 152280"/>
              <a:gd name="textAreaTop" fmla="*/ 0 h 679320"/>
              <a:gd name="textAreaBottom" fmla="*/ 679680 h 679320"/>
            </a:gdLst>
            <a:ahLst/>
            <a:rect l="textAreaLeft" t="textAreaTop" r="textAreaRight" b="textAreaBottom"/>
            <a:pathLst>
              <a:path w="21600" h="96181">
                <a:moveTo>
                  <a:pt x="0" y="0"/>
                </a:moveTo>
                <a:arcTo wR="0" hR="0" stAng="10800000" swAng="-5400000"/>
                <a:lnTo>
                  <a:pt x="0" y="96181"/>
                </a:lnTo>
                <a:arcTo wR="0" hR="0" stAng="16200000" swAng="-5400000"/>
                <a:lnTo>
                  <a:pt x="21600" y="96181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55c1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AutoShape 7"/>
          <p:cNvSpPr/>
          <p:nvPr/>
        </p:nvSpPr>
        <p:spPr>
          <a:xfrm>
            <a:off x="2257560" y="5705640"/>
            <a:ext cx="152280" cy="1245960"/>
          </a:xfrm>
          <a:custGeom>
            <a:avLst/>
            <a:gdLst>
              <a:gd name="textAreaLeft" fmla="*/ 0 w 152280"/>
              <a:gd name="textAreaRight" fmla="*/ 152640 w 152280"/>
              <a:gd name="textAreaTop" fmla="*/ 0 h 1245960"/>
              <a:gd name="textAreaBottom" fmla="*/ 1245960 h 1245960"/>
            </a:gdLst>
            <a:ahLst/>
            <a:rect l="textAreaLeft" t="textAreaTop" r="textAreaRight" b="textAreaBottom"/>
            <a:pathLst>
              <a:path w="21600" h="176366">
                <a:moveTo>
                  <a:pt x="0" y="0"/>
                </a:moveTo>
                <a:arcTo wR="0" hR="0" stAng="10800000" swAng="-5400000"/>
                <a:lnTo>
                  <a:pt x="0" y="176366"/>
                </a:lnTo>
                <a:arcTo wR="0" hR="0" stAng="16200000" swAng="-5400000"/>
                <a:lnTo>
                  <a:pt x="21600" y="176366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c1153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AutoShape 8"/>
          <p:cNvSpPr/>
          <p:nvPr/>
        </p:nvSpPr>
        <p:spPr>
          <a:xfrm>
            <a:off x="2257560" y="6953400"/>
            <a:ext cx="152280" cy="131760"/>
          </a:xfrm>
          <a:custGeom>
            <a:avLst/>
            <a:gdLst>
              <a:gd name="textAreaLeft" fmla="*/ 0 w 152280"/>
              <a:gd name="textAreaRight" fmla="*/ 152280 w 15228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24955" h="21600">
                <a:moveTo>
                  <a:pt x="0" y="0"/>
                </a:moveTo>
                <a:arcTo wR="0" hR="0" stAng="10800000" swAng="-5400000"/>
                <a:lnTo>
                  <a:pt x="0" y="21600"/>
                </a:lnTo>
                <a:arcTo wR="0" hR="0" stAng="16200000" swAng="-5400000"/>
                <a:lnTo>
                  <a:pt x="24955" y="21600"/>
                </a:lnTo>
                <a:arcTo wR="0" hR="0" stAng="10800000" swAng="-5400000"/>
                <a:lnTo>
                  <a:pt x="24955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9"/>
          <p:cNvSpPr/>
          <p:nvPr/>
        </p:nvSpPr>
        <p:spPr>
          <a:xfrm>
            <a:off x="2391480" y="2825640"/>
            <a:ext cx="7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sat 0.50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10"/>
          <p:cNvSpPr/>
          <p:nvPr/>
        </p:nvSpPr>
        <p:spPr>
          <a:xfrm>
            <a:off x="2476440" y="3757680"/>
            <a:ext cx="861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BS-10, 1BS-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11"/>
          <p:cNvSpPr/>
          <p:nvPr/>
        </p:nvSpPr>
        <p:spPr>
          <a:xfrm>
            <a:off x="2502720" y="4896000"/>
            <a:ext cx="1085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BL-6, 1BL-1 </a:t>
            </a:r>
            <a:r>
              <a:rPr b="0" i="1" lang="en-GB" sz="800" spc="-1" strike="noStrike">
                <a:solidFill>
                  <a:srgbClr val="0619ff"/>
                </a:solidFill>
                <a:latin typeface="Arial"/>
              </a:rPr>
              <a:t>Cab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12"/>
          <p:cNvSpPr/>
          <p:nvPr/>
        </p:nvSpPr>
        <p:spPr>
          <a:xfrm>
            <a:off x="2503440" y="561024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BL-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13"/>
          <p:cNvSpPr/>
          <p:nvPr/>
        </p:nvSpPr>
        <p:spPr>
          <a:xfrm>
            <a:off x="2503800" y="4516560"/>
            <a:ext cx="26316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14"/>
          <p:cNvSpPr/>
          <p:nvPr/>
        </p:nvSpPr>
        <p:spPr>
          <a:xfrm>
            <a:off x="2392200" y="415764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50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15"/>
          <p:cNvSpPr/>
          <p:nvPr/>
        </p:nvSpPr>
        <p:spPr>
          <a:xfrm>
            <a:off x="2391840" y="622152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69-0.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17"/>
          <p:cNvSpPr/>
          <p:nvPr/>
        </p:nvSpPr>
        <p:spPr>
          <a:xfrm>
            <a:off x="2435400" y="7015320"/>
            <a:ext cx="123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8"/>
          <p:cNvSpPr/>
          <p:nvPr/>
        </p:nvSpPr>
        <p:spPr>
          <a:xfrm flipV="1">
            <a:off x="2436840" y="6951240"/>
            <a:ext cx="0" cy="135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19"/>
          <p:cNvSpPr/>
          <p:nvPr/>
        </p:nvSpPr>
        <p:spPr>
          <a:xfrm>
            <a:off x="4500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B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20"/>
          <p:cNvSpPr/>
          <p:nvPr/>
        </p:nvSpPr>
        <p:spPr>
          <a:xfrm>
            <a:off x="206676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B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21"/>
          <p:cNvSpPr/>
          <p:nvPr/>
        </p:nvSpPr>
        <p:spPr>
          <a:xfrm>
            <a:off x="394092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B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29"/>
          <p:cNvSpPr/>
          <p:nvPr/>
        </p:nvSpPr>
        <p:spPr>
          <a:xfrm>
            <a:off x="2430360" y="38606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30"/>
          <p:cNvSpPr/>
          <p:nvPr/>
        </p:nvSpPr>
        <p:spPr>
          <a:xfrm flipV="1">
            <a:off x="2436840" y="3686040"/>
            <a:ext cx="0" cy="331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32"/>
          <p:cNvSpPr/>
          <p:nvPr/>
        </p:nvSpPr>
        <p:spPr>
          <a:xfrm>
            <a:off x="2390760" y="5288040"/>
            <a:ext cx="872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47-0.69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x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5" name="Picture 35" descr="1B Screen shot 2013-01-06 at 17"/>
          <p:cNvPicPr/>
          <p:nvPr/>
        </p:nvPicPr>
        <p:blipFill>
          <a:blip r:embed="rId2"/>
          <a:stretch/>
        </p:blipFill>
        <p:spPr>
          <a:xfrm>
            <a:off x="220680" y="2538360"/>
            <a:ext cx="368280" cy="546264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36" descr="Screen shot 2013-01-06 at 17"/>
          <p:cNvPicPr/>
          <p:nvPr/>
        </p:nvPicPr>
        <p:blipFill>
          <a:blip r:embed="rId3"/>
          <a:stretch/>
        </p:blipFill>
        <p:spPr>
          <a:xfrm>
            <a:off x="272880" y="4594320"/>
            <a:ext cx="201960" cy="415800"/>
          </a:xfrm>
          <a:prstGeom prst="rect">
            <a:avLst/>
          </a:prstGeom>
          <a:ln w="0">
            <a:noFill/>
          </a:ln>
        </p:spPr>
      </p:pic>
      <p:sp>
        <p:nvSpPr>
          <p:cNvPr id="107" name="Line 40"/>
          <p:cNvSpPr/>
          <p:nvPr/>
        </p:nvSpPr>
        <p:spPr>
          <a:xfrm>
            <a:off x="260280" y="4768920"/>
            <a:ext cx="225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41"/>
          <p:cNvSpPr/>
          <p:nvPr/>
        </p:nvSpPr>
        <p:spPr>
          <a:xfrm>
            <a:off x="257040" y="4797360"/>
            <a:ext cx="225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43"/>
          <p:cNvSpPr/>
          <p:nvPr/>
        </p:nvSpPr>
        <p:spPr>
          <a:xfrm>
            <a:off x="495360" y="2549520"/>
            <a:ext cx="1757880" cy="535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1p77.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mgl077, 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Glia (sat 0.50-1.00e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5080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044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0325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308-1B (sat 0.50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5249-1B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5p64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575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5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176-1B, wPt-4366 (sat 0.50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60-1B, wPt-8744 (1.06-sat 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974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34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864-1B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mwg7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5p65.5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06 (1.06-sat 0.31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682-1B (0.84-1.06o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078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787-1B, wPt-5678 (C-0.50Sp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266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694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852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613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43p78.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csu10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1 (C-0.32L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425-1B (C-0.50S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389-1B (0.32-0.69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451-1B (0.47-0.69f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566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2019.2(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Aba8)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25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Glu-B1 (0.47-0.69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280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648 (0.69-0.85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967.2, psr162 (0.69-0.85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17p65.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2p78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403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032-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3295-1B, wPt-0459 (0.69-0.85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809-1B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24, barc188 (0.69-0.85a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92p78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532-1B (0.85-1.00q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7p77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51p65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028-1B (0.85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44"/>
          <p:cNvSpPr/>
          <p:nvPr/>
        </p:nvSpPr>
        <p:spPr>
          <a:xfrm>
            <a:off x="260280" y="5702400"/>
            <a:ext cx="257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Oval 34"/>
          <p:cNvSpPr/>
          <p:nvPr/>
        </p:nvSpPr>
        <p:spPr>
          <a:xfrm>
            <a:off x="297000" y="4540320"/>
            <a:ext cx="15228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48"/>
          <p:cNvSpPr/>
          <p:nvPr/>
        </p:nvSpPr>
        <p:spPr>
          <a:xfrm>
            <a:off x="2391840" y="349236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4-1.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50"/>
          <p:cNvSpPr/>
          <p:nvPr/>
        </p:nvSpPr>
        <p:spPr>
          <a:xfrm>
            <a:off x="2391480" y="3216240"/>
            <a:ext cx="7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sat 0.31-0.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51"/>
          <p:cNvSpPr/>
          <p:nvPr/>
        </p:nvSpPr>
        <p:spPr>
          <a:xfrm>
            <a:off x="2391480" y="3344760"/>
            <a:ext cx="7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.06-sat 0.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52"/>
          <p:cNvSpPr/>
          <p:nvPr/>
        </p:nvSpPr>
        <p:spPr>
          <a:xfrm>
            <a:off x="2502000" y="3149640"/>
            <a:ext cx="183960" cy="19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53"/>
          <p:cNvSpPr/>
          <p:nvPr/>
        </p:nvSpPr>
        <p:spPr>
          <a:xfrm>
            <a:off x="2428920" y="32306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55"/>
          <p:cNvSpPr/>
          <p:nvPr/>
        </p:nvSpPr>
        <p:spPr>
          <a:xfrm>
            <a:off x="2502720" y="3137040"/>
            <a:ext cx="52056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BS-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56"/>
          <p:cNvSpPr/>
          <p:nvPr/>
        </p:nvSpPr>
        <p:spPr>
          <a:xfrm>
            <a:off x="3128040" y="3298680"/>
            <a:ext cx="52056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BS-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57"/>
          <p:cNvSpPr/>
          <p:nvPr/>
        </p:nvSpPr>
        <p:spPr>
          <a:xfrm>
            <a:off x="3128760" y="3409920"/>
            <a:ext cx="46404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BS-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60"/>
          <p:cNvSpPr/>
          <p:nvPr/>
        </p:nvSpPr>
        <p:spPr>
          <a:xfrm>
            <a:off x="2133720" y="4608360"/>
            <a:ext cx="423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61"/>
          <p:cNvSpPr/>
          <p:nvPr/>
        </p:nvSpPr>
        <p:spPr>
          <a:xfrm flipV="1">
            <a:off x="2438280" y="4514760"/>
            <a:ext cx="0" cy="192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62"/>
          <p:cNvSpPr/>
          <p:nvPr/>
        </p:nvSpPr>
        <p:spPr>
          <a:xfrm>
            <a:off x="2428920" y="57056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63"/>
          <p:cNvSpPr/>
          <p:nvPr/>
        </p:nvSpPr>
        <p:spPr>
          <a:xfrm>
            <a:off x="2503440" y="691200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BL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64"/>
          <p:cNvSpPr/>
          <p:nvPr/>
        </p:nvSpPr>
        <p:spPr>
          <a:xfrm>
            <a:off x="2391480" y="7373880"/>
            <a:ext cx="1018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5-1.00 </a:t>
            </a:r>
            <a:r>
              <a:rPr b="0" i="1" lang="en-GB" sz="800" spc="-1" strike="noStrike">
                <a:solidFill>
                  <a:srgbClr val="0619ff"/>
                </a:solidFill>
                <a:latin typeface="Arial"/>
              </a:rPr>
              <a:t>ACC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AutoShape 73"/>
          <p:cNvSpPr/>
          <p:nvPr/>
        </p:nvSpPr>
        <p:spPr>
          <a:xfrm>
            <a:off x="2254320" y="4705200"/>
            <a:ext cx="152280" cy="220680"/>
          </a:xfrm>
          <a:custGeom>
            <a:avLst/>
            <a:gdLst>
              <a:gd name="textAreaLeft" fmla="*/ 0 w 152280"/>
              <a:gd name="textAreaRight" fmla="*/ 152640 w 152280"/>
              <a:gd name="textAreaTop" fmla="*/ 0 h 220680"/>
              <a:gd name="textAreaBottom" fmla="*/ 221040 h 220680"/>
            </a:gdLst>
            <a:ahLst/>
            <a:rect l="textAreaLeft" t="textAreaTop" r="textAreaRight" b="textAreaBottom"/>
            <a:pathLst>
              <a:path w="21600" h="31279">
                <a:moveTo>
                  <a:pt x="0" y="0"/>
                </a:moveTo>
                <a:arcTo wR="0" hR="0" stAng="10800000" swAng="-5400000"/>
                <a:lnTo>
                  <a:pt x="0" y="31279"/>
                </a:lnTo>
                <a:arcTo wR="0" hR="0" stAng="16200000" swAng="-5400000"/>
                <a:lnTo>
                  <a:pt x="21600" y="31279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a933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AutoShape 28"/>
          <p:cNvSpPr/>
          <p:nvPr/>
        </p:nvSpPr>
        <p:spPr>
          <a:xfrm>
            <a:off x="2257560" y="2592360"/>
            <a:ext cx="152280" cy="531504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5315040"/>
              <a:gd name="textAreaBottom" fmla="*/ 5297400 h 5315040"/>
            </a:gdLst>
            <a:ahLst/>
            <a:rect l="textAreaLeft" t="textAreaTop" r="textAreaRight" b="textAreaBottom"/>
            <a:pathLst>
              <a:path w="21600" h="752179">
                <a:moveTo>
                  <a:pt x="3600" y="0"/>
                </a:moveTo>
                <a:arcTo wR="3600" hR="3600" stAng="0" swAng="5400000"/>
                <a:lnTo>
                  <a:pt x="0" y="748579"/>
                </a:lnTo>
                <a:arcTo wR="3600" hR="3600" stAng="16200000" swAng="5400000"/>
                <a:lnTo>
                  <a:pt x="18000" y="752179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75"/>
          <p:cNvSpPr/>
          <p:nvPr/>
        </p:nvSpPr>
        <p:spPr>
          <a:xfrm>
            <a:off x="2389680" y="4711680"/>
            <a:ext cx="54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32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77"/>
          <p:cNvSpPr/>
          <p:nvPr/>
        </p:nvSpPr>
        <p:spPr>
          <a:xfrm flipV="1">
            <a:off x="2438280" y="4925520"/>
            <a:ext cx="0" cy="141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78"/>
          <p:cNvSpPr/>
          <p:nvPr/>
        </p:nvSpPr>
        <p:spPr>
          <a:xfrm>
            <a:off x="2438280" y="499752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0" name="Grupa 11"/>
          <p:cNvGrpSpPr/>
          <p:nvPr/>
        </p:nvGrpSpPr>
        <p:grpSpPr>
          <a:xfrm>
            <a:off x="5375160" y="6280200"/>
            <a:ext cx="459000" cy="1006560"/>
            <a:chOff x="5375160" y="6280200"/>
            <a:chExt cx="459000" cy="1006560"/>
          </a:xfrm>
        </p:grpSpPr>
        <p:pic>
          <p:nvPicPr>
            <p:cNvPr id="131" name="Picture 2" descr=""/>
            <p:cNvPicPr/>
            <p:nvPr/>
          </p:nvPicPr>
          <p:blipFill>
            <a:blip r:embed="rId4"/>
            <a:srcRect l="81090" t="2443" r="9455" b="88061"/>
            <a:stretch/>
          </p:blipFill>
          <p:spPr>
            <a:xfrm>
              <a:off x="5375160" y="6280200"/>
              <a:ext cx="459000" cy="350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2" name="Picture 2" descr=""/>
            <p:cNvPicPr/>
            <p:nvPr/>
          </p:nvPicPr>
          <p:blipFill>
            <a:blip r:embed="rId5"/>
            <a:srcRect l="81090" t="14650" r="9455" b="66948"/>
            <a:stretch/>
          </p:blipFill>
          <p:spPr>
            <a:xfrm>
              <a:off x="5375160" y="6607800"/>
              <a:ext cx="459000" cy="678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33" name="pole tekstowe 4"/>
          <p:cNvSpPr/>
          <p:nvPr/>
        </p:nvSpPr>
        <p:spPr>
          <a:xfrm>
            <a:off x="5734080" y="6248520"/>
            <a:ext cx="990720" cy="105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2008  DW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AutoNum type="arabicPlain" startAt="2008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ET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2010  TR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2011  DI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2010  SPA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2011  SPA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2007  Ca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2007  Y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</a:rPr>
              <a:t>2008  Y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131"/>
          <p:cNvSpPr/>
          <p:nvPr/>
        </p:nvSpPr>
        <p:spPr>
          <a:xfrm>
            <a:off x="3076560" y="34923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132"/>
          <p:cNvSpPr/>
          <p:nvPr/>
        </p:nvSpPr>
        <p:spPr>
          <a:xfrm>
            <a:off x="3076560" y="338292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8" name="Picture 3" descr=""/>
          <p:cNvPicPr/>
          <p:nvPr/>
        </p:nvPicPr>
        <p:blipFill>
          <a:blip r:embed="rId1"/>
          <a:stretch/>
        </p:blipFill>
        <p:spPr>
          <a:xfrm>
            <a:off x="3198960" y="2376360"/>
            <a:ext cx="3430440" cy="5900760"/>
          </a:xfrm>
          <a:prstGeom prst="rect">
            <a:avLst/>
          </a:prstGeom>
          <a:ln w="0">
            <a:noFill/>
          </a:ln>
        </p:spPr>
      </p:pic>
      <p:grpSp>
        <p:nvGrpSpPr>
          <p:cNvPr id="839" name="Group 92"/>
          <p:cNvGrpSpPr/>
          <p:nvPr/>
        </p:nvGrpSpPr>
        <p:grpSpPr>
          <a:xfrm>
            <a:off x="5334120" y="6629400"/>
            <a:ext cx="1104840" cy="413640"/>
            <a:chOff x="5334120" y="6629400"/>
            <a:chExt cx="1104840" cy="413640"/>
          </a:xfrm>
        </p:grpSpPr>
        <p:pic>
          <p:nvPicPr>
            <p:cNvPr id="840" name="Picture 5" descr=""/>
            <p:cNvPicPr/>
            <p:nvPr/>
          </p:nvPicPr>
          <p:blipFill>
            <a:blip r:embed="rId2"/>
            <a:srcRect l="81771" t="2673" r="9851" b="87603"/>
            <a:stretch/>
          </p:blipFill>
          <p:spPr>
            <a:xfrm>
              <a:off x="5334120" y="6680160"/>
              <a:ext cx="442800" cy="35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1" name="pole tekstowe 4"/>
            <p:cNvSpPr/>
            <p:nvPr/>
          </p:nvSpPr>
          <p:spPr>
            <a:xfrm>
              <a:off x="5735520" y="6629400"/>
              <a:ext cx="703440" cy="41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DW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Y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GW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42" name="Picture 43" descr="7B Screen shot 2013-01-11 at 12"/>
          <p:cNvPicPr/>
          <p:nvPr/>
        </p:nvPicPr>
        <p:blipFill>
          <a:blip r:embed="rId3"/>
          <a:srcRect l="0" t="0" r="0" b="88"/>
          <a:stretch/>
        </p:blipFill>
        <p:spPr>
          <a:xfrm>
            <a:off x="227160" y="2593800"/>
            <a:ext cx="271440" cy="5554800"/>
          </a:xfrm>
          <a:prstGeom prst="rect">
            <a:avLst/>
          </a:prstGeom>
          <a:ln w="0">
            <a:noFill/>
          </a:ln>
        </p:spPr>
      </p:pic>
      <p:sp>
        <p:nvSpPr>
          <p:cNvPr id="843" name="AutoShape 3"/>
          <p:cNvSpPr/>
          <p:nvPr/>
        </p:nvSpPr>
        <p:spPr>
          <a:xfrm>
            <a:off x="2536920" y="2622600"/>
            <a:ext cx="149040" cy="2025720"/>
          </a:xfrm>
          <a:custGeom>
            <a:avLst/>
            <a:gdLst>
              <a:gd name="textAreaLeft" fmla="*/ 17280 w 149040"/>
              <a:gd name="textAreaRight" fmla="*/ 131760 w 149040"/>
              <a:gd name="textAreaTop" fmla="*/ 17280 h 2025720"/>
              <a:gd name="textAreaBottom" fmla="*/ 2008440 h 2025720"/>
            </a:gdLst>
            <a:ahLst/>
            <a:rect l="textAreaLeft" t="textAreaTop" r="textAreaRight" b="textAreaBottom"/>
            <a:pathLst>
              <a:path w="21600" h="292927">
                <a:moveTo>
                  <a:pt x="3600" y="0"/>
                </a:moveTo>
                <a:arcTo wR="3600" hR="3600" stAng="0" swAng="5400000"/>
                <a:lnTo>
                  <a:pt x="0" y="289327"/>
                </a:lnTo>
                <a:arcTo wR="3600" hR="3600" stAng="16200000" swAng="5400000"/>
                <a:lnTo>
                  <a:pt x="18000" y="292927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436db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4" name="AutoShape 4"/>
          <p:cNvSpPr/>
          <p:nvPr/>
        </p:nvSpPr>
        <p:spPr>
          <a:xfrm>
            <a:off x="2533680" y="4565520"/>
            <a:ext cx="152280" cy="158760"/>
          </a:xfrm>
          <a:custGeom>
            <a:avLst/>
            <a:gdLst>
              <a:gd name="textAreaLeft" fmla="*/ 0 w 152280"/>
              <a:gd name="textAreaRight" fmla="*/ 152640 w 152280"/>
              <a:gd name="textAreaTop" fmla="*/ 0 h 158760"/>
              <a:gd name="textAreaBottom" fmla="*/ 159120 h 158760"/>
            </a:gdLst>
            <a:ahLst/>
            <a:rect l="textAreaLeft" t="textAreaTop" r="textAreaRight" b="textAreaBottom"/>
            <a:pathLst>
              <a:path w="21600" h="22517">
                <a:moveTo>
                  <a:pt x="0" y="0"/>
                </a:moveTo>
                <a:arcTo wR="0" hR="0" stAng="10800000" swAng="-5400000"/>
                <a:lnTo>
                  <a:pt x="0" y="22517"/>
                </a:lnTo>
                <a:arcTo wR="0" hR="0" stAng="16200000" swAng="-5400000"/>
                <a:lnTo>
                  <a:pt x="21600" y="22517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ef293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5" name="AutoShape 6"/>
          <p:cNvSpPr/>
          <p:nvPr/>
        </p:nvSpPr>
        <p:spPr>
          <a:xfrm>
            <a:off x="2532240" y="5486400"/>
            <a:ext cx="152280" cy="266076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2660760"/>
              <a:gd name="textAreaBottom" fmla="*/ 2643120 h 2660760"/>
            </a:gdLst>
            <a:ahLst/>
            <a:rect l="textAreaLeft" t="textAreaTop" r="textAreaRight" b="textAreaBottom"/>
            <a:pathLst>
              <a:path w="21600" h="376574">
                <a:moveTo>
                  <a:pt x="3600" y="0"/>
                </a:moveTo>
                <a:arcTo wR="3600" hR="3600" stAng="0" swAng="5400000"/>
                <a:lnTo>
                  <a:pt x="0" y="372974"/>
                </a:lnTo>
                <a:arcTo wR="3600" hR="3600" stAng="16200000" swAng="5400000"/>
                <a:lnTo>
                  <a:pt x="18000" y="376574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c1153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6" name="AutoShape 7"/>
          <p:cNvSpPr/>
          <p:nvPr/>
        </p:nvSpPr>
        <p:spPr>
          <a:xfrm>
            <a:off x="2535120" y="4711680"/>
            <a:ext cx="152640" cy="717480"/>
          </a:xfrm>
          <a:custGeom>
            <a:avLst/>
            <a:gdLst>
              <a:gd name="textAreaLeft" fmla="*/ 0 w 152640"/>
              <a:gd name="textAreaRight" fmla="*/ 153000 w 152640"/>
              <a:gd name="textAreaTop" fmla="*/ 0 h 717480"/>
              <a:gd name="textAreaBottom" fmla="*/ 717480 h 717480"/>
            </a:gdLst>
            <a:ahLst/>
            <a:rect l="textAreaLeft" t="textAreaTop" r="textAreaRight" b="textAreaBottom"/>
            <a:pathLst>
              <a:path w="21600" h="101342">
                <a:moveTo>
                  <a:pt x="0" y="0"/>
                </a:moveTo>
                <a:arcTo wR="0" hR="0" stAng="10800000" swAng="-5400000"/>
                <a:lnTo>
                  <a:pt x="0" y="101342"/>
                </a:lnTo>
                <a:arcTo wR="0" hR="0" stAng="16200000" swAng="-5400000"/>
                <a:lnTo>
                  <a:pt x="21600" y="101342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4943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7" name="AutoShape 10"/>
          <p:cNvSpPr/>
          <p:nvPr/>
        </p:nvSpPr>
        <p:spPr>
          <a:xfrm>
            <a:off x="2535120" y="5276880"/>
            <a:ext cx="152640" cy="304920"/>
          </a:xfrm>
          <a:custGeom>
            <a:avLst/>
            <a:gdLst>
              <a:gd name="textAreaLeft" fmla="*/ 0 w 152640"/>
              <a:gd name="textAreaRight" fmla="*/ 153000 w 152640"/>
              <a:gd name="textAreaTop" fmla="*/ 0 h 304920"/>
              <a:gd name="textAreaBottom" fmla="*/ 304920 h 304920"/>
            </a:gdLst>
            <a:ahLst/>
            <a:rect l="textAreaLeft" t="textAreaTop" r="textAreaRight" b="textAreaBottom"/>
            <a:pathLst>
              <a:path w="21600" h="43098">
                <a:moveTo>
                  <a:pt x="0" y="0"/>
                </a:moveTo>
                <a:arcTo wR="0" hR="0" stAng="10800000" swAng="-5400000"/>
                <a:lnTo>
                  <a:pt x="0" y="43098"/>
                </a:lnTo>
                <a:arcTo wR="0" hR="0" stAng="16200000" swAng="-5400000"/>
                <a:lnTo>
                  <a:pt x="21600" y="4309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8" name="AutoShape 51"/>
          <p:cNvSpPr/>
          <p:nvPr/>
        </p:nvSpPr>
        <p:spPr>
          <a:xfrm>
            <a:off x="2533680" y="4908600"/>
            <a:ext cx="152280" cy="336600"/>
          </a:xfrm>
          <a:custGeom>
            <a:avLst/>
            <a:gdLst>
              <a:gd name="textAreaLeft" fmla="*/ 0 w 152280"/>
              <a:gd name="textAreaRight" fmla="*/ 152640 w 152280"/>
              <a:gd name="textAreaTop" fmla="*/ 0 h 336600"/>
              <a:gd name="textAreaBottom" fmla="*/ 336960 h 336600"/>
            </a:gdLst>
            <a:ahLst/>
            <a:rect l="textAreaLeft" t="textAreaTop" r="textAreaRight" b="textAreaBottom"/>
            <a:pathLst>
              <a:path w="21600" h="47683">
                <a:moveTo>
                  <a:pt x="0" y="0"/>
                </a:moveTo>
                <a:arcTo wR="0" hR="0" stAng="10800000" swAng="-5400000"/>
                <a:lnTo>
                  <a:pt x="0" y="47683"/>
                </a:lnTo>
                <a:arcTo wR="0" hR="0" stAng="16200000" swAng="-5400000"/>
                <a:lnTo>
                  <a:pt x="21600" y="47683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9e66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9" name="AutoShape 9"/>
          <p:cNvSpPr/>
          <p:nvPr/>
        </p:nvSpPr>
        <p:spPr>
          <a:xfrm>
            <a:off x="2533680" y="5181480"/>
            <a:ext cx="152280" cy="292320"/>
          </a:xfrm>
          <a:custGeom>
            <a:avLst/>
            <a:gdLst>
              <a:gd name="textAreaLeft" fmla="*/ 0 w 152280"/>
              <a:gd name="textAreaRight" fmla="*/ 152640 w 152280"/>
              <a:gd name="textAreaTop" fmla="*/ 0 h 292320"/>
              <a:gd name="textAreaBottom" fmla="*/ 292680 h 292320"/>
            </a:gdLst>
            <a:ahLst/>
            <a:rect l="textAreaLeft" t="textAreaTop" r="textAreaRight" b="textAreaBottom"/>
            <a:pathLst>
              <a:path w="21600" h="41417">
                <a:moveTo>
                  <a:pt x="0" y="0"/>
                </a:moveTo>
                <a:arcTo wR="0" hR="0" stAng="10800000" swAng="-5400000"/>
                <a:lnTo>
                  <a:pt x="0" y="41417"/>
                </a:lnTo>
                <a:arcTo wR="0" hR="0" stAng="16200000" swAng="-5400000"/>
                <a:lnTo>
                  <a:pt x="21600" y="41417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55c1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0" name="AutoShape 11"/>
          <p:cNvSpPr/>
          <p:nvPr/>
        </p:nvSpPr>
        <p:spPr>
          <a:xfrm>
            <a:off x="2532240" y="2622600"/>
            <a:ext cx="152280" cy="552276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5522760"/>
              <a:gd name="textAreaBottom" fmla="*/ 5505120 h 5522760"/>
            </a:gdLst>
            <a:ahLst/>
            <a:rect l="textAreaLeft" t="textAreaTop" r="textAreaRight" b="textAreaBottom"/>
            <a:pathLst>
              <a:path w="21600" h="781574">
                <a:moveTo>
                  <a:pt x="3600" y="0"/>
                </a:moveTo>
                <a:arcTo wR="3600" hR="3600" stAng="0" swAng="5400000"/>
                <a:lnTo>
                  <a:pt x="0" y="777974"/>
                </a:lnTo>
                <a:arcTo wR="3600" hR="3600" stAng="16200000" swAng="5400000"/>
                <a:lnTo>
                  <a:pt x="18000" y="781574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1" name="Text Box 13"/>
          <p:cNvSpPr/>
          <p:nvPr/>
        </p:nvSpPr>
        <p:spPr>
          <a:xfrm>
            <a:off x="18648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7B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2" name="Text Box 14"/>
          <p:cNvSpPr/>
          <p:nvPr/>
        </p:nvSpPr>
        <p:spPr>
          <a:xfrm>
            <a:off x="221148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7B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3" name="Text Box 15"/>
          <p:cNvSpPr/>
          <p:nvPr/>
        </p:nvSpPr>
        <p:spPr>
          <a:xfrm>
            <a:off x="402192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7B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4" name="Picture 16" descr="Chrom blank Screen shot 2013-01-07 at 10"/>
          <p:cNvPicPr/>
          <p:nvPr/>
        </p:nvPicPr>
        <p:blipFill>
          <a:blip r:embed="rId4">
            <a:lum contrast="-2000"/>
          </a:blip>
          <a:srcRect l="0" t="0" r="7663" b="0"/>
          <a:stretch/>
        </p:blipFill>
        <p:spPr>
          <a:xfrm>
            <a:off x="241200" y="3443400"/>
            <a:ext cx="166680" cy="417240"/>
          </a:xfrm>
          <a:prstGeom prst="rect">
            <a:avLst/>
          </a:prstGeom>
          <a:ln w="0">
            <a:noFill/>
          </a:ln>
        </p:spPr>
      </p:pic>
      <p:sp>
        <p:nvSpPr>
          <p:cNvPr id="855" name="Oval 17"/>
          <p:cNvSpPr/>
          <p:nvPr/>
        </p:nvSpPr>
        <p:spPr>
          <a:xfrm>
            <a:off x="254160" y="4648320"/>
            <a:ext cx="15228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6" name="Text Box 18"/>
          <p:cNvSpPr/>
          <p:nvPr/>
        </p:nvSpPr>
        <p:spPr>
          <a:xfrm>
            <a:off x="2757600" y="461628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7" name="Text Box 19"/>
          <p:cNvSpPr/>
          <p:nvPr/>
        </p:nvSpPr>
        <p:spPr>
          <a:xfrm>
            <a:off x="2680920" y="355140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27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8" name="Text Box 20"/>
          <p:cNvSpPr/>
          <p:nvPr/>
        </p:nvSpPr>
        <p:spPr>
          <a:xfrm>
            <a:off x="2768400" y="444672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BS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9" name="Line 22"/>
          <p:cNvSpPr/>
          <p:nvPr/>
        </p:nvSpPr>
        <p:spPr>
          <a:xfrm>
            <a:off x="2394000" y="471168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0" name="Line 23"/>
          <p:cNvSpPr/>
          <p:nvPr/>
        </p:nvSpPr>
        <p:spPr>
          <a:xfrm>
            <a:off x="2698920" y="4562640"/>
            <a:ext cx="12348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1" name="Text Box 26"/>
          <p:cNvSpPr/>
          <p:nvPr/>
        </p:nvSpPr>
        <p:spPr>
          <a:xfrm>
            <a:off x="2683440" y="4730760"/>
            <a:ext cx="54180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33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2" name="Text Box 34"/>
          <p:cNvSpPr/>
          <p:nvPr/>
        </p:nvSpPr>
        <p:spPr>
          <a:xfrm>
            <a:off x="2768760" y="507528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BL-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3" name="Line 35"/>
          <p:cNvSpPr/>
          <p:nvPr/>
        </p:nvSpPr>
        <p:spPr>
          <a:xfrm>
            <a:off x="2692440" y="517212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4" name="Text Box 38"/>
          <p:cNvSpPr/>
          <p:nvPr/>
        </p:nvSpPr>
        <p:spPr>
          <a:xfrm>
            <a:off x="2768760" y="480708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BL-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5" name="Line 39"/>
          <p:cNvSpPr/>
          <p:nvPr/>
        </p:nvSpPr>
        <p:spPr>
          <a:xfrm>
            <a:off x="2692440" y="490392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6" name="Text Box 40"/>
          <p:cNvSpPr/>
          <p:nvPr/>
        </p:nvSpPr>
        <p:spPr>
          <a:xfrm>
            <a:off x="2680920" y="494028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33-0.6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7" name="Text Box 41"/>
          <p:cNvSpPr/>
          <p:nvPr/>
        </p:nvSpPr>
        <p:spPr>
          <a:xfrm>
            <a:off x="2680920" y="662472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8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8" name="Text Box 44"/>
          <p:cNvSpPr/>
          <p:nvPr/>
        </p:nvSpPr>
        <p:spPr>
          <a:xfrm>
            <a:off x="414360" y="2590920"/>
            <a:ext cx="1909800" cy="555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309-7B (0.27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736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59p78.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76 (0.27-1.00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072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771 (0.27-1.00p)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490.1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Ss1) (0.27-1.00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7, gwm573 (0.27-1.00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1p78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03 (0.27Lb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25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137-7B, wPt-4230 (C-0.33Lq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41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106-7B (C-0.63L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467-7B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927.1 (0.63-0.78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833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919-7B (0.78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070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49p78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2p64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665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3p78.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33 (0.78-1.00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29 (0.63-0.78a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7362-7B (0.78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19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194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300-7B (0.78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938-7B (0.78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156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093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2p64.9, m43p78.14, m71p78.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2p64.11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73a (0.24-0.40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76 (0.78-1.00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7247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190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600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007-7B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875-7B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3p65.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6p65.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066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215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677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7p64.12, 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BE404737 (0.78-1.00e),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8504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140-7B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3700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402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013-7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418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9" name="Text Box 45"/>
          <p:cNvSpPr/>
          <p:nvPr/>
        </p:nvSpPr>
        <p:spPr>
          <a:xfrm>
            <a:off x="2700360" y="452916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27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0" name="Picture 46" descr="Screen shot 2013-01-11 at 14"/>
          <p:cNvPicPr/>
          <p:nvPr/>
        </p:nvPicPr>
        <p:blipFill>
          <a:blip r:embed="rId5"/>
          <a:srcRect l="0" t="20243" r="0" b="0"/>
          <a:stretch/>
        </p:blipFill>
        <p:spPr>
          <a:xfrm>
            <a:off x="212760" y="6006960"/>
            <a:ext cx="280800" cy="90720"/>
          </a:xfrm>
          <a:prstGeom prst="rect">
            <a:avLst/>
          </a:prstGeom>
          <a:ln w="0">
            <a:noFill/>
          </a:ln>
        </p:spPr>
      </p:pic>
      <p:sp>
        <p:nvSpPr>
          <p:cNvPr id="871" name="Line 48"/>
          <p:cNvSpPr/>
          <p:nvPr/>
        </p:nvSpPr>
        <p:spPr>
          <a:xfrm flipV="1">
            <a:off x="2717640" y="5479920"/>
            <a:ext cx="0" cy="108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2" name="Line 49"/>
          <p:cNvSpPr/>
          <p:nvPr/>
        </p:nvSpPr>
        <p:spPr>
          <a:xfrm>
            <a:off x="2709720" y="553068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3" name="Text Box 50"/>
          <p:cNvSpPr/>
          <p:nvPr/>
        </p:nvSpPr>
        <p:spPr>
          <a:xfrm>
            <a:off x="2763720" y="542448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BL-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4" name="Text Box 52"/>
          <p:cNvSpPr/>
          <p:nvPr/>
        </p:nvSpPr>
        <p:spPr>
          <a:xfrm>
            <a:off x="2681280" y="5575320"/>
            <a:ext cx="59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Xantha-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5" name="Text Box 53"/>
          <p:cNvSpPr/>
          <p:nvPr/>
        </p:nvSpPr>
        <p:spPr>
          <a:xfrm>
            <a:off x="2680920" y="521964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63-0.7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6" name="Line 57"/>
          <p:cNvSpPr/>
          <p:nvPr/>
        </p:nvSpPr>
        <p:spPr>
          <a:xfrm>
            <a:off x="5788080" y="2641680"/>
            <a:ext cx="0" cy="54417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7" name="Text Box 58"/>
          <p:cNvSpPr/>
          <p:nvPr/>
        </p:nvSpPr>
        <p:spPr>
          <a:xfrm>
            <a:off x="2679840" y="7481880"/>
            <a:ext cx="56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sy1-B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8" name="Text Box 71"/>
          <p:cNvSpPr/>
          <p:nvPr/>
        </p:nvSpPr>
        <p:spPr>
          <a:xfrm>
            <a:off x="2680200" y="4237200"/>
            <a:ext cx="35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9" name="Picture 2" descr=""/>
          <p:cNvPicPr/>
          <p:nvPr/>
        </p:nvPicPr>
        <p:blipFill>
          <a:blip r:embed="rId1"/>
          <a:stretch/>
        </p:blipFill>
        <p:spPr>
          <a:xfrm>
            <a:off x="3446640" y="2398680"/>
            <a:ext cx="3271680" cy="5708520"/>
          </a:xfrm>
          <a:prstGeom prst="rect">
            <a:avLst/>
          </a:prstGeom>
          <a:ln w="0">
            <a:noFill/>
          </a:ln>
        </p:spPr>
      </p:pic>
      <p:sp>
        <p:nvSpPr>
          <p:cNvPr id="880" name="AutoShape 5"/>
          <p:cNvSpPr/>
          <p:nvPr/>
        </p:nvSpPr>
        <p:spPr>
          <a:xfrm>
            <a:off x="2585880" y="7283520"/>
            <a:ext cx="152640" cy="73008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730080"/>
              <a:gd name="textAreaBottom" fmla="*/ 712080 h 730080"/>
            </a:gdLst>
            <a:ahLst/>
            <a:rect l="textAreaLeft" t="textAreaTop" r="textAreaRight" b="textAreaBottom"/>
            <a:pathLst>
              <a:path w="21600" h="103121">
                <a:moveTo>
                  <a:pt x="3600" y="0"/>
                </a:moveTo>
                <a:arcTo wR="3600" hR="3600" stAng="0" swAng="5400000"/>
                <a:lnTo>
                  <a:pt x="0" y="99521"/>
                </a:lnTo>
                <a:arcTo wR="3600" hR="3600" stAng="16200000" swAng="5400000"/>
                <a:lnTo>
                  <a:pt x="18000" y="103121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c1153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1" name="AutoShape 43"/>
          <p:cNvSpPr/>
          <p:nvPr/>
        </p:nvSpPr>
        <p:spPr>
          <a:xfrm>
            <a:off x="2587680" y="5759280"/>
            <a:ext cx="152280" cy="768600"/>
          </a:xfrm>
          <a:custGeom>
            <a:avLst/>
            <a:gdLst>
              <a:gd name="textAreaLeft" fmla="*/ 0 w 152280"/>
              <a:gd name="textAreaRight" fmla="*/ 152640 w 152280"/>
              <a:gd name="textAreaTop" fmla="*/ 0 h 768600"/>
              <a:gd name="textAreaBottom" fmla="*/ 768960 h 768600"/>
            </a:gdLst>
            <a:ahLst/>
            <a:rect l="textAreaLeft" t="textAreaTop" r="textAreaRight" b="textAreaBottom"/>
            <a:pathLst>
              <a:path w="21600" h="108815">
                <a:moveTo>
                  <a:pt x="0" y="0"/>
                </a:moveTo>
                <a:arcTo wR="0" hR="0" stAng="10800000" swAng="-5400000"/>
                <a:lnTo>
                  <a:pt x="0" y="108815"/>
                </a:lnTo>
                <a:arcTo wR="0" hR="0" stAng="16200000" swAng="-5400000"/>
                <a:lnTo>
                  <a:pt x="21600" y="108815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e8f3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2" name="Picture 38" descr="7D Screen shot 2013-01-11 at 15"/>
          <p:cNvPicPr/>
          <p:nvPr/>
        </p:nvPicPr>
        <p:blipFill>
          <a:blip r:embed="rId2">
            <a:lum bright="6000"/>
          </a:blip>
          <a:stretch/>
        </p:blipFill>
        <p:spPr>
          <a:xfrm>
            <a:off x="120600" y="2575080"/>
            <a:ext cx="311040" cy="5476680"/>
          </a:xfrm>
          <a:prstGeom prst="rect">
            <a:avLst/>
          </a:prstGeom>
          <a:ln w="0">
            <a:noFill/>
          </a:ln>
        </p:spPr>
      </p:pic>
      <p:sp>
        <p:nvSpPr>
          <p:cNvPr id="883" name="AutoShape 3"/>
          <p:cNvSpPr/>
          <p:nvPr/>
        </p:nvSpPr>
        <p:spPr>
          <a:xfrm>
            <a:off x="2590920" y="2622600"/>
            <a:ext cx="149040" cy="2025720"/>
          </a:xfrm>
          <a:custGeom>
            <a:avLst/>
            <a:gdLst>
              <a:gd name="textAreaLeft" fmla="*/ 17280 w 149040"/>
              <a:gd name="textAreaRight" fmla="*/ 131760 w 149040"/>
              <a:gd name="textAreaTop" fmla="*/ 17280 h 2025720"/>
              <a:gd name="textAreaBottom" fmla="*/ 2008440 h 2025720"/>
            </a:gdLst>
            <a:ahLst/>
            <a:rect l="textAreaLeft" t="textAreaTop" r="textAreaRight" b="textAreaBottom"/>
            <a:pathLst>
              <a:path w="21600" h="292927">
                <a:moveTo>
                  <a:pt x="3600" y="0"/>
                </a:moveTo>
                <a:arcTo wR="3600" hR="3600" stAng="0" swAng="5400000"/>
                <a:lnTo>
                  <a:pt x="0" y="289327"/>
                </a:lnTo>
                <a:arcTo wR="3600" hR="3600" stAng="16200000" swAng="5400000"/>
                <a:lnTo>
                  <a:pt x="18000" y="292927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436db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4" name="AutoShape 7"/>
          <p:cNvSpPr/>
          <p:nvPr/>
        </p:nvSpPr>
        <p:spPr>
          <a:xfrm>
            <a:off x="2581200" y="4584600"/>
            <a:ext cx="152640" cy="304920"/>
          </a:xfrm>
          <a:custGeom>
            <a:avLst/>
            <a:gdLst>
              <a:gd name="textAreaLeft" fmla="*/ 0 w 152640"/>
              <a:gd name="textAreaRight" fmla="*/ 153000 w 152640"/>
              <a:gd name="textAreaTop" fmla="*/ 0 h 304920"/>
              <a:gd name="textAreaBottom" fmla="*/ 304920 h 304920"/>
            </a:gdLst>
            <a:ahLst/>
            <a:rect l="textAreaLeft" t="textAreaTop" r="textAreaRight" b="textAreaBottom"/>
            <a:pathLst>
              <a:path w="21600" h="43098">
                <a:moveTo>
                  <a:pt x="0" y="0"/>
                </a:moveTo>
                <a:arcTo wR="0" hR="0" stAng="10800000" swAng="-5400000"/>
                <a:lnTo>
                  <a:pt x="0" y="43098"/>
                </a:lnTo>
                <a:arcTo wR="0" hR="0" stAng="16200000" swAng="-5400000"/>
                <a:lnTo>
                  <a:pt x="21600" y="4309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5" name="AutoShape 9"/>
          <p:cNvSpPr/>
          <p:nvPr/>
        </p:nvSpPr>
        <p:spPr>
          <a:xfrm>
            <a:off x="2587680" y="6419880"/>
            <a:ext cx="152280" cy="743040"/>
          </a:xfrm>
          <a:custGeom>
            <a:avLst/>
            <a:gdLst>
              <a:gd name="textAreaLeft" fmla="*/ 0 w 152280"/>
              <a:gd name="textAreaRight" fmla="*/ 152640 w 152280"/>
              <a:gd name="textAreaTop" fmla="*/ 0 h 743040"/>
              <a:gd name="textAreaBottom" fmla="*/ 743400 h 743040"/>
            </a:gdLst>
            <a:ahLst/>
            <a:rect l="textAreaLeft" t="textAreaTop" r="textAreaRight" b="textAreaBottom"/>
            <a:pathLst>
              <a:path w="21600" h="105198">
                <a:moveTo>
                  <a:pt x="0" y="0"/>
                </a:moveTo>
                <a:arcTo wR="0" hR="0" stAng="10800000" swAng="-5400000"/>
                <a:lnTo>
                  <a:pt x="0" y="105198"/>
                </a:lnTo>
                <a:arcTo wR="0" hR="0" stAng="16200000" swAng="-5400000"/>
                <a:lnTo>
                  <a:pt x="21600" y="10519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55c1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6" name="Text Box 11"/>
          <p:cNvSpPr/>
          <p:nvPr/>
        </p:nvSpPr>
        <p:spPr>
          <a:xfrm>
            <a:off x="145080" y="201132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7D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7" name="Text Box 12"/>
          <p:cNvSpPr/>
          <p:nvPr/>
        </p:nvSpPr>
        <p:spPr>
          <a:xfrm>
            <a:off x="2255760" y="2011320"/>
            <a:ext cx="12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7D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8" name="Text Box 13"/>
          <p:cNvSpPr/>
          <p:nvPr/>
        </p:nvSpPr>
        <p:spPr>
          <a:xfrm>
            <a:off x="4018680" y="2011320"/>
            <a:ext cx="216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7D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9" name="Picture 14" descr="Chrom blank Screen shot 2013-01-07 at 10"/>
          <p:cNvPicPr/>
          <p:nvPr/>
        </p:nvPicPr>
        <p:blipFill>
          <a:blip r:embed="rId3">
            <a:lum contrast="-2000"/>
          </a:blip>
          <a:srcRect l="0" t="0" r="7663" b="0"/>
          <a:stretch/>
        </p:blipFill>
        <p:spPr>
          <a:xfrm>
            <a:off x="157320" y="5070600"/>
            <a:ext cx="169560" cy="722160"/>
          </a:xfrm>
          <a:prstGeom prst="rect">
            <a:avLst/>
          </a:prstGeom>
          <a:ln w="0">
            <a:noFill/>
          </a:ln>
        </p:spPr>
      </p:pic>
      <p:sp>
        <p:nvSpPr>
          <p:cNvPr id="890" name="Oval 15"/>
          <p:cNvSpPr/>
          <p:nvPr/>
        </p:nvSpPr>
        <p:spPr>
          <a:xfrm>
            <a:off x="171360" y="5734080"/>
            <a:ext cx="15264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1" name="Text Box 17"/>
          <p:cNvSpPr/>
          <p:nvPr/>
        </p:nvSpPr>
        <p:spPr>
          <a:xfrm>
            <a:off x="2734920" y="351936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61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2" name="Text Box 24"/>
          <p:cNvSpPr/>
          <p:nvPr/>
        </p:nvSpPr>
        <p:spPr>
          <a:xfrm>
            <a:off x="2822760" y="6313320"/>
            <a:ext cx="79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DL-5, 7DL-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3" name="Line 25"/>
          <p:cNvSpPr/>
          <p:nvPr/>
        </p:nvSpPr>
        <p:spPr>
          <a:xfrm>
            <a:off x="2746440" y="64101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4" name="Text Box 26"/>
          <p:cNvSpPr/>
          <p:nvPr/>
        </p:nvSpPr>
        <p:spPr>
          <a:xfrm>
            <a:off x="2735280" y="521496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36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5" name="Text Box 27"/>
          <p:cNvSpPr/>
          <p:nvPr/>
        </p:nvSpPr>
        <p:spPr>
          <a:xfrm>
            <a:off x="2734560" y="6688080"/>
            <a:ext cx="1052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61-0.82 </a:t>
            </a: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Xantha-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6" name="AutoShape 42"/>
          <p:cNvSpPr/>
          <p:nvPr/>
        </p:nvSpPr>
        <p:spPr>
          <a:xfrm>
            <a:off x="2587680" y="4857840"/>
            <a:ext cx="152280" cy="958680"/>
          </a:xfrm>
          <a:custGeom>
            <a:avLst/>
            <a:gdLst>
              <a:gd name="textAreaLeft" fmla="*/ 0 w 152280"/>
              <a:gd name="textAreaRight" fmla="*/ 152640 w 152280"/>
              <a:gd name="textAreaTop" fmla="*/ 0 h 958680"/>
              <a:gd name="textAreaBottom" fmla="*/ 959040 h 958680"/>
            </a:gdLst>
            <a:ahLst/>
            <a:rect l="textAreaLeft" t="textAreaTop" r="textAreaRight" b="textAreaBottom"/>
            <a:pathLst>
              <a:path w="21600" h="135713">
                <a:moveTo>
                  <a:pt x="0" y="0"/>
                </a:moveTo>
                <a:arcTo wR="0" hR="0" stAng="10800000" swAng="-5400000"/>
                <a:lnTo>
                  <a:pt x="0" y="135713"/>
                </a:lnTo>
                <a:arcTo wR="0" hR="0" stAng="16200000" swAng="-5400000"/>
                <a:lnTo>
                  <a:pt x="21600" y="135713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ee2e3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7" name="Line 32"/>
          <p:cNvSpPr/>
          <p:nvPr/>
        </p:nvSpPr>
        <p:spPr>
          <a:xfrm flipV="1">
            <a:off x="2766960" y="4584240"/>
            <a:ext cx="0" cy="273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8" name="Text Box 34"/>
          <p:cNvSpPr/>
          <p:nvPr/>
        </p:nvSpPr>
        <p:spPr>
          <a:xfrm>
            <a:off x="2816640" y="4616280"/>
            <a:ext cx="81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DS-4, 7DS-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9" name="Text Box 36"/>
          <p:cNvSpPr/>
          <p:nvPr/>
        </p:nvSpPr>
        <p:spPr>
          <a:xfrm>
            <a:off x="2735640" y="6006960"/>
            <a:ext cx="54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30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0" name="Line 39"/>
          <p:cNvSpPr/>
          <p:nvPr/>
        </p:nvSpPr>
        <p:spPr>
          <a:xfrm>
            <a:off x="155520" y="5524560"/>
            <a:ext cx="182520" cy="0"/>
          </a:xfrm>
          <a:prstGeom prst="line">
            <a:avLst/>
          </a:prstGeom>
          <a:ln w="172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1" name="Text Box 40"/>
          <p:cNvSpPr/>
          <p:nvPr/>
        </p:nvSpPr>
        <p:spPr>
          <a:xfrm>
            <a:off x="349200" y="2590920"/>
            <a:ext cx="2341440" cy="54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92.2 (0.61-1.00b), psr160.2(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Plc)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4727,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359-7D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	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              wPt-5150-7D (0.61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57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45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354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372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459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934-7D (0.61-1.00f)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63.1 (0.61-1.00b)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11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635a (0.61-1.00ad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3028                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(0.36-0.61a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406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333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43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350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7174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31 (C-0.36Sa) (0.61-1.00r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63 (0.61-1.00c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54 (0.61-1.00as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mgl5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35 (1.00S-0.30Lt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789-7D (0.36S-0.30Lu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709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508-7D (C-0.15Sv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0208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113, barc26 (C-0.30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437 (C-0.30La) (C-0.14L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4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88a (C-0.30L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45 (0.76-0.82w) (0.30-0.82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94b (0.61-0.82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57 (0.30-0.61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4354 (0.82-1.00y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674-7D (0.82-1.00z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8151, wPt-4441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1p77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73b (0.77-1.00d), gwm37 (0.82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1p77.7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054-7D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BG6078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2" name="AutoShape 44"/>
          <p:cNvSpPr/>
          <p:nvPr/>
        </p:nvSpPr>
        <p:spPr>
          <a:xfrm>
            <a:off x="2587680" y="7232760"/>
            <a:ext cx="152280" cy="164880"/>
          </a:xfrm>
          <a:custGeom>
            <a:avLst/>
            <a:gdLst>
              <a:gd name="textAreaLeft" fmla="*/ 0 w 152280"/>
              <a:gd name="textAreaRight" fmla="*/ 152640 w 152280"/>
              <a:gd name="textAreaTop" fmla="*/ 0 h 164880"/>
              <a:gd name="textAreaBottom" fmla="*/ 165240 h 164880"/>
            </a:gdLst>
            <a:ahLst/>
            <a:rect l="textAreaLeft" t="textAreaTop" r="textAreaRight" b="textAreaBottom"/>
            <a:pathLst>
              <a:path w="21600" h="23383">
                <a:moveTo>
                  <a:pt x="0" y="0"/>
                </a:moveTo>
                <a:arcTo wR="0" hR="0" stAng="10800000" swAng="-5400000"/>
                <a:lnTo>
                  <a:pt x="0" y="23383"/>
                </a:lnTo>
                <a:arcTo wR="0" hR="0" stAng="16200000" swAng="-5400000"/>
                <a:lnTo>
                  <a:pt x="21600" y="23383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3" name="AutoShape 10"/>
          <p:cNvSpPr/>
          <p:nvPr/>
        </p:nvSpPr>
        <p:spPr>
          <a:xfrm>
            <a:off x="2585880" y="2622600"/>
            <a:ext cx="152640" cy="538956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5389560"/>
              <a:gd name="textAreaBottom" fmla="*/ 5371560 h 5389560"/>
            </a:gdLst>
            <a:ahLst/>
            <a:rect l="textAreaLeft" t="textAreaTop" r="textAreaRight" b="textAreaBottom"/>
            <a:pathLst>
              <a:path w="21600" h="760930">
                <a:moveTo>
                  <a:pt x="3600" y="0"/>
                </a:moveTo>
                <a:arcTo wR="3600" hR="3600" stAng="0" swAng="5400000"/>
                <a:lnTo>
                  <a:pt x="0" y="757330"/>
                </a:lnTo>
                <a:arcTo wR="3600" hR="3600" stAng="16200000" swAng="5400000"/>
                <a:lnTo>
                  <a:pt x="18000" y="760930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4" name="Text Box 16"/>
          <p:cNvSpPr/>
          <p:nvPr/>
        </p:nvSpPr>
        <p:spPr>
          <a:xfrm>
            <a:off x="2811600" y="570852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5" name="Line 19"/>
          <p:cNvSpPr/>
          <p:nvPr/>
        </p:nvSpPr>
        <p:spPr>
          <a:xfrm>
            <a:off x="2448000" y="581040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6" name="Line 45"/>
          <p:cNvSpPr/>
          <p:nvPr/>
        </p:nvSpPr>
        <p:spPr>
          <a:xfrm flipV="1">
            <a:off x="2768760" y="7162920"/>
            <a:ext cx="0" cy="234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7" name="Line 46"/>
          <p:cNvSpPr/>
          <p:nvPr/>
        </p:nvSpPr>
        <p:spPr>
          <a:xfrm>
            <a:off x="2765520" y="72770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8" name="Text Box 47"/>
          <p:cNvSpPr/>
          <p:nvPr/>
        </p:nvSpPr>
        <p:spPr>
          <a:xfrm>
            <a:off x="2819520" y="7175520"/>
            <a:ext cx="45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DL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9" name="Text Box 48"/>
          <p:cNvSpPr/>
          <p:nvPr/>
        </p:nvSpPr>
        <p:spPr>
          <a:xfrm>
            <a:off x="2734920" y="757548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2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0" name="Text Box 49"/>
          <p:cNvSpPr/>
          <p:nvPr/>
        </p:nvSpPr>
        <p:spPr>
          <a:xfrm>
            <a:off x="2734560" y="2602080"/>
            <a:ext cx="32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l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1" name="Line 52"/>
          <p:cNvSpPr/>
          <p:nvPr/>
        </p:nvSpPr>
        <p:spPr>
          <a:xfrm>
            <a:off x="2762280" y="47163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2" name="Line 57"/>
          <p:cNvSpPr/>
          <p:nvPr/>
        </p:nvSpPr>
        <p:spPr>
          <a:xfrm>
            <a:off x="5245200" y="2641680"/>
            <a:ext cx="0" cy="528300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3" name="Text Box 58"/>
          <p:cNvSpPr/>
          <p:nvPr/>
        </p:nvSpPr>
        <p:spPr>
          <a:xfrm>
            <a:off x="2734200" y="2730600"/>
            <a:ext cx="35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4" name="Text Box 60"/>
          <p:cNvSpPr/>
          <p:nvPr/>
        </p:nvSpPr>
        <p:spPr>
          <a:xfrm>
            <a:off x="2733840" y="7684920"/>
            <a:ext cx="57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ef2c2b"/>
                </a:solidFill>
                <a:latin typeface="Arial"/>
              </a:rPr>
              <a:t>Psy1-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15" name="Group 70"/>
          <p:cNvGrpSpPr/>
          <p:nvPr/>
        </p:nvGrpSpPr>
        <p:grpSpPr>
          <a:xfrm>
            <a:off x="5407200" y="5641920"/>
            <a:ext cx="1209240" cy="946440"/>
            <a:chOff x="5407200" y="5641920"/>
            <a:chExt cx="1209240" cy="946440"/>
          </a:xfrm>
        </p:grpSpPr>
        <p:pic>
          <p:nvPicPr>
            <p:cNvPr id="916" name="Picture 4" descr=""/>
            <p:cNvPicPr/>
            <p:nvPr/>
          </p:nvPicPr>
          <p:blipFill>
            <a:blip r:embed="rId4"/>
            <a:srcRect l="82187" t="2707" r="9601" b="73544"/>
            <a:stretch/>
          </p:blipFill>
          <p:spPr>
            <a:xfrm>
              <a:off x="5407200" y="5692680"/>
              <a:ext cx="496800" cy="86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7" name="pole tekstowe 4"/>
            <p:cNvSpPr/>
            <p:nvPr/>
          </p:nvSpPr>
          <p:spPr>
            <a:xfrm>
              <a:off x="5794200" y="5641920"/>
              <a:ext cx="822240" cy="94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Chl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+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SPA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Ca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DI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Picture 2" descr=""/>
          <p:cNvPicPr/>
          <p:nvPr/>
        </p:nvPicPr>
        <p:blipFill>
          <a:blip r:embed="rId1"/>
          <a:stretch/>
        </p:blipFill>
        <p:spPr>
          <a:xfrm>
            <a:off x="3414600" y="2387520"/>
            <a:ext cx="3195720" cy="546408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53" descr="1D Screen shot 2013-01-07 at 11"/>
          <p:cNvPicPr/>
          <p:nvPr/>
        </p:nvPicPr>
        <p:blipFill>
          <a:blip r:embed="rId2"/>
          <a:stretch/>
        </p:blipFill>
        <p:spPr>
          <a:xfrm>
            <a:off x="222120" y="2530440"/>
            <a:ext cx="349560" cy="5334120"/>
          </a:xfrm>
          <a:prstGeom prst="rect">
            <a:avLst/>
          </a:prstGeom>
          <a:ln w="0">
            <a:noFill/>
          </a:ln>
        </p:spPr>
      </p:pic>
      <p:sp>
        <p:nvSpPr>
          <p:cNvPr id="138" name="AutoShape 2"/>
          <p:cNvSpPr/>
          <p:nvPr/>
        </p:nvSpPr>
        <p:spPr>
          <a:xfrm>
            <a:off x="2257560" y="2585880"/>
            <a:ext cx="152280" cy="15289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528920"/>
              <a:gd name="textAreaBottom" fmla="*/ 1511280 h 1528920"/>
            </a:gdLst>
            <a:ahLst/>
            <a:rect l="textAreaLeft" t="textAreaTop" r="textAreaRight" b="textAreaBottom"/>
            <a:pathLst>
              <a:path w="21600" h="216408">
                <a:moveTo>
                  <a:pt x="3600" y="0"/>
                </a:moveTo>
                <a:arcTo wR="3600" hR="3600" stAng="0" swAng="5400000"/>
                <a:lnTo>
                  <a:pt x="0" y="212808"/>
                </a:lnTo>
                <a:arcTo wR="3600" hR="3600" stAng="16200000" swAng="5400000"/>
                <a:lnTo>
                  <a:pt x="18000" y="216408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436db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AutoShape 55"/>
          <p:cNvSpPr/>
          <p:nvPr/>
        </p:nvSpPr>
        <p:spPr>
          <a:xfrm>
            <a:off x="2262240" y="4027320"/>
            <a:ext cx="152280" cy="131760"/>
          </a:xfrm>
          <a:custGeom>
            <a:avLst/>
            <a:gdLst>
              <a:gd name="textAreaLeft" fmla="*/ 0 w 152280"/>
              <a:gd name="textAreaRight" fmla="*/ 152280 w 15228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24955" h="21600">
                <a:moveTo>
                  <a:pt x="0" y="0"/>
                </a:moveTo>
                <a:arcTo wR="0" hR="0" stAng="10800000" swAng="-5400000"/>
                <a:lnTo>
                  <a:pt x="0" y="21600"/>
                </a:lnTo>
                <a:arcTo wR="0" hR="0" stAng="16200000" swAng="-5400000"/>
                <a:lnTo>
                  <a:pt x="24955" y="21600"/>
                </a:lnTo>
                <a:arcTo wR="0" hR="0" stAng="10800000" swAng="-5400000"/>
                <a:lnTo>
                  <a:pt x="24955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AutoShape 5"/>
          <p:cNvSpPr/>
          <p:nvPr/>
        </p:nvSpPr>
        <p:spPr>
          <a:xfrm>
            <a:off x="2257560" y="5494320"/>
            <a:ext cx="152280" cy="227664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2276640"/>
              <a:gd name="textAreaBottom" fmla="*/ 2259000 h 2276640"/>
            </a:gdLst>
            <a:ahLst/>
            <a:rect l="textAreaLeft" t="textAreaTop" r="textAreaRight" b="textAreaBottom"/>
            <a:pathLst>
              <a:path w="21600" h="322217">
                <a:moveTo>
                  <a:pt x="3600" y="0"/>
                </a:moveTo>
                <a:arcTo wR="3600" hR="3600" stAng="0" swAng="5400000"/>
                <a:lnTo>
                  <a:pt x="0" y="318617"/>
                </a:lnTo>
                <a:arcTo wR="3600" hR="3600" stAng="16200000" swAng="5400000"/>
                <a:lnTo>
                  <a:pt x="18000" y="322217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55c1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AutoShape 8"/>
          <p:cNvSpPr/>
          <p:nvPr/>
        </p:nvSpPr>
        <p:spPr>
          <a:xfrm>
            <a:off x="2257560" y="4648320"/>
            <a:ext cx="152280" cy="608040"/>
          </a:xfrm>
          <a:custGeom>
            <a:avLst/>
            <a:gdLst>
              <a:gd name="textAreaLeft" fmla="*/ 0 w 152280"/>
              <a:gd name="textAreaRight" fmla="*/ 152640 w 152280"/>
              <a:gd name="textAreaTop" fmla="*/ 0 h 608040"/>
              <a:gd name="textAreaBottom" fmla="*/ 608040 h 608040"/>
            </a:gdLst>
            <a:ahLst/>
            <a:rect l="textAreaLeft" t="textAreaTop" r="textAreaRight" b="textAreaBottom"/>
            <a:pathLst>
              <a:path w="21600" h="86094">
                <a:moveTo>
                  <a:pt x="0" y="0"/>
                </a:moveTo>
                <a:arcTo wR="0" hR="0" stAng="10800000" swAng="-5400000"/>
                <a:lnTo>
                  <a:pt x="0" y="86094"/>
                </a:lnTo>
                <a:arcTo wR="0" hR="0" stAng="16200000" swAng="-5400000"/>
                <a:lnTo>
                  <a:pt x="21600" y="86094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913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AutoShape 6"/>
          <p:cNvSpPr/>
          <p:nvPr/>
        </p:nvSpPr>
        <p:spPr>
          <a:xfrm>
            <a:off x="2257560" y="4311720"/>
            <a:ext cx="152280" cy="407880"/>
          </a:xfrm>
          <a:custGeom>
            <a:avLst/>
            <a:gdLst>
              <a:gd name="textAreaLeft" fmla="*/ 0 w 152280"/>
              <a:gd name="textAreaRight" fmla="*/ 152640 w 152280"/>
              <a:gd name="textAreaTop" fmla="*/ 0 h 407880"/>
              <a:gd name="textAreaBottom" fmla="*/ 408240 h 407880"/>
            </a:gdLst>
            <a:ahLst/>
            <a:rect l="textAreaLeft" t="textAreaTop" r="textAreaRight" b="textAreaBottom"/>
            <a:pathLst>
              <a:path w="21600" h="57770">
                <a:moveTo>
                  <a:pt x="0" y="0"/>
                </a:moveTo>
                <a:arcTo wR="0" hR="0" stAng="10800000" swAng="-5400000"/>
                <a:lnTo>
                  <a:pt x="0" y="57770"/>
                </a:lnTo>
                <a:arcTo wR="0" hR="0" stAng="16200000" swAng="-5400000"/>
                <a:lnTo>
                  <a:pt x="21600" y="57770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8bd19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AutoShape 10"/>
          <p:cNvSpPr/>
          <p:nvPr/>
        </p:nvSpPr>
        <p:spPr>
          <a:xfrm>
            <a:off x="2257560" y="5438880"/>
            <a:ext cx="152280" cy="131760"/>
          </a:xfrm>
          <a:custGeom>
            <a:avLst/>
            <a:gdLst>
              <a:gd name="textAreaLeft" fmla="*/ 0 w 152280"/>
              <a:gd name="textAreaRight" fmla="*/ 152280 w 15228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24955" h="21600">
                <a:moveTo>
                  <a:pt x="0" y="0"/>
                </a:moveTo>
                <a:arcTo wR="0" hR="0" stAng="10800000" swAng="-5400000"/>
                <a:lnTo>
                  <a:pt x="0" y="21600"/>
                </a:lnTo>
                <a:arcTo wR="0" hR="0" stAng="16200000" swAng="-5400000"/>
                <a:lnTo>
                  <a:pt x="24955" y="21600"/>
                </a:lnTo>
                <a:arcTo wR="0" hR="0" stAng="10800000" swAng="-5400000"/>
                <a:lnTo>
                  <a:pt x="24955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12"/>
          <p:cNvSpPr/>
          <p:nvPr/>
        </p:nvSpPr>
        <p:spPr>
          <a:xfrm>
            <a:off x="2477880" y="4064040"/>
            <a:ext cx="46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DS-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13"/>
          <p:cNvSpPr/>
          <p:nvPr/>
        </p:nvSpPr>
        <p:spPr>
          <a:xfrm>
            <a:off x="2503800" y="461484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16"/>
          <p:cNvSpPr/>
          <p:nvPr/>
        </p:nvSpPr>
        <p:spPr>
          <a:xfrm>
            <a:off x="2391840" y="426240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9-0.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18"/>
          <p:cNvSpPr/>
          <p:nvPr/>
        </p:nvSpPr>
        <p:spPr>
          <a:xfrm>
            <a:off x="2435400" y="5415120"/>
            <a:ext cx="123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19"/>
          <p:cNvSpPr/>
          <p:nvPr/>
        </p:nvSpPr>
        <p:spPr>
          <a:xfrm flipV="1">
            <a:off x="2438280" y="5257800"/>
            <a:ext cx="0" cy="3096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20"/>
          <p:cNvSpPr/>
          <p:nvPr/>
        </p:nvSpPr>
        <p:spPr>
          <a:xfrm>
            <a:off x="42120" y="201132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D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21"/>
          <p:cNvSpPr/>
          <p:nvPr/>
        </p:nvSpPr>
        <p:spPr>
          <a:xfrm>
            <a:off x="2006640" y="2011320"/>
            <a:ext cx="12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D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 Box 22"/>
          <p:cNvSpPr/>
          <p:nvPr/>
        </p:nvSpPr>
        <p:spPr>
          <a:xfrm>
            <a:off x="3938040" y="2011320"/>
            <a:ext cx="216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D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24"/>
          <p:cNvSpPr/>
          <p:nvPr/>
        </p:nvSpPr>
        <p:spPr>
          <a:xfrm>
            <a:off x="2430360" y="41673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25"/>
          <p:cNvSpPr/>
          <p:nvPr/>
        </p:nvSpPr>
        <p:spPr>
          <a:xfrm flipV="1">
            <a:off x="2438280" y="4029120"/>
            <a:ext cx="0" cy="280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26"/>
          <p:cNvSpPr/>
          <p:nvPr/>
        </p:nvSpPr>
        <p:spPr>
          <a:xfrm>
            <a:off x="2392920" y="4888080"/>
            <a:ext cx="54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18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Oval 35"/>
          <p:cNvSpPr/>
          <p:nvPr/>
        </p:nvSpPr>
        <p:spPr>
          <a:xfrm>
            <a:off x="304920" y="4648320"/>
            <a:ext cx="15228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36"/>
          <p:cNvSpPr/>
          <p:nvPr/>
        </p:nvSpPr>
        <p:spPr>
          <a:xfrm>
            <a:off x="2391840" y="322596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0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39"/>
          <p:cNvSpPr/>
          <p:nvPr/>
        </p:nvSpPr>
        <p:spPr>
          <a:xfrm>
            <a:off x="2502000" y="5292720"/>
            <a:ext cx="183960" cy="19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47"/>
          <p:cNvSpPr/>
          <p:nvPr/>
        </p:nvSpPr>
        <p:spPr>
          <a:xfrm>
            <a:off x="2503440" y="5311800"/>
            <a:ext cx="1095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DL-4, 1DL-2 </a:t>
            </a:r>
            <a:r>
              <a:rPr b="0" i="1" lang="en-GB" sz="800" spc="-1" strike="noStrike">
                <a:solidFill>
                  <a:srgbClr val="0619ff"/>
                </a:solidFill>
                <a:latin typeface="Arial"/>
              </a:rPr>
              <a:t>Cab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48"/>
          <p:cNvSpPr/>
          <p:nvPr/>
        </p:nvSpPr>
        <p:spPr>
          <a:xfrm>
            <a:off x="2391480" y="6505560"/>
            <a:ext cx="93960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41-1.00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Cab2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CytP, GluT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0" name="Picture 51" descr="Chrom blank Screen shot 2013-01-07 at 10"/>
          <p:cNvPicPr/>
          <p:nvPr/>
        </p:nvPicPr>
        <p:blipFill>
          <a:blip r:embed="rId3"/>
          <a:srcRect l="0" t="6669" r="0" b="0"/>
          <a:stretch/>
        </p:blipFill>
        <p:spPr>
          <a:xfrm>
            <a:off x="271440" y="5014800"/>
            <a:ext cx="228600" cy="503280"/>
          </a:xfrm>
          <a:prstGeom prst="rect">
            <a:avLst/>
          </a:prstGeom>
          <a:ln w="0">
            <a:noFill/>
          </a:ln>
        </p:spPr>
      </p:pic>
      <p:sp>
        <p:nvSpPr>
          <p:cNvPr id="161" name="Text Box 52"/>
          <p:cNvSpPr/>
          <p:nvPr/>
        </p:nvSpPr>
        <p:spPr>
          <a:xfrm>
            <a:off x="488520" y="2575080"/>
            <a:ext cx="1701720" cy="519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078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32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71592, wPt-0786 (0.7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738-1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73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0p64.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46-1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707-1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664-1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39p78.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7199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206-1D (0.70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482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1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3p65.3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rPt-4471-1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503-1D, wPt-5320 (C-0.48r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671-1D (0.59-0.7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65a (C-0.18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29 (C-0.18L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316-1D (C-0.18Ls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79.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642 (0.41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Glu-D1 (0.41-1.00b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743-1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6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27 (0.41-1.00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405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408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8p78.3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059-1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55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2982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488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263-1D, wPt-4427 (0.1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711-1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685-1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5p64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59p78.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AutoShape 69"/>
          <p:cNvSpPr/>
          <p:nvPr/>
        </p:nvSpPr>
        <p:spPr>
          <a:xfrm flipH="1">
            <a:off x="2255760" y="4336920"/>
            <a:ext cx="152640" cy="387360"/>
          </a:xfrm>
          <a:prstGeom prst="rtTriangle">
            <a:avLst/>
          </a:prstGeom>
          <a:solidFill>
            <a:srgbClr val="e9212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Line 59"/>
          <p:cNvSpPr/>
          <p:nvPr/>
        </p:nvSpPr>
        <p:spPr>
          <a:xfrm>
            <a:off x="2133720" y="472428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AutoShape 23"/>
          <p:cNvSpPr/>
          <p:nvPr/>
        </p:nvSpPr>
        <p:spPr>
          <a:xfrm>
            <a:off x="2257560" y="2592360"/>
            <a:ext cx="152280" cy="517680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5176800"/>
              <a:gd name="textAreaBottom" fmla="*/ 5159160 h 5176800"/>
            </a:gdLst>
            <a:ahLst/>
            <a:rect l="textAreaLeft" t="textAreaTop" r="textAreaRight" b="textAreaBottom"/>
            <a:pathLst>
              <a:path w="21600" h="732617">
                <a:moveTo>
                  <a:pt x="3600" y="0"/>
                </a:moveTo>
                <a:arcTo wR="3600" hR="3600" stAng="0" swAng="5400000"/>
                <a:lnTo>
                  <a:pt x="0" y="729017"/>
                </a:lnTo>
                <a:arcTo wR="3600" hR="3600" stAng="16200000" swAng="5400000"/>
                <a:lnTo>
                  <a:pt x="18000" y="732617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70"/>
          <p:cNvSpPr/>
          <p:nvPr/>
        </p:nvSpPr>
        <p:spPr>
          <a:xfrm>
            <a:off x="2390760" y="4522680"/>
            <a:ext cx="81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48S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x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71"/>
          <p:cNvSpPr/>
          <p:nvPr/>
        </p:nvSpPr>
        <p:spPr>
          <a:xfrm>
            <a:off x="2477160" y="4398840"/>
            <a:ext cx="81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1DS-1, 1DS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Line 72"/>
          <p:cNvSpPr/>
          <p:nvPr/>
        </p:nvSpPr>
        <p:spPr>
          <a:xfrm>
            <a:off x="2432160" y="450540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73"/>
          <p:cNvSpPr/>
          <p:nvPr/>
        </p:nvSpPr>
        <p:spPr>
          <a:xfrm flipV="1">
            <a:off x="2440080" y="4366800"/>
            <a:ext cx="0" cy="2811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76"/>
          <p:cNvSpPr/>
          <p:nvPr/>
        </p:nvSpPr>
        <p:spPr>
          <a:xfrm>
            <a:off x="5172120" y="2625840"/>
            <a:ext cx="0" cy="50511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ole tekstowe 4"/>
          <p:cNvSpPr/>
          <p:nvPr/>
        </p:nvSpPr>
        <p:spPr>
          <a:xfrm>
            <a:off x="5686560" y="5486400"/>
            <a:ext cx="847440" cy="8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1  SPA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TR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0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TR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DI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0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DI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ABS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1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F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v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F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1" name="Picture 2" descr=""/>
          <p:cNvPicPr/>
          <p:nvPr/>
        </p:nvPicPr>
        <p:blipFill>
          <a:blip r:embed="rId4"/>
          <a:srcRect l="81980" t="1977" r="9659" b="75594"/>
          <a:stretch/>
        </p:blipFill>
        <p:spPr>
          <a:xfrm>
            <a:off x="5346720" y="5505480"/>
            <a:ext cx="420840" cy="807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2" name="Picture 3" descr=""/>
          <p:cNvPicPr/>
          <p:nvPr/>
        </p:nvPicPr>
        <p:blipFill>
          <a:blip r:embed="rId1"/>
          <a:stretch/>
        </p:blipFill>
        <p:spPr>
          <a:xfrm>
            <a:off x="3591000" y="2351160"/>
            <a:ext cx="3146400" cy="6013440"/>
          </a:xfrm>
          <a:prstGeom prst="rect">
            <a:avLst/>
          </a:prstGeom>
          <a:ln w="0">
            <a:noFill/>
          </a:ln>
        </p:spPr>
      </p:pic>
      <p:sp>
        <p:nvSpPr>
          <p:cNvPr id="173" name="Line 49"/>
          <p:cNvSpPr/>
          <p:nvPr/>
        </p:nvSpPr>
        <p:spPr>
          <a:xfrm>
            <a:off x="5645160" y="2604960"/>
            <a:ext cx="0" cy="5580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AutoShape 3"/>
          <p:cNvSpPr/>
          <p:nvPr/>
        </p:nvSpPr>
        <p:spPr>
          <a:xfrm>
            <a:off x="2440080" y="2585880"/>
            <a:ext cx="152280" cy="183384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833840"/>
              <a:gd name="textAreaBottom" fmla="*/ 1816200 h 1833840"/>
            </a:gdLst>
            <a:ahLst/>
            <a:rect l="textAreaLeft" t="textAreaTop" r="textAreaRight" b="textAreaBottom"/>
            <a:pathLst>
              <a:path w="21600" h="259557">
                <a:moveTo>
                  <a:pt x="3600" y="0"/>
                </a:moveTo>
                <a:arcTo wR="3600" hR="3600" stAng="0" swAng="5400000"/>
                <a:lnTo>
                  <a:pt x="0" y="255957"/>
                </a:lnTo>
                <a:arcTo wR="3600" hR="3600" stAng="16200000" swAng="5400000"/>
                <a:lnTo>
                  <a:pt x="18000" y="259557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1d62a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AutoShape 4"/>
          <p:cNvSpPr/>
          <p:nvPr/>
        </p:nvSpPr>
        <p:spPr>
          <a:xfrm>
            <a:off x="2444760" y="5506920"/>
            <a:ext cx="152280" cy="131760"/>
          </a:xfrm>
          <a:custGeom>
            <a:avLst/>
            <a:gdLst>
              <a:gd name="textAreaLeft" fmla="*/ 0 w 152280"/>
              <a:gd name="textAreaRight" fmla="*/ 152280 w 15228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24955" h="21600">
                <a:moveTo>
                  <a:pt x="0" y="0"/>
                </a:moveTo>
                <a:arcTo wR="0" hR="0" stAng="10800000" swAng="-5400000"/>
                <a:lnTo>
                  <a:pt x="0" y="21600"/>
                </a:lnTo>
                <a:arcTo wR="0" hR="0" stAng="16200000" swAng="-5400000"/>
                <a:lnTo>
                  <a:pt x="24955" y="21600"/>
                </a:lnTo>
                <a:arcTo wR="0" hR="0" stAng="10800000" swAng="-5400000"/>
                <a:lnTo>
                  <a:pt x="24955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AutoShape 5"/>
          <p:cNvSpPr/>
          <p:nvPr/>
        </p:nvSpPr>
        <p:spPr>
          <a:xfrm>
            <a:off x="2440080" y="6713640"/>
            <a:ext cx="152280" cy="15523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552320"/>
              <a:gd name="textAreaBottom" fmla="*/ 1534680 h 1552320"/>
            </a:gdLst>
            <a:ahLst/>
            <a:rect l="textAreaLeft" t="textAreaTop" r="textAreaRight" b="textAreaBottom"/>
            <a:pathLst>
              <a:path w="21600" h="219719">
                <a:moveTo>
                  <a:pt x="3600" y="0"/>
                </a:moveTo>
                <a:arcTo wR="3600" hR="3600" stAng="0" swAng="5400000"/>
                <a:lnTo>
                  <a:pt x="0" y="216119"/>
                </a:lnTo>
                <a:arcTo wR="3600" hR="3600" stAng="16200000" swAng="5400000"/>
                <a:lnTo>
                  <a:pt x="18000" y="219719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9d66a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AutoShape 6"/>
          <p:cNvSpPr/>
          <p:nvPr/>
        </p:nvSpPr>
        <p:spPr>
          <a:xfrm>
            <a:off x="2440080" y="5562720"/>
            <a:ext cx="152280" cy="1257120"/>
          </a:xfrm>
          <a:custGeom>
            <a:avLst/>
            <a:gdLst>
              <a:gd name="textAreaLeft" fmla="*/ 0 w 152280"/>
              <a:gd name="textAreaRight" fmla="*/ 152640 w 152280"/>
              <a:gd name="textAreaTop" fmla="*/ 0 h 1257120"/>
              <a:gd name="textAreaBottom" fmla="*/ 1257480 h 1257120"/>
            </a:gdLst>
            <a:ahLst/>
            <a:rect l="textAreaLeft" t="textAreaTop" r="textAreaRight" b="textAreaBottom"/>
            <a:pathLst>
              <a:path w="21600" h="177945">
                <a:moveTo>
                  <a:pt x="0" y="0"/>
                </a:moveTo>
                <a:arcTo wR="0" hR="0" stAng="10800000" swAng="-5400000"/>
                <a:lnTo>
                  <a:pt x="0" y="177945"/>
                </a:lnTo>
                <a:arcTo wR="0" hR="0" stAng="16200000" swAng="-5400000"/>
                <a:lnTo>
                  <a:pt x="21600" y="177945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5923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AutoShape 7"/>
          <p:cNvSpPr/>
          <p:nvPr/>
        </p:nvSpPr>
        <p:spPr>
          <a:xfrm>
            <a:off x="2440080" y="4356000"/>
            <a:ext cx="152280" cy="1276560"/>
          </a:xfrm>
          <a:custGeom>
            <a:avLst/>
            <a:gdLst>
              <a:gd name="textAreaLeft" fmla="*/ 0 w 152280"/>
              <a:gd name="textAreaRight" fmla="*/ 152640 w 152280"/>
              <a:gd name="textAreaTop" fmla="*/ 0 h 1276560"/>
              <a:gd name="textAreaBottom" fmla="*/ 1276920 h 1276560"/>
            </a:gdLst>
            <a:ahLst/>
            <a:rect l="textAreaLeft" t="textAreaTop" r="textAreaRight" b="textAreaBottom"/>
            <a:pathLst>
              <a:path w="21600" h="180696">
                <a:moveTo>
                  <a:pt x="0" y="0"/>
                </a:moveTo>
                <a:arcTo wR="0" hR="0" stAng="10800000" swAng="-5400000"/>
                <a:lnTo>
                  <a:pt x="0" y="180696"/>
                </a:lnTo>
                <a:arcTo wR="0" hR="0" stAng="16200000" swAng="-5400000"/>
                <a:lnTo>
                  <a:pt x="21600" y="180696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8dcf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9"/>
          <p:cNvSpPr/>
          <p:nvPr/>
        </p:nvSpPr>
        <p:spPr>
          <a:xfrm>
            <a:off x="2660400" y="425304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2AS-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10"/>
          <p:cNvSpPr/>
          <p:nvPr/>
        </p:nvSpPr>
        <p:spPr>
          <a:xfrm>
            <a:off x="2686320" y="552456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14"/>
          <p:cNvSpPr/>
          <p:nvPr/>
        </p:nvSpPr>
        <p:spPr>
          <a:xfrm>
            <a:off x="4680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A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15"/>
          <p:cNvSpPr/>
          <p:nvPr/>
        </p:nvSpPr>
        <p:spPr>
          <a:xfrm>
            <a:off x="225108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A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16"/>
          <p:cNvSpPr/>
          <p:nvPr/>
        </p:nvSpPr>
        <p:spPr>
          <a:xfrm>
            <a:off x="396648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A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AutoShape 17"/>
          <p:cNvSpPr/>
          <p:nvPr/>
        </p:nvSpPr>
        <p:spPr>
          <a:xfrm>
            <a:off x="2440080" y="2592360"/>
            <a:ext cx="152280" cy="567216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5672160"/>
              <a:gd name="textAreaBottom" fmla="*/ 5654520 h 5672160"/>
            </a:gdLst>
            <a:ahLst/>
            <a:rect l="textAreaLeft" t="textAreaTop" r="textAreaRight" b="textAreaBottom"/>
            <a:pathLst>
              <a:path w="21600" h="802715">
                <a:moveTo>
                  <a:pt x="3600" y="0"/>
                </a:moveTo>
                <a:arcTo wR="3600" hR="3600" stAng="0" swAng="5400000"/>
                <a:lnTo>
                  <a:pt x="0" y="799115"/>
                </a:lnTo>
                <a:arcTo wR="3600" hR="3600" stAng="16200000" swAng="5400000"/>
                <a:lnTo>
                  <a:pt x="18000" y="802715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20"/>
          <p:cNvSpPr/>
          <p:nvPr/>
        </p:nvSpPr>
        <p:spPr>
          <a:xfrm>
            <a:off x="2573280" y="4765680"/>
            <a:ext cx="145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78S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Fe</a:t>
            </a:r>
            <a:r>
              <a:rPr b="0" i="1" lang="en-GB" sz="700" spc="-1" strike="noStrike">
                <a:solidFill>
                  <a:srgbClr val="0808ff"/>
                </a:solidFill>
                <a:latin typeface="Arial"/>
              </a:rPr>
              <a:t>-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NADP(H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ubisco</a:t>
            </a:r>
            <a:r>
              <a:rPr b="0" i="1" lang="en-GB" sz="700" spc="-1" strike="noStrike">
                <a:solidFill>
                  <a:srgbClr val="03b800"/>
                </a:solidFill>
                <a:latin typeface="Arial"/>
              </a:rPr>
              <a:t>-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s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23"/>
          <p:cNvSpPr/>
          <p:nvPr/>
        </p:nvSpPr>
        <p:spPr>
          <a:xfrm>
            <a:off x="2571840" y="3332160"/>
            <a:ext cx="1390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8-1.00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SI-L, ACCase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CPN-60a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26"/>
          <p:cNvSpPr/>
          <p:nvPr/>
        </p:nvSpPr>
        <p:spPr>
          <a:xfrm>
            <a:off x="2571840" y="6010200"/>
            <a:ext cx="1355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85L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SI-K, Cab-10A,</a:t>
            </a: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Asc, </a:t>
            </a: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Hyd3, Ppo1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CopIII-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8" name="Group 39"/>
          <p:cNvGrpSpPr/>
          <p:nvPr/>
        </p:nvGrpSpPr>
        <p:grpSpPr>
          <a:xfrm>
            <a:off x="182520" y="2538360"/>
            <a:ext cx="327240" cy="5791320"/>
            <a:chOff x="182520" y="2538360"/>
            <a:chExt cx="327240" cy="5791320"/>
          </a:xfrm>
        </p:grpSpPr>
        <p:pic>
          <p:nvPicPr>
            <p:cNvPr id="189" name="Picture 29" descr="2A Screen shot 2013-01-07 at 12"/>
            <p:cNvPicPr/>
            <p:nvPr/>
          </p:nvPicPr>
          <p:blipFill>
            <a:blip r:embed="rId2"/>
            <a:stretch/>
          </p:blipFill>
          <p:spPr>
            <a:xfrm>
              <a:off x="182520" y="2538360"/>
              <a:ext cx="327240" cy="5791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0" name="Oval 22"/>
            <p:cNvSpPr/>
            <p:nvPr/>
          </p:nvSpPr>
          <p:spPr>
            <a:xfrm>
              <a:off x="258840" y="5524560"/>
              <a:ext cx="152280" cy="1522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91" name="Picture 27" descr="Chrom blank Screen shot 2013-01-07 at 10"/>
            <p:cNvPicPr/>
            <p:nvPr/>
          </p:nvPicPr>
          <p:blipFill>
            <a:blip r:embed="rId3"/>
            <a:srcRect l="0" t="6669" r="7663" b="20007"/>
            <a:stretch/>
          </p:blipFill>
          <p:spPr>
            <a:xfrm>
              <a:off x="237960" y="5014800"/>
              <a:ext cx="190800" cy="39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2" name="Line 30"/>
            <p:cNvSpPr/>
            <p:nvPr/>
          </p:nvSpPr>
          <p:spPr>
            <a:xfrm>
              <a:off x="220680" y="5318280"/>
              <a:ext cx="225360" cy="0"/>
            </a:xfrm>
            <a:prstGeom prst="line">
              <a:avLst/>
            </a:prstGeom>
            <a:ln w="19080">
              <a:solidFill>
                <a:srgbClr val="000000">
                  <a:alpha val="75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3" name="Text Box 31"/>
          <p:cNvSpPr/>
          <p:nvPr/>
        </p:nvSpPr>
        <p:spPr>
          <a:xfrm>
            <a:off x="411480" y="2530440"/>
            <a:ext cx="2093400" cy="572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611-2A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744-2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328-2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197-2A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24b (0.78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7p78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92p78.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32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721-2A, </a:t>
            </a:r>
            <a:r>
              <a:rPr b="0" lang="en-US" sz="600" spc="-1" strike="noStrike">
                <a:solidFill>
                  <a:srgbClr val="0808ff"/>
                </a:solidFill>
                <a:latin typeface="Arial"/>
              </a:rPr>
              <a:t>psr109</a:t>
            </a:r>
            <a:r>
              <a:rPr b="0" lang="en-US" sz="600" spc="-1" strike="noStrike">
                <a:solidFill>
                  <a:srgbClr val="ff9136"/>
                </a:solidFill>
                <a:latin typeface="Arial"/>
              </a:rPr>
              <a:t>(RbcS)</a:t>
            </a:r>
            <a:r>
              <a:rPr b="0" lang="en-US" sz="600" spc="-1" strike="noStrike">
                <a:solidFill>
                  <a:srgbClr val="fa9335"/>
                </a:solidFill>
                <a:latin typeface="Arial"/>
              </a:rPr>
              <a:t> (0.78-1.00e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77 (C-0.78S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43p78.9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068-2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4251-2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32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5p65.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3p65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53a (C-0.78S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320-2A (C-0.78S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220-2A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5p65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39 (Cent 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4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558 (C-0.85La), barc15 (0.77-0.85a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06-2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75.1 (0.16-0.59b),</a:t>
            </a:r>
            <a:r>
              <a:rPr b="0" lang="en-US" sz="600" spc="-1" strike="noStrike">
                <a:solidFill>
                  <a:srgbClr val="ff0300"/>
                </a:solidFill>
                <a:latin typeface="Arial"/>
              </a:rPr>
              <a:t> gwm630a (C-0.85Lh),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300"/>
                </a:solidFill>
                <a:latin typeface="Arial"/>
              </a:rPr>
              <a:t>	</a:t>
            </a:r>
            <a:r>
              <a:rPr b="0" lang="en-US" sz="600" spc="-1" strike="noStrike">
                <a:solidFill>
                  <a:srgbClr val="ff0300"/>
                </a:solidFill>
                <a:latin typeface="Arial"/>
              </a:rPr>
              <a:t>gwm304b (C-0.85L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114-2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9p78.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0p64.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5 (C-0.85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294 (0.77-0.85La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024-2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70b (C-0.85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81 (0.85-1.00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GS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2151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10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56 (0.85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7p78.6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50b (0.85-1.00a), gwm311b (0.85-1.00a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29945, wPt-0071 (0.85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793-2A (0.85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400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41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33"/>
          <p:cNvSpPr/>
          <p:nvPr/>
        </p:nvSpPr>
        <p:spPr>
          <a:xfrm>
            <a:off x="2611440" y="434988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5" name="Group 36"/>
          <p:cNvGrpSpPr/>
          <p:nvPr/>
        </p:nvGrpSpPr>
        <p:grpSpPr>
          <a:xfrm>
            <a:off x="2611440" y="6723000"/>
            <a:ext cx="501480" cy="215640"/>
            <a:chOff x="2611440" y="6723000"/>
            <a:chExt cx="501480" cy="215640"/>
          </a:xfrm>
        </p:grpSpPr>
        <p:sp>
          <p:nvSpPr>
            <p:cNvPr id="196" name="Text Box 34"/>
            <p:cNvSpPr/>
            <p:nvPr/>
          </p:nvSpPr>
          <p:spPr>
            <a:xfrm>
              <a:off x="2660760" y="6723000"/>
              <a:ext cx="45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2AL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35"/>
            <p:cNvSpPr/>
            <p:nvPr/>
          </p:nvSpPr>
          <p:spPr>
            <a:xfrm>
              <a:off x="2611440" y="6819840"/>
              <a:ext cx="123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8" name="Text Box 37"/>
          <p:cNvSpPr/>
          <p:nvPr/>
        </p:nvSpPr>
        <p:spPr>
          <a:xfrm>
            <a:off x="2574360" y="743112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5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41"/>
          <p:cNvSpPr/>
          <p:nvPr/>
        </p:nvSpPr>
        <p:spPr>
          <a:xfrm>
            <a:off x="2305080" y="562932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 Box 54"/>
          <p:cNvSpPr/>
          <p:nvPr/>
        </p:nvSpPr>
        <p:spPr>
          <a:xfrm>
            <a:off x="2573280" y="4135320"/>
            <a:ext cx="7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ubisco-ss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55"/>
          <p:cNvSpPr/>
          <p:nvPr/>
        </p:nvSpPr>
        <p:spPr>
          <a:xfrm>
            <a:off x="2574360" y="5389560"/>
            <a:ext cx="41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s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57"/>
          <p:cNvSpPr/>
          <p:nvPr/>
        </p:nvSpPr>
        <p:spPr>
          <a:xfrm>
            <a:off x="2574720" y="5634000"/>
            <a:ext cx="351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Z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3" name="Picture 4" descr=""/>
          <p:cNvPicPr/>
          <p:nvPr/>
        </p:nvPicPr>
        <p:blipFill>
          <a:blip r:embed="rId4"/>
          <a:srcRect l="83679" t="2568" r="9498" b="68095"/>
          <a:stretch/>
        </p:blipFill>
        <p:spPr>
          <a:xfrm>
            <a:off x="5670720" y="6216480"/>
            <a:ext cx="371160" cy="1073160"/>
          </a:xfrm>
          <a:prstGeom prst="rect">
            <a:avLst/>
          </a:prstGeom>
          <a:ln w="0">
            <a:noFill/>
          </a:ln>
        </p:spPr>
      </p:pic>
      <p:sp>
        <p:nvSpPr>
          <p:cNvPr id="204" name="pole tekstowe 4"/>
          <p:cNvSpPr/>
          <p:nvPr/>
        </p:nvSpPr>
        <p:spPr>
          <a:xfrm>
            <a:off x="5929200" y="6172200"/>
            <a:ext cx="83340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ET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ET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1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ET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0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TR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1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TR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P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ABS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0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ABS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1  P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1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F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v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F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" name="Picture 2" descr=""/>
          <p:cNvPicPr/>
          <p:nvPr/>
        </p:nvPicPr>
        <p:blipFill>
          <a:blip r:embed="rId1"/>
          <a:stretch/>
        </p:blipFill>
        <p:spPr>
          <a:xfrm>
            <a:off x="3568680" y="2381400"/>
            <a:ext cx="3067200" cy="5479920"/>
          </a:xfrm>
          <a:prstGeom prst="rect">
            <a:avLst/>
          </a:prstGeom>
          <a:ln w="0">
            <a:noFill/>
          </a:ln>
        </p:spPr>
      </p:pic>
      <p:sp>
        <p:nvSpPr>
          <p:cNvPr id="206" name="Line 38"/>
          <p:cNvSpPr/>
          <p:nvPr/>
        </p:nvSpPr>
        <p:spPr>
          <a:xfrm>
            <a:off x="5492880" y="2619360"/>
            <a:ext cx="0" cy="50529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AutoShape 33"/>
          <p:cNvSpPr/>
          <p:nvPr/>
        </p:nvSpPr>
        <p:spPr>
          <a:xfrm>
            <a:off x="2244600" y="3967200"/>
            <a:ext cx="152640" cy="1628640"/>
          </a:xfrm>
          <a:custGeom>
            <a:avLst/>
            <a:gdLst>
              <a:gd name="textAreaLeft" fmla="*/ 0 w 152640"/>
              <a:gd name="textAreaRight" fmla="*/ 153000 w 152640"/>
              <a:gd name="textAreaTop" fmla="*/ 0 h 1628640"/>
              <a:gd name="textAreaBottom" fmla="*/ 1629000 h 1628640"/>
            </a:gdLst>
            <a:ahLst/>
            <a:rect l="textAreaLeft" t="textAreaTop" r="textAreaRight" b="textAreaBottom"/>
            <a:pathLst>
              <a:path w="21600" h="229976">
                <a:moveTo>
                  <a:pt x="0" y="0"/>
                </a:moveTo>
                <a:arcTo wR="0" hR="0" stAng="10800000" swAng="-5400000"/>
                <a:lnTo>
                  <a:pt x="0" y="229976"/>
                </a:lnTo>
                <a:arcTo wR="0" hR="0" stAng="16200000" swAng="-5400000"/>
                <a:lnTo>
                  <a:pt x="21600" y="229976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646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8" name="Picture 29" descr="2B Screen shot 2013-01-07 at 14"/>
          <p:cNvPicPr/>
          <p:nvPr/>
        </p:nvPicPr>
        <p:blipFill>
          <a:blip r:embed="rId2"/>
          <a:stretch/>
        </p:blipFill>
        <p:spPr>
          <a:xfrm>
            <a:off x="193680" y="2543040"/>
            <a:ext cx="317520" cy="5259600"/>
          </a:xfrm>
          <a:prstGeom prst="rect">
            <a:avLst/>
          </a:prstGeom>
          <a:ln w="0">
            <a:noFill/>
          </a:ln>
        </p:spPr>
      </p:pic>
      <p:sp>
        <p:nvSpPr>
          <p:cNvPr id="209" name="AutoShape 3"/>
          <p:cNvSpPr/>
          <p:nvPr/>
        </p:nvSpPr>
        <p:spPr>
          <a:xfrm>
            <a:off x="2246400" y="2585880"/>
            <a:ext cx="152280" cy="92880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928800"/>
              <a:gd name="textAreaBottom" fmla="*/ 911160 h 928800"/>
            </a:gdLst>
            <a:ahLst/>
            <a:rect l="textAreaLeft" t="textAreaTop" r="textAreaRight" b="textAreaBottom"/>
            <a:pathLst>
              <a:path w="21600" h="131485">
                <a:moveTo>
                  <a:pt x="3600" y="0"/>
                </a:moveTo>
                <a:arcTo wR="3600" hR="3600" stAng="0" swAng="5400000"/>
                <a:lnTo>
                  <a:pt x="0" y="127885"/>
                </a:lnTo>
                <a:arcTo wR="3600" hR="3600" stAng="16200000" swAng="5400000"/>
                <a:lnTo>
                  <a:pt x="18000" y="131485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1d62a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AutoShape 4"/>
          <p:cNvSpPr/>
          <p:nvPr/>
        </p:nvSpPr>
        <p:spPr>
          <a:xfrm>
            <a:off x="2251080" y="7259760"/>
            <a:ext cx="152280" cy="131760"/>
          </a:xfrm>
          <a:custGeom>
            <a:avLst/>
            <a:gdLst>
              <a:gd name="textAreaLeft" fmla="*/ 0 w 152280"/>
              <a:gd name="textAreaRight" fmla="*/ 152280 w 15228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24955" h="21600">
                <a:moveTo>
                  <a:pt x="0" y="0"/>
                </a:moveTo>
                <a:arcTo wR="0" hR="0" stAng="10800000" swAng="-5400000"/>
                <a:lnTo>
                  <a:pt x="0" y="21600"/>
                </a:lnTo>
                <a:arcTo wR="0" hR="0" stAng="16200000" swAng="-5400000"/>
                <a:lnTo>
                  <a:pt x="24955" y="21600"/>
                </a:lnTo>
                <a:arcTo wR="0" hR="0" stAng="10800000" swAng="-5400000"/>
                <a:lnTo>
                  <a:pt x="24955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AutoShape 5"/>
          <p:cNvSpPr/>
          <p:nvPr/>
        </p:nvSpPr>
        <p:spPr>
          <a:xfrm>
            <a:off x="2246400" y="6019920"/>
            <a:ext cx="152280" cy="173196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731960"/>
              <a:gd name="textAreaBottom" fmla="*/ 1714320 h 1731960"/>
            </a:gdLst>
            <a:ahLst/>
            <a:rect l="textAreaLeft" t="textAreaTop" r="textAreaRight" b="textAreaBottom"/>
            <a:pathLst>
              <a:path w="21600" h="245140">
                <a:moveTo>
                  <a:pt x="3600" y="0"/>
                </a:moveTo>
                <a:arcTo wR="3600" hR="3600" stAng="0" swAng="5400000"/>
                <a:lnTo>
                  <a:pt x="0" y="241540"/>
                </a:lnTo>
                <a:arcTo wR="3600" hR="3600" stAng="16200000" swAng="5400000"/>
                <a:lnTo>
                  <a:pt x="18000" y="245140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c4113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AutoShape 6"/>
          <p:cNvSpPr/>
          <p:nvPr/>
        </p:nvSpPr>
        <p:spPr>
          <a:xfrm>
            <a:off x="2246400" y="5510160"/>
            <a:ext cx="152280" cy="473040"/>
          </a:xfrm>
          <a:custGeom>
            <a:avLst/>
            <a:gdLst>
              <a:gd name="textAreaLeft" fmla="*/ 0 w 152280"/>
              <a:gd name="textAreaRight" fmla="*/ 152640 w 152280"/>
              <a:gd name="textAreaTop" fmla="*/ 0 h 473040"/>
              <a:gd name="textAreaBottom" fmla="*/ 473040 h 473040"/>
            </a:gdLst>
            <a:ahLst/>
            <a:rect l="textAreaLeft" t="textAreaTop" r="textAreaRight" b="textAreaBottom"/>
            <a:pathLst>
              <a:path w="21600" h="66991">
                <a:moveTo>
                  <a:pt x="0" y="0"/>
                </a:moveTo>
                <a:arcTo wR="0" hR="0" stAng="10800000" swAng="-5400000"/>
                <a:lnTo>
                  <a:pt x="0" y="66991"/>
                </a:lnTo>
                <a:arcTo wR="0" hR="0" stAng="16200000" swAng="-5400000"/>
                <a:lnTo>
                  <a:pt x="21600" y="66991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5923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AutoShape 7"/>
          <p:cNvSpPr/>
          <p:nvPr/>
        </p:nvSpPr>
        <p:spPr>
          <a:xfrm>
            <a:off x="2246400" y="3456000"/>
            <a:ext cx="152280" cy="430200"/>
          </a:xfrm>
          <a:custGeom>
            <a:avLst/>
            <a:gdLst>
              <a:gd name="textAreaLeft" fmla="*/ 0 w 152280"/>
              <a:gd name="textAreaRight" fmla="*/ 152640 w 152280"/>
              <a:gd name="textAreaTop" fmla="*/ 0 h 430200"/>
              <a:gd name="textAreaBottom" fmla="*/ 430560 h 430200"/>
            </a:gdLst>
            <a:ahLst/>
            <a:rect l="textAreaLeft" t="textAreaTop" r="textAreaRight" b="textAreaBottom"/>
            <a:pathLst>
              <a:path w="21600" h="60928">
                <a:moveTo>
                  <a:pt x="0" y="0"/>
                </a:moveTo>
                <a:arcTo wR="0" hR="0" stAng="10800000" swAng="-5400000"/>
                <a:lnTo>
                  <a:pt x="0" y="60928"/>
                </a:lnTo>
                <a:arcTo wR="0" hR="0" stAng="16200000" swAng="-5400000"/>
                <a:lnTo>
                  <a:pt x="21600" y="6092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 Box 8"/>
          <p:cNvSpPr/>
          <p:nvPr/>
        </p:nvSpPr>
        <p:spPr>
          <a:xfrm>
            <a:off x="2472840" y="385920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2AS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 Box 9"/>
          <p:cNvSpPr/>
          <p:nvPr/>
        </p:nvSpPr>
        <p:spPr>
          <a:xfrm>
            <a:off x="2492640" y="536724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 Box 10"/>
          <p:cNvSpPr/>
          <p:nvPr/>
        </p:nvSpPr>
        <p:spPr>
          <a:xfrm>
            <a:off x="4680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B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 Box 11"/>
          <p:cNvSpPr/>
          <p:nvPr/>
        </p:nvSpPr>
        <p:spPr>
          <a:xfrm>
            <a:off x="205740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B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 Box 12"/>
          <p:cNvSpPr/>
          <p:nvPr/>
        </p:nvSpPr>
        <p:spPr>
          <a:xfrm>
            <a:off x="394272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B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AutoShape 42"/>
          <p:cNvSpPr/>
          <p:nvPr/>
        </p:nvSpPr>
        <p:spPr>
          <a:xfrm>
            <a:off x="2244600" y="5697360"/>
            <a:ext cx="152640" cy="406440"/>
          </a:xfrm>
          <a:custGeom>
            <a:avLst/>
            <a:gdLst>
              <a:gd name="textAreaLeft" fmla="*/ 0 w 152640"/>
              <a:gd name="textAreaRight" fmla="*/ 153000 w 152640"/>
              <a:gd name="textAreaTop" fmla="*/ 0 h 406440"/>
              <a:gd name="textAreaBottom" fmla="*/ 406800 h 406440"/>
            </a:gdLst>
            <a:ahLst/>
            <a:rect l="textAreaLeft" t="textAreaTop" r="textAreaRight" b="textAreaBottom"/>
            <a:pathLst>
              <a:path w="21600" h="57431">
                <a:moveTo>
                  <a:pt x="0" y="0"/>
                </a:moveTo>
                <a:arcTo wR="0" hR="0" stAng="10800000" swAng="-5400000"/>
                <a:lnTo>
                  <a:pt x="0" y="57431"/>
                </a:lnTo>
                <a:arcTo wR="0" hR="0" stAng="16200000" swAng="-5400000"/>
                <a:lnTo>
                  <a:pt x="21600" y="57431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55c1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AutoShape 124"/>
          <p:cNvSpPr/>
          <p:nvPr/>
        </p:nvSpPr>
        <p:spPr>
          <a:xfrm>
            <a:off x="2247840" y="5591160"/>
            <a:ext cx="152640" cy="387360"/>
          </a:xfrm>
          <a:custGeom>
            <a:avLst/>
            <a:gdLst>
              <a:gd name="textAreaLeft" fmla="*/ 0 w 152640"/>
              <a:gd name="textAreaRight" fmla="*/ 153000 w 152640"/>
              <a:gd name="textAreaTop" fmla="*/ 0 h 387360"/>
              <a:gd name="textAreaBottom" fmla="*/ 387720 h 387360"/>
            </a:gdLst>
            <a:ahLst/>
            <a:rect l="textAreaLeft" t="textAreaTop" r="textAreaRight" b="textAreaBottom"/>
            <a:pathLst>
              <a:path w="21600" h="54737">
                <a:moveTo>
                  <a:pt x="0" y="0"/>
                </a:moveTo>
                <a:arcTo wR="0" hR="0" stAng="10800000" swAng="-5400000"/>
                <a:lnTo>
                  <a:pt x="0" y="54737"/>
                </a:lnTo>
                <a:arcTo wR="0" hR="0" stAng="16200000" swAng="-5400000"/>
                <a:lnTo>
                  <a:pt x="21600" y="54737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a065a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AutoShape 13"/>
          <p:cNvSpPr/>
          <p:nvPr/>
        </p:nvSpPr>
        <p:spPr>
          <a:xfrm>
            <a:off x="2246400" y="2592360"/>
            <a:ext cx="152280" cy="51577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5157720"/>
              <a:gd name="textAreaBottom" fmla="*/ 5140080 h 5157720"/>
            </a:gdLst>
            <a:ahLst/>
            <a:rect l="textAreaLeft" t="textAreaTop" r="textAreaRight" b="textAreaBottom"/>
            <a:pathLst>
              <a:path w="21600" h="729917">
                <a:moveTo>
                  <a:pt x="3600" y="0"/>
                </a:moveTo>
                <a:arcTo wR="3600" hR="3600" stAng="0" swAng="5400000"/>
                <a:lnTo>
                  <a:pt x="0" y="726317"/>
                </a:lnTo>
                <a:arcTo wR="3600" hR="3600" stAng="16200000" swAng="5400000"/>
                <a:lnTo>
                  <a:pt x="18000" y="729917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 Box 14"/>
          <p:cNvSpPr/>
          <p:nvPr/>
        </p:nvSpPr>
        <p:spPr>
          <a:xfrm>
            <a:off x="2380320" y="4637160"/>
            <a:ext cx="1159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53S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Fe-NADP(H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 Box 17"/>
          <p:cNvSpPr/>
          <p:nvPr/>
        </p:nvSpPr>
        <p:spPr>
          <a:xfrm>
            <a:off x="2379600" y="2849400"/>
            <a:ext cx="1076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4-1.00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ACCase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CPN-60a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18"/>
          <p:cNvSpPr/>
          <p:nvPr/>
        </p:nvSpPr>
        <p:spPr>
          <a:xfrm>
            <a:off x="2376000" y="5486400"/>
            <a:ext cx="1297800" cy="18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36L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SI-K, Asc, </a:t>
            </a: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Z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5" name="Picture 19" descr="Chrom blank Screen shot 2013-01-07 at 10"/>
          <p:cNvPicPr/>
          <p:nvPr/>
        </p:nvPicPr>
        <p:blipFill>
          <a:blip r:embed="rId3"/>
          <a:srcRect l="0" t="6669" r="7663" b="20007"/>
          <a:stretch/>
        </p:blipFill>
        <p:spPr>
          <a:xfrm>
            <a:off x="225360" y="5094360"/>
            <a:ext cx="193680" cy="341280"/>
          </a:xfrm>
          <a:prstGeom prst="rect">
            <a:avLst/>
          </a:prstGeom>
          <a:ln w="0">
            <a:noFill/>
          </a:ln>
        </p:spPr>
      </p:pic>
      <p:sp>
        <p:nvSpPr>
          <p:cNvPr id="226" name="Line 20"/>
          <p:cNvSpPr/>
          <p:nvPr/>
        </p:nvSpPr>
        <p:spPr>
          <a:xfrm>
            <a:off x="222120" y="5184720"/>
            <a:ext cx="225720" cy="0"/>
          </a:xfrm>
          <a:prstGeom prst="line">
            <a:avLst/>
          </a:prstGeom>
          <a:ln w="1908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Line 22"/>
          <p:cNvSpPr/>
          <p:nvPr/>
        </p:nvSpPr>
        <p:spPr>
          <a:xfrm>
            <a:off x="2417760" y="39560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 Box 24"/>
          <p:cNvSpPr/>
          <p:nvPr/>
        </p:nvSpPr>
        <p:spPr>
          <a:xfrm>
            <a:off x="2459160" y="582444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2BL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Line 25"/>
          <p:cNvSpPr/>
          <p:nvPr/>
        </p:nvSpPr>
        <p:spPr>
          <a:xfrm flipV="1">
            <a:off x="2417760" y="5931000"/>
            <a:ext cx="115920" cy="3024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 Box 26"/>
          <p:cNvSpPr/>
          <p:nvPr/>
        </p:nvSpPr>
        <p:spPr>
          <a:xfrm>
            <a:off x="2380680" y="679284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9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 Box 30"/>
          <p:cNvSpPr/>
          <p:nvPr/>
        </p:nvSpPr>
        <p:spPr>
          <a:xfrm>
            <a:off x="429840" y="2532240"/>
            <a:ext cx="1826640" cy="520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24c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274-2B, wPt-1024 (0.75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210a (0.89-1.00at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058-2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2p78.8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613-2B (0.75-1.00f)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59p78.1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859-2B, wPt-0289 (0.75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949-2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43a (0.89-1.00ht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964-2B, tPt-4627 (0.84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57 (0.89-1.00t), wmc25b (0.89-1.00t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6p65.1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072-2B (C-0.53S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6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429 (0.27-0.53at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556-2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638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477-2B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48 (0.15-0.27dt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7 (0.27-0.53t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471-2B (C-0.53S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9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7p78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46, psr126 (C-0.53Se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335-2B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77 (C-0.36Lt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55 (C-0.53Sah) (C-0.36Lt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28a (0.36-0.89u) (0.69-0.89t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01a (0.36-0.50h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109-2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870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Aba1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31.2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654-2B, wPt-0189 (0.50-0.89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00425,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bcd453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9851, wPt-7305 (C-0.89L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360 (0.89-1.00v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6p65.2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755-2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694-2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794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210-2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F1R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5p64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776-2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397-2B (0.89-1.00f), wPt-0948 (0.89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506-2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418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7p64.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632-2B (0.89-1.00v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7p77.7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274-2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43-2B (0.89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11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2" name="Group 36"/>
          <p:cNvGrpSpPr/>
          <p:nvPr/>
        </p:nvGrpSpPr>
        <p:grpSpPr>
          <a:xfrm>
            <a:off x="2424240" y="3359160"/>
            <a:ext cx="512640" cy="215640"/>
            <a:chOff x="2424240" y="3359160"/>
            <a:chExt cx="512640" cy="215640"/>
          </a:xfrm>
        </p:grpSpPr>
        <p:sp>
          <p:nvSpPr>
            <p:cNvPr id="233" name="Text Box 34"/>
            <p:cNvSpPr/>
            <p:nvPr/>
          </p:nvSpPr>
          <p:spPr>
            <a:xfrm>
              <a:off x="2472840" y="335916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2BS-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35"/>
            <p:cNvSpPr/>
            <p:nvPr/>
          </p:nvSpPr>
          <p:spPr>
            <a:xfrm>
              <a:off x="2424240" y="3455640"/>
              <a:ext cx="1234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5" name="Text Box 37"/>
          <p:cNvSpPr/>
          <p:nvPr/>
        </p:nvSpPr>
        <p:spPr>
          <a:xfrm>
            <a:off x="2472840" y="360216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2BS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38"/>
          <p:cNvSpPr/>
          <p:nvPr/>
        </p:nvSpPr>
        <p:spPr>
          <a:xfrm>
            <a:off x="2425680" y="370512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Line 39"/>
          <p:cNvSpPr/>
          <p:nvPr/>
        </p:nvSpPr>
        <p:spPr>
          <a:xfrm flipV="1">
            <a:off x="2433600" y="3459240"/>
            <a:ext cx="0" cy="503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 Box 40"/>
          <p:cNvSpPr/>
          <p:nvPr/>
        </p:nvSpPr>
        <p:spPr>
          <a:xfrm>
            <a:off x="2380680" y="348300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5-0.8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 Box 41"/>
          <p:cNvSpPr/>
          <p:nvPr/>
        </p:nvSpPr>
        <p:spPr>
          <a:xfrm>
            <a:off x="2379600" y="3735360"/>
            <a:ext cx="105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3-0.75 </a:t>
            </a: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Xantha-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 Box 43"/>
          <p:cNvSpPr/>
          <p:nvPr/>
        </p:nvSpPr>
        <p:spPr>
          <a:xfrm>
            <a:off x="2380680" y="592452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0-0.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 Box 45"/>
          <p:cNvSpPr/>
          <p:nvPr/>
        </p:nvSpPr>
        <p:spPr>
          <a:xfrm>
            <a:off x="2467080" y="601200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2BL-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Line 46"/>
          <p:cNvSpPr/>
          <p:nvPr/>
        </p:nvSpPr>
        <p:spPr>
          <a:xfrm>
            <a:off x="2417760" y="610884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Line 48"/>
          <p:cNvSpPr/>
          <p:nvPr/>
        </p:nvSpPr>
        <p:spPr>
          <a:xfrm>
            <a:off x="2120760" y="5500800"/>
            <a:ext cx="419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 Box 50"/>
          <p:cNvSpPr/>
          <p:nvPr/>
        </p:nvSpPr>
        <p:spPr>
          <a:xfrm>
            <a:off x="3055320" y="5929200"/>
            <a:ext cx="6393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Cab-10A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CopIII-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 Box 58"/>
          <p:cNvSpPr/>
          <p:nvPr/>
        </p:nvSpPr>
        <p:spPr>
          <a:xfrm>
            <a:off x="2379600" y="3251160"/>
            <a:ext cx="7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ubisco-ss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Text Box 59"/>
          <p:cNvSpPr/>
          <p:nvPr/>
        </p:nvSpPr>
        <p:spPr>
          <a:xfrm>
            <a:off x="2380680" y="5272200"/>
            <a:ext cx="41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s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Text Box 61"/>
          <p:cNvSpPr/>
          <p:nvPr/>
        </p:nvSpPr>
        <p:spPr>
          <a:xfrm>
            <a:off x="2806200" y="583236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Ppo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8" name="Group 119"/>
          <p:cNvGrpSpPr/>
          <p:nvPr/>
        </p:nvGrpSpPr>
        <p:grpSpPr>
          <a:xfrm>
            <a:off x="5510160" y="3352680"/>
            <a:ext cx="1201680" cy="1479240"/>
            <a:chOff x="5510160" y="3352680"/>
            <a:chExt cx="1201680" cy="1479240"/>
          </a:xfrm>
        </p:grpSpPr>
        <p:sp>
          <p:nvSpPr>
            <p:cNvPr id="249" name="pole tekstowe 4"/>
            <p:cNvSpPr/>
            <p:nvPr/>
          </p:nvSpPr>
          <p:spPr>
            <a:xfrm>
              <a:off x="5873400" y="3352680"/>
              <a:ext cx="838440" cy="1479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hl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+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DW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Y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W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W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TR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50" name="Picture 2" descr=""/>
            <p:cNvPicPr/>
            <p:nvPr/>
          </p:nvPicPr>
          <p:blipFill>
            <a:blip r:embed="rId4"/>
            <a:srcRect l="82222" t="3388" r="9532" b="58964"/>
            <a:stretch/>
          </p:blipFill>
          <p:spPr>
            <a:xfrm>
              <a:off x="5510160" y="3435480"/>
              <a:ext cx="465120" cy="13474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51" name="Text Box 122"/>
          <p:cNvSpPr/>
          <p:nvPr/>
        </p:nvSpPr>
        <p:spPr>
          <a:xfrm>
            <a:off x="2611080" y="5357880"/>
            <a:ext cx="53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Ggpps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126"/>
          <p:cNvSpPr/>
          <p:nvPr/>
        </p:nvSpPr>
        <p:spPr>
          <a:xfrm>
            <a:off x="2417760" y="5600880"/>
            <a:ext cx="111240" cy="6804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127"/>
          <p:cNvSpPr/>
          <p:nvPr/>
        </p:nvSpPr>
        <p:spPr>
          <a:xfrm>
            <a:off x="2459160" y="556272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2BL-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 Box 128"/>
          <p:cNvSpPr/>
          <p:nvPr/>
        </p:nvSpPr>
        <p:spPr>
          <a:xfrm>
            <a:off x="2380680" y="5695920"/>
            <a:ext cx="610560" cy="18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36-0.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130"/>
          <p:cNvSpPr/>
          <p:nvPr/>
        </p:nvSpPr>
        <p:spPr>
          <a:xfrm>
            <a:off x="2829960" y="5638680"/>
            <a:ext cx="418320" cy="18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Hyd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Oval 16"/>
          <p:cNvSpPr/>
          <p:nvPr/>
        </p:nvSpPr>
        <p:spPr>
          <a:xfrm>
            <a:off x="247680" y="5396040"/>
            <a:ext cx="15228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7" name="Picture 2" descr=""/>
          <p:cNvPicPr/>
          <p:nvPr/>
        </p:nvPicPr>
        <p:blipFill>
          <a:blip r:embed="rId1"/>
          <a:stretch/>
        </p:blipFill>
        <p:spPr>
          <a:xfrm>
            <a:off x="3454560" y="2386080"/>
            <a:ext cx="3214440" cy="5443560"/>
          </a:xfrm>
          <a:prstGeom prst="rect">
            <a:avLst/>
          </a:prstGeom>
          <a:ln w="0">
            <a:noFill/>
          </a:ln>
        </p:spPr>
      </p:pic>
      <p:grpSp>
        <p:nvGrpSpPr>
          <p:cNvPr id="258" name="Group 115"/>
          <p:cNvGrpSpPr/>
          <p:nvPr/>
        </p:nvGrpSpPr>
        <p:grpSpPr>
          <a:xfrm>
            <a:off x="5257800" y="4133880"/>
            <a:ext cx="1182600" cy="1585800"/>
            <a:chOff x="5257800" y="4133880"/>
            <a:chExt cx="1182600" cy="1585800"/>
          </a:xfrm>
        </p:grpSpPr>
        <p:sp>
          <p:nvSpPr>
            <p:cNvPr id="259" name="pole tekstowe 4"/>
            <p:cNvSpPr/>
            <p:nvPr/>
          </p:nvSpPr>
          <p:spPr>
            <a:xfrm>
              <a:off x="5618160" y="4133880"/>
              <a:ext cx="822240" cy="158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marL="228600" indent="-228600">
                <a:buClr>
                  <a:srgbClr val="000000"/>
                </a:buClr>
                <a:buFont typeface="Arial"/>
                <a:buAutoNum type="arabicPlain" startAt="2010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hl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+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10  SPA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11  SPA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10  Ca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10  ET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v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/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marL="228600" indent="-228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v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/F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60" name="Picture 2" descr=""/>
            <p:cNvPicPr/>
            <p:nvPr/>
          </p:nvPicPr>
          <p:blipFill>
            <a:blip r:embed="rId2"/>
            <a:srcRect l="82186" t="1803" r="9588" b="55758"/>
            <a:stretch/>
          </p:blipFill>
          <p:spPr>
            <a:xfrm>
              <a:off x="5257800" y="4152960"/>
              <a:ext cx="426960" cy="151308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261" name="Picture 41" descr="2D Screen shot 2013-01-07 at 20"/>
          <p:cNvPicPr/>
          <p:nvPr/>
        </p:nvPicPr>
        <p:blipFill>
          <a:blip r:embed="rId3"/>
          <a:srcRect l="0" t="0" r="5907" b="0"/>
          <a:stretch/>
        </p:blipFill>
        <p:spPr>
          <a:xfrm>
            <a:off x="187200" y="2546280"/>
            <a:ext cx="304920" cy="5273640"/>
          </a:xfrm>
          <a:prstGeom prst="rect">
            <a:avLst/>
          </a:prstGeom>
          <a:ln w="0">
            <a:noFill/>
          </a:ln>
        </p:spPr>
      </p:pic>
      <p:sp>
        <p:nvSpPr>
          <p:cNvPr id="262" name="AutoShape 4"/>
          <p:cNvSpPr/>
          <p:nvPr/>
        </p:nvSpPr>
        <p:spPr>
          <a:xfrm>
            <a:off x="2193840" y="2592360"/>
            <a:ext cx="152640" cy="92880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928800"/>
              <a:gd name="textAreaBottom" fmla="*/ 910800 h 928800"/>
            </a:gdLst>
            <a:ahLst/>
            <a:rect l="textAreaLeft" t="textAreaTop" r="textAreaRight" b="textAreaBottom"/>
            <a:pathLst>
              <a:path w="21600" h="131176">
                <a:moveTo>
                  <a:pt x="3600" y="0"/>
                </a:moveTo>
                <a:arcTo wR="3600" hR="3600" stAng="0" swAng="5400000"/>
                <a:lnTo>
                  <a:pt x="0" y="127576"/>
                </a:lnTo>
                <a:arcTo wR="3600" hR="3600" stAng="16200000" swAng="5400000"/>
                <a:lnTo>
                  <a:pt x="18000" y="131176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1d62a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AutoShape 2"/>
          <p:cNvSpPr/>
          <p:nvPr/>
        </p:nvSpPr>
        <p:spPr>
          <a:xfrm>
            <a:off x="2192400" y="3149640"/>
            <a:ext cx="152280" cy="1806480"/>
          </a:xfrm>
          <a:custGeom>
            <a:avLst/>
            <a:gdLst>
              <a:gd name="textAreaLeft" fmla="*/ 0 w 152280"/>
              <a:gd name="textAreaRight" fmla="*/ 152640 w 152280"/>
              <a:gd name="textAreaTop" fmla="*/ 0 h 1806480"/>
              <a:gd name="textAreaBottom" fmla="*/ 1806840 h 1806480"/>
            </a:gdLst>
            <a:ahLst/>
            <a:rect l="textAreaLeft" t="textAreaTop" r="textAreaRight" b="textAreaBottom"/>
            <a:pathLst>
              <a:path w="21600" h="255685">
                <a:moveTo>
                  <a:pt x="0" y="0"/>
                </a:moveTo>
                <a:arcTo wR="0" hR="0" stAng="10800000" swAng="-5400000"/>
                <a:lnTo>
                  <a:pt x="0" y="255685"/>
                </a:lnTo>
                <a:arcTo wR="0" hR="0" stAng="16200000" swAng="-5400000"/>
                <a:lnTo>
                  <a:pt x="21600" y="255685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8dcc9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AutoShape 5"/>
          <p:cNvSpPr/>
          <p:nvPr/>
        </p:nvSpPr>
        <p:spPr>
          <a:xfrm>
            <a:off x="2198520" y="7259760"/>
            <a:ext cx="152640" cy="131760"/>
          </a:xfrm>
          <a:custGeom>
            <a:avLst/>
            <a:gdLst>
              <a:gd name="textAreaLeft" fmla="*/ 0 w 152640"/>
              <a:gd name="textAreaRight" fmla="*/ 152640 w 15264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25014" h="21600">
                <a:moveTo>
                  <a:pt x="0" y="0"/>
                </a:moveTo>
                <a:arcTo wR="0" hR="0" stAng="10800000" swAng="-5400000"/>
                <a:lnTo>
                  <a:pt x="0" y="21600"/>
                </a:lnTo>
                <a:arcTo wR="0" hR="0" stAng="16200000" swAng="-5400000"/>
                <a:lnTo>
                  <a:pt x="25014" y="21600"/>
                </a:lnTo>
                <a:arcTo wR="0" hR="0" stAng="10800000" swAng="-5400000"/>
                <a:lnTo>
                  <a:pt x="25014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AutoShape 6"/>
          <p:cNvSpPr/>
          <p:nvPr/>
        </p:nvSpPr>
        <p:spPr>
          <a:xfrm>
            <a:off x="2193840" y="6477120"/>
            <a:ext cx="152640" cy="125244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1252440"/>
              <a:gd name="textAreaBottom" fmla="*/ 1234440 h 1252440"/>
            </a:gdLst>
            <a:ahLst/>
            <a:rect l="textAreaLeft" t="textAreaTop" r="textAreaRight" b="textAreaBottom"/>
            <a:pathLst>
              <a:path w="21600" h="176866">
                <a:moveTo>
                  <a:pt x="3600" y="0"/>
                </a:moveTo>
                <a:arcTo wR="3600" hR="3600" stAng="0" swAng="5400000"/>
                <a:lnTo>
                  <a:pt x="0" y="173266"/>
                </a:lnTo>
                <a:arcTo wR="3600" hR="3600" stAng="16200000" swAng="5400000"/>
                <a:lnTo>
                  <a:pt x="18000" y="176866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52c2a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 Box 9"/>
          <p:cNvSpPr/>
          <p:nvPr/>
        </p:nvSpPr>
        <p:spPr>
          <a:xfrm>
            <a:off x="2414880" y="502920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 Box 11"/>
          <p:cNvSpPr/>
          <p:nvPr/>
        </p:nvSpPr>
        <p:spPr>
          <a:xfrm>
            <a:off x="43560" y="201132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D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 Box 12"/>
          <p:cNvSpPr/>
          <p:nvPr/>
        </p:nvSpPr>
        <p:spPr>
          <a:xfrm>
            <a:off x="2001960" y="2011320"/>
            <a:ext cx="12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D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Text Box 13"/>
          <p:cNvSpPr/>
          <p:nvPr/>
        </p:nvSpPr>
        <p:spPr>
          <a:xfrm>
            <a:off x="3939480" y="2011320"/>
            <a:ext cx="216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D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AutoShape 44"/>
          <p:cNvSpPr/>
          <p:nvPr/>
        </p:nvSpPr>
        <p:spPr>
          <a:xfrm>
            <a:off x="2193840" y="6383160"/>
            <a:ext cx="152640" cy="430560"/>
          </a:xfrm>
          <a:custGeom>
            <a:avLst/>
            <a:gdLst>
              <a:gd name="textAreaLeft" fmla="*/ 0 w 152640"/>
              <a:gd name="textAreaRight" fmla="*/ 153000 w 152640"/>
              <a:gd name="textAreaTop" fmla="*/ 0 h 430560"/>
              <a:gd name="textAreaBottom" fmla="*/ 430920 h 430560"/>
            </a:gdLst>
            <a:ahLst/>
            <a:rect l="textAreaLeft" t="textAreaTop" r="textAreaRight" b="textAreaBottom"/>
            <a:pathLst>
              <a:path w="21600" h="60836">
                <a:moveTo>
                  <a:pt x="0" y="0"/>
                </a:moveTo>
                <a:arcTo wR="0" hR="0" stAng="10800000" swAng="-5400000"/>
                <a:lnTo>
                  <a:pt x="0" y="60836"/>
                </a:lnTo>
                <a:arcTo wR="0" hR="0" stAng="16200000" swAng="-5400000"/>
                <a:lnTo>
                  <a:pt x="21600" y="60836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AutoShape 7"/>
          <p:cNvSpPr/>
          <p:nvPr/>
        </p:nvSpPr>
        <p:spPr>
          <a:xfrm>
            <a:off x="2193840" y="5137200"/>
            <a:ext cx="152640" cy="1384200"/>
          </a:xfrm>
          <a:custGeom>
            <a:avLst/>
            <a:gdLst>
              <a:gd name="textAreaLeft" fmla="*/ 0 w 152640"/>
              <a:gd name="textAreaRight" fmla="*/ 153000 w 152640"/>
              <a:gd name="textAreaTop" fmla="*/ 0 h 1384200"/>
              <a:gd name="textAreaBottom" fmla="*/ 1384560 h 1384200"/>
            </a:gdLst>
            <a:ahLst/>
            <a:rect l="textAreaLeft" t="textAreaTop" r="textAreaRight" b="textAreaBottom"/>
            <a:pathLst>
              <a:path w="21600" h="195467">
                <a:moveTo>
                  <a:pt x="0" y="0"/>
                </a:moveTo>
                <a:arcTo wR="0" hR="0" stAng="10800000" swAng="-5400000"/>
                <a:lnTo>
                  <a:pt x="0" y="195467"/>
                </a:lnTo>
                <a:arcTo wR="0" hR="0" stAng="16200000" swAng="-5400000"/>
                <a:lnTo>
                  <a:pt x="21600" y="195467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6904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AutoShape 15"/>
          <p:cNvSpPr/>
          <p:nvPr/>
        </p:nvSpPr>
        <p:spPr>
          <a:xfrm>
            <a:off x="2193840" y="2590920"/>
            <a:ext cx="152640" cy="5133960"/>
          </a:xfrm>
          <a:custGeom>
            <a:avLst/>
            <a:gdLst>
              <a:gd name="textAreaLeft" fmla="*/ 18000 w 152640"/>
              <a:gd name="textAreaRight" fmla="*/ 134640 w 152640"/>
              <a:gd name="textAreaTop" fmla="*/ 18000 h 5133960"/>
              <a:gd name="textAreaBottom" fmla="*/ 5115960 h 5133960"/>
            </a:gdLst>
            <a:ahLst/>
            <a:rect l="textAreaLeft" t="textAreaTop" r="textAreaRight" b="textAreaBottom"/>
            <a:pathLst>
              <a:path w="21600" h="724845">
                <a:moveTo>
                  <a:pt x="3600" y="0"/>
                </a:moveTo>
                <a:arcTo wR="3600" hR="3600" stAng="0" swAng="5400000"/>
                <a:lnTo>
                  <a:pt x="0" y="721245"/>
                </a:lnTo>
                <a:arcTo wR="3600" hR="3600" stAng="16200000" swAng="5400000"/>
                <a:lnTo>
                  <a:pt x="18000" y="724845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Oval 18"/>
          <p:cNvSpPr/>
          <p:nvPr/>
        </p:nvSpPr>
        <p:spPr>
          <a:xfrm>
            <a:off x="237960" y="5062680"/>
            <a:ext cx="15264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 Box 19"/>
          <p:cNvSpPr/>
          <p:nvPr/>
        </p:nvSpPr>
        <p:spPr>
          <a:xfrm>
            <a:off x="2327400" y="2673360"/>
            <a:ext cx="1273320" cy="40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47-1.00 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Fe-NADP(H)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ACCase,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CPN-60a,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ubisco-ssu</a:t>
            </a: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20"/>
          <p:cNvSpPr/>
          <p:nvPr/>
        </p:nvSpPr>
        <p:spPr>
          <a:xfrm>
            <a:off x="2322720" y="5605560"/>
            <a:ext cx="1317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49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808ff"/>
                </a:solidFill>
                <a:latin typeface="Arial"/>
              </a:rPr>
              <a:t>PSI-K, PSII-10kDa, Asc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Ppo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6" name="Picture 21" descr="Chrom blank Screen shot 2013-01-07 at 10"/>
          <p:cNvPicPr/>
          <p:nvPr/>
        </p:nvPicPr>
        <p:blipFill>
          <a:blip r:embed="rId4"/>
          <a:srcRect l="0" t="0" r="7663" b="0"/>
          <a:stretch/>
        </p:blipFill>
        <p:spPr>
          <a:xfrm>
            <a:off x="214200" y="5470560"/>
            <a:ext cx="193680" cy="466560"/>
          </a:xfrm>
          <a:prstGeom prst="rect">
            <a:avLst/>
          </a:prstGeom>
          <a:ln w="0">
            <a:noFill/>
          </a:ln>
        </p:spPr>
      </p:pic>
      <p:sp>
        <p:nvSpPr>
          <p:cNvPr id="277" name="Line 22"/>
          <p:cNvSpPr/>
          <p:nvPr/>
        </p:nvSpPr>
        <p:spPr>
          <a:xfrm>
            <a:off x="203040" y="5781600"/>
            <a:ext cx="225720" cy="0"/>
          </a:xfrm>
          <a:prstGeom prst="line">
            <a:avLst/>
          </a:prstGeom>
          <a:ln w="15840">
            <a:solidFill>
              <a:srgbClr val="000000">
                <a:alpha val="75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Text Box 25"/>
          <p:cNvSpPr/>
          <p:nvPr/>
        </p:nvSpPr>
        <p:spPr>
          <a:xfrm>
            <a:off x="2413440" y="4938840"/>
            <a:ext cx="854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2DS-1 </a:t>
            </a: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Ggpps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 Box 27"/>
          <p:cNvSpPr/>
          <p:nvPr/>
        </p:nvSpPr>
        <p:spPr>
          <a:xfrm>
            <a:off x="2327400" y="7129440"/>
            <a:ext cx="1053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6-1.00 </a:t>
            </a: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CopIII-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0" name="Group 29"/>
          <p:cNvGrpSpPr/>
          <p:nvPr/>
        </p:nvGrpSpPr>
        <p:grpSpPr>
          <a:xfrm>
            <a:off x="2365200" y="3052800"/>
            <a:ext cx="517680" cy="215640"/>
            <a:chOff x="2365200" y="3052800"/>
            <a:chExt cx="517680" cy="215640"/>
          </a:xfrm>
        </p:grpSpPr>
        <p:sp>
          <p:nvSpPr>
            <p:cNvPr id="281" name="Text Box 30"/>
            <p:cNvSpPr/>
            <p:nvPr/>
          </p:nvSpPr>
          <p:spPr>
            <a:xfrm>
              <a:off x="2414160" y="3052800"/>
              <a:ext cx="46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2DS-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31"/>
            <p:cNvSpPr/>
            <p:nvPr/>
          </p:nvSpPr>
          <p:spPr>
            <a:xfrm>
              <a:off x="2365200" y="3149280"/>
              <a:ext cx="123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3" name="Text Box 35"/>
          <p:cNvSpPr/>
          <p:nvPr/>
        </p:nvSpPr>
        <p:spPr>
          <a:xfrm>
            <a:off x="2328480" y="395136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33-0.4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 Box 39"/>
          <p:cNvSpPr/>
          <p:nvPr/>
        </p:nvSpPr>
        <p:spPr>
          <a:xfrm>
            <a:off x="2414880" y="6564240"/>
            <a:ext cx="79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2DL-3, 2DL-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Text Box 42"/>
          <p:cNvSpPr/>
          <p:nvPr/>
        </p:nvSpPr>
        <p:spPr>
          <a:xfrm>
            <a:off x="409680" y="2560680"/>
            <a:ext cx="1952640" cy="523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124a (0.47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639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00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51a (0.47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5a (0.47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2401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261 (0.47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12, cfd53 (0.33-0.47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196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53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707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797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330-2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87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02 (0.33-0.47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2p78.4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11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564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8 (C-0.49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0a (C-0.49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761-2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6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539 (C-0.49La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413-2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728-2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66-2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88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6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574-2D, </a:t>
            </a:r>
            <a:r>
              <a:rPr b="0" lang="en-US" sz="600" spc="-1" strike="noStrike">
                <a:solidFill>
                  <a:srgbClr val="e8422d"/>
                </a:solidFill>
                <a:latin typeface="Arial"/>
              </a:rPr>
              <a:t>gwm608a (C-0.49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752-2D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31.1 (0.95-1.00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73 (C-0.49La) (0.76-1.00c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823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06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51p65.0, m86p65.3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749-2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825-2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064-2D (0.76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49 (0.76-1.00a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9848-2D, wPt-432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11a (0.76-1.00a)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	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             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(0.76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301-2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51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615-2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45"/>
          <p:cNvSpPr/>
          <p:nvPr/>
        </p:nvSpPr>
        <p:spPr>
          <a:xfrm>
            <a:off x="2373480" y="5035680"/>
            <a:ext cx="123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46"/>
          <p:cNvSpPr/>
          <p:nvPr/>
        </p:nvSpPr>
        <p:spPr>
          <a:xfrm flipV="1">
            <a:off x="2376360" y="4952880"/>
            <a:ext cx="0" cy="1843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Line 47"/>
          <p:cNvSpPr/>
          <p:nvPr/>
        </p:nvSpPr>
        <p:spPr>
          <a:xfrm>
            <a:off x="2370240" y="666108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Line 48"/>
          <p:cNvSpPr/>
          <p:nvPr/>
        </p:nvSpPr>
        <p:spPr>
          <a:xfrm flipV="1">
            <a:off x="2376360" y="6506640"/>
            <a:ext cx="0" cy="3128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Line 51"/>
          <p:cNvSpPr/>
          <p:nvPr/>
        </p:nvSpPr>
        <p:spPr>
          <a:xfrm>
            <a:off x="2066760" y="5138640"/>
            <a:ext cx="419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Line 57"/>
          <p:cNvSpPr/>
          <p:nvPr/>
        </p:nvSpPr>
        <p:spPr>
          <a:xfrm flipH="1">
            <a:off x="5006880" y="2629080"/>
            <a:ext cx="6480" cy="50101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 Box 66"/>
          <p:cNvSpPr/>
          <p:nvPr/>
        </p:nvSpPr>
        <p:spPr>
          <a:xfrm>
            <a:off x="2328120" y="4781520"/>
            <a:ext cx="41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us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 Box 67"/>
          <p:cNvSpPr/>
          <p:nvPr/>
        </p:nvSpPr>
        <p:spPr>
          <a:xfrm>
            <a:off x="2328480" y="5148360"/>
            <a:ext cx="351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Z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68"/>
          <p:cNvSpPr/>
          <p:nvPr/>
        </p:nvSpPr>
        <p:spPr>
          <a:xfrm>
            <a:off x="2328480" y="637380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f0300"/>
                </a:solidFill>
                <a:latin typeface="Arial"/>
              </a:rPr>
              <a:t>Hyd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5" name="Picture 3" descr=""/>
          <p:cNvPicPr/>
          <p:nvPr/>
        </p:nvPicPr>
        <p:blipFill>
          <a:blip r:embed="rId1"/>
          <a:stretch/>
        </p:blipFill>
        <p:spPr>
          <a:xfrm>
            <a:off x="3686040" y="2430360"/>
            <a:ext cx="2881440" cy="4724640"/>
          </a:xfrm>
          <a:prstGeom prst="rect">
            <a:avLst/>
          </a:prstGeom>
          <a:ln w="0">
            <a:noFill/>
          </a:ln>
        </p:spPr>
      </p:pic>
      <p:sp>
        <p:nvSpPr>
          <p:cNvPr id="296" name="pole tekstowe 4"/>
          <p:cNvSpPr/>
          <p:nvPr/>
        </p:nvSpPr>
        <p:spPr>
          <a:xfrm>
            <a:off x="5705640" y="5948280"/>
            <a:ext cx="8096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Chl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a+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Chl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a+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Ca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7  GWE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ET</a:t>
            </a:r>
            <a:r>
              <a:rPr b="0" lang="pl-PL" sz="500" spc="-1" strike="noStrike">
                <a:solidFill>
                  <a:srgbClr val="000000"/>
                </a:solidFill>
                <a:latin typeface="Arial"/>
                <a:ea typeface="Times New Roman"/>
              </a:rPr>
              <a:t>0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RC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PI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1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F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v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/F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7" name="Picture 2" descr=""/>
          <p:cNvPicPr/>
          <p:nvPr/>
        </p:nvPicPr>
        <p:blipFill>
          <a:blip r:embed="rId2"/>
          <a:srcRect l="81852" t="2175" r="9713" b="72482"/>
          <a:stretch/>
        </p:blipFill>
        <p:spPr>
          <a:xfrm>
            <a:off x="5388120" y="5979960"/>
            <a:ext cx="401400" cy="903600"/>
          </a:xfrm>
          <a:prstGeom prst="rect">
            <a:avLst/>
          </a:prstGeom>
          <a:ln w="0">
            <a:noFill/>
          </a:ln>
        </p:spPr>
      </p:pic>
      <p:pic>
        <p:nvPicPr>
          <p:cNvPr id="298" name="Picture 2" descr="Screen shot 2013-01-06 at 10"/>
          <p:cNvPicPr/>
          <p:nvPr/>
        </p:nvPicPr>
        <p:blipFill>
          <a:blip r:embed="rId3"/>
          <a:stretch/>
        </p:blipFill>
        <p:spPr>
          <a:xfrm>
            <a:off x="81000" y="2514600"/>
            <a:ext cx="365040" cy="4660920"/>
          </a:xfrm>
          <a:prstGeom prst="rect">
            <a:avLst/>
          </a:prstGeom>
          <a:ln w="0">
            <a:noFill/>
          </a:ln>
        </p:spPr>
      </p:pic>
      <p:sp>
        <p:nvSpPr>
          <p:cNvPr id="299" name="Text Box 3"/>
          <p:cNvSpPr/>
          <p:nvPr/>
        </p:nvSpPr>
        <p:spPr>
          <a:xfrm>
            <a:off x="348480" y="2552760"/>
            <a:ext cx="2111400" cy="454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ff"/>
                </a:solidFill>
                <a:latin typeface="Arial"/>
              </a:rPr>
              <a:t>psr345.2 (0.71-1.00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m60p64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barc12 (0.45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9928-3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7992-3A (0.45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7890-3A (0.45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6854-3A (0.45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1464-3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tPt-6949-3A,</a:t>
            </a: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wmc11a (0.45-1.00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wmc532 (0.45-1.00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2478-3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0836-3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9900"/>
                </a:solidFill>
                <a:latin typeface="Arial"/>
              </a:rPr>
              <a:t>Stb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ff"/>
                </a:solidFill>
                <a:latin typeface="Arial"/>
              </a:rPr>
              <a:t>psr598 (0.45-1.00b),</a:t>
            </a: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gwm2 (0.45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psp3047 (C-0.45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cfa2234 (C-0.21Ld),</a:t>
            </a: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 tPt-1143-3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rPt-9057-3A (C-0.45Lw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cfa2262 (0.42-0.85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7327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73407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313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cfa2193 (0.42-0.85d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9761-3A (C-0.42Lh),</a:t>
            </a: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 m69p78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wmc388a,</a:t>
            </a: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 tPt-02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ff0000"/>
                </a:solidFill>
                <a:latin typeface="Arial"/>
              </a:rPr>
              <a:t>gwm480, wmc169 (0.85-1.00d),</a:t>
            </a: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 wPt-5133-3A (C-0.42L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889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4398-3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8203-3A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8146-3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ff"/>
                </a:solidFill>
                <a:latin typeface="Arial"/>
              </a:rPr>
              <a:t>psr1203.1 (0.85-1.00b),</a:t>
            </a: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 wPt-9160-3A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8741-3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339966"/>
                </a:solidFill>
                <a:latin typeface="Arial"/>
              </a:rPr>
              <a:t>wPt-2813-3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0" name="Group 4"/>
          <p:cNvGrpSpPr/>
          <p:nvPr/>
        </p:nvGrpSpPr>
        <p:grpSpPr>
          <a:xfrm>
            <a:off x="2457360" y="2610000"/>
            <a:ext cx="152640" cy="4470120"/>
            <a:chOff x="2457360" y="2610000"/>
            <a:chExt cx="152640" cy="4470120"/>
          </a:xfrm>
        </p:grpSpPr>
        <p:sp>
          <p:nvSpPr>
            <p:cNvPr id="301" name="AutoShape 5"/>
            <p:cNvSpPr/>
            <p:nvPr/>
          </p:nvSpPr>
          <p:spPr>
            <a:xfrm>
              <a:off x="2457360" y="6419880"/>
              <a:ext cx="152640" cy="657360"/>
            </a:xfrm>
            <a:custGeom>
              <a:avLst/>
              <a:gdLst>
                <a:gd name="textAreaLeft" fmla="*/ 18000 w 152640"/>
                <a:gd name="textAreaRight" fmla="*/ 134640 w 152640"/>
                <a:gd name="textAreaTop" fmla="*/ 18000 h 657360"/>
                <a:gd name="textAreaBottom" fmla="*/ 639360 h 657360"/>
              </a:gdLst>
              <a:ahLst/>
              <a:rect l="textAreaLeft" t="textAreaTop" r="textAreaRight" b="textAreaBottom"/>
              <a:pathLst>
                <a:path w="21600" h="92855">
                  <a:moveTo>
                    <a:pt x="3600" y="0"/>
                  </a:moveTo>
                  <a:arcTo wR="3600" hR="3600" stAng="0" swAng="5400000"/>
                  <a:lnTo>
                    <a:pt x="0" y="89255"/>
                  </a:lnTo>
                  <a:arcTo wR="3600" hR="3600" stAng="16200000" swAng="5400000"/>
                  <a:lnTo>
                    <a:pt x="18000" y="92855"/>
                  </a:lnTo>
                  <a:arcTo wR="3600" hR="3600" stAng="10800000" swAng="5400000"/>
                  <a:lnTo>
                    <a:pt x="21600" y="3600"/>
                  </a:lnTo>
                  <a:arcTo wR="3600" hR="3600" stAng="5400000" swAng="5400000"/>
                  <a:close/>
                </a:path>
              </a:pathLst>
            </a:custGeom>
            <a:solidFill>
              <a:srgbClr val="51c2a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AutoShape 6"/>
            <p:cNvSpPr/>
            <p:nvPr/>
          </p:nvSpPr>
          <p:spPr>
            <a:xfrm>
              <a:off x="2457360" y="5823000"/>
              <a:ext cx="152640" cy="638280"/>
            </a:xfrm>
            <a:custGeom>
              <a:avLst/>
              <a:gdLst>
                <a:gd name="textAreaLeft" fmla="*/ 0 w 152640"/>
                <a:gd name="textAreaRight" fmla="*/ 153000 w 152640"/>
                <a:gd name="textAreaTop" fmla="*/ 0 h 638280"/>
                <a:gd name="textAreaBottom" fmla="*/ 638640 h 638280"/>
              </a:gdLst>
              <a:ahLst/>
              <a:rect l="textAreaLeft" t="textAreaTop" r="textAreaRight" b="textAreaBottom"/>
              <a:pathLst>
                <a:path w="21600" h="90161">
                  <a:moveTo>
                    <a:pt x="0" y="0"/>
                  </a:moveTo>
                  <a:arcTo wR="0" hR="0" stAng="10800000" swAng="-5400000"/>
                  <a:lnTo>
                    <a:pt x="0" y="90161"/>
                  </a:lnTo>
                  <a:arcTo wR="0" hR="0" stAng="16200000" swAng="-5400000"/>
                  <a:lnTo>
                    <a:pt x="21600" y="90161"/>
                  </a:lnTo>
                  <a:arcTo wR="0" hR="0" stAng="10800000" swAng="-5400000"/>
                  <a:lnTo>
                    <a:pt x="21600" y="0"/>
                  </a:lnTo>
                  <a:arcTo wR="0" hR="0" stAng="16200000" swAng="-5400000"/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AutoShape 7"/>
            <p:cNvSpPr/>
            <p:nvPr/>
          </p:nvSpPr>
          <p:spPr>
            <a:xfrm>
              <a:off x="2457360" y="2610000"/>
              <a:ext cx="152640" cy="1657080"/>
            </a:xfrm>
            <a:custGeom>
              <a:avLst/>
              <a:gdLst>
                <a:gd name="textAreaLeft" fmla="*/ 18000 w 152640"/>
                <a:gd name="textAreaRight" fmla="*/ 134640 w 152640"/>
                <a:gd name="textAreaTop" fmla="*/ 18000 h 1657080"/>
                <a:gd name="textAreaBottom" fmla="*/ 1639080 h 1657080"/>
              </a:gdLst>
              <a:ahLst/>
              <a:rect l="textAreaLeft" t="textAreaTop" r="textAreaRight" b="textAreaBottom"/>
              <a:pathLst>
                <a:path w="21600" h="233992">
                  <a:moveTo>
                    <a:pt x="3600" y="0"/>
                  </a:moveTo>
                  <a:arcTo wR="3600" hR="3600" stAng="0" swAng="5400000"/>
                  <a:lnTo>
                    <a:pt x="0" y="230392"/>
                  </a:lnTo>
                  <a:arcTo wR="3600" hR="3600" stAng="16200000" swAng="5400000"/>
                  <a:lnTo>
                    <a:pt x="18000" y="233992"/>
                  </a:lnTo>
                  <a:arcTo wR="3600" hR="3600" stAng="10800000" swAng="5400000"/>
                  <a:lnTo>
                    <a:pt x="21600" y="3600"/>
                  </a:lnTo>
                  <a:arcTo wR="3600" hR="3600" stAng="5400000" swAng="5400000"/>
                  <a:close/>
                </a:path>
              </a:pathLst>
            </a:custGeom>
            <a:solidFill>
              <a:srgbClr val="1f60a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AutoShape 8"/>
            <p:cNvSpPr/>
            <p:nvPr/>
          </p:nvSpPr>
          <p:spPr>
            <a:xfrm>
              <a:off x="2457360" y="4181400"/>
              <a:ext cx="152640" cy="466920"/>
            </a:xfrm>
            <a:custGeom>
              <a:avLst/>
              <a:gdLst>
                <a:gd name="textAreaLeft" fmla="*/ 0 w 152640"/>
                <a:gd name="textAreaRight" fmla="*/ 153000 w 152640"/>
                <a:gd name="textAreaTop" fmla="*/ 0 h 466920"/>
                <a:gd name="textAreaBottom" fmla="*/ 467280 h 466920"/>
              </a:gdLst>
              <a:ahLst/>
              <a:rect l="textAreaLeft" t="textAreaTop" r="textAreaRight" b="textAreaBottom"/>
              <a:pathLst>
                <a:path w="21600" h="65969">
                  <a:moveTo>
                    <a:pt x="0" y="0"/>
                  </a:moveTo>
                  <a:arcTo wR="0" hR="0" stAng="10800000" swAng="-5400000"/>
                  <a:lnTo>
                    <a:pt x="0" y="65969"/>
                  </a:lnTo>
                  <a:arcTo wR="0" hR="0" stAng="16200000" swAng="-5400000"/>
                  <a:lnTo>
                    <a:pt x="21600" y="65969"/>
                  </a:lnTo>
                  <a:arcTo wR="0" hR="0" stAng="10800000" swAng="-5400000"/>
                  <a:lnTo>
                    <a:pt x="21600" y="0"/>
                  </a:lnTo>
                  <a:arcTo wR="0" hR="0" stAng="16200000" swAng="-5400000"/>
                  <a:close/>
                </a:path>
              </a:pathLst>
            </a:custGeom>
            <a:solidFill>
              <a:srgbClr val="eba24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AutoShape 9"/>
            <p:cNvSpPr/>
            <p:nvPr/>
          </p:nvSpPr>
          <p:spPr>
            <a:xfrm>
              <a:off x="2457360" y="4533840"/>
              <a:ext cx="152640" cy="1596960"/>
            </a:xfrm>
            <a:custGeom>
              <a:avLst/>
              <a:gdLst>
                <a:gd name="textAreaLeft" fmla="*/ 0 w 152640"/>
                <a:gd name="textAreaRight" fmla="*/ 153000 w 152640"/>
                <a:gd name="textAreaTop" fmla="*/ 0 h 1596960"/>
                <a:gd name="textAreaBottom" fmla="*/ 1597320 h 1596960"/>
              </a:gdLst>
              <a:ahLst/>
              <a:rect l="textAreaLeft" t="textAreaTop" r="textAreaRight" b="textAreaBottom"/>
              <a:pathLst>
                <a:path w="21600" h="225504">
                  <a:moveTo>
                    <a:pt x="0" y="0"/>
                  </a:moveTo>
                  <a:arcTo wR="0" hR="0" stAng="10800000" swAng="-5400000"/>
                  <a:lnTo>
                    <a:pt x="0" y="225504"/>
                  </a:lnTo>
                  <a:arcTo wR="0" hR="0" stAng="16200000" swAng="-5400000"/>
                  <a:lnTo>
                    <a:pt x="21600" y="225504"/>
                  </a:lnTo>
                  <a:arcTo wR="0" hR="0" stAng="10800000" swAng="-5400000"/>
                  <a:lnTo>
                    <a:pt x="21600" y="0"/>
                  </a:lnTo>
                  <a:arcTo wR="0" hR="0" stAng="16200000" swAng="-5400000"/>
                  <a:close/>
                </a:path>
              </a:pathLst>
            </a:custGeom>
            <a:solidFill>
              <a:srgbClr val="9d69a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AutoShape 10"/>
            <p:cNvSpPr/>
            <p:nvPr/>
          </p:nvSpPr>
          <p:spPr>
            <a:xfrm>
              <a:off x="2457360" y="2616120"/>
              <a:ext cx="152640" cy="4464000"/>
            </a:xfrm>
            <a:custGeom>
              <a:avLst/>
              <a:gdLst>
                <a:gd name="textAreaLeft" fmla="*/ 18000 w 152640"/>
                <a:gd name="textAreaRight" fmla="*/ 134640 w 152640"/>
                <a:gd name="textAreaTop" fmla="*/ 18000 h 4464000"/>
                <a:gd name="textAreaBottom" fmla="*/ 4446000 h 4464000"/>
              </a:gdLst>
              <a:ahLst/>
              <a:rect l="textAreaLeft" t="textAreaTop" r="textAreaRight" b="textAreaBottom"/>
              <a:pathLst>
                <a:path w="21600" h="630263">
                  <a:moveTo>
                    <a:pt x="3600" y="0"/>
                  </a:moveTo>
                  <a:arcTo wR="3600" hR="3600" stAng="0" swAng="5400000"/>
                  <a:lnTo>
                    <a:pt x="0" y="626663"/>
                  </a:lnTo>
                  <a:arcTo wR="3600" hR="3600" stAng="16200000" swAng="5400000"/>
                  <a:lnTo>
                    <a:pt x="18000" y="630263"/>
                  </a:lnTo>
                  <a:arcTo wR="3600" hR="3600" stAng="10800000" swAng="5400000"/>
                  <a:lnTo>
                    <a:pt x="21600" y="3600"/>
                  </a:lnTo>
                  <a:arcTo wR="3600" hR="3600" stAng="5400000" swAng="5400000"/>
                  <a:close/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7" name="Text Box 11"/>
          <p:cNvSpPr/>
          <p:nvPr/>
        </p:nvSpPr>
        <p:spPr>
          <a:xfrm>
            <a:off x="2574720" y="3289320"/>
            <a:ext cx="875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0.45-1.00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Text Box 12"/>
          <p:cNvSpPr/>
          <p:nvPr/>
        </p:nvSpPr>
        <p:spPr>
          <a:xfrm>
            <a:off x="2686320" y="4073400"/>
            <a:ext cx="1028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3AS-4, 3AS-2, 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Text Box 13"/>
          <p:cNvSpPr/>
          <p:nvPr/>
        </p:nvSpPr>
        <p:spPr>
          <a:xfrm>
            <a:off x="2686680" y="4416480"/>
            <a:ext cx="48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3AL-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Text Box 14"/>
          <p:cNvSpPr/>
          <p:nvPr/>
        </p:nvSpPr>
        <p:spPr>
          <a:xfrm>
            <a:off x="2686680" y="6188040"/>
            <a:ext cx="48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3AL-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Text Box 15"/>
          <p:cNvSpPr/>
          <p:nvPr/>
        </p:nvSpPr>
        <p:spPr>
          <a:xfrm>
            <a:off x="2574360" y="4262400"/>
            <a:ext cx="90288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-0.42L </a:t>
            </a:r>
            <a:r>
              <a:rPr b="0" i="1" lang="en-GB" sz="900" spc="-1" strike="noStrike">
                <a:solidFill>
                  <a:srgbClr val="fc0000"/>
                </a:solidFill>
                <a:latin typeface="Arial"/>
              </a:rPr>
              <a:t>e-Lc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 Box 16"/>
          <p:cNvSpPr/>
          <p:nvPr/>
        </p:nvSpPr>
        <p:spPr>
          <a:xfrm>
            <a:off x="2575080" y="5200560"/>
            <a:ext cx="666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0.42-0.7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 Box 17"/>
          <p:cNvSpPr/>
          <p:nvPr/>
        </p:nvSpPr>
        <p:spPr>
          <a:xfrm>
            <a:off x="2572920" y="6618240"/>
            <a:ext cx="1290240" cy="30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0.78-1.00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ubisco-ssu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Line 19"/>
          <p:cNvSpPr/>
          <p:nvPr/>
        </p:nvSpPr>
        <p:spPr>
          <a:xfrm>
            <a:off x="2622600" y="453060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5" name="Group 20"/>
          <p:cNvGrpSpPr/>
          <p:nvPr/>
        </p:nvGrpSpPr>
        <p:grpSpPr>
          <a:xfrm>
            <a:off x="2629080" y="6135840"/>
            <a:ext cx="123480" cy="320400"/>
            <a:chOff x="2629080" y="6135840"/>
            <a:chExt cx="123480" cy="320400"/>
          </a:xfrm>
        </p:grpSpPr>
        <p:sp>
          <p:nvSpPr>
            <p:cNvPr id="316" name="Line 21"/>
            <p:cNvSpPr/>
            <p:nvPr/>
          </p:nvSpPr>
          <p:spPr>
            <a:xfrm>
              <a:off x="2629080" y="6299280"/>
              <a:ext cx="1234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22"/>
            <p:cNvSpPr/>
            <p:nvPr/>
          </p:nvSpPr>
          <p:spPr>
            <a:xfrm flipV="1">
              <a:off x="2634840" y="6135840"/>
              <a:ext cx="0" cy="320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8" name="Text Box 24"/>
          <p:cNvSpPr/>
          <p:nvPr/>
        </p:nvSpPr>
        <p:spPr>
          <a:xfrm>
            <a:off x="4500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A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 Box 25"/>
          <p:cNvSpPr/>
          <p:nvPr/>
        </p:nvSpPr>
        <p:spPr>
          <a:xfrm>
            <a:off x="213660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A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26"/>
          <p:cNvSpPr/>
          <p:nvPr/>
        </p:nvSpPr>
        <p:spPr>
          <a:xfrm>
            <a:off x="394092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A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Oval 28"/>
          <p:cNvSpPr/>
          <p:nvPr/>
        </p:nvSpPr>
        <p:spPr>
          <a:xfrm>
            <a:off x="185760" y="4102200"/>
            <a:ext cx="152280" cy="1522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2" name="Picture 29" descr="Chrom blank Screen shot 2013-01-07 at 10"/>
          <p:cNvPicPr/>
          <p:nvPr/>
        </p:nvPicPr>
        <p:blipFill>
          <a:blip r:embed="rId4">
            <a:lum contrast="-2000"/>
          </a:blip>
          <a:srcRect l="7663" t="0" r="0" b="0"/>
          <a:stretch/>
        </p:blipFill>
        <p:spPr>
          <a:xfrm>
            <a:off x="173160" y="4375080"/>
            <a:ext cx="168120" cy="324000"/>
          </a:xfrm>
          <a:prstGeom prst="rect">
            <a:avLst/>
          </a:prstGeom>
          <a:ln w="0">
            <a:noFill/>
          </a:ln>
        </p:spPr>
      </p:pic>
      <p:pic>
        <p:nvPicPr>
          <p:cNvPr id="323" name="Picture 31" descr="Chrom blank Screen shot 2013-01-07 at 10"/>
          <p:cNvPicPr/>
          <p:nvPr/>
        </p:nvPicPr>
        <p:blipFill>
          <a:blip r:embed="rId5">
            <a:lum contrast="-2000"/>
          </a:blip>
          <a:srcRect l="7663" t="0" r="0" b="0"/>
          <a:stretch/>
        </p:blipFill>
        <p:spPr>
          <a:xfrm>
            <a:off x="171360" y="4716360"/>
            <a:ext cx="168480" cy="501840"/>
          </a:xfrm>
          <a:prstGeom prst="rect">
            <a:avLst/>
          </a:prstGeom>
          <a:ln w="0">
            <a:noFill/>
          </a:ln>
        </p:spPr>
      </p:pic>
      <p:sp>
        <p:nvSpPr>
          <p:cNvPr id="324" name="Line 32"/>
          <p:cNvSpPr/>
          <p:nvPr/>
        </p:nvSpPr>
        <p:spPr>
          <a:xfrm>
            <a:off x="2325600" y="417672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Line 38"/>
          <p:cNvSpPr/>
          <p:nvPr/>
        </p:nvSpPr>
        <p:spPr>
          <a:xfrm>
            <a:off x="5270400" y="2635200"/>
            <a:ext cx="0" cy="43815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 Box 39"/>
          <p:cNvSpPr/>
          <p:nvPr/>
        </p:nvSpPr>
        <p:spPr>
          <a:xfrm>
            <a:off x="2576520" y="2666880"/>
            <a:ext cx="35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900" spc="-1" strike="noStrike">
                <a:solidFill>
                  <a:srgbClr val="fc0000"/>
                </a:solidFill>
                <a:latin typeface="Arial"/>
              </a:rPr>
              <a:t>Dx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" name="Picture 3" descr=""/>
          <p:cNvPicPr/>
          <p:nvPr/>
        </p:nvPicPr>
        <p:blipFill>
          <a:blip r:embed="rId1"/>
          <a:stretch/>
        </p:blipFill>
        <p:spPr>
          <a:xfrm>
            <a:off x="3360600" y="2360520"/>
            <a:ext cx="3326040" cy="5862600"/>
          </a:xfrm>
          <a:prstGeom prst="rect">
            <a:avLst/>
          </a:prstGeom>
          <a:ln w="0">
            <a:noFill/>
          </a:ln>
        </p:spPr>
      </p:pic>
      <p:sp>
        <p:nvSpPr>
          <p:cNvPr id="328" name="Line 57"/>
          <p:cNvSpPr/>
          <p:nvPr/>
        </p:nvSpPr>
        <p:spPr>
          <a:xfrm>
            <a:off x="5530680" y="2622600"/>
            <a:ext cx="0" cy="539748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AutoShape 5"/>
          <p:cNvSpPr/>
          <p:nvPr/>
        </p:nvSpPr>
        <p:spPr>
          <a:xfrm>
            <a:off x="2451240" y="5715000"/>
            <a:ext cx="152280" cy="23875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2387520"/>
              <a:gd name="textAreaBottom" fmla="*/ 2369880 h 2387520"/>
            </a:gdLst>
            <a:ahLst/>
            <a:rect l="textAreaLeft" t="textAreaTop" r="textAreaRight" b="textAreaBottom"/>
            <a:pathLst>
              <a:path w="21600" h="337908">
                <a:moveTo>
                  <a:pt x="3600" y="0"/>
                </a:moveTo>
                <a:arcTo wR="3600" hR="3600" stAng="0" swAng="5400000"/>
                <a:lnTo>
                  <a:pt x="0" y="334308"/>
                </a:lnTo>
                <a:arcTo wR="3600" hR="3600" stAng="16200000" swAng="5400000"/>
                <a:lnTo>
                  <a:pt x="18000" y="337908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ac6c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AutoShape 6"/>
          <p:cNvSpPr/>
          <p:nvPr/>
        </p:nvSpPr>
        <p:spPr>
          <a:xfrm>
            <a:off x="2451240" y="5410080"/>
            <a:ext cx="152280" cy="368280"/>
          </a:xfrm>
          <a:custGeom>
            <a:avLst/>
            <a:gdLst>
              <a:gd name="textAreaLeft" fmla="*/ 0 w 152280"/>
              <a:gd name="textAreaRight" fmla="*/ 152640 w 152280"/>
              <a:gd name="textAreaTop" fmla="*/ 0 h 368280"/>
              <a:gd name="textAreaBottom" fmla="*/ 368280 h 368280"/>
            </a:gdLst>
            <a:ahLst/>
            <a:rect l="textAreaLeft" t="textAreaTop" r="textAreaRight" b="textAreaBottom"/>
            <a:pathLst>
              <a:path w="21600" h="52166">
                <a:moveTo>
                  <a:pt x="0" y="0"/>
                </a:moveTo>
                <a:arcTo wR="0" hR="0" stAng="10800000" swAng="-5400000"/>
                <a:lnTo>
                  <a:pt x="0" y="52166"/>
                </a:lnTo>
                <a:arcTo wR="0" hR="0" stAng="16200000" swAng="-5400000"/>
                <a:lnTo>
                  <a:pt x="21600" y="52166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AutoShape 32"/>
          <p:cNvSpPr/>
          <p:nvPr/>
        </p:nvSpPr>
        <p:spPr>
          <a:xfrm>
            <a:off x="2451240" y="4867200"/>
            <a:ext cx="152280" cy="390600"/>
          </a:xfrm>
          <a:custGeom>
            <a:avLst/>
            <a:gdLst>
              <a:gd name="textAreaLeft" fmla="*/ 0 w 152280"/>
              <a:gd name="textAreaRight" fmla="*/ 152640 w 152280"/>
              <a:gd name="textAreaTop" fmla="*/ 0 h 390600"/>
              <a:gd name="textAreaBottom" fmla="*/ 390960 h 390600"/>
            </a:gdLst>
            <a:ahLst/>
            <a:rect l="textAreaLeft" t="textAreaTop" r="textAreaRight" b="textAreaBottom"/>
            <a:pathLst>
              <a:path w="21600" h="55325">
                <a:moveTo>
                  <a:pt x="0" y="0"/>
                </a:moveTo>
                <a:arcTo wR="0" hR="0" stAng="10800000" swAng="-5400000"/>
                <a:lnTo>
                  <a:pt x="0" y="55325"/>
                </a:lnTo>
                <a:arcTo wR="0" hR="0" stAng="16200000" swAng="-5400000"/>
                <a:lnTo>
                  <a:pt x="21600" y="55325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e8422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AutoShape 7"/>
          <p:cNvSpPr/>
          <p:nvPr/>
        </p:nvSpPr>
        <p:spPr>
          <a:xfrm>
            <a:off x="2451240" y="2610000"/>
            <a:ext cx="152280" cy="13525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352520"/>
              <a:gd name="textAreaBottom" fmla="*/ 1334880 h 1352520"/>
            </a:gdLst>
            <a:ahLst/>
            <a:rect l="textAreaLeft" t="textAreaTop" r="textAreaRight" b="textAreaBottom"/>
            <a:pathLst>
              <a:path w="21600" h="191445">
                <a:moveTo>
                  <a:pt x="3600" y="0"/>
                </a:moveTo>
                <a:arcTo wR="3600" hR="3600" stAng="0" swAng="5400000"/>
                <a:lnTo>
                  <a:pt x="0" y="187845"/>
                </a:lnTo>
                <a:arcTo wR="3600" hR="3600" stAng="16200000" swAng="5400000"/>
                <a:lnTo>
                  <a:pt x="18000" y="191445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1f60a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AutoShape 8"/>
          <p:cNvSpPr/>
          <p:nvPr/>
        </p:nvSpPr>
        <p:spPr>
          <a:xfrm>
            <a:off x="2451240" y="3879720"/>
            <a:ext cx="152280" cy="917640"/>
          </a:xfrm>
          <a:custGeom>
            <a:avLst/>
            <a:gdLst>
              <a:gd name="textAreaLeft" fmla="*/ 0 w 152280"/>
              <a:gd name="textAreaRight" fmla="*/ 152640 w 152280"/>
              <a:gd name="textAreaTop" fmla="*/ 0 h 917640"/>
              <a:gd name="textAreaBottom" fmla="*/ 918000 h 917640"/>
            </a:gdLst>
            <a:ahLst/>
            <a:rect l="textAreaLeft" t="textAreaTop" r="textAreaRight" b="textAreaBottom"/>
            <a:pathLst>
              <a:path w="21600" h="129906">
                <a:moveTo>
                  <a:pt x="0" y="0"/>
                </a:moveTo>
                <a:arcTo wR="0" hR="0" stAng="10800000" swAng="-5400000"/>
                <a:lnTo>
                  <a:pt x="0" y="129906"/>
                </a:lnTo>
                <a:arcTo wR="0" hR="0" stAng="16200000" swAng="-5400000"/>
                <a:lnTo>
                  <a:pt x="21600" y="129906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8ecc9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AutoShape 9"/>
          <p:cNvSpPr/>
          <p:nvPr/>
        </p:nvSpPr>
        <p:spPr>
          <a:xfrm>
            <a:off x="2451240" y="4946760"/>
            <a:ext cx="152280" cy="412560"/>
          </a:xfrm>
          <a:custGeom>
            <a:avLst/>
            <a:gdLst>
              <a:gd name="textAreaLeft" fmla="*/ 0 w 152280"/>
              <a:gd name="textAreaRight" fmla="*/ 152640 w 152280"/>
              <a:gd name="textAreaTop" fmla="*/ 0 h 412560"/>
              <a:gd name="textAreaBottom" fmla="*/ 412920 h 412560"/>
            </a:gdLst>
            <a:ahLst/>
            <a:rect l="textAreaLeft" t="textAreaTop" r="textAreaRight" b="textAreaBottom"/>
            <a:pathLst>
              <a:path w="21600" h="58432">
                <a:moveTo>
                  <a:pt x="0" y="0"/>
                </a:moveTo>
                <a:arcTo wR="0" hR="0" stAng="10800000" swAng="-5400000"/>
                <a:lnTo>
                  <a:pt x="0" y="58432"/>
                </a:lnTo>
                <a:arcTo wR="0" hR="0" stAng="16200000" swAng="-5400000"/>
                <a:lnTo>
                  <a:pt x="21600" y="58432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b943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AutoShape 10"/>
          <p:cNvSpPr/>
          <p:nvPr/>
        </p:nvSpPr>
        <p:spPr>
          <a:xfrm>
            <a:off x="2451240" y="2616120"/>
            <a:ext cx="152280" cy="548640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5486400"/>
              <a:gd name="textAreaBottom" fmla="*/ 5468760 h 5486400"/>
            </a:gdLst>
            <a:ahLst/>
            <a:rect l="textAreaLeft" t="textAreaTop" r="textAreaRight" b="textAreaBottom"/>
            <a:pathLst>
              <a:path w="21600" h="776428">
                <a:moveTo>
                  <a:pt x="3600" y="0"/>
                </a:moveTo>
                <a:arcTo wR="3600" hR="3600" stAng="0" swAng="5400000"/>
                <a:lnTo>
                  <a:pt x="0" y="772828"/>
                </a:lnTo>
                <a:arcTo wR="3600" hR="3600" stAng="16200000" swAng="5400000"/>
                <a:lnTo>
                  <a:pt x="18000" y="776428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 Box 11"/>
          <p:cNvSpPr/>
          <p:nvPr/>
        </p:nvSpPr>
        <p:spPr>
          <a:xfrm>
            <a:off x="2569680" y="313524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78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 Box 12"/>
          <p:cNvSpPr/>
          <p:nvPr/>
        </p:nvSpPr>
        <p:spPr>
          <a:xfrm>
            <a:off x="2680920" y="377676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3BS-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 Box 13"/>
          <p:cNvSpPr/>
          <p:nvPr/>
        </p:nvSpPr>
        <p:spPr>
          <a:xfrm>
            <a:off x="2681280" y="481968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 Box 14"/>
          <p:cNvSpPr/>
          <p:nvPr/>
        </p:nvSpPr>
        <p:spPr>
          <a:xfrm>
            <a:off x="2681280" y="546588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3BL-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 Box 15"/>
          <p:cNvSpPr/>
          <p:nvPr/>
        </p:nvSpPr>
        <p:spPr>
          <a:xfrm>
            <a:off x="2569320" y="4270320"/>
            <a:ext cx="81612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7-0.78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 Box 16"/>
          <p:cNvSpPr/>
          <p:nvPr/>
        </p:nvSpPr>
        <p:spPr>
          <a:xfrm>
            <a:off x="2569320" y="5040360"/>
            <a:ext cx="820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-0.22L </a:t>
            </a:r>
            <a:r>
              <a:rPr b="0" i="1" lang="en-GB" sz="800" spc="-1" strike="noStrike">
                <a:solidFill>
                  <a:srgbClr val="fc0000"/>
                </a:solidFill>
                <a:latin typeface="Arial"/>
              </a:rPr>
              <a:t>e-Lc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 Box 17"/>
          <p:cNvSpPr/>
          <p:nvPr/>
        </p:nvSpPr>
        <p:spPr>
          <a:xfrm>
            <a:off x="2567520" y="6745320"/>
            <a:ext cx="1230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63-1.00 </a:t>
            </a: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ubisco-ssu,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S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Line 18"/>
          <p:cNvSpPr/>
          <p:nvPr/>
        </p:nvSpPr>
        <p:spPr>
          <a:xfrm>
            <a:off x="2616120" y="38703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Line 21"/>
          <p:cNvSpPr/>
          <p:nvPr/>
        </p:nvSpPr>
        <p:spPr>
          <a:xfrm>
            <a:off x="2629080" y="5560920"/>
            <a:ext cx="123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Line 22"/>
          <p:cNvSpPr/>
          <p:nvPr/>
        </p:nvSpPr>
        <p:spPr>
          <a:xfrm flipV="1">
            <a:off x="2633760" y="5359320"/>
            <a:ext cx="0" cy="419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Text Box 24"/>
          <p:cNvSpPr/>
          <p:nvPr/>
        </p:nvSpPr>
        <p:spPr>
          <a:xfrm>
            <a:off x="45000" y="201132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B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Text Box 25"/>
          <p:cNvSpPr/>
          <p:nvPr/>
        </p:nvSpPr>
        <p:spPr>
          <a:xfrm>
            <a:off x="2286000" y="2011320"/>
            <a:ext cx="11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B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Text Box 26"/>
          <p:cNvSpPr/>
          <p:nvPr/>
        </p:nvSpPr>
        <p:spPr>
          <a:xfrm>
            <a:off x="3940920" y="2011320"/>
            <a:ext cx="215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B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9" name="Group 30"/>
          <p:cNvGrpSpPr/>
          <p:nvPr/>
        </p:nvGrpSpPr>
        <p:grpSpPr>
          <a:xfrm>
            <a:off x="152280" y="2549520"/>
            <a:ext cx="255600" cy="5603400"/>
            <a:chOff x="152280" y="2549520"/>
            <a:chExt cx="255600" cy="5603400"/>
          </a:xfrm>
        </p:grpSpPr>
        <p:pic>
          <p:nvPicPr>
            <p:cNvPr id="350" name="Picture 27" descr="3B Screen shot 2013-01-07 at 22"/>
            <p:cNvPicPr/>
            <p:nvPr/>
          </p:nvPicPr>
          <p:blipFill>
            <a:blip r:embed="rId2"/>
            <a:stretch/>
          </p:blipFill>
          <p:spPr>
            <a:xfrm>
              <a:off x="152280" y="2549520"/>
              <a:ext cx="255600" cy="5603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51" name="Picture 28" descr="Screen shot 2013-01-07 at 22"/>
            <p:cNvPicPr/>
            <p:nvPr/>
          </p:nvPicPr>
          <p:blipFill>
            <a:blip r:embed="rId3"/>
            <a:srcRect l="0" t="30558" r="8591" b="0"/>
            <a:stretch/>
          </p:blipFill>
          <p:spPr>
            <a:xfrm>
              <a:off x="176760" y="4556880"/>
              <a:ext cx="158400" cy="3164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352" name="Text Box 29"/>
          <p:cNvSpPr/>
          <p:nvPr/>
        </p:nvSpPr>
        <p:spPr>
          <a:xfrm>
            <a:off x="324000" y="2570040"/>
            <a:ext cx="2151360" cy="556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92p78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21p76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43p78.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533 (0.78-0.87ax), barc74 (0.78-1.00a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264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84-3B (0.78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162-3B (0.78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260-3B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989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132-3B (0.78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04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302-3B (0.78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536-3B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493 (0.78-1.00ad) (0.78-0.87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682-3B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842-3B (0.78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1261-3B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9p78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432-3B (0.78-1.00h)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567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a9335"/>
                </a:solidFill>
                <a:latin typeface="Arial"/>
              </a:rPr>
              <a:t>Blt4.1 (0.78-1.00e),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2p64.7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298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0005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4159-3B, wPt-8356 (0.57-0.78f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0948-3B (0.57-0.87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239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tPt-9273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244-3B (0.33-0.78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371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231 (0.57-0.75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68 (0.57-0.78a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209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225-3B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0p64.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285 (C-0.33Sahx)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3p65.10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rPt-5396 (C-0.22L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048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1218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1024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 (C-0.22Lc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0033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144 (C-0.22L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364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940-3B (0.07-0.22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327-3B (0.07-0.22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dupw227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9p78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418 (0.50-0.63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254-3B (0.63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112a (0.31-0.38x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171-3B (0.63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0546-3B (0.63-1.00x)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7p64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7p77.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60p64.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6p65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92p78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678-3B (0.63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5358-3B (0.63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222-3B (0.63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896-3B (0.63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84 (0.63-1.00ah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205 (0.81-1.00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326 (0.63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77 (0.63-1.00ax)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491-3B (0.63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021-3B (0.63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7746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367-3B (0.63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50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3541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wia858.1</a:t>
            </a:r>
            <a:r>
              <a:rPr b="0" lang="en-US" sz="600" spc="-1" strike="noStrike">
                <a:solidFill>
                  <a:srgbClr val="fb9438"/>
                </a:solidFill>
                <a:latin typeface="Arial"/>
              </a:rPr>
              <a:t>(Glb35) (0.63-1.00be)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912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10537-3B (0.63-1.00x)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386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psp3001b (0.63-1.00x), </a:t>
            </a: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8845-3B (0.63-1.00f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178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324-3B (0.63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2559-3B (0.63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0343-3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412-3B (0.63-1.00h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40-3B (0.63-1.00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40 (0.63-1.00dx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17p65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 Box 33"/>
          <p:cNvSpPr/>
          <p:nvPr/>
        </p:nvSpPr>
        <p:spPr>
          <a:xfrm>
            <a:off x="2679480" y="4722840"/>
            <a:ext cx="80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3BS-1, 3BS-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Line 35"/>
          <p:cNvSpPr/>
          <p:nvPr/>
        </p:nvSpPr>
        <p:spPr>
          <a:xfrm>
            <a:off x="2629080" y="4826160"/>
            <a:ext cx="123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Line 36"/>
          <p:cNvSpPr/>
          <p:nvPr/>
        </p:nvSpPr>
        <p:spPr>
          <a:xfrm flipV="1">
            <a:off x="2635200" y="4781520"/>
            <a:ext cx="0" cy="85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6" name="Group 40"/>
          <p:cNvGrpSpPr/>
          <p:nvPr/>
        </p:nvGrpSpPr>
        <p:grpSpPr>
          <a:xfrm>
            <a:off x="2622600" y="5262480"/>
            <a:ext cx="517320" cy="215640"/>
            <a:chOff x="2622600" y="5262480"/>
            <a:chExt cx="517320" cy="215640"/>
          </a:xfrm>
        </p:grpSpPr>
        <p:sp>
          <p:nvSpPr>
            <p:cNvPr id="357" name="Text Box 38"/>
            <p:cNvSpPr/>
            <p:nvPr/>
          </p:nvSpPr>
          <p:spPr>
            <a:xfrm>
              <a:off x="2687760" y="5262480"/>
              <a:ext cx="45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3BL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Line 39"/>
            <p:cNvSpPr/>
            <p:nvPr/>
          </p:nvSpPr>
          <p:spPr>
            <a:xfrm>
              <a:off x="2622600" y="5356080"/>
              <a:ext cx="123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59" name="Group 42"/>
          <p:cNvGrpSpPr/>
          <p:nvPr/>
        </p:nvGrpSpPr>
        <p:grpSpPr>
          <a:xfrm>
            <a:off x="2622600" y="5675400"/>
            <a:ext cx="517320" cy="215640"/>
            <a:chOff x="2622600" y="5675400"/>
            <a:chExt cx="517320" cy="215640"/>
          </a:xfrm>
        </p:grpSpPr>
        <p:sp>
          <p:nvSpPr>
            <p:cNvPr id="360" name="Text Box 43"/>
            <p:cNvSpPr/>
            <p:nvPr/>
          </p:nvSpPr>
          <p:spPr>
            <a:xfrm>
              <a:off x="2687760" y="5675400"/>
              <a:ext cx="45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3BL-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Line 44"/>
            <p:cNvSpPr/>
            <p:nvPr/>
          </p:nvSpPr>
          <p:spPr>
            <a:xfrm>
              <a:off x="2622600" y="5769000"/>
              <a:ext cx="123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2" name="Oval 46"/>
          <p:cNvSpPr/>
          <p:nvPr/>
        </p:nvSpPr>
        <p:spPr>
          <a:xfrm>
            <a:off x="184320" y="4863960"/>
            <a:ext cx="152280" cy="152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Line 47"/>
          <p:cNvSpPr/>
          <p:nvPr/>
        </p:nvSpPr>
        <p:spPr>
          <a:xfrm>
            <a:off x="2317680" y="493884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 Box 58"/>
          <p:cNvSpPr/>
          <p:nvPr/>
        </p:nvSpPr>
        <p:spPr>
          <a:xfrm>
            <a:off x="2570400" y="2754360"/>
            <a:ext cx="33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c0000"/>
                </a:solidFill>
                <a:latin typeface="Arial"/>
              </a:rPr>
              <a:t>Dx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Text Box 59"/>
          <p:cNvSpPr/>
          <p:nvPr/>
        </p:nvSpPr>
        <p:spPr>
          <a:xfrm>
            <a:off x="2569680" y="536256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22-0.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 Box 60"/>
          <p:cNvSpPr/>
          <p:nvPr/>
        </p:nvSpPr>
        <p:spPr>
          <a:xfrm>
            <a:off x="2568600" y="5568840"/>
            <a:ext cx="964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0-0.63 </a:t>
            </a:r>
            <a:r>
              <a:rPr b="0" i="1" lang="en-GB" sz="800" spc="-1" strike="noStrike">
                <a:solidFill>
                  <a:srgbClr val="0a04fc"/>
                </a:solidFill>
                <a:latin typeface="Arial"/>
              </a:rPr>
              <a:t>PSII-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Prostokąt 41"/>
          <p:cNvSpPr/>
          <p:nvPr/>
        </p:nvSpPr>
        <p:spPr>
          <a:xfrm>
            <a:off x="5805360" y="6781680"/>
            <a:ext cx="8146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08  Chl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a+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2010  </a:t>
            </a:r>
            <a:r>
              <a:rPr b="0" lang="pl-PL" sz="700" spc="-1" strike="noStrike">
                <a:solidFill>
                  <a:srgbClr val="000000"/>
                </a:solidFill>
                <a:latin typeface="Arial"/>
                <a:ea typeface="Times New Roman"/>
              </a:rPr>
              <a:t>ABS/CS</a:t>
            </a:r>
            <a:r>
              <a:rPr b="0" lang="pl-PL" sz="600" spc="-1" strike="noStrike">
                <a:solidFill>
                  <a:srgbClr val="000000"/>
                </a:solidFill>
                <a:latin typeface="Arial"/>
                <a:ea typeface="Times New Roman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8" name="Picture 2" descr=""/>
          <p:cNvPicPr/>
          <p:nvPr/>
        </p:nvPicPr>
        <p:blipFill>
          <a:blip r:embed="rId4"/>
          <a:srcRect l="82317" t="2595" r="10577" b="91301"/>
          <a:stretch/>
        </p:blipFill>
        <p:spPr>
          <a:xfrm>
            <a:off x="5543640" y="6846840"/>
            <a:ext cx="311040" cy="195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9" name="Picture 2" descr=""/>
          <p:cNvPicPr/>
          <p:nvPr/>
        </p:nvPicPr>
        <p:blipFill>
          <a:blip r:embed="rId1"/>
          <a:stretch/>
        </p:blipFill>
        <p:spPr>
          <a:xfrm>
            <a:off x="3506760" y="2406600"/>
            <a:ext cx="2970360" cy="4705560"/>
          </a:xfrm>
          <a:prstGeom prst="rect">
            <a:avLst/>
          </a:prstGeom>
          <a:ln w="0">
            <a:noFill/>
          </a:ln>
        </p:spPr>
      </p:pic>
      <p:sp>
        <p:nvSpPr>
          <p:cNvPr id="370" name="AutoShape 2"/>
          <p:cNvSpPr/>
          <p:nvPr/>
        </p:nvSpPr>
        <p:spPr>
          <a:xfrm>
            <a:off x="2470320" y="6095880"/>
            <a:ext cx="152280" cy="92736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927360"/>
              <a:gd name="textAreaBottom" fmla="*/ 909720 h 927360"/>
            </a:gdLst>
            <a:ahLst/>
            <a:rect l="textAreaLeft" t="textAreaTop" r="textAreaRight" b="textAreaBottom"/>
            <a:pathLst>
              <a:path w="21600" h="131281">
                <a:moveTo>
                  <a:pt x="3600" y="0"/>
                </a:moveTo>
                <a:arcTo wR="3600" hR="3600" stAng="0" swAng="5400000"/>
                <a:lnTo>
                  <a:pt x="0" y="127681"/>
                </a:lnTo>
                <a:arcTo wR="3600" hR="3600" stAng="16200000" swAng="5400000"/>
                <a:lnTo>
                  <a:pt x="18000" y="131281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55c1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AutoShape 3"/>
          <p:cNvSpPr/>
          <p:nvPr/>
        </p:nvSpPr>
        <p:spPr>
          <a:xfrm>
            <a:off x="2470320" y="5410080"/>
            <a:ext cx="152280" cy="800280"/>
          </a:xfrm>
          <a:custGeom>
            <a:avLst/>
            <a:gdLst>
              <a:gd name="textAreaLeft" fmla="*/ 0 w 152280"/>
              <a:gd name="textAreaRight" fmla="*/ 152640 w 152280"/>
              <a:gd name="textAreaTop" fmla="*/ 0 h 800280"/>
              <a:gd name="textAreaBottom" fmla="*/ 800640 h 800280"/>
            </a:gdLst>
            <a:ahLst/>
            <a:rect l="textAreaLeft" t="textAreaTop" r="textAreaRight" b="textAreaBottom"/>
            <a:pathLst>
              <a:path w="21600" h="113298">
                <a:moveTo>
                  <a:pt x="0" y="0"/>
                </a:moveTo>
                <a:arcTo wR="0" hR="0" stAng="10800000" swAng="-5400000"/>
                <a:lnTo>
                  <a:pt x="0" y="113298"/>
                </a:lnTo>
                <a:arcTo wR="0" hR="0" stAng="16200000" swAng="-5400000"/>
                <a:lnTo>
                  <a:pt x="21600" y="113298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AutoShape 5"/>
          <p:cNvSpPr/>
          <p:nvPr/>
        </p:nvSpPr>
        <p:spPr>
          <a:xfrm>
            <a:off x="2470320" y="2610000"/>
            <a:ext cx="152280" cy="165708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1657080"/>
              <a:gd name="textAreaBottom" fmla="*/ 1639440 h 1657080"/>
            </a:gdLst>
            <a:ahLst/>
            <a:rect l="textAreaLeft" t="textAreaTop" r="textAreaRight" b="textAreaBottom"/>
            <a:pathLst>
              <a:path w="21600" h="234543">
                <a:moveTo>
                  <a:pt x="3600" y="0"/>
                </a:moveTo>
                <a:arcTo wR="3600" hR="3600" stAng="0" swAng="5400000"/>
                <a:lnTo>
                  <a:pt x="0" y="230943"/>
                </a:lnTo>
                <a:arcTo wR="3600" hR="3600" stAng="16200000" swAng="5400000"/>
                <a:lnTo>
                  <a:pt x="18000" y="234543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solidFill>
            <a:srgbClr val="1f60a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AutoShape 43"/>
          <p:cNvSpPr/>
          <p:nvPr/>
        </p:nvSpPr>
        <p:spPr>
          <a:xfrm>
            <a:off x="2470320" y="4213080"/>
            <a:ext cx="152280" cy="74880"/>
          </a:xfrm>
          <a:custGeom>
            <a:avLst/>
            <a:gdLst>
              <a:gd name="textAreaLeft" fmla="*/ 0 w 152280"/>
              <a:gd name="textAreaRight" fmla="*/ 152640 w 152280"/>
              <a:gd name="textAreaTop" fmla="*/ 0 h 74880"/>
              <a:gd name="textAreaBottom" fmla="*/ 75240 h 74880"/>
            </a:gdLst>
            <a:ahLst/>
            <a:rect l="textAreaLeft" t="textAreaTop" r="textAreaRight" b="textAreaBottom"/>
            <a:pathLst>
              <a:path w="43820" h="21600">
                <a:moveTo>
                  <a:pt x="0" y="0"/>
                </a:moveTo>
                <a:arcTo wR="0" hR="0" stAng="10800000" swAng="-5400000"/>
                <a:lnTo>
                  <a:pt x="0" y="21600"/>
                </a:lnTo>
                <a:arcTo wR="0" hR="0" stAng="16200000" swAng="-5400000"/>
                <a:lnTo>
                  <a:pt x="43820" y="21600"/>
                </a:lnTo>
                <a:arcTo wR="0" hR="0" stAng="10800000" swAng="-5400000"/>
                <a:lnTo>
                  <a:pt x="43820" y="0"/>
                </a:lnTo>
                <a:arcTo wR="0" hR="0" stAng="1620000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440" bIns="284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AutoShape 7"/>
          <p:cNvSpPr/>
          <p:nvPr/>
        </p:nvSpPr>
        <p:spPr>
          <a:xfrm>
            <a:off x="2470320" y="4273560"/>
            <a:ext cx="152280" cy="1174680"/>
          </a:xfrm>
          <a:custGeom>
            <a:avLst/>
            <a:gdLst>
              <a:gd name="textAreaLeft" fmla="*/ 0 w 152280"/>
              <a:gd name="textAreaRight" fmla="*/ 152640 w 152280"/>
              <a:gd name="textAreaTop" fmla="*/ 0 h 1174680"/>
              <a:gd name="textAreaBottom" fmla="*/ 1174680 h 1174680"/>
            </a:gdLst>
            <a:ahLst/>
            <a:rect l="textAreaLeft" t="textAreaTop" r="textAreaRight" b="textAreaBottom"/>
            <a:pathLst>
              <a:path w="21600" h="166279">
                <a:moveTo>
                  <a:pt x="0" y="0"/>
                </a:moveTo>
                <a:arcTo wR="0" hR="0" stAng="10800000" swAng="-5400000"/>
                <a:lnTo>
                  <a:pt x="0" y="166279"/>
                </a:lnTo>
                <a:arcTo wR="0" hR="0" stAng="16200000" swAng="-5400000"/>
                <a:lnTo>
                  <a:pt x="21600" y="166279"/>
                </a:lnTo>
                <a:arcTo wR="0" hR="0" stAng="10800000" swAng="-5400000"/>
                <a:lnTo>
                  <a:pt x="21600" y="0"/>
                </a:lnTo>
                <a:arcTo wR="0" hR="0" stAng="16200000" swAng="-5400000"/>
                <a:close/>
              </a:path>
            </a:pathLst>
          </a:custGeom>
          <a:solidFill>
            <a:srgbClr val="a06ba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AutoShape 8"/>
          <p:cNvSpPr/>
          <p:nvPr/>
        </p:nvSpPr>
        <p:spPr>
          <a:xfrm>
            <a:off x="2470320" y="2616120"/>
            <a:ext cx="152280" cy="4407120"/>
          </a:xfrm>
          <a:custGeom>
            <a:avLst/>
            <a:gdLst>
              <a:gd name="textAreaLeft" fmla="*/ 17640 w 152280"/>
              <a:gd name="textAreaRight" fmla="*/ 134640 w 152280"/>
              <a:gd name="textAreaTop" fmla="*/ 17640 h 4407120"/>
              <a:gd name="textAreaBottom" fmla="*/ 4389480 h 4407120"/>
            </a:gdLst>
            <a:ahLst/>
            <a:rect l="textAreaLeft" t="textAreaTop" r="textAreaRight" b="textAreaBottom"/>
            <a:pathLst>
              <a:path w="21600" h="623700">
                <a:moveTo>
                  <a:pt x="3600" y="0"/>
                </a:moveTo>
                <a:arcTo wR="3600" hR="3600" stAng="0" swAng="5400000"/>
                <a:lnTo>
                  <a:pt x="0" y="620100"/>
                </a:lnTo>
                <a:arcTo wR="3600" hR="3600" stAng="16200000" swAng="5400000"/>
                <a:lnTo>
                  <a:pt x="18000" y="623700"/>
                </a:lnTo>
                <a:arcTo wR="3600" hR="3600" stAng="10800000" swAng="5400000"/>
                <a:lnTo>
                  <a:pt x="21600" y="3600"/>
                </a:lnTo>
                <a:arcTo wR="3600" hR="3600" stAng="5400000" swAng="5400000"/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Text Box 9"/>
          <p:cNvSpPr/>
          <p:nvPr/>
        </p:nvSpPr>
        <p:spPr>
          <a:xfrm>
            <a:off x="2588760" y="328464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55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Text Box 11"/>
          <p:cNvSpPr/>
          <p:nvPr/>
        </p:nvSpPr>
        <p:spPr>
          <a:xfrm>
            <a:off x="2698920" y="4087800"/>
            <a:ext cx="958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3DS-6, 3DS-5,</a:t>
            </a: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 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Text Box 12"/>
          <p:cNvSpPr/>
          <p:nvPr/>
        </p:nvSpPr>
        <p:spPr>
          <a:xfrm>
            <a:off x="2700360" y="5719680"/>
            <a:ext cx="79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3DL-2, 3DL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Text Box 13"/>
          <p:cNvSpPr/>
          <p:nvPr/>
        </p:nvSpPr>
        <p:spPr>
          <a:xfrm>
            <a:off x="2588760" y="4759200"/>
            <a:ext cx="610560" cy="19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27-0.5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Text Box 15"/>
          <p:cNvSpPr/>
          <p:nvPr/>
        </p:nvSpPr>
        <p:spPr>
          <a:xfrm>
            <a:off x="2588760" y="648828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0.81-1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Line 18"/>
          <p:cNvSpPr/>
          <p:nvPr/>
        </p:nvSpPr>
        <p:spPr>
          <a:xfrm>
            <a:off x="2646360" y="58197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Line 19"/>
          <p:cNvSpPr/>
          <p:nvPr/>
        </p:nvSpPr>
        <p:spPr>
          <a:xfrm flipV="1">
            <a:off x="2655720" y="5447880"/>
            <a:ext cx="0" cy="755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Text Box 20"/>
          <p:cNvSpPr/>
          <p:nvPr/>
        </p:nvSpPr>
        <p:spPr>
          <a:xfrm>
            <a:off x="78480" y="201132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D 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Text Box 21"/>
          <p:cNvSpPr/>
          <p:nvPr/>
        </p:nvSpPr>
        <p:spPr>
          <a:xfrm>
            <a:off x="2301840" y="2011320"/>
            <a:ext cx="12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D bins+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Text Box 22"/>
          <p:cNvSpPr/>
          <p:nvPr/>
        </p:nvSpPr>
        <p:spPr>
          <a:xfrm>
            <a:off x="3938040" y="2011320"/>
            <a:ext cx="216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D CIM LOD+additive eff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86" name="Picture 38" descr="3D Screen shot 2013-01-08 at 18"/>
          <p:cNvPicPr/>
          <p:nvPr/>
        </p:nvPicPr>
        <p:blipFill>
          <a:blip r:embed="rId2"/>
          <a:stretch/>
        </p:blipFill>
        <p:spPr>
          <a:xfrm>
            <a:off x="182520" y="2552760"/>
            <a:ext cx="270000" cy="4540320"/>
          </a:xfrm>
          <a:prstGeom prst="rect">
            <a:avLst/>
          </a:prstGeom>
          <a:ln w="0">
            <a:noFill/>
          </a:ln>
        </p:spPr>
      </p:pic>
      <p:sp>
        <p:nvSpPr>
          <p:cNvPr id="387" name="Oval 39"/>
          <p:cNvSpPr/>
          <p:nvPr/>
        </p:nvSpPr>
        <p:spPr>
          <a:xfrm>
            <a:off x="220680" y="4146480"/>
            <a:ext cx="152280" cy="15264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88" name="Picture 40" descr="Chrom blank Screen shot 2013-01-07 at 10"/>
          <p:cNvPicPr/>
          <p:nvPr/>
        </p:nvPicPr>
        <p:blipFill>
          <a:blip r:embed="rId3">
            <a:lum contrast="-2000"/>
          </a:blip>
          <a:srcRect l="0" t="0" r="7663" b="0"/>
          <a:stretch/>
        </p:blipFill>
        <p:spPr>
          <a:xfrm>
            <a:off x="214200" y="3606840"/>
            <a:ext cx="162000" cy="466560"/>
          </a:xfrm>
          <a:prstGeom prst="rect">
            <a:avLst/>
          </a:prstGeom>
          <a:ln w="0">
            <a:noFill/>
          </a:ln>
        </p:spPr>
      </p:pic>
      <p:sp>
        <p:nvSpPr>
          <p:cNvPr id="389" name="Text Box 41"/>
          <p:cNvSpPr/>
          <p:nvPr/>
        </p:nvSpPr>
        <p:spPr>
          <a:xfrm>
            <a:off x="356760" y="2567160"/>
            <a:ext cx="2009520" cy="448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965-3D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11b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71p77.4, </a:t>
            </a: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cfd35 (0.55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161 (0.55-1.00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dupw173</a:t>
            </a:r>
            <a:r>
              <a:rPr b="0" lang="en-US" sz="600" spc="-1" strike="noStrike">
                <a:solidFill>
                  <a:srgbClr val="fe9138"/>
                </a:solidFill>
                <a:latin typeface="Arial"/>
              </a:rPr>
              <a:t>(Ltp) (0.55-1.00e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4569-3D (0.55-1.00g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09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150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135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4103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wmc533 (0.55-1.00c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41 (0.24-0.55Sa), gwm456 (Cent 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52 (0.27-0.51L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6948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barc4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645 (0.27-0.51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383 (0.27-0.51a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gwm66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49p78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83p65.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43p78.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wia858.2</a:t>
            </a:r>
            <a:r>
              <a:rPr b="0" lang="en-US" sz="600" spc="-1" strike="noStrike">
                <a:solidFill>
                  <a:srgbClr val="ff9900"/>
                </a:solidFill>
                <a:latin typeface="Arial"/>
              </a:rPr>
              <a:t>(Glb35) (0.81-1.00e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233-3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705-3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290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6909-3D,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59p78.3, </a:t>
            </a: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psr1203.2 (0.81-1.00b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8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339966"/>
                </a:solidFill>
                <a:latin typeface="Arial"/>
              </a:rPr>
              <a:t>wPt-73093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Text Box 45"/>
          <p:cNvSpPr/>
          <p:nvPr/>
        </p:nvSpPr>
        <p:spPr>
          <a:xfrm>
            <a:off x="2700000" y="4191120"/>
            <a:ext cx="735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3DL-2 </a:t>
            </a:r>
            <a:r>
              <a:rPr b="0" i="1" lang="en-GB" sz="800" spc="-1" strike="noStrike">
                <a:solidFill>
                  <a:srgbClr val="fc0000"/>
                </a:solidFill>
                <a:latin typeface="Arial"/>
              </a:rPr>
              <a:t>e-Lc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Line 46"/>
          <p:cNvSpPr/>
          <p:nvPr/>
        </p:nvSpPr>
        <p:spPr>
          <a:xfrm>
            <a:off x="2655720" y="4248000"/>
            <a:ext cx="93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Line 47"/>
          <p:cNvSpPr/>
          <p:nvPr/>
        </p:nvSpPr>
        <p:spPr>
          <a:xfrm flipV="1">
            <a:off x="2655720" y="4200480"/>
            <a:ext cx="0" cy="763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Line 50"/>
          <p:cNvSpPr/>
          <p:nvPr/>
        </p:nvSpPr>
        <p:spPr>
          <a:xfrm>
            <a:off x="2336760" y="4205160"/>
            <a:ext cx="419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Line 57"/>
          <p:cNvSpPr/>
          <p:nvPr/>
        </p:nvSpPr>
        <p:spPr>
          <a:xfrm>
            <a:off x="5442120" y="2610000"/>
            <a:ext cx="0" cy="43495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Text Box 58"/>
          <p:cNvSpPr/>
          <p:nvPr/>
        </p:nvSpPr>
        <p:spPr>
          <a:xfrm>
            <a:off x="2586240" y="5943600"/>
            <a:ext cx="977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3b800"/>
                </a:solidFill>
                <a:latin typeface="Arial"/>
              </a:rPr>
              <a:t>Rubisco-ssu, S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Text Box 59"/>
          <p:cNvSpPr/>
          <p:nvPr/>
        </p:nvSpPr>
        <p:spPr>
          <a:xfrm>
            <a:off x="2589480" y="2732040"/>
            <a:ext cx="33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fc0000"/>
                </a:solidFill>
                <a:latin typeface="Arial"/>
              </a:rPr>
              <a:t>Dx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97" name="Group 106"/>
          <p:cNvGrpSpPr/>
          <p:nvPr/>
        </p:nvGrpSpPr>
        <p:grpSpPr>
          <a:xfrm>
            <a:off x="5452920" y="5410080"/>
            <a:ext cx="1176480" cy="1201680"/>
            <a:chOff x="5452920" y="5410080"/>
            <a:chExt cx="1176480" cy="1201680"/>
          </a:xfrm>
        </p:grpSpPr>
        <p:pic>
          <p:nvPicPr>
            <p:cNvPr id="398" name="Picture 3" descr=""/>
            <p:cNvPicPr/>
            <p:nvPr/>
          </p:nvPicPr>
          <p:blipFill>
            <a:blip r:embed="rId4"/>
            <a:srcRect l="82169" t="2358" r="9368" b="67956"/>
            <a:stretch/>
          </p:blipFill>
          <p:spPr>
            <a:xfrm>
              <a:off x="5452920" y="5448240"/>
              <a:ext cx="468360" cy="1117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99" name="pole tekstowe 4"/>
            <p:cNvSpPr/>
            <p:nvPr/>
          </p:nvSpPr>
          <p:spPr>
            <a:xfrm>
              <a:off x="5807160" y="5410080"/>
              <a:ext cx="822240" cy="120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7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hl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+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PA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a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W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W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1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C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I</a:t>
              </a:r>
              <a:r>
                <a:rPr b="0" lang="pl-PL" sz="5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8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10  </a:t>
              </a:r>
              <a:r>
                <a:rPr b="0" lang="pl-PL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BS/CS</a:t>
              </a:r>
              <a:r>
                <a:rPr b="0" lang="pl-PL" sz="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8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06T09:42:17Z</dcterms:created>
  <dc:creator>Steve Quarrie;&amp; ICzM</dc:creator>
  <dc:description/>
  <dc:language>en-US</dc:language>
  <cp:lastModifiedBy>I.Czyczyło-Mysza</cp:lastModifiedBy>
  <cp:lastPrinted>2013-03-14T18:02:34Z</cp:lastPrinted>
  <dcterms:modified xsi:type="dcterms:W3CDTF">2013-04-02T08:40:00Z</dcterms:modified>
  <cp:revision>1451</cp:revision>
  <dc:subject/>
  <dc:title>PowerPoint Presentation</dc:title>
</cp:coreProperties>
</file>